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66" r:id="rId2"/>
    <p:sldId id="269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  <a:srgbClr val="375723"/>
    <a:srgbClr val="203864"/>
    <a:srgbClr val="F5B183"/>
    <a:srgbClr val="00B050"/>
    <a:srgbClr val="B7B7B7"/>
    <a:srgbClr val="EE7D30"/>
    <a:srgbClr val="021F60"/>
    <a:srgbClr val="FFFF00"/>
    <a:srgbClr val="E3F1D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023BD75-3484-F245-B723-6E8D9C13CED4}" v="210" dt="2023-03-28T07:57:28.541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673" autoAdjust="0"/>
    <p:restoredTop sz="96076" autoAdjust="0"/>
  </p:normalViewPr>
  <p:slideViewPr>
    <p:cSldViewPr snapToGrid="0">
      <p:cViewPr varScale="1">
        <p:scale>
          <a:sx n="40" d="100"/>
          <a:sy n="40" d="100"/>
        </p:scale>
        <p:origin x="251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im Ji-Eun" userId="5d7677e0d52343ec" providerId="LiveId" clId="{F023BD75-3484-F245-B723-6E8D9C13CED4}"/>
    <pc:docChg chg="undo custSel addSld delSld modSld sldOrd">
      <pc:chgData name="Kim Ji-Eun" userId="5d7677e0d52343ec" providerId="LiveId" clId="{F023BD75-3484-F245-B723-6E8D9C13CED4}" dt="2023-04-17T06:24:38.391" v="3068" actId="2696"/>
      <pc:docMkLst>
        <pc:docMk/>
      </pc:docMkLst>
      <pc:sldChg chg="modSp mod">
        <pc:chgData name="Kim Ji-Eun" userId="5d7677e0d52343ec" providerId="LiveId" clId="{F023BD75-3484-F245-B723-6E8D9C13CED4}" dt="2023-04-03T07:28:40.769" v="3049" actId="20577"/>
        <pc:sldMkLst>
          <pc:docMk/>
          <pc:sldMk cId="267184415" sldId="263"/>
        </pc:sldMkLst>
        <pc:spChg chg="mod">
          <ac:chgData name="Kim Ji-Eun" userId="5d7677e0d52343ec" providerId="LiveId" clId="{F023BD75-3484-F245-B723-6E8D9C13CED4}" dt="2023-04-03T04:53:05.590" v="2932" actId="20577"/>
          <ac:spMkLst>
            <pc:docMk/>
            <pc:sldMk cId="267184415" sldId="263"/>
            <ac:spMk id="19" creationId="{57107138-08F5-C413-14A0-00FDB538EC86}"/>
          </ac:spMkLst>
        </pc:spChg>
        <pc:spChg chg="mod">
          <ac:chgData name="Kim Ji-Eun" userId="5d7677e0d52343ec" providerId="LiveId" clId="{F023BD75-3484-F245-B723-6E8D9C13CED4}" dt="2023-04-03T04:53:13.174" v="2937" actId="20577"/>
          <ac:spMkLst>
            <pc:docMk/>
            <pc:sldMk cId="267184415" sldId="263"/>
            <ac:spMk id="21" creationId="{8060DAEB-F52C-C4C7-3DEF-E20058B1D843}"/>
          </ac:spMkLst>
        </pc:spChg>
        <pc:spChg chg="mod">
          <ac:chgData name="Kim Ji-Eun" userId="5d7677e0d52343ec" providerId="LiveId" clId="{F023BD75-3484-F245-B723-6E8D9C13CED4}" dt="2023-04-03T07:28:40.769" v="3049" actId="20577"/>
          <ac:spMkLst>
            <pc:docMk/>
            <pc:sldMk cId="267184415" sldId="263"/>
            <ac:spMk id="32" creationId="{F2605BFE-45BB-3DC7-B3E7-F487D661DFAE}"/>
          </ac:spMkLst>
        </pc:spChg>
        <pc:spChg chg="mod">
          <ac:chgData name="Kim Ji-Eun" userId="5d7677e0d52343ec" providerId="LiveId" clId="{F023BD75-3484-F245-B723-6E8D9C13CED4}" dt="2023-04-03T04:53:18.633" v="2939" actId="20577"/>
          <ac:spMkLst>
            <pc:docMk/>
            <pc:sldMk cId="267184415" sldId="263"/>
            <ac:spMk id="97" creationId="{7E00390C-1873-4453-4311-1B39F11665F9}"/>
          </ac:spMkLst>
        </pc:spChg>
        <pc:spChg chg="mod">
          <ac:chgData name="Kim Ji-Eun" userId="5d7677e0d52343ec" providerId="LiveId" clId="{F023BD75-3484-F245-B723-6E8D9C13CED4}" dt="2023-04-03T04:53:21.511" v="2941" actId="20577"/>
          <ac:spMkLst>
            <pc:docMk/>
            <pc:sldMk cId="267184415" sldId="263"/>
            <ac:spMk id="98" creationId="{53C7A7D6-53FC-3FB4-4B94-4FFD5F7ADF82}"/>
          </ac:spMkLst>
        </pc:spChg>
        <pc:spChg chg="mod">
          <ac:chgData name="Kim Ji-Eun" userId="5d7677e0d52343ec" providerId="LiveId" clId="{F023BD75-3484-F245-B723-6E8D9C13CED4}" dt="2023-04-03T04:53:24.243" v="2943" actId="20577"/>
          <ac:spMkLst>
            <pc:docMk/>
            <pc:sldMk cId="267184415" sldId="263"/>
            <ac:spMk id="99" creationId="{9216D3F3-8C0B-7185-FD79-324DE1F5564E}"/>
          </ac:spMkLst>
        </pc:spChg>
        <pc:spChg chg="mod">
          <ac:chgData name="Kim Ji-Eun" userId="5d7677e0d52343ec" providerId="LiveId" clId="{F023BD75-3484-F245-B723-6E8D9C13CED4}" dt="2023-04-03T04:53:27.084" v="2945" actId="20577"/>
          <ac:spMkLst>
            <pc:docMk/>
            <pc:sldMk cId="267184415" sldId="263"/>
            <ac:spMk id="100" creationId="{D3408796-0D3A-173E-C23B-CB25DACC9B7E}"/>
          </ac:spMkLst>
        </pc:spChg>
        <pc:spChg chg="mod">
          <ac:chgData name="Kim Ji-Eun" userId="5d7677e0d52343ec" providerId="LiveId" clId="{F023BD75-3484-F245-B723-6E8D9C13CED4}" dt="2023-04-03T04:53:29.652" v="2947" actId="20577"/>
          <ac:spMkLst>
            <pc:docMk/>
            <pc:sldMk cId="267184415" sldId="263"/>
            <ac:spMk id="224" creationId="{BF04FE15-7E26-9FEE-7B04-57452AF72421}"/>
          </ac:spMkLst>
        </pc:spChg>
        <pc:spChg chg="mod">
          <ac:chgData name="Kim Ji-Eun" userId="5d7677e0d52343ec" providerId="LiveId" clId="{F023BD75-3484-F245-B723-6E8D9C13CED4}" dt="2023-04-03T04:53:33.014" v="2949" actId="20577"/>
          <ac:spMkLst>
            <pc:docMk/>
            <pc:sldMk cId="267184415" sldId="263"/>
            <ac:spMk id="225" creationId="{8E3AC94C-6026-A1C2-3687-894A4961500D}"/>
          </ac:spMkLst>
        </pc:spChg>
        <pc:spChg chg="mod">
          <ac:chgData name="Kim Ji-Eun" userId="5d7677e0d52343ec" providerId="LiveId" clId="{F023BD75-3484-F245-B723-6E8D9C13CED4}" dt="2023-04-03T04:53:35.806" v="2951" actId="20577"/>
          <ac:spMkLst>
            <pc:docMk/>
            <pc:sldMk cId="267184415" sldId="263"/>
            <ac:spMk id="226" creationId="{F081F1DE-2D58-BB5A-42EE-CFA041FBE144}"/>
          </ac:spMkLst>
        </pc:spChg>
        <pc:spChg chg="mod">
          <ac:chgData name="Kim Ji-Eun" userId="5d7677e0d52343ec" providerId="LiveId" clId="{F023BD75-3484-F245-B723-6E8D9C13CED4}" dt="2023-04-03T04:53:39.676" v="2953" actId="20577"/>
          <ac:spMkLst>
            <pc:docMk/>
            <pc:sldMk cId="267184415" sldId="263"/>
            <ac:spMk id="227" creationId="{BB4188AE-F426-C800-FBB2-8C6E488DEDB4}"/>
          </ac:spMkLst>
        </pc:spChg>
        <pc:spChg chg="mod">
          <ac:chgData name="Kim Ji-Eun" userId="5d7677e0d52343ec" providerId="LiveId" clId="{F023BD75-3484-F245-B723-6E8D9C13CED4}" dt="2023-03-22T01:43:50.200" v="1705" actId="20577"/>
          <ac:spMkLst>
            <pc:docMk/>
            <pc:sldMk cId="267184415" sldId="263"/>
            <ac:spMk id="309" creationId="{596850A7-D9BC-3D23-D2A2-2051224CDF2E}"/>
          </ac:spMkLst>
        </pc:spChg>
        <pc:spChg chg="mod">
          <ac:chgData name="Kim Ji-Eun" userId="5d7677e0d52343ec" providerId="LiveId" clId="{F023BD75-3484-F245-B723-6E8D9C13CED4}" dt="2023-04-03T04:53:49.738" v="2958" actId="20577"/>
          <ac:spMkLst>
            <pc:docMk/>
            <pc:sldMk cId="267184415" sldId="263"/>
            <ac:spMk id="350" creationId="{5388F125-1068-C1E4-2DFF-D03FF1477606}"/>
          </ac:spMkLst>
        </pc:spChg>
        <pc:spChg chg="mod">
          <ac:chgData name="Kim Ji-Eun" userId="5d7677e0d52343ec" providerId="LiveId" clId="{F023BD75-3484-F245-B723-6E8D9C13CED4}" dt="2023-04-03T04:53:53.901" v="2961" actId="20577"/>
          <ac:spMkLst>
            <pc:docMk/>
            <pc:sldMk cId="267184415" sldId="263"/>
            <ac:spMk id="352" creationId="{D66D33E2-262E-C184-4421-BB03C55D4CD1}"/>
          </ac:spMkLst>
        </pc:spChg>
      </pc:sldChg>
      <pc:sldChg chg="addSp delSp modSp mod">
        <pc:chgData name="Kim Ji-Eun" userId="5d7677e0d52343ec" providerId="LiveId" clId="{F023BD75-3484-F245-B723-6E8D9C13CED4}" dt="2023-04-03T04:54:33.031" v="2985" actId="20577"/>
        <pc:sldMkLst>
          <pc:docMk/>
          <pc:sldMk cId="3988803251" sldId="264"/>
        </pc:sldMkLst>
        <pc:spChg chg="mod">
          <ac:chgData name="Kim Ji-Eun" userId="5d7677e0d52343ec" providerId="LiveId" clId="{F023BD75-3484-F245-B723-6E8D9C13CED4}" dt="2023-03-22T01:43:12.501" v="1703"/>
          <ac:spMkLst>
            <pc:docMk/>
            <pc:sldMk cId="3988803251" sldId="264"/>
            <ac:spMk id="4" creationId="{0403CBEC-6A69-A332-39CB-1541C4821C82}"/>
          </ac:spMkLst>
        </pc:spChg>
        <pc:spChg chg="mod">
          <ac:chgData name="Kim Ji-Eun" userId="5d7677e0d52343ec" providerId="LiveId" clId="{F023BD75-3484-F245-B723-6E8D9C13CED4}" dt="2023-03-22T01:43:12.501" v="1703"/>
          <ac:spMkLst>
            <pc:docMk/>
            <pc:sldMk cId="3988803251" sldId="264"/>
            <ac:spMk id="5" creationId="{BE6C2ED7-9F7E-2F03-D427-C51B6B637C03}"/>
          </ac:spMkLst>
        </pc:spChg>
        <pc:spChg chg="mod">
          <ac:chgData name="Kim Ji-Eun" userId="5d7677e0d52343ec" providerId="LiveId" clId="{F023BD75-3484-F245-B723-6E8D9C13CED4}" dt="2023-03-22T01:43:12.501" v="1703"/>
          <ac:spMkLst>
            <pc:docMk/>
            <pc:sldMk cId="3988803251" sldId="264"/>
            <ac:spMk id="6" creationId="{811063F5-6780-8A76-7238-1E988450EB34}"/>
          </ac:spMkLst>
        </pc:spChg>
        <pc:spChg chg="mod">
          <ac:chgData name="Kim Ji-Eun" userId="5d7677e0d52343ec" providerId="LiveId" clId="{F023BD75-3484-F245-B723-6E8D9C13CED4}" dt="2023-03-22T01:43:12.501" v="1703"/>
          <ac:spMkLst>
            <pc:docMk/>
            <pc:sldMk cId="3988803251" sldId="264"/>
            <ac:spMk id="10" creationId="{622A0315-0A30-D136-2172-9242E70A4965}"/>
          </ac:spMkLst>
        </pc:spChg>
        <pc:spChg chg="mod">
          <ac:chgData name="Kim Ji-Eun" userId="5d7677e0d52343ec" providerId="LiveId" clId="{F023BD75-3484-F245-B723-6E8D9C13CED4}" dt="2023-03-22T01:43:12.501" v="1703"/>
          <ac:spMkLst>
            <pc:docMk/>
            <pc:sldMk cId="3988803251" sldId="264"/>
            <ac:spMk id="11" creationId="{1C0E1E82-8DFE-9A8B-A34C-0991C40FCE2D}"/>
          </ac:spMkLst>
        </pc:spChg>
        <pc:spChg chg="mod">
          <ac:chgData name="Kim Ji-Eun" userId="5d7677e0d52343ec" providerId="LiveId" clId="{F023BD75-3484-F245-B723-6E8D9C13CED4}" dt="2023-03-22T01:43:12.501" v="1703"/>
          <ac:spMkLst>
            <pc:docMk/>
            <pc:sldMk cId="3988803251" sldId="264"/>
            <ac:spMk id="12" creationId="{4619FA2E-6AEF-A64F-0B5A-AFAA4512FB48}"/>
          </ac:spMkLst>
        </pc:spChg>
        <pc:spChg chg="del">
          <ac:chgData name="Kim Ji-Eun" userId="5d7677e0d52343ec" providerId="LiveId" clId="{F023BD75-3484-F245-B723-6E8D9C13CED4}" dt="2023-03-22T01:43:12.223" v="1702" actId="478"/>
          <ac:spMkLst>
            <pc:docMk/>
            <pc:sldMk cId="3988803251" sldId="264"/>
            <ac:spMk id="28" creationId="{AD9465E4-B0A6-6199-14AC-6B9FA671C3A5}"/>
          </ac:spMkLst>
        </pc:spChg>
        <pc:spChg chg="mod">
          <ac:chgData name="Kim Ji-Eun" userId="5d7677e0d52343ec" providerId="LiveId" clId="{F023BD75-3484-F245-B723-6E8D9C13CED4}" dt="2023-03-22T01:43:12.501" v="1703"/>
          <ac:spMkLst>
            <pc:docMk/>
            <pc:sldMk cId="3988803251" sldId="264"/>
            <ac:spMk id="30" creationId="{4BC41834-60AD-D412-81F6-76D6E0ADAE86}"/>
          </ac:spMkLst>
        </pc:spChg>
        <pc:spChg chg="mod">
          <ac:chgData name="Kim Ji-Eun" userId="5d7677e0d52343ec" providerId="LiveId" clId="{F023BD75-3484-F245-B723-6E8D9C13CED4}" dt="2023-03-22T01:43:12.501" v="1703"/>
          <ac:spMkLst>
            <pc:docMk/>
            <pc:sldMk cId="3988803251" sldId="264"/>
            <ac:spMk id="36" creationId="{AC1D28A2-F318-181A-4325-E265D8BB9B2C}"/>
          </ac:spMkLst>
        </pc:spChg>
        <pc:spChg chg="mod">
          <ac:chgData name="Kim Ji-Eun" userId="5d7677e0d52343ec" providerId="LiveId" clId="{F023BD75-3484-F245-B723-6E8D9C13CED4}" dt="2023-03-22T01:43:12.501" v="1703"/>
          <ac:spMkLst>
            <pc:docMk/>
            <pc:sldMk cId="3988803251" sldId="264"/>
            <ac:spMk id="45" creationId="{D0B3166A-45F4-0E90-7743-BDF430369AAE}"/>
          </ac:spMkLst>
        </pc:spChg>
        <pc:spChg chg="mod">
          <ac:chgData name="Kim Ji-Eun" userId="5d7677e0d52343ec" providerId="LiveId" clId="{F023BD75-3484-F245-B723-6E8D9C13CED4}" dt="2023-03-22T01:43:12.501" v="1703"/>
          <ac:spMkLst>
            <pc:docMk/>
            <pc:sldMk cId="3988803251" sldId="264"/>
            <ac:spMk id="46" creationId="{0C003BE8-CFA6-115F-5E09-91D0CA906FCE}"/>
          </ac:spMkLst>
        </pc:spChg>
        <pc:spChg chg="del">
          <ac:chgData name="Kim Ji-Eun" userId="5d7677e0d52343ec" providerId="LiveId" clId="{F023BD75-3484-F245-B723-6E8D9C13CED4}" dt="2023-03-22T01:43:12.223" v="1702" actId="478"/>
          <ac:spMkLst>
            <pc:docMk/>
            <pc:sldMk cId="3988803251" sldId="264"/>
            <ac:spMk id="48" creationId="{9D8F6E00-5E57-DCA1-5572-4C50901DF0E5}"/>
          </ac:spMkLst>
        </pc:spChg>
        <pc:spChg chg="del">
          <ac:chgData name="Kim Ji-Eun" userId="5d7677e0d52343ec" providerId="LiveId" clId="{F023BD75-3484-F245-B723-6E8D9C13CED4}" dt="2023-03-22T01:43:12.223" v="1702" actId="478"/>
          <ac:spMkLst>
            <pc:docMk/>
            <pc:sldMk cId="3988803251" sldId="264"/>
            <ac:spMk id="49" creationId="{0579D6EA-1ABF-A74A-0BF1-A4B7DC7FA25F}"/>
          </ac:spMkLst>
        </pc:spChg>
        <pc:spChg chg="del">
          <ac:chgData name="Kim Ji-Eun" userId="5d7677e0d52343ec" providerId="LiveId" clId="{F023BD75-3484-F245-B723-6E8D9C13CED4}" dt="2023-03-22T01:43:12.223" v="1702" actId="478"/>
          <ac:spMkLst>
            <pc:docMk/>
            <pc:sldMk cId="3988803251" sldId="264"/>
            <ac:spMk id="50" creationId="{FC48A90D-5B5C-6600-51FB-D44C66C27511}"/>
          </ac:spMkLst>
        </pc:spChg>
        <pc:spChg chg="del">
          <ac:chgData name="Kim Ji-Eun" userId="5d7677e0d52343ec" providerId="LiveId" clId="{F023BD75-3484-F245-B723-6E8D9C13CED4}" dt="2023-03-22T01:43:12.223" v="1702" actId="478"/>
          <ac:spMkLst>
            <pc:docMk/>
            <pc:sldMk cId="3988803251" sldId="264"/>
            <ac:spMk id="51" creationId="{40C0F13B-B2A0-F133-F204-3C26C14C0856}"/>
          </ac:spMkLst>
        </pc:spChg>
        <pc:spChg chg="mod">
          <ac:chgData name="Kim Ji-Eun" userId="5d7677e0d52343ec" providerId="LiveId" clId="{F023BD75-3484-F245-B723-6E8D9C13CED4}" dt="2023-03-22T01:43:12.501" v="1703"/>
          <ac:spMkLst>
            <pc:docMk/>
            <pc:sldMk cId="3988803251" sldId="264"/>
            <ac:spMk id="52" creationId="{EFCEA1AB-F27D-8357-7365-E09B94B33FFD}"/>
          </ac:spMkLst>
        </pc:spChg>
        <pc:spChg chg="mod">
          <ac:chgData name="Kim Ji-Eun" userId="5d7677e0d52343ec" providerId="LiveId" clId="{F023BD75-3484-F245-B723-6E8D9C13CED4}" dt="2023-04-03T04:54:27.681" v="2980" actId="20577"/>
          <ac:spMkLst>
            <pc:docMk/>
            <pc:sldMk cId="3988803251" sldId="264"/>
            <ac:spMk id="56" creationId="{E6377E3E-F3D7-BEA1-6251-30DC812477EF}"/>
          </ac:spMkLst>
        </pc:spChg>
        <pc:spChg chg="mod">
          <ac:chgData name="Kim Ji-Eun" userId="5d7677e0d52343ec" providerId="LiveId" clId="{F023BD75-3484-F245-B723-6E8D9C13CED4}" dt="2023-04-03T04:54:33.031" v="2985" actId="20577"/>
          <ac:spMkLst>
            <pc:docMk/>
            <pc:sldMk cId="3988803251" sldId="264"/>
            <ac:spMk id="58" creationId="{17B3E4EC-2A13-9354-E23F-4DD862EAFF3D}"/>
          </ac:spMkLst>
        </pc:spChg>
        <pc:spChg chg="add mod">
          <ac:chgData name="Kim Ji-Eun" userId="5d7677e0d52343ec" providerId="LiveId" clId="{F023BD75-3484-F245-B723-6E8D9C13CED4}" dt="2023-03-22T01:43:12.501" v="1703"/>
          <ac:spMkLst>
            <pc:docMk/>
            <pc:sldMk cId="3988803251" sldId="264"/>
            <ac:spMk id="59" creationId="{9CB84895-0B17-E295-AD3F-0870F8A67407}"/>
          </ac:spMkLst>
        </pc:spChg>
        <pc:spChg chg="add mod">
          <ac:chgData name="Kim Ji-Eun" userId="5d7677e0d52343ec" providerId="LiveId" clId="{F023BD75-3484-F245-B723-6E8D9C13CED4}" dt="2023-03-22T01:43:12.501" v="1703"/>
          <ac:spMkLst>
            <pc:docMk/>
            <pc:sldMk cId="3988803251" sldId="264"/>
            <ac:spMk id="61" creationId="{E0809F5E-30B0-9CBA-7EF9-90D68172A915}"/>
          </ac:spMkLst>
        </pc:spChg>
        <pc:spChg chg="add mod">
          <ac:chgData name="Kim Ji-Eun" userId="5d7677e0d52343ec" providerId="LiveId" clId="{F023BD75-3484-F245-B723-6E8D9C13CED4}" dt="2023-04-03T04:54:17.912" v="2972" actId="20577"/>
          <ac:spMkLst>
            <pc:docMk/>
            <pc:sldMk cId="3988803251" sldId="264"/>
            <ac:spMk id="62" creationId="{6264AA67-6F30-B07D-AF68-0BBF81782C02}"/>
          </ac:spMkLst>
        </pc:spChg>
        <pc:spChg chg="add mod">
          <ac:chgData name="Kim Ji-Eun" userId="5d7677e0d52343ec" providerId="LiveId" clId="{F023BD75-3484-F245-B723-6E8D9C13CED4}" dt="2023-03-22T01:43:12.501" v="1703"/>
          <ac:spMkLst>
            <pc:docMk/>
            <pc:sldMk cId="3988803251" sldId="264"/>
            <ac:spMk id="63" creationId="{841620FA-DE9F-3F3E-CFF8-FA4E186F30F1}"/>
          </ac:spMkLst>
        </pc:spChg>
        <pc:spChg chg="add mod">
          <ac:chgData name="Kim Ji-Eun" userId="5d7677e0d52343ec" providerId="LiveId" clId="{F023BD75-3484-F245-B723-6E8D9C13CED4}" dt="2023-04-03T04:54:22.678" v="2977" actId="20577"/>
          <ac:spMkLst>
            <pc:docMk/>
            <pc:sldMk cId="3988803251" sldId="264"/>
            <ac:spMk id="64" creationId="{3D868323-D0E1-88E0-9A87-1CEBE7D6DBCC}"/>
          </ac:spMkLst>
        </pc:spChg>
        <pc:grpChg chg="add mod">
          <ac:chgData name="Kim Ji-Eun" userId="5d7677e0d52343ec" providerId="LiveId" clId="{F023BD75-3484-F245-B723-6E8D9C13CED4}" dt="2023-03-22T01:43:12.501" v="1703"/>
          <ac:grpSpMkLst>
            <pc:docMk/>
            <pc:sldMk cId="3988803251" sldId="264"/>
            <ac:grpSpMk id="2" creationId="{F6B4B4D9-1754-2603-58BA-7FC43E1ED82F}"/>
          </ac:grpSpMkLst>
        </pc:grpChg>
        <pc:grpChg chg="add mod">
          <ac:chgData name="Kim Ji-Eun" userId="5d7677e0d52343ec" providerId="LiveId" clId="{F023BD75-3484-F245-B723-6E8D9C13CED4}" dt="2023-03-22T01:43:12.501" v="1703"/>
          <ac:grpSpMkLst>
            <pc:docMk/>
            <pc:sldMk cId="3988803251" sldId="264"/>
            <ac:grpSpMk id="13" creationId="{C8673027-04DA-8DF0-2E1F-4E3C96C3023B}"/>
          </ac:grpSpMkLst>
        </pc:grpChg>
        <pc:grpChg chg="del">
          <ac:chgData name="Kim Ji-Eun" userId="5d7677e0d52343ec" providerId="LiveId" clId="{F023BD75-3484-F245-B723-6E8D9C13CED4}" dt="2023-03-22T01:43:12.223" v="1702" actId="478"/>
          <ac:grpSpMkLst>
            <pc:docMk/>
            <pc:sldMk cId="3988803251" sldId="264"/>
            <ac:grpSpMk id="14" creationId="{54AA00D9-F98C-8293-E926-E4AA9A20D905}"/>
          </ac:grpSpMkLst>
        </pc:grpChg>
        <pc:grpChg chg="del">
          <ac:chgData name="Kim Ji-Eun" userId="5d7677e0d52343ec" providerId="LiveId" clId="{F023BD75-3484-F245-B723-6E8D9C13CED4}" dt="2023-03-22T01:43:12.223" v="1702" actId="478"/>
          <ac:grpSpMkLst>
            <pc:docMk/>
            <pc:sldMk cId="3988803251" sldId="264"/>
            <ac:grpSpMk id="29" creationId="{6AE79E9F-1F77-DEF9-FBD6-C1A3F03C2133}"/>
          </ac:grpSpMkLst>
        </pc:grpChg>
        <pc:picChg chg="del">
          <ac:chgData name="Kim Ji-Eun" userId="5d7677e0d52343ec" providerId="LiveId" clId="{F023BD75-3484-F245-B723-6E8D9C13CED4}" dt="2023-03-22T01:43:12.223" v="1702" actId="478"/>
          <ac:picMkLst>
            <pc:docMk/>
            <pc:sldMk cId="3988803251" sldId="264"/>
            <ac:picMk id="3" creationId="{1851430A-1D4A-2765-A1AF-42D0D17D43F9}"/>
          </ac:picMkLst>
        </pc:picChg>
        <pc:picChg chg="del">
          <ac:chgData name="Kim Ji-Eun" userId="5d7677e0d52343ec" providerId="LiveId" clId="{F023BD75-3484-F245-B723-6E8D9C13CED4}" dt="2023-03-22T01:43:12.223" v="1702" actId="478"/>
          <ac:picMkLst>
            <pc:docMk/>
            <pc:sldMk cId="3988803251" sldId="264"/>
            <ac:picMk id="47" creationId="{EE3C477D-5FF9-4385-9667-B0B582B7742F}"/>
          </ac:picMkLst>
        </pc:picChg>
        <pc:picChg chg="add mod">
          <ac:chgData name="Kim Ji-Eun" userId="5d7677e0d52343ec" providerId="LiveId" clId="{F023BD75-3484-F245-B723-6E8D9C13CED4}" dt="2023-03-22T01:43:12.501" v="1703"/>
          <ac:picMkLst>
            <pc:docMk/>
            <pc:sldMk cId="3988803251" sldId="264"/>
            <ac:picMk id="60" creationId="{A7AFC003-2E9C-750E-C3FD-E57AA25077A2}"/>
          </ac:picMkLst>
        </pc:picChg>
        <pc:picChg chg="add mod">
          <ac:chgData name="Kim Ji-Eun" userId="5d7677e0d52343ec" providerId="LiveId" clId="{F023BD75-3484-F245-B723-6E8D9C13CED4}" dt="2023-03-22T01:43:12.501" v="1703"/>
          <ac:picMkLst>
            <pc:docMk/>
            <pc:sldMk cId="3988803251" sldId="264"/>
            <ac:picMk id="65" creationId="{ADDB02F8-5B2E-5246-16A0-00393D7B01D0}"/>
          </ac:picMkLst>
        </pc:picChg>
      </pc:sldChg>
      <pc:sldChg chg="addSp delSp modSp mod ord">
        <pc:chgData name="Kim Ji-Eun" userId="5d7677e0d52343ec" providerId="LiveId" clId="{F023BD75-3484-F245-B723-6E8D9C13CED4}" dt="2023-04-03T04:52:44.654" v="2929" actId="20577"/>
        <pc:sldMkLst>
          <pc:docMk/>
          <pc:sldMk cId="983287386" sldId="265"/>
        </pc:sldMkLst>
        <pc:spChg chg="del">
          <ac:chgData name="Kim Ji-Eun" userId="5d7677e0d52343ec" providerId="LiveId" clId="{F023BD75-3484-F245-B723-6E8D9C13CED4}" dt="2023-03-22T01:45:07.994" v="1706" actId="478"/>
          <ac:spMkLst>
            <pc:docMk/>
            <pc:sldMk cId="983287386" sldId="265"/>
            <ac:spMk id="2" creationId="{CD542F29-DCDB-7DEF-5833-5FACE9EC7AAB}"/>
          </ac:spMkLst>
        </pc:spChg>
        <pc:spChg chg="del">
          <ac:chgData name="Kim Ji-Eun" userId="5d7677e0d52343ec" providerId="LiveId" clId="{F023BD75-3484-F245-B723-6E8D9C13CED4}" dt="2023-03-22T01:45:07.994" v="1706" actId="478"/>
          <ac:spMkLst>
            <pc:docMk/>
            <pc:sldMk cId="983287386" sldId="265"/>
            <ac:spMk id="3" creationId="{047C8D5C-FEE5-C307-23D2-B151FBFECCFC}"/>
          </ac:spMkLst>
        </pc:spChg>
        <pc:spChg chg="add mod">
          <ac:chgData name="Kim Ji-Eun" userId="5d7677e0d52343ec" providerId="LiveId" clId="{F023BD75-3484-F245-B723-6E8D9C13CED4}" dt="2023-03-22T01:45:08.306" v="1707"/>
          <ac:spMkLst>
            <pc:docMk/>
            <pc:sldMk cId="983287386" sldId="265"/>
            <ac:spMk id="4" creationId="{BF8B7ABE-A13D-6ED3-D6A0-244C30B5522B}"/>
          </ac:spMkLst>
        </pc:spChg>
        <pc:spChg chg="del">
          <ac:chgData name="Kim Ji-Eun" userId="5d7677e0d52343ec" providerId="LiveId" clId="{F023BD75-3484-F245-B723-6E8D9C13CED4}" dt="2023-03-22T01:45:07.994" v="1706" actId="478"/>
          <ac:spMkLst>
            <pc:docMk/>
            <pc:sldMk cId="983287386" sldId="265"/>
            <ac:spMk id="5" creationId="{D76D1F59-6B01-CCFC-FDFB-460C1652EC11}"/>
          </ac:spMkLst>
        </pc:spChg>
        <pc:spChg chg="add mod">
          <ac:chgData name="Kim Ji-Eun" userId="5d7677e0d52343ec" providerId="LiveId" clId="{F023BD75-3484-F245-B723-6E8D9C13CED4}" dt="2023-03-22T01:45:08.306" v="1707"/>
          <ac:spMkLst>
            <pc:docMk/>
            <pc:sldMk cId="983287386" sldId="265"/>
            <ac:spMk id="6" creationId="{7C3248C9-A842-C40B-AB6D-97C9CE6ED286}"/>
          </ac:spMkLst>
        </pc:spChg>
        <pc:spChg chg="del">
          <ac:chgData name="Kim Ji-Eun" userId="5d7677e0d52343ec" providerId="LiveId" clId="{F023BD75-3484-F245-B723-6E8D9C13CED4}" dt="2023-03-22T01:45:07.994" v="1706" actId="478"/>
          <ac:spMkLst>
            <pc:docMk/>
            <pc:sldMk cId="983287386" sldId="265"/>
            <ac:spMk id="7" creationId="{C5BE4CB1-6B9D-F2BD-764D-79FC6E3328AD}"/>
          </ac:spMkLst>
        </pc:spChg>
        <pc:spChg chg="del">
          <ac:chgData name="Kim Ji-Eun" userId="5d7677e0d52343ec" providerId="LiveId" clId="{F023BD75-3484-F245-B723-6E8D9C13CED4}" dt="2023-03-22T01:45:07.994" v="1706" actId="478"/>
          <ac:spMkLst>
            <pc:docMk/>
            <pc:sldMk cId="983287386" sldId="265"/>
            <ac:spMk id="8" creationId="{622FBC81-BB3B-3A5A-7B54-587F2EFC8DEC}"/>
          </ac:spMkLst>
        </pc:spChg>
        <pc:spChg chg="del">
          <ac:chgData name="Kim Ji-Eun" userId="5d7677e0d52343ec" providerId="LiveId" clId="{F023BD75-3484-F245-B723-6E8D9C13CED4}" dt="2023-03-22T01:45:07.994" v="1706" actId="478"/>
          <ac:spMkLst>
            <pc:docMk/>
            <pc:sldMk cId="983287386" sldId="265"/>
            <ac:spMk id="9" creationId="{3A93093B-A813-C01E-4A07-4DAFA151C6AF}"/>
          </ac:spMkLst>
        </pc:spChg>
        <pc:spChg chg="del">
          <ac:chgData name="Kim Ji-Eun" userId="5d7677e0d52343ec" providerId="LiveId" clId="{F023BD75-3484-F245-B723-6E8D9C13CED4}" dt="2023-03-22T01:45:07.994" v="1706" actId="478"/>
          <ac:spMkLst>
            <pc:docMk/>
            <pc:sldMk cId="983287386" sldId="265"/>
            <ac:spMk id="10" creationId="{621D2A89-BB1E-DACD-796F-571F1A46AE34}"/>
          </ac:spMkLst>
        </pc:spChg>
        <pc:spChg chg="add mod">
          <ac:chgData name="Kim Ji-Eun" userId="5d7677e0d52343ec" providerId="LiveId" clId="{F023BD75-3484-F245-B723-6E8D9C13CED4}" dt="2023-03-22T01:45:08.306" v="1707"/>
          <ac:spMkLst>
            <pc:docMk/>
            <pc:sldMk cId="983287386" sldId="265"/>
            <ac:spMk id="11" creationId="{8BF8C79C-04F6-EC95-9191-E739A02B5F6B}"/>
          </ac:spMkLst>
        </pc:spChg>
        <pc:spChg chg="del">
          <ac:chgData name="Kim Ji-Eun" userId="5d7677e0d52343ec" providerId="LiveId" clId="{F023BD75-3484-F245-B723-6E8D9C13CED4}" dt="2023-03-22T01:45:07.994" v="1706" actId="478"/>
          <ac:spMkLst>
            <pc:docMk/>
            <pc:sldMk cId="983287386" sldId="265"/>
            <ac:spMk id="12" creationId="{8DD56A06-F557-3080-3BB8-11BE224EEF1E}"/>
          </ac:spMkLst>
        </pc:spChg>
        <pc:spChg chg="del">
          <ac:chgData name="Kim Ji-Eun" userId="5d7677e0d52343ec" providerId="LiveId" clId="{F023BD75-3484-F245-B723-6E8D9C13CED4}" dt="2023-03-22T01:45:07.994" v="1706" actId="478"/>
          <ac:spMkLst>
            <pc:docMk/>
            <pc:sldMk cId="983287386" sldId="265"/>
            <ac:spMk id="13" creationId="{5552F363-2896-5A30-784B-5FD0399C8FD8}"/>
          </ac:spMkLst>
        </pc:spChg>
        <pc:spChg chg="add mod">
          <ac:chgData name="Kim Ji-Eun" userId="5d7677e0d52343ec" providerId="LiveId" clId="{F023BD75-3484-F245-B723-6E8D9C13CED4}" dt="2023-03-22T01:45:08.306" v="1707"/>
          <ac:spMkLst>
            <pc:docMk/>
            <pc:sldMk cId="983287386" sldId="265"/>
            <ac:spMk id="14" creationId="{856BB6FD-65BA-92DE-62C8-3FF4984A289D}"/>
          </ac:spMkLst>
        </pc:spChg>
        <pc:spChg chg="del">
          <ac:chgData name="Kim Ji-Eun" userId="5d7677e0d52343ec" providerId="LiveId" clId="{F023BD75-3484-F245-B723-6E8D9C13CED4}" dt="2023-03-22T01:45:07.994" v="1706" actId="478"/>
          <ac:spMkLst>
            <pc:docMk/>
            <pc:sldMk cId="983287386" sldId="265"/>
            <ac:spMk id="15" creationId="{1F6645AC-900A-D39F-1054-510C80307BB1}"/>
          </ac:spMkLst>
        </pc:spChg>
        <pc:spChg chg="add mod">
          <ac:chgData name="Kim Ji-Eun" userId="5d7677e0d52343ec" providerId="LiveId" clId="{F023BD75-3484-F245-B723-6E8D9C13CED4}" dt="2023-03-22T01:45:08.306" v="1707"/>
          <ac:spMkLst>
            <pc:docMk/>
            <pc:sldMk cId="983287386" sldId="265"/>
            <ac:spMk id="16" creationId="{D6339AC5-2FF5-31CD-E6D0-3D95A72A50B6}"/>
          </ac:spMkLst>
        </pc:spChg>
        <pc:spChg chg="add mod">
          <ac:chgData name="Kim Ji-Eun" userId="5d7677e0d52343ec" providerId="LiveId" clId="{F023BD75-3484-F245-B723-6E8D9C13CED4}" dt="2023-03-22T01:45:08.306" v="1707"/>
          <ac:spMkLst>
            <pc:docMk/>
            <pc:sldMk cId="983287386" sldId="265"/>
            <ac:spMk id="23" creationId="{5F202E4F-9EAE-AC72-5088-E093855F6DB8}"/>
          </ac:spMkLst>
        </pc:spChg>
        <pc:spChg chg="add mod">
          <ac:chgData name="Kim Ji-Eun" userId="5d7677e0d52343ec" providerId="LiveId" clId="{F023BD75-3484-F245-B723-6E8D9C13CED4}" dt="2023-03-22T01:45:08.306" v="1707"/>
          <ac:spMkLst>
            <pc:docMk/>
            <pc:sldMk cId="983287386" sldId="265"/>
            <ac:spMk id="24" creationId="{D9DF6C32-8962-27C8-AE84-529F90DD0210}"/>
          </ac:spMkLst>
        </pc:spChg>
        <pc:spChg chg="add mod">
          <ac:chgData name="Kim Ji-Eun" userId="5d7677e0d52343ec" providerId="LiveId" clId="{F023BD75-3484-F245-B723-6E8D9C13CED4}" dt="2023-03-22T01:45:08.306" v="1707"/>
          <ac:spMkLst>
            <pc:docMk/>
            <pc:sldMk cId="983287386" sldId="265"/>
            <ac:spMk id="26" creationId="{8592F364-1521-38A1-941D-92A707F5F92F}"/>
          </ac:spMkLst>
        </pc:spChg>
        <pc:spChg chg="mod">
          <ac:chgData name="Kim Ji-Eun" userId="5d7677e0d52343ec" providerId="LiveId" clId="{F023BD75-3484-F245-B723-6E8D9C13CED4}" dt="2023-03-22T01:45:08.306" v="1707"/>
          <ac:spMkLst>
            <pc:docMk/>
            <pc:sldMk cId="983287386" sldId="265"/>
            <ac:spMk id="32" creationId="{577279B5-37A3-5325-D1C2-ADB1D0199F54}"/>
          </ac:spMkLst>
        </pc:spChg>
        <pc:spChg chg="mod">
          <ac:chgData name="Kim Ji-Eun" userId="5d7677e0d52343ec" providerId="LiveId" clId="{F023BD75-3484-F245-B723-6E8D9C13CED4}" dt="2023-03-27T07:32:54.599" v="1714" actId="20577"/>
          <ac:spMkLst>
            <pc:docMk/>
            <pc:sldMk cId="983287386" sldId="265"/>
            <ac:spMk id="33" creationId="{3B63B417-C84A-1080-68F2-3A5B79E780D9}"/>
          </ac:spMkLst>
        </pc:spChg>
        <pc:spChg chg="mod">
          <ac:chgData name="Kim Ji-Eun" userId="5d7677e0d52343ec" providerId="LiveId" clId="{F023BD75-3484-F245-B723-6E8D9C13CED4}" dt="2023-03-22T01:45:08.306" v="1707"/>
          <ac:spMkLst>
            <pc:docMk/>
            <pc:sldMk cId="983287386" sldId="265"/>
            <ac:spMk id="34" creationId="{757CA46A-52AC-239B-0AB8-1A4BAEEF569E}"/>
          </ac:spMkLst>
        </pc:spChg>
        <pc:spChg chg="del">
          <ac:chgData name="Kim Ji-Eun" userId="5d7677e0d52343ec" providerId="LiveId" clId="{F023BD75-3484-F245-B723-6E8D9C13CED4}" dt="2023-03-22T01:45:07.994" v="1706" actId="478"/>
          <ac:spMkLst>
            <pc:docMk/>
            <pc:sldMk cId="983287386" sldId="265"/>
            <ac:spMk id="39" creationId="{C27F1F1B-C029-7726-2CC5-434C327E7EBD}"/>
          </ac:spMkLst>
        </pc:spChg>
        <pc:spChg chg="del">
          <ac:chgData name="Kim Ji-Eun" userId="5d7677e0d52343ec" providerId="LiveId" clId="{F023BD75-3484-F245-B723-6E8D9C13CED4}" dt="2023-03-22T01:45:07.994" v="1706" actId="478"/>
          <ac:spMkLst>
            <pc:docMk/>
            <pc:sldMk cId="983287386" sldId="265"/>
            <ac:spMk id="40" creationId="{544CE8E0-48FF-5971-2E95-7F42A3275D1D}"/>
          </ac:spMkLst>
        </pc:spChg>
        <pc:spChg chg="del">
          <ac:chgData name="Kim Ji-Eun" userId="5d7677e0d52343ec" providerId="LiveId" clId="{F023BD75-3484-F245-B723-6E8D9C13CED4}" dt="2023-03-22T01:45:07.994" v="1706" actId="478"/>
          <ac:spMkLst>
            <pc:docMk/>
            <pc:sldMk cId="983287386" sldId="265"/>
            <ac:spMk id="41" creationId="{D003D8D6-26B2-E27C-BC65-34E2415F8E80}"/>
          </ac:spMkLst>
        </pc:spChg>
        <pc:spChg chg="del">
          <ac:chgData name="Kim Ji-Eun" userId="5d7677e0d52343ec" providerId="LiveId" clId="{F023BD75-3484-F245-B723-6E8D9C13CED4}" dt="2023-03-22T01:45:07.994" v="1706" actId="478"/>
          <ac:spMkLst>
            <pc:docMk/>
            <pc:sldMk cId="983287386" sldId="265"/>
            <ac:spMk id="42" creationId="{48E9EE21-03C5-E65A-A79C-4FD74F960621}"/>
          </ac:spMkLst>
        </pc:spChg>
        <pc:spChg chg="del">
          <ac:chgData name="Kim Ji-Eun" userId="5d7677e0d52343ec" providerId="LiveId" clId="{F023BD75-3484-F245-B723-6E8D9C13CED4}" dt="2023-03-22T01:45:07.994" v="1706" actId="478"/>
          <ac:spMkLst>
            <pc:docMk/>
            <pc:sldMk cId="983287386" sldId="265"/>
            <ac:spMk id="43" creationId="{B5E5E835-7E11-8953-97A7-2192DF2EDB63}"/>
          </ac:spMkLst>
        </pc:spChg>
        <pc:spChg chg="del">
          <ac:chgData name="Kim Ji-Eun" userId="5d7677e0d52343ec" providerId="LiveId" clId="{F023BD75-3484-F245-B723-6E8D9C13CED4}" dt="2023-03-22T01:45:07.994" v="1706" actId="478"/>
          <ac:spMkLst>
            <pc:docMk/>
            <pc:sldMk cId="983287386" sldId="265"/>
            <ac:spMk id="44" creationId="{142BD3BD-11A8-8292-E59A-AAEEE8D3A889}"/>
          </ac:spMkLst>
        </pc:spChg>
        <pc:spChg chg="del">
          <ac:chgData name="Kim Ji-Eun" userId="5d7677e0d52343ec" providerId="LiveId" clId="{F023BD75-3484-F245-B723-6E8D9C13CED4}" dt="2023-03-22T01:45:07.994" v="1706" actId="478"/>
          <ac:spMkLst>
            <pc:docMk/>
            <pc:sldMk cId="983287386" sldId="265"/>
            <ac:spMk id="51" creationId="{DBA3CE58-CB09-CF77-45C6-3AE6DD5E1761}"/>
          </ac:spMkLst>
        </pc:spChg>
        <pc:spChg chg="mod">
          <ac:chgData name="Kim Ji-Eun" userId="5d7677e0d52343ec" providerId="LiveId" clId="{F023BD75-3484-F245-B723-6E8D9C13CED4}" dt="2023-03-22T01:45:08.306" v="1707"/>
          <ac:spMkLst>
            <pc:docMk/>
            <pc:sldMk cId="983287386" sldId="265"/>
            <ac:spMk id="53" creationId="{9A91EA5F-8C49-76F0-75FF-C7DEDCE4FA8D}"/>
          </ac:spMkLst>
        </pc:spChg>
        <pc:spChg chg="mod">
          <ac:chgData name="Kim Ji-Eun" userId="5d7677e0d52343ec" providerId="LiveId" clId="{F023BD75-3484-F245-B723-6E8D9C13CED4}" dt="2023-03-22T01:45:08.306" v="1707"/>
          <ac:spMkLst>
            <pc:docMk/>
            <pc:sldMk cId="983287386" sldId="265"/>
            <ac:spMk id="55" creationId="{9DCB9FCD-9569-95A9-A239-363722E5439F}"/>
          </ac:spMkLst>
        </pc:spChg>
        <pc:spChg chg="mod">
          <ac:chgData name="Kim Ji-Eun" userId="5d7677e0d52343ec" providerId="LiveId" clId="{F023BD75-3484-F245-B723-6E8D9C13CED4}" dt="2023-03-22T01:45:08.306" v="1707"/>
          <ac:spMkLst>
            <pc:docMk/>
            <pc:sldMk cId="983287386" sldId="265"/>
            <ac:spMk id="56" creationId="{DA988F40-D1D3-209B-6215-1B7929516C91}"/>
          </ac:spMkLst>
        </pc:spChg>
        <pc:spChg chg="mod">
          <ac:chgData name="Kim Ji-Eun" userId="5d7677e0d52343ec" providerId="LiveId" clId="{F023BD75-3484-F245-B723-6E8D9C13CED4}" dt="2023-03-22T01:45:08.306" v="1707"/>
          <ac:spMkLst>
            <pc:docMk/>
            <pc:sldMk cId="983287386" sldId="265"/>
            <ac:spMk id="57" creationId="{D377F90E-EE41-A86D-FC9D-4E977BE7577B}"/>
          </ac:spMkLst>
        </pc:spChg>
        <pc:spChg chg="add mod">
          <ac:chgData name="Kim Ji-Eun" userId="5d7677e0d52343ec" providerId="LiveId" clId="{F023BD75-3484-F245-B723-6E8D9C13CED4}" dt="2023-03-22T01:45:08.306" v="1707"/>
          <ac:spMkLst>
            <pc:docMk/>
            <pc:sldMk cId="983287386" sldId="265"/>
            <ac:spMk id="58" creationId="{ED0BC03B-65DA-55D2-3278-50669BF0EF8E}"/>
          </ac:spMkLst>
        </pc:spChg>
        <pc:spChg chg="add mod">
          <ac:chgData name="Kim Ji-Eun" userId="5d7677e0d52343ec" providerId="LiveId" clId="{F023BD75-3484-F245-B723-6E8D9C13CED4}" dt="2023-03-22T01:45:08.306" v="1707"/>
          <ac:spMkLst>
            <pc:docMk/>
            <pc:sldMk cId="983287386" sldId="265"/>
            <ac:spMk id="60" creationId="{5EA164A1-F4BA-DB85-1D0E-AB5DE0610D01}"/>
          </ac:spMkLst>
        </pc:spChg>
        <pc:spChg chg="add mod">
          <ac:chgData name="Kim Ji-Eun" userId="5d7677e0d52343ec" providerId="LiveId" clId="{F023BD75-3484-F245-B723-6E8D9C13CED4}" dt="2023-03-22T01:45:08.306" v="1707"/>
          <ac:spMkLst>
            <pc:docMk/>
            <pc:sldMk cId="983287386" sldId="265"/>
            <ac:spMk id="61" creationId="{0E2BC7E4-B780-7482-4CD8-A3A1F687E895}"/>
          </ac:spMkLst>
        </pc:spChg>
        <pc:spChg chg="add mod">
          <ac:chgData name="Kim Ji-Eun" userId="5d7677e0d52343ec" providerId="LiveId" clId="{F023BD75-3484-F245-B723-6E8D9C13CED4}" dt="2023-03-22T01:45:08.306" v="1707"/>
          <ac:spMkLst>
            <pc:docMk/>
            <pc:sldMk cId="983287386" sldId="265"/>
            <ac:spMk id="62" creationId="{9D102A8E-F122-D7A4-8B9C-D33D60817245}"/>
          </ac:spMkLst>
        </pc:spChg>
        <pc:spChg chg="add mod">
          <ac:chgData name="Kim Ji-Eun" userId="5d7677e0d52343ec" providerId="LiveId" clId="{F023BD75-3484-F245-B723-6E8D9C13CED4}" dt="2023-03-22T01:45:08.306" v="1707"/>
          <ac:spMkLst>
            <pc:docMk/>
            <pc:sldMk cId="983287386" sldId="265"/>
            <ac:spMk id="63" creationId="{708852FB-3827-FE2C-69B9-43B41A3ACB66}"/>
          </ac:spMkLst>
        </pc:spChg>
        <pc:spChg chg="add mod">
          <ac:chgData name="Kim Ji-Eun" userId="5d7677e0d52343ec" providerId="LiveId" clId="{F023BD75-3484-F245-B723-6E8D9C13CED4}" dt="2023-03-22T01:45:08.306" v="1707"/>
          <ac:spMkLst>
            <pc:docMk/>
            <pc:sldMk cId="983287386" sldId="265"/>
            <ac:spMk id="64" creationId="{EDE81B2D-A69C-CAF4-5200-825A90F4583E}"/>
          </ac:spMkLst>
        </pc:spChg>
        <pc:spChg chg="add mod">
          <ac:chgData name="Kim Ji-Eun" userId="5d7677e0d52343ec" providerId="LiveId" clId="{F023BD75-3484-F245-B723-6E8D9C13CED4}" dt="2023-03-22T01:45:08.306" v="1707"/>
          <ac:spMkLst>
            <pc:docMk/>
            <pc:sldMk cId="983287386" sldId="265"/>
            <ac:spMk id="65" creationId="{7C9FC455-0044-B245-777E-485276DE9848}"/>
          </ac:spMkLst>
        </pc:spChg>
        <pc:spChg chg="mod">
          <ac:chgData name="Kim Ji-Eun" userId="5d7677e0d52343ec" providerId="LiveId" clId="{F023BD75-3484-F245-B723-6E8D9C13CED4}" dt="2023-03-22T01:45:08.306" v="1707"/>
          <ac:spMkLst>
            <pc:docMk/>
            <pc:sldMk cId="983287386" sldId="265"/>
            <ac:spMk id="67" creationId="{024550C7-81F2-83DC-E61D-6715819C44D1}"/>
          </ac:spMkLst>
        </pc:spChg>
        <pc:spChg chg="mod">
          <ac:chgData name="Kim Ji-Eun" userId="5d7677e0d52343ec" providerId="LiveId" clId="{F023BD75-3484-F245-B723-6E8D9C13CED4}" dt="2023-03-22T01:45:08.306" v="1707"/>
          <ac:spMkLst>
            <pc:docMk/>
            <pc:sldMk cId="983287386" sldId="265"/>
            <ac:spMk id="68" creationId="{86CB97A9-1F57-9E96-F452-22217D6F417D}"/>
          </ac:spMkLst>
        </pc:spChg>
        <pc:spChg chg="mod">
          <ac:chgData name="Kim Ji-Eun" userId="5d7677e0d52343ec" providerId="LiveId" clId="{F023BD75-3484-F245-B723-6E8D9C13CED4}" dt="2023-03-22T01:45:08.306" v="1707"/>
          <ac:spMkLst>
            <pc:docMk/>
            <pc:sldMk cId="983287386" sldId="265"/>
            <ac:spMk id="70" creationId="{9ED714B3-573B-B903-ED41-51E505A492B5}"/>
          </ac:spMkLst>
        </pc:spChg>
        <pc:spChg chg="mod">
          <ac:chgData name="Kim Ji-Eun" userId="5d7677e0d52343ec" providerId="LiveId" clId="{F023BD75-3484-F245-B723-6E8D9C13CED4}" dt="2023-03-22T01:45:08.306" v="1707"/>
          <ac:spMkLst>
            <pc:docMk/>
            <pc:sldMk cId="983287386" sldId="265"/>
            <ac:spMk id="71" creationId="{524AA2A8-F2B8-38F9-C87F-8B0ABC39DDC4}"/>
          </ac:spMkLst>
        </pc:spChg>
        <pc:spChg chg="mod">
          <ac:chgData name="Kim Ji-Eun" userId="5d7677e0d52343ec" providerId="LiveId" clId="{F023BD75-3484-F245-B723-6E8D9C13CED4}" dt="2023-03-22T01:45:08.306" v="1707"/>
          <ac:spMkLst>
            <pc:docMk/>
            <pc:sldMk cId="983287386" sldId="265"/>
            <ac:spMk id="72" creationId="{8E4783CC-B536-8BD8-9ECB-08DCBBB70FFA}"/>
          </ac:spMkLst>
        </pc:spChg>
        <pc:spChg chg="mod">
          <ac:chgData name="Kim Ji-Eun" userId="5d7677e0d52343ec" providerId="LiveId" clId="{F023BD75-3484-F245-B723-6E8D9C13CED4}" dt="2023-03-22T01:45:08.306" v="1707"/>
          <ac:spMkLst>
            <pc:docMk/>
            <pc:sldMk cId="983287386" sldId="265"/>
            <ac:spMk id="79" creationId="{FF3350D7-72FA-8F53-3AB8-8336690F68C3}"/>
          </ac:spMkLst>
        </pc:spChg>
        <pc:spChg chg="mod">
          <ac:chgData name="Kim Ji-Eun" userId="5d7677e0d52343ec" providerId="LiveId" clId="{F023BD75-3484-F245-B723-6E8D9C13CED4}" dt="2023-04-03T04:52:44.654" v="2929" actId="20577"/>
          <ac:spMkLst>
            <pc:docMk/>
            <pc:sldMk cId="983287386" sldId="265"/>
            <ac:spMk id="80" creationId="{A73B1315-DEA4-6DF5-41A3-0DDA9441CF41}"/>
          </ac:spMkLst>
        </pc:spChg>
        <pc:spChg chg="mod">
          <ac:chgData name="Kim Ji-Eun" userId="5d7677e0d52343ec" providerId="LiveId" clId="{F023BD75-3484-F245-B723-6E8D9C13CED4}" dt="2023-03-22T01:45:08.306" v="1707"/>
          <ac:spMkLst>
            <pc:docMk/>
            <pc:sldMk cId="983287386" sldId="265"/>
            <ac:spMk id="81" creationId="{DF73BE1F-0980-AF56-8CE0-3688B177A2BB}"/>
          </ac:spMkLst>
        </pc:spChg>
        <pc:spChg chg="mod">
          <ac:chgData name="Kim Ji-Eun" userId="5d7677e0d52343ec" providerId="LiveId" clId="{F023BD75-3484-F245-B723-6E8D9C13CED4}" dt="2023-04-03T04:52:42.509" v="2927" actId="20577"/>
          <ac:spMkLst>
            <pc:docMk/>
            <pc:sldMk cId="983287386" sldId="265"/>
            <ac:spMk id="82" creationId="{BF7892C8-E9B6-E715-3E80-DFF4A453BEB4}"/>
          </ac:spMkLst>
        </pc:spChg>
        <pc:spChg chg="add mod">
          <ac:chgData name="Kim Ji-Eun" userId="5d7677e0d52343ec" providerId="LiveId" clId="{F023BD75-3484-F245-B723-6E8D9C13CED4}" dt="2023-03-22T01:45:08.306" v="1707"/>
          <ac:spMkLst>
            <pc:docMk/>
            <pc:sldMk cId="983287386" sldId="265"/>
            <ac:spMk id="84" creationId="{CA5E2DB4-F388-BCB6-462A-023DFD79DC0D}"/>
          </ac:spMkLst>
        </pc:spChg>
        <pc:spChg chg="add mod">
          <ac:chgData name="Kim Ji-Eun" userId="5d7677e0d52343ec" providerId="LiveId" clId="{F023BD75-3484-F245-B723-6E8D9C13CED4}" dt="2023-03-22T01:45:08.306" v="1707"/>
          <ac:spMkLst>
            <pc:docMk/>
            <pc:sldMk cId="983287386" sldId="265"/>
            <ac:spMk id="85" creationId="{6B94693B-4435-6CB6-7490-B74AEBB3F18D}"/>
          </ac:spMkLst>
        </pc:spChg>
        <pc:grpChg chg="del">
          <ac:chgData name="Kim Ji-Eun" userId="5d7677e0d52343ec" providerId="LiveId" clId="{F023BD75-3484-F245-B723-6E8D9C13CED4}" dt="2023-03-22T01:45:07.994" v="1706" actId="478"/>
          <ac:grpSpMkLst>
            <pc:docMk/>
            <pc:sldMk cId="983287386" sldId="265"/>
            <ac:grpSpMk id="17" creationId="{27870E2A-FB1C-F905-E530-83018CDD1650}"/>
          </ac:grpSpMkLst>
        </pc:grpChg>
        <pc:grpChg chg="add mod">
          <ac:chgData name="Kim Ji-Eun" userId="5d7677e0d52343ec" providerId="LiveId" clId="{F023BD75-3484-F245-B723-6E8D9C13CED4}" dt="2023-03-22T01:45:08.306" v="1707"/>
          <ac:grpSpMkLst>
            <pc:docMk/>
            <pc:sldMk cId="983287386" sldId="265"/>
            <ac:grpSpMk id="31" creationId="{586EC8C4-6ECD-19F5-1324-8AFE1F0CDDF2}"/>
          </ac:grpSpMkLst>
        </pc:grpChg>
        <pc:grpChg chg="del">
          <ac:chgData name="Kim Ji-Eun" userId="5d7677e0d52343ec" providerId="LiveId" clId="{F023BD75-3484-F245-B723-6E8D9C13CED4}" dt="2023-03-22T01:45:07.994" v="1706" actId="478"/>
          <ac:grpSpMkLst>
            <pc:docMk/>
            <pc:sldMk cId="983287386" sldId="265"/>
            <ac:grpSpMk id="52" creationId="{963BC4E1-7977-F622-EE69-263727366C37}"/>
          </ac:grpSpMkLst>
        </pc:grpChg>
        <pc:grpChg chg="add mod">
          <ac:chgData name="Kim Ji-Eun" userId="5d7677e0d52343ec" providerId="LiveId" clId="{F023BD75-3484-F245-B723-6E8D9C13CED4}" dt="2023-03-22T01:45:08.306" v="1707"/>
          <ac:grpSpMkLst>
            <pc:docMk/>
            <pc:sldMk cId="983287386" sldId="265"/>
            <ac:grpSpMk id="66" creationId="{1212ADAB-9176-0A08-4571-E434F52CF2F5}"/>
          </ac:grpSpMkLst>
        </pc:grpChg>
        <pc:grpChg chg="del">
          <ac:chgData name="Kim Ji-Eun" userId="5d7677e0d52343ec" providerId="LiveId" clId="{F023BD75-3484-F245-B723-6E8D9C13CED4}" dt="2023-03-22T01:45:07.994" v="1706" actId="478"/>
          <ac:grpSpMkLst>
            <pc:docMk/>
            <pc:sldMk cId="983287386" sldId="265"/>
            <ac:grpSpMk id="69" creationId="{9AD93849-269A-BCEF-E075-4EC1792174E8}"/>
          </ac:grpSpMkLst>
        </pc:grpChg>
        <pc:grpChg chg="add mod">
          <ac:chgData name="Kim Ji-Eun" userId="5d7677e0d52343ec" providerId="LiveId" clId="{F023BD75-3484-F245-B723-6E8D9C13CED4}" dt="2023-03-22T01:45:08.306" v="1707"/>
          <ac:grpSpMkLst>
            <pc:docMk/>
            <pc:sldMk cId="983287386" sldId="265"/>
            <ac:grpSpMk id="73" creationId="{32B09B6B-26E8-7F7A-D30C-BDBCA023B924}"/>
          </ac:grpSpMkLst>
        </pc:grpChg>
        <pc:grpChg chg="mod">
          <ac:chgData name="Kim Ji-Eun" userId="5d7677e0d52343ec" providerId="LiveId" clId="{F023BD75-3484-F245-B723-6E8D9C13CED4}" dt="2023-03-22T01:45:08.306" v="1707"/>
          <ac:grpSpMkLst>
            <pc:docMk/>
            <pc:sldMk cId="983287386" sldId="265"/>
            <ac:grpSpMk id="75" creationId="{D518BCFF-9D4F-9E0F-3F3D-EAA37BBD6ABD}"/>
          </ac:grpSpMkLst>
        </pc:grpChg>
        <pc:picChg chg="del">
          <ac:chgData name="Kim Ji-Eun" userId="5d7677e0d52343ec" providerId="LiveId" clId="{F023BD75-3484-F245-B723-6E8D9C13CED4}" dt="2023-03-22T01:45:07.994" v="1706" actId="478"/>
          <ac:picMkLst>
            <pc:docMk/>
            <pc:sldMk cId="983287386" sldId="265"/>
            <ac:picMk id="35" creationId="{CDCEA89D-D276-6A2C-AF15-A1B5B50913A4}"/>
          </ac:picMkLst>
        </pc:picChg>
        <pc:picChg chg="del">
          <ac:chgData name="Kim Ji-Eun" userId="5d7677e0d52343ec" providerId="LiveId" clId="{F023BD75-3484-F245-B723-6E8D9C13CED4}" dt="2023-03-22T01:45:07.994" v="1706" actId="478"/>
          <ac:picMkLst>
            <pc:docMk/>
            <pc:sldMk cId="983287386" sldId="265"/>
            <ac:picMk id="37" creationId="{FEB171B1-C44E-07C8-40E6-D2F69B60E073}"/>
          </ac:picMkLst>
        </pc:picChg>
        <pc:picChg chg="add mod">
          <ac:chgData name="Kim Ji-Eun" userId="5d7677e0d52343ec" providerId="LiveId" clId="{F023BD75-3484-F245-B723-6E8D9C13CED4}" dt="2023-03-22T01:45:08.306" v="1707"/>
          <ac:picMkLst>
            <pc:docMk/>
            <pc:sldMk cId="983287386" sldId="265"/>
            <ac:picMk id="59" creationId="{617845C3-EFF0-3487-6C98-922A9BEFC61C}"/>
          </ac:picMkLst>
        </pc:picChg>
        <pc:picChg chg="mod">
          <ac:chgData name="Kim Ji-Eun" userId="5d7677e0d52343ec" providerId="LiveId" clId="{F023BD75-3484-F245-B723-6E8D9C13CED4}" dt="2023-03-22T01:45:08.306" v="1707"/>
          <ac:picMkLst>
            <pc:docMk/>
            <pc:sldMk cId="983287386" sldId="265"/>
            <ac:picMk id="74" creationId="{98AABFE6-A017-8245-4991-9ED9F38E76FC}"/>
          </ac:picMkLst>
        </pc:picChg>
        <pc:picChg chg="mod">
          <ac:chgData name="Kim Ji-Eun" userId="5d7677e0d52343ec" providerId="LiveId" clId="{F023BD75-3484-F245-B723-6E8D9C13CED4}" dt="2023-03-22T01:45:08.306" v="1707"/>
          <ac:picMkLst>
            <pc:docMk/>
            <pc:sldMk cId="983287386" sldId="265"/>
            <ac:picMk id="76" creationId="{919E9B3C-DD5E-7528-EC66-1B6123B0DC35}"/>
          </ac:picMkLst>
        </pc:picChg>
        <pc:picChg chg="mod">
          <ac:chgData name="Kim Ji-Eun" userId="5d7677e0d52343ec" providerId="LiveId" clId="{F023BD75-3484-F245-B723-6E8D9C13CED4}" dt="2023-03-22T01:45:08.306" v="1707"/>
          <ac:picMkLst>
            <pc:docMk/>
            <pc:sldMk cId="983287386" sldId="265"/>
            <ac:picMk id="77" creationId="{A0870D54-1166-A392-E39D-45C66A3B98DA}"/>
          </ac:picMkLst>
        </pc:picChg>
        <pc:picChg chg="mod">
          <ac:chgData name="Kim Ji-Eun" userId="5d7677e0d52343ec" providerId="LiveId" clId="{F023BD75-3484-F245-B723-6E8D9C13CED4}" dt="2023-03-22T01:45:08.306" v="1707"/>
          <ac:picMkLst>
            <pc:docMk/>
            <pc:sldMk cId="983287386" sldId="265"/>
            <ac:picMk id="78" creationId="{B3DFE087-030E-809E-CE03-1521B1541A84}"/>
          </ac:picMkLst>
        </pc:picChg>
        <pc:picChg chg="add mod">
          <ac:chgData name="Kim Ji-Eun" userId="5d7677e0d52343ec" providerId="LiveId" clId="{F023BD75-3484-F245-B723-6E8D9C13CED4}" dt="2023-03-22T01:45:08.306" v="1707"/>
          <ac:picMkLst>
            <pc:docMk/>
            <pc:sldMk cId="983287386" sldId="265"/>
            <ac:picMk id="86" creationId="{C151BC78-E0E0-8019-19AD-57349490713D}"/>
          </ac:picMkLst>
        </pc:picChg>
      </pc:sldChg>
      <pc:sldChg chg="addSp delSp modSp mod">
        <pc:chgData name="Kim Ji-Eun" userId="5d7677e0d52343ec" providerId="LiveId" clId="{F023BD75-3484-F245-B723-6E8D9C13CED4}" dt="2023-04-03T04:56:19.331" v="3038" actId="1037"/>
        <pc:sldMkLst>
          <pc:docMk/>
          <pc:sldMk cId="4031803587" sldId="266"/>
        </pc:sldMkLst>
        <pc:spChg chg="mod">
          <ac:chgData name="Kim Ji-Eun" userId="5d7677e0d52343ec" providerId="LiveId" clId="{F023BD75-3484-F245-B723-6E8D9C13CED4}" dt="2023-04-03T04:55:05.081" v="3003" actId="20577"/>
          <ac:spMkLst>
            <pc:docMk/>
            <pc:sldMk cId="4031803587" sldId="266"/>
            <ac:spMk id="11" creationId="{082DD465-D69E-DA9B-588F-9BAD1CF9DE55}"/>
          </ac:spMkLst>
        </pc:spChg>
        <pc:spChg chg="mod">
          <ac:chgData name="Kim Ji-Eun" userId="5d7677e0d52343ec" providerId="LiveId" clId="{F023BD75-3484-F245-B723-6E8D9C13CED4}" dt="2023-04-03T04:55:00.974" v="3000" actId="20577"/>
          <ac:spMkLst>
            <pc:docMk/>
            <pc:sldMk cId="4031803587" sldId="266"/>
            <ac:spMk id="12" creationId="{B077927E-6F17-9D74-A515-CDA598E7028A}"/>
          </ac:spMkLst>
        </pc:spChg>
        <pc:spChg chg="add mod">
          <ac:chgData name="Kim Ji-Eun" userId="5d7677e0d52343ec" providerId="LiveId" clId="{F023BD75-3484-F245-B723-6E8D9C13CED4}" dt="2023-03-22T01:42:30.706" v="1701" actId="1037"/>
          <ac:spMkLst>
            <pc:docMk/>
            <pc:sldMk cId="4031803587" sldId="266"/>
            <ac:spMk id="32" creationId="{2DE1BE53-429A-FEFD-8FC6-502F70081E05}"/>
          </ac:spMkLst>
        </pc:spChg>
        <pc:spChg chg="mod">
          <ac:chgData name="Kim Ji-Eun" userId="5d7677e0d52343ec" providerId="LiveId" clId="{F023BD75-3484-F245-B723-6E8D9C13CED4}" dt="2023-03-22T01:42:23.647" v="1698"/>
          <ac:spMkLst>
            <pc:docMk/>
            <pc:sldMk cId="4031803587" sldId="266"/>
            <ac:spMk id="64" creationId="{3F19A19D-1BE8-DD22-3FE8-83C203ECD5A6}"/>
          </ac:spMkLst>
        </pc:spChg>
        <pc:spChg chg="mod">
          <ac:chgData name="Kim Ji-Eun" userId="5d7677e0d52343ec" providerId="LiveId" clId="{F023BD75-3484-F245-B723-6E8D9C13CED4}" dt="2023-03-22T01:42:23.647" v="1698"/>
          <ac:spMkLst>
            <pc:docMk/>
            <pc:sldMk cId="4031803587" sldId="266"/>
            <ac:spMk id="81" creationId="{A99B5117-F058-1F3C-D347-2C4B4DBB22E2}"/>
          </ac:spMkLst>
        </pc:spChg>
        <pc:spChg chg="mod">
          <ac:chgData name="Kim Ji-Eun" userId="5d7677e0d52343ec" providerId="LiveId" clId="{F023BD75-3484-F245-B723-6E8D9C13CED4}" dt="2023-03-22T01:42:23.647" v="1698"/>
          <ac:spMkLst>
            <pc:docMk/>
            <pc:sldMk cId="4031803587" sldId="266"/>
            <ac:spMk id="82" creationId="{22E87E85-0DD1-8D36-B33D-255692A0EF81}"/>
          </ac:spMkLst>
        </pc:spChg>
        <pc:spChg chg="mod">
          <ac:chgData name="Kim Ji-Eun" userId="5d7677e0d52343ec" providerId="LiveId" clId="{F023BD75-3484-F245-B723-6E8D9C13CED4}" dt="2023-03-22T01:42:23.647" v="1698"/>
          <ac:spMkLst>
            <pc:docMk/>
            <pc:sldMk cId="4031803587" sldId="266"/>
            <ac:spMk id="96" creationId="{E96852D8-ECD8-CA69-7AF5-751F321B7C53}"/>
          </ac:spMkLst>
        </pc:spChg>
        <pc:spChg chg="mod">
          <ac:chgData name="Kim Ji-Eun" userId="5d7677e0d52343ec" providerId="LiveId" clId="{F023BD75-3484-F245-B723-6E8D9C13CED4}" dt="2023-03-22T01:42:23.647" v="1698"/>
          <ac:spMkLst>
            <pc:docMk/>
            <pc:sldMk cId="4031803587" sldId="266"/>
            <ac:spMk id="103" creationId="{98A8B90F-57A7-300D-F4E7-E955162A1A26}"/>
          </ac:spMkLst>
        </pc:spChg>
        <pc:spChg chg="mod">
          <ac:chgData name="Kim Ji-Eun" userId="5d7677e0d52343ec" providerId="LiveId" clId="{F023BD75-3484-F245-B723-6E8D9C13CED4}" dt="2023-04-03T04:55:42.028" v="3012" actId="20577"/>
          <ac:spMkLst>
            <pc:docMk/>
            <pc:sldMk cId="4031803587" sldId="266"/>
            <ac:spMk id="113" creationId="{8AF3F12E-56DE-937E-08F0-ED1B984D95EC}"/>
          </ac:spMkLst>
        </pc:spChg>
        <pc:spChg chg="mod">
          <ac:chgData name="Kim Ji-Eun" userId="5d7677e0d52343ec" providerId="LiveId" clId="{F023BD75-3484-F245-B723-6E8D9C13CED4}" dt="2023-04-03T04:55:45.457" v="3013" actId="20577"/>
          <ac:spMkLst>
            <pc:docMk/>
            <pc:sldMk cId="4031803587" sldId="266"/>
            <ac:spMk id="117" creationId="{B06CA1D3-609E-C183-0983-88AAE91E5620}"/>
          </ac:spMkLst>
        </pc:spChg>
        <pc:spChg chg="mod">
          <ac:chgData name="Kim Ji-Eun" userId="5d7677e0d52343ec" providerId="LiveId" clId="{F023BD75-3484-F245-B723-6E8D9C13CED4}" dt="2023-03-22T01:42:23.647" v="1698"/>
          <ac:spMkLst>
            <pc:docMk/>
            <pc:sldMk cId="4031803587" sldId="266"/>
            <ac:spMk id="119" creationId="{727DACF5-F7D0-A782-E33D-695C2E36E5AB}"/>
          </ac:spMkLst>
        </pc:spChg>
        <pc:spChg chg="mod">
          <ac:chgData name="Kim Ji-Eun" userId="5d7677e0d52343ec" providerId="LiveId" clId="{F023BD75-3484-F245-B723-6E8D9C13CED4}" dt="2023-04-03T04:54:46.426" v="2991" actId="20577"/>
          <ac:spMkLst>
            <pc:docMk/>
            <pc:sldMk cId="4031803587" sldId="266"/>
            <ac:spMk id="141" creationId="{B084F296-2319-7423-C58D-460B3D555F76}"/>
          </ac:spMkLst>
        </pc:spChg>
        <pc:spChg chg="mod">
          <ac:chgData name="Kim Ji-Eun" userId="5d7677e0d52343ec" providerId="LiveId" clId="{F023BD75-3484-F245-B723-6E8D9C13CED4}" dt="2023-04-03T04:54:42.645" v="2988" actId="20577"/>
          <ac:spMkLst>
            <pc:docMk/>
            <pc:sldMk cId="4031803587" sldId="266"/>
            <ac:spMk id="142" creationId="{EF6D6D81-31C7-7B6C-8EB0-4C3D2A563BB3}"/>
          </ac:spMkLst>
        </pc:spChg>
        <pc:spChg chg="mod">
          <ac:chgData name="Kim Ji-Eun" userId="5d7677e0d52343ec" providerId="LiveId" clId="{F023BD75-3484-F245-B723-6E8D9C13CED4}" dt="2023-04-03T04:54:50.772" v="2994" actId="20577"/>
          <ac:spMkLst>
            <pc:docMk/>
            <pc:sldMk cId="4031803587" sldId="266"/>
            <ac:spMk id="144" creationId="{E6DBE705-92A0-97CD-649F-9B88D93C27C8}"/>
          </ac:spMkLst>
        </pc:spChg>
        <pc:spChg chg="mod">
          <ac:chgData name="Kim Ji-Eun" userId="5d7677e0d52343ec" providerId="LiveId" clId="{F023BD75-3484-F245-B723-6E8D9C13CED4}" dt="2023-04-03T04:54:55.217" v="2997" actId="20577"/>
          <ac:spMkLst>
            <pc:docMk/>
            <pc:sldMk cId="4031803587" sldId="266"/>
            <ac:spMk id="145" creationId="{9ACC509F-422E-61EF-F6A4-391C2B9518DD}"/>
          </ac:spMkLst>
        </pc:spChg>
        <pc:spChg chg="mod">
          <ac:chgData name="Kim Ji-Eun" userId="5d7677e0d52343ec" providerId="LiveId" clId="{F023BD75-3484-F245-B723-6E8D9C13CED4}" dt="2023-04-03T04:55:54.904" v="3016" actId="20577"/>
          <ac:spMkLst>
            <pc:docMk/>
            <pc:sldMk cId="4031803587" sldId="266"/>
            <ac:spMk id="165" creationId="{B2B37D07-2AC3-CB82-FF8C-24CC2EF3A9CD}"/>
          </ac:spMkLst>
        </pc:spChg>
        <pc:spChg chg="mod">
          <ac:chgData name="Kim Ji-Eun" userId="5d7677e0d52343ec" providerId="LiveId" clId="{F023BD75-3484-F245-B723-6E8D9C13CED4}" dt="2023-04-03T04:56:02.919" v="3021" actId="20577"/>
          <ac:spMkLst>
            <pc:docMk/>
            <pc:sldMk cId="4031803587" sldId="266"/>
            <ac:spMk id="166" creationId="{EC55F626-E6CA-DEDC-E6CA-8EDC2E3EEF7F}"/>
          </ac:spMkLst>
        </pc:spChg>
        <pc:spChg chg="mod">
          <ac:chgData name="Kim Ji-Eun" userId="5d7677e0d52343ec" providerId="LiveId" clId="{F023BD75-3484-F245-B723-6E8D9C13CED4}" dt="2023-04-03T04:56:06.160" v="3024" actId="20577"/>
          <ac:spMkLst>
            <pc:docMk/>
            <pc:sldMk cId="4031803587" sldId="266"/>
            <ac:spMk id="168" creationId="{D04BFE93-22D1-3AD6-B335-5DA06987295D}"/>
          </ac:spMkLst>
        </pc:spChg>
        <pc:spChg chg="mod">
          <ac:chgData name="Kim Ji-Eun" userId="5d7677e0d52343ec" providerId="LiveId" clId="{F023BD75-3484-F245-B723-6E8D9C13CED4}" dt="2023-04-03T04:56:12.268" v="3029" actId="20577"/>
          <ac:spMkLst>
            <pc:docMk/>
            <pc:sldMk cId="4031803587" sldId="266"/>
            <ac:spMk id="169" creationId="{C23F1C9C-9333-367F-48D7-0FF3AF5C33BC}"/>
          </ac:spMkLst>
        </pc:spChg>
        <pc:spChg chg="mod">
          <ac:chgData name="Kim Ji-Eun" userId="5d7677e0d52343ec" providerId="LiveId" clId="{F023BD75-3484-F245-B723-6E8D9C13CED4}" dt="2023-04-03T04:55:16.295" v="3008" actId="20577"/>
          <ac:spMkLst>
            <pc:docMk/>
            <pc:sldMk cId="4031803587" sldId="266"/>
            <ac:spMk id="236" creationId="{914904BC-6DB6-CB3A-F4E6-6E3883BA0BB6}"/>
          </ac:spMkLst>
        </pc:spChg>
        <pc:spChg chg="mod">
          <ac:chgData name="Kim Ji-Eun" userId="5d7677e0d52343ec" providerId="LiveId" clId="{F023BD75-3484-F245-B723-6E8D9C13CED4}" dt="2023-04-03T04:55:38.977" v="3011" actId="20577"/>
          <ac:spMkLst>
            <pc:docMk/>
            <pc:sldMk cId="4031803587" sldId="266"/>
            <ac:spMk id="237" creationId="{645F9645-8602-F9DE-41D0-139E032F86A8}"/>
          </ac:spMkLst>
        </pc:spChg>
        <pc:grpChg chg="add mod">
          <ac:chgData name="Kim Ji-Eun" userId="5d7677e0d52343ec" providerId="LiveId" clId="{F023BD75-3484-F245-B723-6E8D9C13CED4}" dt="2023-03-22T01:42:30.706" v="1701" actId="1037"/>
          <ac:grpSpMkLst>
            <pc:docMk/>
            <pc:sldMk cId="4031803587" sldId="266"/>
            <ac:grpSpMk id="58" creationId="{BDC3E383-11A3-0A8A-5EE7-A5899AE1771C}"/>
          </ac:grpSpMkLst>
        </pc:grpChg>
        <pc:grpChg chg="add mod">
          <ac:chgData name="Kim Ji-Eun" userId="5d7677e0d52343ec" providerId="LiveId" clId="{F023BD75-3484-F245-B723-6E8D9C13CED4}" dt="2023-03-22T01:42:30.706" v="1701" actId="1037"/>
          <ac:grpSpMkLst>
            <pc:docMk/>
            <pc:sldMk cId="4031803587" sldId="266"/>
            <ac:grpSpMk id="100" creationId="{7A86F150-0EFF-DABC-3220-049213B189CE}"/>
          </ac:grpSpMkLst>
        </pc:grpChg>
        <pc:grpChg chg="del">
          <ac:chgData name="Kim Ji-Eun" userId="5d7677e0d52343ec" providerId="LiveId" clId="{F023BD75-3484-F245-B723-6E8D9C13CED4}" dt="2023-03-22T01:42:19.073" v="1697" actId="478"/>
          <ac:grpSpMkLst>
            <pc:docMk/>
            <pc:sldMk cId="4031803587" sldId="266"/>
            <ac:grpSpMk id="225" creationId="{13D800C2-0DF2-6916-AF35-C6978BE93D84}"/>
          </ac:grpSpMkLst>
        </pc:grpChg>
        <pc:grpChg chg="mod">
          <ac:chgData name="Kim Ji-Eun" userId="5d7677e0d52343ec" providerId="LiveId" clId="{F023BD75-3484-F245-B723-6E8D9C13CED4}" dt="2023-04-03T04:56:19.331" v="3038" actId="1037"/>
          <ac:grpSpMkLst>
            <pc:docMk/>
            <pc:sldMk cId="4031803587" sldId="266"/>
            <ac:grpSpMk id="231" creationId="{2F771142-133F-C45D-69C7-A8931A30D152}"/>
          </ac:grpSpMkLst>
        </pc:grpChg>
        <pc:picChg chg="add mod">
          <ac:chgData name="Kim Ji-Eun" userId="5d7677e0d52343ec" providerId="LiveId" clId="{F023BD75-3484-F245-B723-6E8D9C13CED4}" dt="2023-03-22T01:42:30.706" v="1701" actId="1037"/>
          <ac:picMkLst>
            <pc:docMk/>
            <pc:sldMk cId="4031803587" sldId="266"/>
            <ac:picMk id="120" creationId="{98EA960F-770A-507B-464E-1FD14780B4A7}"/>
          </ac:picMkLst>
        </pc:picChg>
        <pc:cxnChg chg="mod">
          <ac:chgData name="Kim Ji-Eun" userId="5d7677e0d52343ec" providerId="LiveId" clId="{F023BD75-3484-F245-B723-6E8D9C13CED4}" dt="2023-03-22T01:42:23.647" v="1698"/>
          <ac:cxnSpMkLst>
            <pc:docMk/>
            <pc:sldMk cId="4031803587" sldId="266"/>
            <ac:cxnSpMk id="118" creationId="{2365A094-0961-B249-7676-4FF6CEC5D017}"/>
          </ac:cxnSpMkLst>
        </pc:cxnChg>
      </pc:sldChg>
      <pc:sldChg chg="addSp delSp modSp del mod">
        <pc:chgData name="Kim Ji-Eun" userId="5d7677e0d52343ec" providerId="LiveId" clId="{F023BD75-3484-F245-B723-6E8D9C13CED4}" dt="2023-03-27T08:23:26.778" v="1764" actId="2696"/>
        <pc:sldMkLst>
          <pc:docMk/>
          <pc:sldMk cId="2545416559" sldId="267"/>
        </pc:sldMkLst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9" creationId="{CFA9E59A-4EDB-7665-06B5-CE4336A77774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10" creationId="{798B790C-1DBE-DAF8-508F-55F2643C5CD7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11" creationId="{250A4BC8-CE7D-31A6-7D92-B6182FED156C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13" creationId="{2948BAF0-3175-8E9E-00EC-281D60D4AE43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14" creationId="{C1D74C99-894B-08AE-FEEE-80C6CFDA7358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15" creationId="{4FF3E31B-2566-E621-5279-42A94E1B406F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16" creationId="{16C527B0-1095-0178-EFA2-AE4961AC03AF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17" creationId="{8E6874CE-4A3D-2A67-12BF-E2F38744C336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18" creationId="{81BE8DDF-5664-CE8E-E8F8-2D836B4144B7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19" creationId="{29B12B82-340A-5586-CF42-E640D0291026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20" creationId="{072B022B-3F85-EBCF-1066-CD4E427459FE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21" creationId="{2F31A1B8-0399-096A-3F62-43F866E279B9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22" creationId="{8E7CEA67-B237-029C-0ACB-6F3F09762964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23" creationId="{8CAFEF5B-8A97-2A1D-7A51-AA702297EC3F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24" creationId="{DF6AEB7D-F806-A2B5-97A7-64A1773C251C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25" creationId="{E4273477-902A-853B-5A2D-9DCA99C9D328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26" creationId="{639F8E87-D3D9-4EB2-57CE-198ABB05A9F8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27" creationId="{5FEB9D19-F1AD-1A70-6FCB-31AF76EA05A6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28" creationId="{C79BFBD9-1D07-E3B7-4EF8-C03287DF410E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29" creationId="{5B795411-D96A-A617-0A1B-00310A443607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30" creationId="{58C73145-A837-355A-C3B8-7592FD9A2513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31" creationId="{0B21C6B8-F4B6-8934-6021-23F1E4EB8203}"/>
          </ac:spMkLst>
        </pc:spChg>
        <pc:spChg chg="add del mod">
          <ac:chgData name="Kim Ji-Eun" userId="5d7677e0d52343ec" providerId="LiveId" clId="{F023BD75-3484-F245-B723-6E8D9C13CED4}" dt="2023-03-21T05:51:47.858" v="965" actId="21"/>
          <ac:spMkLst>
            <pc:docMk/>
            <pc:sldMk cId="2545416559" sldId="267"/>
            <ac:spMk id="33" creationId="{6C19A4C7-423E-9119-78B2-9A1B549B8F2F}"/>
          </ac:spMkLst>
        </pc:spChg>
        <pc:spChg chg="add del mod">
          <ac:chgData name="Kim Ji-Eun" userId="5d7677e0d52343ec" providerId="LiveId" clId="{F023BD75-3484-F245-B723-6E8D9C13CED4}" dt="2023-03-21T05:51:47.858" v="965" actId="21"/>
          <ac:spMkLst>
            <pc:docMk/>
            <pc:sldMk cId="2545416559" sldId="267"/>
            <ac:spMk id="34" creationId="{A4D73CCF-C54E-B29E-EA60-EED16787A29E}"/>
          </ac:spMkLst>
        </pc:spChg>
        <pc:spChg chg="add del mod">
          <ac:chgData name="Kim Ji-Eun" userId="5d7677e0d52343ec" providerId="LiveId" clId="{F023BD75-3484-F245-B723-6E8D9C13CED4}" dt="2023-03-21T05:51:47.858" v="965" actId="21"/>
          <ac:spMkLst>
            <pc:docMk/>
            <pc:sldMk cId="2545416559" sldId="267"/>
            <ac:spMk id="39" creationId="{62076498-80E9-21FF-3BFC-AB3C75AA2FA1}"/>
          </ac:spMkLst>
        </pc:spChg>
        <pc:spChg chg="add del mod">
          <ac:chgData name="Kim Ji-Eun" userId="5d7677e0d52343ec" providerId="LiveId" clId="{F023BD75-3484-F245-B723-6E8D9C13CED4}" dt="2023-03-21T05:51:47.858" v="965" actId="21"/>
          <ac:spMkLst>
            <pc:docMk/>
            <pc:sldMk cId="2545416559" sldId="267"/>
            <ac:spMk id="40" creationId="{FD9F392D-B25B-0FE3-7D5D-F6A039A662DD}"/>
          </ac:spMkLst>
        </pc:spChg>
        <pc:spChg chg="add del mod">
          <ac:chgData name="Kim Ji-Eun" userId="5d7677e0d52343ec" providerId="LiveId" clId="{F023BD75-3484-F245-B723-6E8D9C13CED4}" dt="2023-03-21T05:51:47.858" v="965" actId="21"/>
          <ac:spMkLst>
            <pc:docMk/>
            <pc:sldMk cId="2545416559" sldId="267"/>
            <ac:spMk id="41" creationId="{A223324F-7562-6A78-5E0D-44B0FF9D92CD}"/>
          </ac:spMkLst>
        </pc:spChg>
        <pc:spChg chg="add del mod">
          <ac:chgData name="Kim Ji-Eun" userId="5d7677e0d52343ec" providerId="LiveId" clId="{F023BD75-3484-F245-B723-6E8D9C13CED4}" dt="2023-03-21T05:51:47.858" v="965" actId="21"/>
          <ac:spMkLst>
            <pc:docMk/>
            <pc:sldMk cId="2545416559" sldId="267"/>
            <ac:spMk id="42" creationId="{A131E23D-EF21-8CCB-69BA-C60B84ACDBB8}"/>
          </ac:spMkLst>
        </pc:spChg>
        <pc:spChg chg="mod">
          <ac:chgData name="Kim Ji-Eun" userId="5d7677e0d52343ec" providerId="LiveId" clId="{F023BD75-3484-F245-B723-6E8D9C13CED4}" dt="2023-03-21T05:51:37.749" v="964"/>
          <ac:spMkLst>
            <pc:docMk/>
            <pc:sldMk cId="2545416559" sldId="267"/>
            <ac:spMk id="49" creationId="{E2611E67-E4E9-1946-964C-AFC8E5EB6AD8}"/>
          </ac:spMkLst>
        </pc:spChg>
        <pc:spChg chg="mod">
          <ac:chgData name="Kim Ji-Eun" userId="5d7677e0d52343ec" providerId="LiveId" clId="{F023BD75-3484-F245-B723-6E8D9C13CED4}" dt="2023-03-21T05:51:37.749" v="964"/>
          <ac:spMkLst>
            <pc:docMk/>
            <pc:sldMk cId="2545416559" sldId="267"/>
            <ac:spMk id="50" creationId="{376ED455-07DB-8645-894E-7C91BB5E4276}"/>
          </ac:spMkLst>
        </pc:spChg>
        <pc:spChg chg="mod">
          <ac:chgData name="Kim Ji-Eun" userId="5d7677e0d52343ec" providerId="LiveId" clId="{F023BD75-3484-F245-B723-6E8D9C13CED4}" dt="2023-03-21T05:51:37.749" v="964"/>
          <ac:spMkLst>
            <pc:docMk/>
            <pc:sldMk cId="2545416559" sldId="267"/>
            <ac:spMk id="51" creationId="{FCCF7265-8CEC-3AA4-6A2B-B6B68B33A5DA}"/>
          </ac:spMkLst>
        </pc:spChg>
        <pc:spChg chg="mod">
          <ac:chgData name="Kim Ji-Eun" userId="5d7677e0d52343ec" providerId="LiveId" clId="{F023BD75-3484-F245-B723-6E8D9C13CED4}" dt="2023-03-21T05:51:37.749" v="964"/>
          <ac:spMkLst>
            <pc:docMk/>
            <pc:sldMk cId="2545416559" sldId="267"/>
            <ac:spMk id="52" creationId="{365177C8-0DF2-EAAC-DA50-9AF5DAB89E63}"/>
          </ac:spMkLst>
        </pc:spChg>
        <pc:spChg chg="mod">
          <ac:chgData name="Kim Ji-Eun" userId="5d7677e0d52343ec" providerId="LiveId" clId="{F023BD75-3484-F245-B723-6E8D9C13CED4}" dt="2023-03-21T05:51:37.749" v="964"/>
          <ac:spMkLst>
            <pc:docMk/>
            <pc:sldMk cId="2545416559" sldId="267"/>
            <ac:spMk id="53" creationId="{BD93E96F-FDA2-DEFE-08DD-DC655BE9447E}"/>
          </ac:spMkLst>
        </pc:spChg>
        <pc:spChg chg="mod">
          <ac:chgData name="Kim Ji-Eun" userId="5d7677e0d52343ec" providerId="LiveId" clId="{F023BD75-3484-F245-B723-6E8D9C13CED4}" dt="2023-03-21T05:51:37.749" v="964"/>
          <ac:spMkLst>
            <pc:docMk/>
            <pc:sldMk cId="2545416559" sldId="267"/>
            <ac:spMk id="54" creationId="{CD70FE14-3CAF-3726-3E5C-D49545041A30}"/>
          </ac:spMkLst>
        </pc:spChg>
        <pc:spChg chg="mod">
          <ac:chgData name="Kim Ji-Eun" userId="5d7677e0d52343ec" providerId="LiveId" clId="{F023BD75-3484-F245-B723-6E8D9C13CED4}" dt="2023-03-21T05:51:37.749" v="964"/>
          <ac:spMkLst>
            <pc:docMk/>
            <pc:sldMk cId="2545416559" sldId="267"/>
            <ac:spMk id="55" creationId="{030ABE12-2A7D-D9DF-34A4-9EC776656FAC}"/>
          </ac:spMkLst>
        </pc:spChg>
        <pc:spChg chg="mod">
          <ac:chgData name="Kim Ji-Eun" userId="5d7677e0d52343ec" providerId="LiveId" clId="{F023BD75-3484-F245-B723-6E8D9C13CED4}" dt="2023-03-21T05:51:37.749" v="964"/>
          <ac:spMkLst>
            <pc:docMk/>
            <pc:sldMk cId="2545416559" sldId="267"/>
            <ac:spMk id="56" creationId="{FAA6D889-5FF7-C45D-1D58-93D8275275B0}"/>
          </ac:spMkLst>
        </pc:spChg>
        <pc:spChg chg="mod">
          <ac:chgData name="Kim Ji-Eun" userId="5d7677e0d52343ec" providerId="LiveId" clId="{F023BD75-3484-F245-B723-6E8D9C13CED4}" dt="2023-03-21T05:51:37.749" v="964"/>
          <ac:spMkLst>
            <pc:docMk/>
            <pc:sldMk cId="2545416559" sldId="267"/>
            <ac:spMk id="57" creationId="{6FDAFAC6-3912-BC9D-F21A-B0199F179FB2}"/>
          </ac:spMkLst>
        </pc:spChg>
        <pc:spChg chg="mod">
          <ac:chgData name="Kim Ji-Eun" userId="5d7677e0d52343ec" providerId="LiveId" clId="{F023BD75-3484-F245-B723-6E8D9C13CED4}" dt="2023-03-21T05:51:37.749" v="964"/>
          <ac:spMkLst>
            <pc:docMk/>
            <pc:sldMk cId="2545416559" sldId="267"/>
            <ac:spMk id="58" creationId="{21697EC7-ED6A-4EB3-D1E1-E3BD82C795B0}"/>
          </ac:spMkLst>
        </pc:spChg>
        <pc:spChg chg="mod">
          <ac:chgData name="Kim Ji-Eun" userId="5d7677e0d52343ec" providerId="LiveId" clId="{F023BD75-3484-F245-B723-6E8D9C13CED4}" dt="2023-03-21T05:51:37.749" v="964"/>
          <ac:spMkLst>
            <pc:docMk/>
            <pc:sldMk cId="2545416559" sldId="267"/>
            <ac:spMk id="59" creationId="{E5462CDB-8E61-6B8C-3211-2E2819990F8C}"/>
          </ac:spMkLst>
        </pc:spChg>
        <pc:spChg chg="mod">
          <ac:chgData name="Kim Ji-Eun" userId="5d7677e0d52343ec" providerId="LiveId" clId="{F023BD75-3484-F245-B723-6E8D9C13CED4}" dt="2023-03-21T05:51:37.749" v="964"/>
          <ac:spMkLst>
            <pc:docMk/>
            <pc:sldMk cId="2545416559" sldId="267"/>
            <ac:spMk id="60" creationId="{471CDA72-238F-BF6C-03C1-74A1F4B0E721}"/>
          </ac:spMkLst>
        </pc:spChg>
        <pc:spChg chg="mod">
          <ac:chgData name="Kim Ji-Eun" userId="5d7677e0d52343ec" providerId="LiveId" clId="{F023BD75-3484-F245-B723-6E8D9C13CED4}" dt="2023-03-21T05:51:37.749" v="964"/>
          <ac:spMkLst>
            <pc:docMk/>
            <pc:sldMk cId="2545416559" sldId="267"/>
            <ac:spMk id="61" creationId="{47A8A2AF-F718-75EE-489A-679EEB209C73}"/>
          </ac:spMkLst>
        </pc:spChg>
        <pc:spChg chg="mod">
          <ac:chgData name="Kim Ji-Eun" userId="5d7677e0d52343ec" providerId="LiveId" clId="{F023BD75-3484-F245-B723-6E8D9C13CED4}" dt="2023-03-21T05:51:37.749" v="964"/>
          <ac:spMkLst>
            <pc:docMk/>
            <pc:sldMk cId="2545416559" sldId="267"/>
            <ac:spMk id="62" creationId="{68009BCC-FFAD-2C49-005A-DFA1F35364DF}"/>
          </ac:spMkLst>
        </pc:spChg>
        <pc:spChg chg="mod">
          <ac:chgData name="Kim Ji-Eun" userId="5d7677e0d52343ec" providerId="LiveId" clId="{F023BD75-3484-F245-B723-6E8D9C13CED4}" dt="2023-03-21T05:51:37.749" v="964"/>
          <ac:spMkLst>
            <pc:docMk/>
            <pc:sldMk cId="2545416559" sldId="267"/>
            <ac:spMk id="63" creationId="{13A21B60-27EF-D79B-E351-9CB94062645E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257" creationId="{3AD2D75F-8436-8689-F67D-1F25B993FAE9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258" creationId="{BBB6C80F-6DA7-C859-5668-C773374171EC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259" creationId="{2D684FE2-0D99-212A-1F47-FCD222B13A22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260" creationId="{B7E32B7D-0629-213C-FDF2-707767128878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261" creationId="{81EA828E-2018-2A8C-B2A8-DAEDF8DA1699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262" creationId="{BF067F7C-8612-80E4-08F1-FCE051D9B546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263" creationId="{72AE16D1-814C-142E-0597-78168EB2D2B4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264" creationId="{0DCD44B2-CB1E-587F-6724-600B258C620F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265" creationId="{B2D381A4-941C-CDBD-0D60-5E120B5F6443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266" creationId="{48B24D96-C876-13A7-52DF-B0DDF3ED2983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267" creationId="{54CC5625-75D0-3DEB-581D-DBA1F1DC32E4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270" creationId="{6521A97F-56EE-16EE-81F0-718A4B4F894C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271" creationId="{8841E8E4-23F2-8D4C-3B48-3D6184D2AF3E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272" creationId="{3DA15CDA-8517-B824-DB15-4E8843E9B674}"/>
          </ac:spMkLst>
        </pc:spChg>
        <pc:spChg chg="mod">
          <ac:chgData name="Kim Ji-Eun" userId="5d7677e0d52343ec" providerId="LiveId" clId="{F023BD75-3484-F245-B723-6E8D9C13CED4}" dt="2023-03-27T07:31:28.588" v="1712" actId="20577"/>
          <ac:spMkLst>
            <pc:docMk/>
            <pc:sldMk cId="2545416559" sldId="267"/>
            <ac:spMk id="285" creationId="{5B754EBF-3868-2A2A-B29C-B2B4F9562340}"/>
          </ac:spMkLst>
        </pc:spChg>
        <pc:spChg chg="mod">
          <ac:chgData name="Kim Ji-Eun" userId="5d7677e0d52343ec" providerId="LiveId" clId="{F023BD75-3484-F245-B723-6E8D9C13CED4}" dt="2023-03-21T05:50:45.513" v="962" actId="1076"/>
          <ac:spMkLst>
            <pc:docMk/>
            <pc:sldMk cId="2545416559" sldId="267"/>
            <ac:spMk id="294" creationId="{D6342C36-7731-D1A3-ED12-AD7830F854DE}"/>
          </ac:spMkLst>
        </pc:spChg>
        <pc:spChg chg="del">
          <ac:chgData name="Kim Ji-Eun" userId="5d7677e0d52343ec" providerId="LiveId" clId="{F023BD75-3484-F245-B723-6E8D9C13CED4}" dt="2023-03-21T05:51:22.989" v="963" actId="478"/>
          <ac:spMkLst>
            <pc:docMk/>
            <pc:sldMk cId="2545416559" sldId="267"/>
            <ac:spMk id="297" creationId="{715F43C2-4003-1699-ED52-FB959AA12774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298" creationId="{1520B7C7-8744-70CA-1C61-794A5F717F47}"/>
          </ac:spMkLst>
        </pc:spChg>
        <pc:spChg chg="del">
          <ac:chgData name="Kim Ji-Eun" userId="5d7677e0d52343ec" providerId="LiveId" clId="{F023BD75-3484-F245-B723-6E8D9C13CED4}" dt="2023-03-21T05:51:22.989" v="963" actId="478"/>
          <ac:spMkLst>
            <pc:docMk/>
            <pc:sldMk cId="2545416559" sldId="267"/>
            <ac:spMk id="299" creationId="{5E4056CF-40CF-50B5-53B6-A7C2ED486BCE}"/>
          </ac:spMkLst>
        </pc:spChg>
        <pc:spChg chg="del">
          <ac:chgData name="Kim Ji-Eun" userId="5d7677e0d52343ec" providerId="LiveId" clId="{F023BD75-3484-F245-B723-6E8D9C13CED4}" dt="2023-03-21T05:51:22.989" v="963" actId="478"/>
          <ac:spMkLst>
            <pc:docMk/>
            <pc:sldMk cId="2545416559" sldId="267"/>
            <ac:spMk id="300" creationId="{0B68A627-7E9B-93D1-6B7C-DC1763EB446E}"/>
          </ac:spMkLst>
        </pc:spChg>
        <pc:spChg chg="del">
          <ac:chgData name="Kim Ji-Eun" userId="5d7677e0d52343ec" providerId="LiveId" clId="{F023BD75-3484-F245-B723-6E8D9C13CED4}" dt="2023-03-21T05:51:22.989" v="963" actId="478"/>
          <ac:spMkLst>
            <pc:docMk/>
            <pc:sldMk cId="2545416559" sldId="267"/>
            <ac:spMk id="301" creationId="{1BDD4E06-1C34-9A14-4BDD-043B9F54E0AE}"/>
          </ac:spMkLst>
        </pc:spChg>
        <pc:spChg chg="del">
          <ac:chgData name="Kim Ji-Eun" userId="5d7677e0d52343ec" providerId="LiveId" clId="{F023BD75-3484-F245-B723-6E8D9C13CED4}" dt="2023-03-21T05:51:22.989" v="963" actId="478"/>
          <ac:spMkLst>
            <pc:docMk/>
            <pc:sldMk cId="2545416559" sldId="267"/>
            <ac:spMk id="302" creationId="{6FC002F8-AD95-EBB6-1C7F-5F107DD2B646}"/>
          </ac:spMkLst>
        </pc:spChg>
        <pc:spChg chg="del">
          <ac:chgData name="Kim Ji-Eun" userId="5d7677e0d52343ec" providerId="LiveId" clId="{F023BD75-3484-F245-B723-6E8D9C13CED4}" dt="2023-03-21T05:51:22.989" v="963" actId="478"/>
          <ac:spMkLst>
            <pc:docMk/>
            <pc:sldMk cId="2545416559" sldId="267"/>
            <ac:spMk id="303" creationId="{D914C473-2CFE-4A28-C195-A16B88E4C1E2}"/>
          </ac:spMkLst>
        </pc:spChg>
        <pc:spChg chg="del">
          <ac:chgData name="Kim Ji-Eun" userId="5d7677e0d52343ec" providerId="LiveId" clId="{F023BD75-3484-F245-B723-6E8D9C13CED4}" dt="2023-03-21T05:51:22.989" v="963" actId="478"/>
          <ac:spMkLst>
            <pc:docMk/>
            <pc:sldMk cId="2545416559" sldId="267"/>
            <ac:spMk id="304" creationId="{D8C292A6-7845-284F-9392-B14296CC419E}"/>
          </ac:spMkLst>
        </pc:spChg>
        <pc:spChg chg="del">
          <ac:chgData name="Kim Ji-Eun" userId="5d7677e0d52343ec" providerId="LiveId" clId="{F023BD75-3484-F245-B723-6E8D9C13CED4}" dt="2023-03-21T05:51:22.989" v="963" actId="478"/>
          <ac:spMkLst>
            <pc:docMk/>
            <pc:sldMk cId="2545416559" sldId="267"/>
            <ac:spMk id="305" creationId="{E56D7F6B-0E5B-EBCD-7805-9E43AEB616C2}"/>
          </ac:spMkLst>
        </pc:spChg>
        <pc:spChg chg="del">
          <ac:chgData name="Kim Ji-Eun" userId="5d7677e0d52343ec" providerId="LiveId" clId="{F023BD75-3484-F245-B723-6E8D9C13CED4}" dt="2023-03-21T05:51:22.989" v="963" actId="478"/>
          <ac:spMkLst>
            <pc:docMk/>
            <pc:sldMk cId="2545416559" sldId="267"/>
            <ac:spMk id="306" creationId="{2B099EF2-0943-270E-263A-8D9EE015CE0A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308" creationId="{91B7D87A-91C7-BA75-4650-873B4E74BD1E}"/>
          </ac:spMkLst>
        </pc:spChg>
        <pc:spChg chg="del">
          <ac:chgData name="Kim Ji-Eun" userId="5d7677e0d52343ec" providerId="LiveId" clId="{F023BD75-3484-F245-B723-6E8D9C13CED4}" dt="2023-03-21T05:51:22.989" v="963" actId="478"/>
          <ac:spMkLst>
            <pc:docMk/>
            <pc:sldMk cId="2545416559" sldId="267"/>
            <ac:spMk id="309" creationId="{46A35B89-ACF9-12E0-7BCC-BBBA805D8E69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310" creationId="{5E2D346D-E6FA-3FC7-488C-35964AF783B5}"/>
          </ac:spMkLst>
        </pc:spChg>
        <pc:spChg chg="mod">
          <ac:chgData name="Kim Ji-Eun" userId="5d7677e0d52343ec" providerId="LiveId" clId="{F023BD75-3484-F245-B723-6E8D9C13CED4}" dt="2023-03-21T05:51:37.749" v="964"/>
          <ac:spMkLst>
            <pc:docMk/>
            <pc:sldMk cId="2545416559" sldId="267"/>
            <ac:spMk id="312" creationId="{7C65A7FB-E11C-10DE-2160-6BAC179A2121}"/>
          </ac:spMkLst>
        </pc:spChg>
        <pc:spChg chg="del">
          <ac:chgData name="Kim Ji-Eun" userId="5d7677e0d52343ec" providerId="LiveId" clId="{F023BD75-3484-F245-B723-6E8D9C13CED4}" dt="2023-03-21T05:51:22.989" v="963" actId="478"/>
          <ac:spMkLst>
            <pc:docMk/>
            <pc:sldMk cId="2545416559" sldId="267"/>
            <ac:spMk id="313" creationId="{8BD2029C-8488-1507-C7A6-CB53274A65EC}"/>
          </ac:spMkLst>
        </pc:spChg>
        <pc:spChg chg="del">
          <ac:chgData name="Kim Ji-Eun" userId="5d7677e0d52343ec" providerId="LiveId" clId="{F023BD75-3484-F245-B723-6E8D9C13CED4}" dt="2023-03-21T05:51:22.989" v="963" actId="478"/>
          <ac:spMkLst>
            <pc:docMk/>
            <pc:sldMk cId="2545416559" sldId="267"/>
            <ac:spMk id="315" creationId="{DBE05DAD-2652-8438-8667-A15AA4E918A2}"/>
          </ac:spMkLst>
        </pc:spChg>
        <pc:spChg chg="mod">
          <ac:chgData name="Kim Ji-Eun" userId="5d7677e0d52343ec" providerId="LiveId" clId="{F023BD75-3484-F245-B723-6E8D9C13CED4}" dt="2023-03-21T05:51:37.749" v="964"/>
          <ac:spMkLst>
            <pc:docMk/>
            <pc:sldMk cId="2545416559" sldId="267"/>
            <ac:spMk id="317" creationId="{C1BC8A0C-9393-97C0-523E-CA2C638E03DC}"/>
          </ac:spMkLst>
        </pc:spChg>
        <pc:spChg chg="del">
          <ac:chgData name="Kim Ji-Eun" userId="5d7677e0d52343ec" providerId="LiveId" clId="{F023BD75-3484-F245-B723-6E8D9C13CED4}" dt="2023-03-21T05:51:22.989" v="963" actId="478"/>
          <ac:spMkLst>
            <pc:docMk/>
            <pc:sldMk cId="2545416559" sldId="267"/>
            <ac:spMk id="318" creationId="{CEA23351-B1C3-D8BE-6B3F-0096DEF258FE}"/>
          </ac:spMkLst>
        </pc:spChg>
        <pc:spChg chg="mod">
          <ac:chgData name="Kim Ji-Eun" userId="5d7677e0d52343ec" providerId="LiveId" clId="{F023BD75-3484-F245-B723-6E8D9C13CED4}" dt="2023-03-21T05:51:37.749" v="964"/>
          <ac:spMkLst>
            <pc:docMk/>
            <pc:sldMk cId="2545416559" sldId="267"/>
            <ac:spMk id="319" creationId="{B63D6CA2-EB18-753E-C440-CE02052B32A2}"/>
          </ac:spMkLst>
        </pc:spChg>
        <pc:spChg chg="mod">
          <ac:chgData name="Kim Ji-Eun" userId="5d7677e0d52343ec" providerId="LiveId" clId="{F023BD75-3484-F245-B723-6E8D9C13CED4}" dt="2023-03-21T05:51:37.749" v="964"/>
          <ac:spMkLst>
            <pc:docMk/>
            <pc:sldMk cId="2545416559" sldId="267"/>
            <ac:spMk id="321" creationId="{C45DD52F-DD86-86B2-82BA-2B4CE87EEC6C}"/>
          </ac:spMkLst>
        </pc:spChg>
        <pc:spChg chg="del">
          <ac:chgData name="Kim Ji-Eun" userId="5d7677e0d52343ec" providerId="LiveId" clId="{F023BD75-3484-F245-B723-6E8D9C13CED4}" dt="2023-03-21T05:51:22.989" v="963" actId="478"/>
          <ac:spMkLst>
            <pc:docMk/>
            <pc:sldMk cId="2545416559" sldId="267"/>
            <ac:spMk id="322" creationId="{3D45DF5D-2DD1-2BDC-0DD9-5EFC7379CC0D}"/>
          </ac:spMkLst>
        </pc:spChg>
        <pc:spChg chg="mod">
          <ac:chgData name="Kim Ji-Eun" userId="5d7677e0d52343ec" providerId="LiveId" clId="{F023BD75-3484-F245-B723-6E8D9C13CED4}" dt="2023-03-21T05:51:37.749" v="964"/>
          <ac:spMkLst>
            <pc:docMk/>
            <pc:sldMk cId="2545416559" sldId="267"/>
            <ac:spMk id="323" creationId="{12FC13C3-2F45-8F62-E1CF-EC46611AF149}"/>
          </ac:spMkLst>
        </pc:spChg>
        <pc:spChg chg="mod">
          <ac:chgData name="Kim Ji-Eun" userId="5d7677e0d52343ec" providerId="LiveId" clId="{F023BD75-3484-F245-B723-6E8D9C13CED4}" dt="2023-03-21T05:51:37.749" v="964"/>
          <ac:spMkLst>
            <pc:docMk/>
            <pc:sldMk cId="2545416559" sldId="267"/>
            <ac:spMk id="324" creationId="{54E7A7B4-0575-DB5B-22E3-9B9330637236}"/>
          </ac:spMkLst>
        </pc:spChg>
        <pc:spChg chg="mod">
          <ac:chgData name="Kim Ji-Eun" userId="5d7677e0d52343ec" providerId="LiveId" clId="{F023BD75-3484-F245-B723-6E8D9C13CED4}" dt="2023-03-21T05:51:37.749" v="964"/>
          <ac:spMkLst>
            <pc:docMk/>
            <pc:sldMk cId="2545416559" sldId="267"/>
            <ac:spMk id="325" creationId="{E0EE5D1D-A916-7014-11A7-62421FD09B5F}"/>
          </ac:spMkLst>
        </pc:spChg>
        <pc:spChg chg="del">
          <ac:chgData name="Kim Ji-Eun" userId="5d7677e0d52343ec" providerId="LiveId" clId="{F023BD75-3484-F245-B723-6E8D9C13CED4}" dt="2023-03-21T05:51:22.989" v="963" actId="478"/>
          <ac:spMkLst>
            <pc:docMk/>
            <pc:sldMk cId="2545416559" sldId="267"/>
            <ac:spMk id="326" creationId="{1A794B67-D6CB-3A09-215D-06BA5E2D3B30}"/>
          </ac:spMkLst>
        </pc:spChg>
        <pc:spChg chg="mod">
          <ac:chgData name="Kim Ji-Eun" userId="5d7677e0d52343ec" providerId="LiveId" clId="{F023BD75-3484-F245-B723-6E8D9C13CED4}" dt="2023-03-21T05:51:37.749" v="964"/>
          <ac:spMkLst>
            <pc:docMk/>
            <pc:sldMk cId="2545416559" sldId="267"/>
            <ac:spMk id="328" creationId="{6ACDE614-52E0-AD5C-33C4-0D16F2355D5F}"/>
          </ac:spMkLst>
        </pc:spChg>
        <pc:spChg chg="del">
          <ac:chgData name="Kim Ji-Eun" userId="5d7677e0d52343ec" providerId="LiveId" clId="{F023BD75-3484-F245-B723-6E8D9C13CED4}" dt="2023-03-21T05:51:22.989" v="963" actId="478"/>
          <ac:spMkLst>
            <pc:docMk/>
            <pc:sldMk cId="2545416559" sldId="267"/>
            <ac:spMk id="329" creationId="{3FB2C62C-5ADE-7DB6-1E4D-42C5FFC80B11}"/>
          </ac:spMkLst>
        </pc:spChg>
        <pc:spChg chg="mod">
          <ac:chgData name="Kim Ji-Eun" userId="5d7677e0d52343ec" providerId="LiveId" clId="{F023BD75-3484-F245-B723-6E8D9C13CED4}" dt="2023-03-21T05:51:37.749" v="964"/>
          <ac:spMkLst>
            <pc:docMk/>
            <pc:sldMk cId="2545416559" sldId="267"/>
            <ac:spMk id="331" creationId="{B2E3AEF2-B247-4D9F-F579-C3D041730D8F}"/>
          </ac:spMkLst>
        </pc:spChg>
        <pc:spChg chg="del">
          <ac:chgData name="Kim Ji-Eun" userId="5d7677e0d52343ec" providerId="LiveId" clId="{F023BD75-3484-F245-B723-6E8D9C13CED4}" dt="2023-03-21T05:51:22.989" v="963" actId="478"/>
          <ac:spMkLst>
            <pc:docMk/>
            <pc:sldMk cId="2545416559" sldId="267"/>
            <ac:spMk id="332" creationId="{F72EB23E-2CDF-E4F6-CB61-0E3E6730141D}"/>
          </ac:spMkLst>
        </pc:spChg>
        <pc:spChg chg="mod">
          <ac:chgData name="Kim Ji-Eun" userId="5d7677e0d52343ec" providerId="LiveId" clId="{F023BD75-3484-F245-B723-6E8D9C13CED4}" dt="2023-03-21T05:51:37.749" v="964"/>
          <ac:spMkLst>
            <pc:docMk/>
            <pc:sldMk cId="2545416559" sldId="267"/>
            <ac:spMk id="334" creationId="{BDCB7A6A-0802-05AF-B91D-5A2FB940F6C6}"/>
          </ac:spMkLst>
        </pc:spChg>
        <pc:spChg chg="del">
          <ac:chgData name="Kim Ji-Eun" userId="5d7677e0d52343ec" providerId="LiveId" clId="{F023BD75-3484-F245-B723-6E8D9C13CED4}" dt="2023-03-21T05:51:22.989" v="963" actId="478"/>
          <ac:spMkLst>
            <pc:docMk/>
            <pc:sldMk cId="2545416559" sldId="267"/>
            <ac:spMk id="335" creationId="{9220E941-5CCD-C4C9-A667-B0E8EECAB5D7}"/>
          </ac:spMkLst>
        </pc:spChg>
        <pc:spChg chg="del">
          <ac:chgData name="Kim Ji-Eun" userId="5d7677e0d52343ec" providerId="LiveId" clId="{F023BD75-3484-F245-B723-6E8D9C13CED4}" dt="2023-03-21T05:51:22.989" v="963" actId="478"/>
          <ac:spMkLst>
            <pc:docMk/>
            <pc:sldMk cId="2545416559" sldId="267"/>
            <ac:spMk id="336" creationId="{D148844D-5D6D-624E-D17C-BE548538B76D}"/>
          </ac:spMkLst>
        </pc:spChg>
        <pc:spChg chg="del">
          <ac:chgData name="Kim Ji-Eun" userId="5d7677e0d52343ec" providerId="LiveId" clId="{F023BD75-3484-F245-B723-6E8D9C13CED4}" dt="2023-03-21T05:51:22.989" v="963" actId="478"/>
          <ac:spMkLst>
            <pc:docMk/>
            <pc:sldMk cId="2545416559" sldId="267"/>
            <ac:spMk id="337" creationId="{776D3C5E-5080-C43E-9D23-4B8201458478}"/>
          </ac:spMkLst>
        </pc:spChg>
        <pc:spChg chg="del">
          <ac:chgData name="Kim Ji-Eun" userId="5d7677e0d52343ec" providerId="LiveId" clId="{F023BD75-3484-F245-B723-6E8D9C13CED4}" dt="2023-03-21T05:51:22.989" v="963" actId="478"/>
          <ac:spMkLst>
            <pc:docMk/>
            <pc:sldMk cId="2545416559" sldId="267"/>
            <ac:spMk id="339" creationId="{6160F427-6B2D-66BD-3AE3-D4EE3CFFCFBD}"/>
          </ac:spMkLst>
        </pc:spChg>
        <pc:spChg chg="mod">
          <ac:chgData name="Kim Ji-Eun" userId="5d7677e0d52343ec" providerId="LiveId" clId="{F023BD75-3484-F245-B723-6E8D9C13CED4}" dt="2023-03-21T05:51:37.749" v="964"/>
          <ac:spMkLst>
            <pc:docMk/>
            <pc:sldMk cId="2545416559" sldId="267"/>
            <ac:spMk id="341" creationId="{81E6F5ED-8C6C-C15F-1EAD-C957B8AB1B20}"/>
          </ac:spMkLst>
        </pc:spChg>
        <pc:spChg chg="del">
          <ac:chgData name="Kim Ji-Eun" userId="5d7677e0d52343ec" providerId="LiveId" clId="{F023BD75-3484-F245-B723-6E8D9C13CED4}" dt="2023-03-21T05:51:22.989" v="963" actId="478"/>
          <ac:spMkLst>
            <pc:docMk/>
            <pc:sldMk cId="2545416559" sldId="267"/>
            <ac:spMk id="342" creationId="{D41BA20A-A843-7403-EA28-156ABB710975}"/>
          </ac:spMkLst>
        </pc:spChg>
        <pc:spChg chg="mod">
          <ac:chgData name="Kim Ji-Eun" userId="5d7677e0d52343ec" providerId="LiveId" clId="{F023BD75-3484-F245-B723-6E8D9C13CED4}" dt="2023-03-21T05:51:37.749" v="964"/>
          <ac:spMkLst>
            <pc:docMk/>
            <pc:sldMk cId="2545416559" sldId="267"/>
            <ac:spMk id="343" creationId="{D6BFBF61-D470-7EBC-A51E-D51DA15B2F93}"/>
          </ac:spMkLst>
        </pc:spChg>
        <pc:spChg chg="mod">
          <ac:chgData name="Kim Ji-Eun" userId="5d7677e0d52343ec" providerId="LiveId" clId="{F023BD75-3484-F245-B723-6E8D9C13CED4}" dt="2023-03-21T05:51:37.749" v="964"/>
          <ac:spMkLst>
            <pc:docMk/>
            <pc:sldMk cId="2545416559" sldId="267"/>
            <ac:spMk id="344" creationId="{8FD7532B-58A7-86D1-EF59-ACF1AD198203}"/>
          </ac:spMkLst>
        </pc:spChg>
        <pc:spChg chg="mod">
          <ac:chgData name="Kim Ji-Eun" userId="5d7677e0d52343ec" providerId="LiveId" clId="{F023BD75-3484-F245-B723-6E8D9C13CED4}" dt="2023-03-21T05:51:37.749" v="964"/>
          <ac:spMkLst>
            <pc:docMk/>
            <pc:sldMk cId="2545416559" sldId="267"/>
            <ac:spMk id="345" creationId="{B8B45581-8D27-AC59-FD04-A0E5DE0DC7DA}"/>
          </ac:spMkLst>
        </pc:spChg>
        <pc:spChg chg="mod">
          <ac:chgData name="Kim Ji-Eun" userId="5d7677e0d52343ec" providerId="LiveId" clId="{F023BD75-3484-F245-B723-6E8D9C13CED4}" dt="2023-03-21T05:51:37.749" v="964"/>
          <ac:spMkLst>
            <pc:docMk/>
            <pc:sldMk cId="2545416559" sldId="267"/>
            <ac:spMk id="346" creationId="{0F408C3D-7AE0-6566-C6D4-329D26BB2B60}"/>
          </ac:spMkLst>
        </pc:spChg>
        <pc:spChg chg="mod">
          <ac:chgData name="Kim Ji-Eun" userId="5d7677e0d52343ec" providerId="LiveId" clId="{F023BD75-3484-F245-B723-6E8D9C13CED4}" dt="2023-03-21T05:51:37.749" v="964"/>
          <ac:spMkLst>
            <pc:docMk/>
            <pc:sldMk cId="2545416559" sldId="267"/>
            <ac:spMk id="347" creationId="{6CBC7768-4B4B-666F-DE39-BE773475C7F9}"/>
          </ac:spMkLst>
        </pc:spChg>
        <pc:spChg chg="mod">
          <ac:chgData name="Kim Ji-Eun" userId="5d7677e0d52343ec" providerId="LiveId" clId="{F023BD75-3484-F245-B723-6E8D9C13CED4}" dt="2023-03-21T05:51:37.749" v="964"/>
          <ac:spMkLst>
            <pc:docMk/>
            <pc:sldMk cId="2545416559" sldId="267"/>
            <ac:spMk id="348" creationId="{FDB7A4BF-1619-633B-FDC0-E7659144AC6F}"/>
          </ac:spMkLst>
        </pc:spChg>
        <pc:spChg chg="mod">
          <ac:chgData name="Kim Ji-Eun" userId="5d7677e0d52343ec" providerId="LiveId" clId="{F023BD75-3484-F245-B723-6E8D9C13CED4}" dt="2023-03-21T05:51:37.749" v="964"/>
          <ac:spMkLst>
            <pc:docMk/>
            <pc:sldMk cId="2545416559" sldId="267"/>
            <ac:spMk id="349" creationId="{C8620D77-91BD-1887-74D0-7E228036167D}"/>
          </ac:spMkLst>
        </pc:spChg>
        <pc:spChg chg="mod">
          <ac:chgData name="Kim Ji-Eun" userId="5d7677e0d52343ec" providerId="LiveId" clId="{F023BD75-3484-F245-B723-6E8D9C13CED4}" dt="2023-03-21T05:51:37.749" v="964"/>
          <ac:spMkLst>
            <pc:docMk/>
            <pc:sldMk cId="2545416559" sldId="267"/>
            <ac:spMk id="350" creationId="{154C7113-B354-8A37-4EEC-2575BC040298}"/>
          </ac:spMkLst>
        </pc:spChg>
        <pc:spChg chg="mod">
          <ac:chgData name="Kim Ji-Eun" userId="5d7677e0d52343ec" providerId="LiveId" clId="{F023BD75-3484-F245-B723-6E8D9C13CED4}" dt="2023-03-21T05:51:37.749" v="964"/>
          <ac:spMkLst>
            <pc:docMk/>
            <pc:sldMk cId="2545416559" sldId="267"/>
            <ac:spMk id="351" creationId="{258C86FC-2E24-FDFF-BB5B-206D12908C44}"/>
          </ac:spMkLst>
        </pc:spChg>
        <pc:spChg chg="mod">
          <ac:chgData name="Kim Ji-Eun" userId="5d7677e0d52343ec" providerId="LiveId" clId="{F023BD75-3484-F245-B723-6E8D9C13CED4}" dt="2023-03-21T05:51:37.749" v="964"/>
          <ac:spMkLst>
            <pc:docMk/>
            <pc:sldMk cId="2545416559" sldId="267"/>
            <ac:spMk id="352" creationId="{04F62B5E-B0CD-32F2-E492-EA2EDCA6830E}"/>
          </ac:spMkLst>
        </pc:spChg>
        <pc:spChg chg="mod">
          <ac:chgData name="Kim Ji-Eun" userId="5d7677e0d52343ec" providerId="LiveId" clId="{F023BD75-3484-F245-B723-6E8D9C13CED4}" dt="2023-03-21T05:51:37.749" v="964"/>
          <ac:spMkLst>
            <pc:docMk/>
            <pc:sldMk cId="2545416559" sldId="267"/>
            <ac:spMk id="353" creationId="{5EC42823-FEB1-0893-818D-36F6C5733AE1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356" creationId="{1F94102D-7407-BCE9-66B5-A86F419EC159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358" creationId="{785C2704-1AAA-457B-7464-35E5E3D45ED1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359" creationId="{D4440FA3-D1A0-5173-7396-CEA819D6CAFE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360" creationId="{8315ED1D-ECA3-3EC7-C4FD-48AC833BAEE9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361" creationId="{F0B42C40-10FB-5D5D-407C-F07FDF6F2E7E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362" creationId="{72388EE8-3635-A779-0AD7-EF940A2E28EF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363" creationId="{51F39CF0-CF1F-08FD-23D9-2145F8EF3682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364" creationId="{D92A793C-D1AE-5524-847E-FA819C8463DD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365" creationId="{46A1761D-755E-0F86-1CFB-3CAF72E3743A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366" creationId="{4B60BFEF-D01B-8CBB-8173-2F9297787558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367" creationId="{36844231-42DA-ACD8-A02A-0A348C4CDE8B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368" creationId="{C3FAC946-6747-186B-F75B-B9CAD5E03EC4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369" creationId="{8303B7C8-2B00-7268-EF06-11C2A1C64CD7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370" creationId="{B54D0F08-1ED5-E318-DDF5-71E9CF052BED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371" creationId="{7E7CF791-8717-6285-D369-FDE74ADD2D38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372" creationId="{0AC29DEA-A21F-C5F9-A38E-C0D90F4D88B2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373" creationId="{0F9FCCA1-B984-EEE6-EB20-EAA07A98142E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374" creationId="{6E3A4C5E-2138-2B66-6341-CDA6345CE3A2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375" creationId="{FF38BA2E-4CAD-C25E-A666-5C001BD5B4E0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376" creationId="{C39DAD1D-BA6D-3F37-F451-FC34AD09724B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377" creationId="{DDF67712-9810-2838-802D-B2FC4C4338F7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378" creationId="{21D676A1-F155-4A99-A5C8-68D6047A8766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379" creationId="{45EC3207-40C8-E966-260C-784838650722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380" creationId="{55542D53-EE55-433B-7CAC-B59ED1A541E4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381" creationId="{B9226298-0507-3B06-CA36-B222E200F292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382" creationId="{7A5F22DE-5B32-01B1-9623-3A56B7CD0058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383" creationId="{98A08C58-EA68-A381-8F58-79B51ECACAC4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384" creationId="{A2CA843E-5AE7-18C3-5DDA-0152382072E6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385" creationId="{3905F745-045C-BF30-EDFD-502C878D215B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386" creationId="{70CFF3D6-DF69-3B51-E7E1-13E99EC9F0C1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387" creationId="{E84158F3-3A5B-D6D0-1BD2-923399BDCFD6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388" creationId="{53A1930B-2881-EBDC-9E98-50175EB63761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389" creationId="{AB021C88-D322-30E8-BD68-2A4D19826F5C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390" creationId="{E6A2411A-2674-3EC6-65EC-BA2CD53C6EA3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391" creationId="{BE014758-404C-D1F6-1DFB-AE5B75F5C8F6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392" creationId="{D855406A-894F-9B0F-9D6F-2F7AE93B6CB3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393" creationId="{3CFD2D43-4FDD-E8F8-F90E-8B80FB27C473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394" creationId="{2CD45ED9-43F5-515F-C57B-746E4B093202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395" creationId="{94EF0F38-D258-72C4-9FCA-7CB6522B1967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396" creationId="{FCC18DAF-F27A-D22F-C1B4-93534F3C2690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397" creationId="{5E061592-93EE-1426-D287-815FB6CAA2DC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398" creationId="{A71684C3-3F3A-951D-08B7-2CCE00E3B040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399" creationId="{04535DB6-EE1E-4070-0A1E-A0DD925F3B44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400" creationId="{B63DC3C6-2317-DBFC-7657-AFDFB3F72734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401" creationId="{6FD4B79E-E874-6862-B99F-DF69368E7FC5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402" creationId="{0944DF9B-E8D3-21AF-F275-D83D3B4725AC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403" creationId="{9176F8DA-6015-5A38-B1BA-0FE5B53D8A3F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404" creationId="{715150C8-BA12-9259-A8D5-F8F64447AB3B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405" creationId="{4E22758A-F5BD-DEAE-EF26-3C2B6580B549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406" creationId="{3A934E16-8164-F363-8B98-5A4B485F5EFE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407" creationId="{5EB8D572-67E8-2307-1CBA-8EAD6C7080C0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408" creationId="{98822829-A788-A394-6837-EB1425CC112B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409" creationId="{159964CE-A248-A673-70FD-2B8F00E17681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414" creationId="{62C46C30-96F7-C7FE-4679-49A68DE16014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417" creationId="{9D3047DA-4894-A381-086B-1ECD9701301D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418" creationId="{63096200-2443-F076-38CC-E528B2EA7938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419" creationId="{D0AD2996-EC0A-5701-835E-377C52E0F091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420" creationId="{FE17DEB2-FAAC-81BB-50E3-2D4AAF6C0B39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421" creationId="{4112D9A6-3DBA-273D-810A-EA9A17008B7D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422" creationId="{5E8622FA-57EF-6A14-98C7-AB9C69490194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423" creationId="{D07DAA12-2EE5-A8E4-D869-808969B668F0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424" creationId="{E8D17E8F-C5BD-9BD7-BF2D-B76DA4B49EE4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425" creationId="{3DE21A0F-E7F0-05AF-63B0-1FE5DCA96FC6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426" creationId="{59295CF7-A47F-EAD9-A420-04622C14B814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427" creationId="{DF9C2460-BF8F-57C2-9645-E783E7A5C082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428" creationId="{F7FA1ADB-C982-08D0-A2A6-E7811E09A2B2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429" creationId="{DF2220BB-5C5F-2B88-E515-4B87AF916997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430" creationId="{AD9CB161-BD2D-CB9D-4786-59CBC75A6E9E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431" creationId="{1893C1C3-A2BB-71A9-30BD-F7A3581AF9C2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432" creationId="{28F68588-211E-E847-E382-E4029595A670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433" creationId="{8E2B91A8-AB8E-3DB6-3467-03E9F303AEF9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434" creationId="{CE4E2077-5D67-E67C-55DE-518CE2ECE80A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435" creationId="{AAC1D438-90CD-F7A0-07AF-65081EEABA83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436" creationId="{D0531A55-170B-8691-131D-C2609EF0DB90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437" creationId="{025E770F-14CF-AA01-9815-5F2E8E063DA5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438" creationId="{F556EF29-0381-56D3-74E0-E9583CF6F3CF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439" creationId="{3D0B131F-BC21-0076-98B0-84ABB044FF2E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440" creationId="{507B5085-77B1-22E6-91CE-9659C0AB457F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441" creationId="{3C6AED45-A9E7-3719-8ADA-F29E8D257760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442" creationId="{63B6A03D-A1D5-08F9-588B-E42D24007F24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443" creationId="{F20ABDC9-8DD5-4802-0F71-FD3AF1EA3DE6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444" creationId="{BBA0B8B8-B4BD-4035-6FE9-1E342BD48A37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445" creationId="{64EAB47A-1504-A36C-003C-7519926AF01F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446" creationId="{6F69B449-0A7F-CCD3-9FB3-5FF02CEF56C2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447" creationId="{3CE161B9-FA4B-8499-88FF-C9F94072DD34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448" creationId="{6D481033-4BEB-D6FB-4543-5850B0BE3124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449" creationId="{90AF3278-30CF-0629-E4F9-4431CC375D78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450" creationId="{29E8132B-A473-8C00-6355-2B5CCBE958AC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451" creationId="{4F59F592-63FE-0141-BE51-0DD5410700AC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452" creationId="{6D4ED984-1FD7-4106-DE90-D71EF161B6A4}"/>
          </ac:spMkLst>
        </pc:spChg>
        <pc:spChg chg="mod">
          <ac:chgData name="Kim Ji-Eun" userId="5d7677e0d52343ec" providerId="LiveId" clId="{F023BD75-3484-F245-B723-6E8D9C13CED4}" dt="2023-03-21T06:29:47.528" v="1695" actId="1036"/>
          <ac:spMkLst>
            <pc:docMk/>
            <pc:sldMk cId="2545416559" sldId="267"/>
            <ac:spMk id="453" creationId="{55E2CE2A-A1F9-5E8D-CA12-FB68FD287648}"/>
          </ac:spMkLst>
        </pc:spChg>
        <pc:spChg chg="add del mod">
          <ac:chgData name="Kim Ji-Eun" userId="5d7677e0d52343ec" providerId="LiveId" clId="{F023BD75-3484-F245-B723-6E8D9C13CED4}" dt="2023-03-21T06:27:49.678" v="1655"/>
          <ac:spMkLst>
            <pc:docMk/>
            <pc:sldMk cId="2545416559" sldId="267"/>
            <ac:spMk id="454" creationId="{E5E810FA-78AC-7D08-671C-E8F914EDE80E}"/>
          </ac:spMkLst>
        </pc:spChg>
        <pc:grpChg chg="mod">
          <ac:chgData name="Kim Ji-Eun" userId="5d7677e0d52343ec" providerId="LiveId" clId="{F023BD75-3484-F245-B723-6E8D9C13CED4}" dt="2023-03-21T06:29:47.528" v="1695" actId="1036"/>
          <ac:grpSpMkLst>
            <pc:docMk/>
            <pc:sldMk cId="2545416559" sldId="267"/>
            <ac:grpSpMk id="4" creationId="{20F2B4A2-7446-E3AC-C88D-DFFF2E2185F5}"/>
          </ac:grpSpMkLst>
        </pc:grpChg>
        <pc:grpChg chg="add del mod">
          <ac:chgData name="Kim Ji-Eun" userId="5d7677e0d52343ec" providerId="LiveId" clId="{F023BD75-3484-F245-B723-6E8D9C13CED4}" dt="2023-03-21T05:51:47.858" v="965" actId="21"/>
          <ac:grpSpMkLst>
            <pc:docMk/>
            <pc:sldMk cId="2545416559" sldId="267"/>
            <ac:grpSpMk id="43" creationId="{922C0733-779E-26C6-B6A1-031334A3703A}"/>
          </ac:grpSpMkLst>
        </pc:grpChg>
        <pc:grpChg chg="mod">
          <ac:chgData name="Kim Ji-Eun" userId="5d7677e0d52343ec" providerId="LiveId" clId="{F023BD75-3484-F245-B723-6E8D9C13CED4}" dt="2023-03-21T06:29:47.528" v="1695" actId="1036"/>
          <ac:grpSpMkLst>
            <pc:docMk/>
            <pc:sldMk cId="2545416559" sldId="267"/>
            <ac:grpSpMk id="256" creationId="{24B2871E-67E8-0933-B38B-8475C488087B}"/>
          </ac:grpSpMkLst>
        </pc:grpChg>
        <pc:grpChg chg="mod">
          <ac:chgData name="Kim Ji-Eun" userId="5d7677e0d52343ec" providerId="LiveId" clId="{F023BD75-3484-F245-B723-6E8D9C13CED4}" dt="2023-03-21T06:29:47.528" v="1695" actId="1036"/>
          <ac:grpSpMkLst>
            <pc:docMk/>
            <pc:sldMk cId="2545416559" sldId="267"/>
            <ac:grpSpMk id="268" creationId="{70EB7425-9C31-95D0-BA2E-5E4BF8C1EC52}"/>
          </ac:grpSpMkLst>
        </pc:grpChg>
        <pc:grpChg chg="mod">
          <ac:chgData name="Kim Ji-Eun" userId="5d7677e0d52343ec" providerId="LiveId" clId="{F023BD75-3484-F245-B723-6E8D9C13CED4}" dt="2023-03-21T06:29:47.528" v="1695" actId="1036"/>
          <ac:grpSpMkLst>
            <pc:docMk/>
            <pc:sldMk cId="2545416559" sldId="267"/>
            <ac:grpSpMk id="269" creationId="{BBE0AE34-6135-2346-8379-1B638EAC216E}"/>
          </ac:grpSpMkLst>
        </pc:grpChg>
        <pc:grpChg chg="del">
          <ac:chgData name="Kim Ji-Eun" userId="5d7677e0d52343ec" providerId="LiveId" clId="{F023BD75-3484-F245-B723-6E8D9C13CED4}" dt="2023-03-21T05:51:22.989" v="963" actId="478"/>
          <ac:grpSpMkLst>
            <pc:docMk/>
            <pc:sldMk cId="2545416559" sldId="267"/>
            <ac:grpSpMk id="296" creationId="{4C3C46AE-6B37-61E5-FCBE-16A35E674862}"/>
          </ac:grpSpMkLst>
        </pc:grpChg>
        <pc:grpChg chg="add mod">
          <ac:chgData name="Kim Ji-Eun" userId="5d7677e0d52343ec" providerId="LiveId" clId="{F023BD75-3484-F245-B723-6E8D9C13CED4}" dt="2023-03-21T06:29:47.528" v="1695" actId="1036"/>
          <ac:grpSpMkLst>
            <pc:docMk/>
            <pc:sldMk cId="2545416559" sldId="267"/>
            <ac:grpSpMk id="354" creationId="{878788DD-F388-798D-7BB6-1D1F177DEE48}"/>
          </ac:grpSpMkLst>
        </pc:grpChg>
        <pc:grpChg chg="add mod">
          <ac:chgData name="Kim Ji-Eun" userId="5d7677e0d52343ec" providerId="LiveId" clId="{F023BD75-3484-F245-B723-6E8D9C13CED4}" dt="2023-03-21T06:29:47.528" v="1695" actId="1036"/>
          <ac:grpSpMkLst>
            <pc:docMk/>
            <pc:sldMk cId="2545416559" sldId="267"/>
            <ac:grpSpMk id="455" creationId="{2FC608CD-032D-1349-810F-1F4387D4A375}"/>
          </ac:grpSpMkLst>
        </pc:grpChg>
        <pc:picChg chg="mod">
          <ac:chgData name="Kim Ji-Eun" userId="5d7677e0d52343ec" providerId="LiveId" clId="{F023BD75-3484-F245-B723-6E8D9C13CED4}" dt="2023-03-21T06:29:47.528" v="1695" actId="1036"/>
          <ac:picMkLst>
            <pc:docMk/>
            <pc:sldMk cId="2545416559" sldId="267"/>
            <ac:picMk id="2" creationId="{78557AA1-13DD-9310-B187-69FD85099269}"/>
          </ac:picMkLst>
        </pc:picChg>
        <pc:picChg chg="del">
          <ac:chgData name="Kim Ji-Eun" userId="5d7677e0d52343ec" providerId="LiveId" clId="{F023BD75-3484-F245-B723-6E8D9C13CED4}" dt="2023-03-21T05:51:22.989" v="963" actId="478"/>
          <ac:picMkLst>
            <pc:docMk/>
            <pc:sldMk cId="2545416559" sldId="267"/>
            <ac:picMk id="5" creationId="{3D12D110-BC8F-6ACC-76FD-C104E6EABD47}"/>
          </ac:picMkLst>
        </pc:picChg>
        <pc:picChg chg="del">
          <ac:chgData name="Kim Ji-Eun" userId="5d7677e0d52343ec" providerId="LiveId" clId="{F023BD75-3484-F245-B723-6E8D9C13CED4}" dt="2023-03-21T05:51:22.989" v="963" actId="478"/>
          <ac:picMkLst>
            <pc:docMk/>
            <pc:sldMk cId="2545416559" sldId="267"/>
            <ac:picMk id="6" creationId="{7F08AF82-8B66-5BAB-A30B-8AA48646A74C}"/>
          </ac:picMkLst>
        </pc:picChg>
        <pc:picChg chg="del">
          <ac:chgData name="Kim Ji-Eun" userId="5d7677e0d52343ec" providerId="LiveId" clId="{F023BD75-3484-F245-B723-6E8D9C13CED4}" dt="2023-03-21T05:51:22.989" v="963" actId="478"/>
          <ac:picMkLst>
            <pc:docMk/>
            <pc:sldMk cId="2545416559" sldId="267"/>
            <ac:picMk id="7" creationId="{D3FA21D4-94B8-E416-A8FC-8E498A06F88B}"/>
          </ac:picMkLst>
        </pc:picChg>
        <pc:picChg chg="del">
          <ac:chgData name="Kim Ji-Eun" userId="5d7677e0d52343ec" providerId="LiveId" clId="{F023BD75-3484-F245-B723-6E8D9C13CED4}" dt="2023-03-21T05:51:22.989" v="963" actId="478"/>
          <ac:picMkLst>
            <pc:docMk/>
            <pc:sldMk cId="2545416559" sldId="267"/>
            <ac:picMk id="8" creationId="{E76F0CB4-3BE7-EBCA-EF88-E0300374D071}"/>
          </ac:picMkLst>
        </pc:picChg>
        <pc:picChg chg="add del mod">
          <ac:chgData name="Kim Ji-Eun" userId="5d7677e0d52343ec" providerId="LiveId" clId="{F023BD75-3484-F245-B723-6E8D9C13CED4}" dt="2023-03-21T05:51:47.858" v="965" actId="21"/>
          <ac:picMkLst>
            <pc:docMk/>
            <pc:sldMk cId="2545416559" sldId="267"/>
            <ac:picMk id="32" creationId="{1304AC9F-4563-B8FD-A542-E252A7F7C15E}"/>
          </ac:picMkLst>
        </pc:picChg>
        <pc:picChg chg="mod">
          <ac:chgData name="Kim Ji-Eun" userId="5d7677e0d52343ec" providerId="LiveId" clId="{F023BD75-3484-F245-B723-6E8D9C13CED4}" dt="2023-03-21T05:51:37.749" v="964"/>
          <ac:picMkLst>
            <pc:docMk/>
            <pc:sldMk cId="2545416559" sldId="267"/>
            <ac:picMk id="44" creationId="{02F91816-ACD6-7E72-B03F-20FBA60CE80C}"/>
          </ac:picMkLst>
        </pc:picChg>
        <pc:picChg chg="mod">
          <ac:chgData name="Kim Ji-Eun" userId="5d7677e0d52343ec" providerId="LiveId" clId="{F023BD75-3484-F245-B723-6E8D9C13CED4}" dt="2023-03-21T05:51:37.749" v="964"/>
          <ac:picMkLst>
            <pc:docMk/>
            <pc:sldMk cId="2545416559" sldId="267"/>
            <ac:picMk id="45" creationId="{B9F37E13-11A2-40EE-2246-8EB51E4726F6}"/>
          </ac:picMkLst>
        </pc:picChg>
        <pc:picChg chg="mod">
          <ac:chgData name="Kim Ji-Eun" userId="5d7677e0d52343ec" providerId="LiveId" clId="{F023BD75-3484-F245-B723-6E8D9C13CED4}" dt="2023-03-21T05:51:37.749" v="964"/>
          <ac:picMkLst>
            <pc:docMk/>
            <pc:sldMk cId="2545416559" sldId="267"/>
            <ac:picMk id="46" creationId="{311007DB-39E5-8A96-34AA-89BF3E6D85CC}"/>
          </ac:picMkLst>
        </pc:picChg>
        <pc:picChg chg="mod">
          <ac:chgData name="Kim Ji-Eun" userId="5d7677e0d52343ec" providerId="LiveId" clId="{F023BD75-3484-F245-B723-6E8D9C13CED4}" dt="2023-03-21T05:51:37.749" v="964"/>
          <ac:picMkLst>
            <pc:docMk/>
            <pc:sldMk cId="2545416559" sldId="267"/>
            <ac:picMk id="47" creationId="{29A93D57-BBFA-937F-37BF-9735292E6BC4}"/>
          </ac:picMkLst>
        </pc:picChg>
        <pc:picChg chg="mod">
          <ac:chgData name="Kim Ji-Eun" userId="5d7677e0d52343ec" providerId="LiveId" clId="{F023BD75-3484-F245-B723-6E8D9C13CED4}" dt="2023-03-21T05:51:37.749" v="964"/>
          <ac:picMkLst>
            <pc:docMk/>
            <pc:sldMk cId="2545416559" sldId="267"/>
            <ac:picMk id="48" creationId="{4FC5D0F9-82A4-A18C-FE19-23BF5D5F6DA6}"/>
          </ac:picMkLst>
        </pc:picChg>
        <pc:picChg chg="mod">
          <ac:chgData name="Kim Ji-Eun" userId="5d7677e0d52343ec" providerId="LiveId" clId="{F023BD75-3484-F245-B723-6E8D9C13CED4}" dt="2023-03-21T06:29:47.528" v="1695" actId="1036"/>
          <ac:picMkLst>
            <pc:docMk/>
            <pc:sldMk cId="2545416559" sldId="267"/>
            <ac:picMk id="355" creationId="{F94B1F86-12DF-1D53-1068-3872EFFCE14D}"/>
          </ac:picMkLst>
        </pc:picChg>
        <pc:picChg chg="mod">
          <ac:chgData name="Kim Ji-Eun" userId="5d7677e0d52343ec" providerId="LiveId" clId="{F023BD75-3484-F245-B723-6E8D9C13CED4}" dt="2023-03-21T06:29:47.528" v="1695" actId="1036"/>
          <ac:picMkLst>
            <pc:docMk/>
            <pc:sldMk cId="2545416559" sldId="267"/>
            <ac:picMk id="410" creationId="{92FA315A-5536-220E-07C9-30A56FCEEA4A}"/>
          </ac:picMkLst>
        </pc:picChg>
        <pc:picChg chg="mod">
          <ac:chgData name="Kim Ji-Eun" userId="5d7677e0d52343ec" providerId="LiveId" clId="{F023BD75-3484-F245-B723-6E8D9C13CED4}" dt="2023-03-21T06:53:12.585" v="1696" actId="1035"/>
          <ac:picMkLst>
            <pc:docMk/>
            <pc:sldMk cId="2545416559" sldId="267"/>
            <ac:picMk id="411" creationId="{687E7C78-E017-3483-46D3-247161897DD0}"/>
          </ac:picMkLst>
        </pc:picChg>
        <pc:picChg chg="mod">
          <ac:chgData name="Kim Ji-Eun" userId="5d7677e0d52343ec" providerId="LiveId" clId="{F023BD75-3484-F245-B723-6E8D9C13CED4}" dt="2023-03-21T06:29:47.528" v="1695" actId="1036"/>
          <ac:picMkLst>
            <pc:docMk/>
            <pc:sldMk cId="2545416559" sldId="267"/>
            <ac:picMk id="412" creationId="{DA141626-AFCE-7CBB-4F65-F245196E29B8}"/>
          </ac:picMkLst>
        </pc:picChg>
        <pc:cxnChg chg="mod">
          <ac:chgData name="Kim Ji-Eun" userId="5d7677e0d52343ec" providerId="LiveId" clId="{F023BD75-3484-F245-B723-6E8D9C13CED4}" dt="2023-03-21T06:29:47.528" v="1695" actId="1036"/>
          <ac:cxnSpMkLst>
            <pc:docMk/>
            <pc:sldMk cId="2545416559" sldId="267"/>
            <ac:cxnSpMk id="3" creationId="{184A693D-69F9-D774-288A-8FA9F6979A16}"/>
          </ac:cxnSpMkLst>
        </pc:cxnChg>
        <pc:cxnChg chg="mod">
          <ac:chgData name="Kim Ji-Eun" userId="5d7677e0d52343ec" providerId="LiveId" clId="{F023BD75-3484-F245-B723-6E8D9C13CED4}" dt="2023-03-21T06:29:47.528" v="1695" actId="1036"/>
          <ac:cxnSpMkLst>
            <pc:docMk/>
            <pc:sldMk cId="2545416559" sldId="267"/>
            <ac:cxnSpMk id="12" creationId="{A84B1EFA-5BE3-8B46-85AE-E5733222023E}"/>
          </ac:cxnSpMkLst>
        </pc:cxnChg>
        <pc:cxnChg chg="add del mod">
          <ac:chgData name="Kim Ji-Eun" userId="5d7677e0d52343ec" providerId="LiveId" clId="{F023BD75-3484-F245-B723-6E8D9C13CED4}" dt="2023-03-21T05:51:47.858" v="965" actId="21"/>
          <ac:cxnSpMkLst>
            <pc:docMk/>
            <pc:sldMk cId="2545416559" sldId="267"/>
            <ac:cxnSpMk id="35" creationId="{646B0319-FB7D-0917-BEF4-A73F88DB9B5B}"/>
          </ac:cxnSpMkLst>
        </pc:cxnChg>
        <pc:cxnChg chg="add del mod">
          <ac:chgData name="Kim Ji-Eun" userId="5d7677e0d52343ec" providerId="LiveId" clId="{F023BD75-3484-F245-B723-6E8D9C13CED4}" dt="2023-03-21T05:51:47.858" v="965" actId="21"/>
          <ac:cxnSpMkLst>
            <pc:docMk/>
            <pc:sldMk cId="2545416559" sldId="267"/>
            <ac:cxnSpMk id="36" creationId="{28E0541D-1CF0-2867-E272-C2A42400898B}"/>
          </ac:cxnSpMkLst>
        </pc:cxnChg>
        <pc:cxnChg chg="add del mod">
          <ac:chgData name="Kim Ji-Eun" userId="5d7677e0d52343ec" providerId="LiveId" clId="{F023BD75-3484-F245-B723-6E8D9C13CED4}" dt="2023-03-21T05:51:47.858" v="965" actId="21"/>
          <ac:cxnSpMkLst>
            <pc:docMk/>
            <pc:sldMk cId="2545416559" sldId="267"/>
            <ac:cxnSpMk id="37" creationId="{9AFF7688-A424-7A97-B30E-2122B6EBD113}"/>
          </ac:cxnSpMkLst>
        </pc:cxnChg>
        <pc:cxnChg chg="add del mod">
          <ac:chgData name="Kim Ji-Eun" userId="5d7677e0d52343ec" providerId="LiveId" clId="{F023BD75-3484-F245-B723-6E8D9C13CED4}" dt="2023-03-21T05:51:47.858" v="965" actId="21"/>
          <ac:cxnSpMkLst>
            <pc:docMk/>
            <pc:sldMk cId="2545416559" sldId="267"/>
            <ac:cxnSpMk id="38" creationId="{A995A19A-A505-B841-766A-779429E2FA5C}"/>
          </ac:cxnSpMkLst>
        </pc:cxnChg>
        <pc:cxnChg chg="del">
          <ac:chgData name="Kim Ji-Eun" userId="5d7677e0d52343ec" providerId="LiveId" clId="{F023BD75-3484-F245-B723-6E8D9C13CED4}" dt="2023-03-21T05:51:22.989" v="963" actId="478"/>
          <ac:cxnSpMkLst>
            <pc:docMk/>
            <pc:sldMk cId="2545416559" sldId="267"/>
            <ac:cxnSpMk id="307" creationId="{F5D5262D-D952-C43A-E341-B5FEFDA2D1CF}"/>
          </ac:cxnSpMkLst>
        </pc:cxnChg>
        <pc:cxnChg chg="del">
          <ac:chgData name="Kim Ji-Eun" userId="5d7677e0d52343ec" providerId="LiveId" clId="{F023BD75-3484-F245-B723-6E8D9C13CED4}" dt="2023-03-21T05:51:22.989" v="963" actId="478"/>
          <ac:cxnSpMkLst>
            <pc:docMk/>
            <pc:sldMk cId="2545416559" sldId="267"/>
            <ac:cxnSpMk id="311" creationId="{1B6051EC-AF41-416F-973A-5CCBCE9B7771}"/>
          </ac:cxnSpMkLst>
        </pc:cxnChg>
        <pc:cxnChg chg="del">
          <ac:chgData name="Kim Ji-Eun" userId="5d7677e0d52343ec" providerId="LiveId" clId="{F023BD75-3484-F245-B723-6E8D9C13CED4}" dt="2023-03-21T05:51:22.989" v="963" actId="478"/>
          <ac:cxnSpMkLst>
            <pc:docMk/>
            <pc:sldMk cId="2545416559" sldId="267"/>
            <ac:cxnSpMk id="314" creationId="{0B8126C0-73FA-BA9F-C48D-7AC2E646CD42}"/>
          </ac:cxnSpMkLst>
        </pc:cxnChg>
        <pc:cxnChg chg="del">
          <ac:chgData name="Kim Ji-Eun" userId="5d7677e0d52343ec" providerId="LiveId" clId="{F023BD75-3484-F245-B723-6E8D9C13CED4}" dt="2023-03-21T05:51:22.989" v="963" actId="478"/>
          <ac:cxnSpMkLst>
            <pc:docMk/>
            <pc:sldMk cId="2545416559" sldId="267"/>
            <ac:cxnSpMk id="316" creationId="{3D3E68B9-9A1C-9E76-9715-D68F72DD10FD}"/>
          </ac:cxnSpMkLst>
        </pc:cxnChg>
        <pc:cxnChg chg="del">
          <ac:chgData name="Kim Ji-Eun" userId="5d7677e0d52343ec" providerId="LiveId" clId="{F023BD75-3484-F245-B723-6E8D9C13CED4}" dt="2023-03-21T05:51:22.989" v="963" actId="478"/>
          <ac:cxnSpMkLst>
            <pc:docMk/>
            <pc:sldMk cId="2545416559" sldId="267"/>
            <ac:cxnSpMk id="320" creationId="{F603F11D-FC4C-3C9A-4A84-ABF1C41F4322}"/>
          </ac:cxnSpMkLst>
        </pc:cxnChg>
        <pc:cxnChg chg="del">
          <ac:chgData name="Kim Ji-Eun" userId="5d7677e0d52343ec" providerId="LiveId" clId="{F023BD75-3484-F245-B723-6E8D9C13CED4}" dt="2023-03-21T05:51:22.989" v="963" actId="478"/>
          <ac:cxnSpMkLst>
            <pc:docMk/>
            <pc:sldMk cId="2545416559" sldId="267"/>
            <ac:cxnSpMk id="327" creationId="{FFE85791-88C3-9DA5-D516-E944C4E20408}"/>
          </ac:cxnSpMkLst>
        </pc:cxnChg>
        <pc:cxnChg chg="del">
          <ac:chgData name="Kim Ji-Eun" userId="5d7677e0d52343ec" providerId="LiveId" clId="{F023BD75-3484-F245-B723-6E8D9C13CED4}" dt="2023-03-21T05:51:22.989" v="963" actId="478"/>
          <ac:cxnSpMkLst>
            <pc:docMk/>
            <pc:sldMk cId="2545416559" sldId="267"/>
            <ac:cxnSpMk id="330" creationId="{7526016E-7A5F-2AD7-C53F-28E8F60CBCDC}"/>
          </ac:cxnSpMkLst>
        </pc:cxnChg>
        <pc:cxnChg chg="del">
          <ac:chgData name="Kim Ji-Eun" userId="5d7677e0d52343ec" providerId="LiveId" clId="{F023BD75-3484-F245-B723-6E8D9C13CED4}" dt="2023-03-21T05:51:22.989" v="963" actId="478"/>
          <ac:cxnSpMkLst>
            <pc:docMk/>
            <pc:sldMk cId="2545416559" sldId="267"/>
            <ac:cxnSpMk id="333" creationId="{C416B3E6-0BCC-15DC-B836-0A93E25BA05E}"/>
          </ac:cxnSpMkLst>
        </pc:cxnChg>
        <pc:cxnChg chg="del">
          <ac:chgData name="Kim Ji-Eun" userId="5d7677e0d52343ec" providerId="LiveId" clId="{F023BD75-3484-F245-B723-6E8D9C13CED4}" dt="2023-03-21T05:51:22.989" v="963" actId="478"/>
          <ac:cxnSpMkLst>
            <pc:docMk/>
            <pc:sldMk cId="2545416559" sldId="267"/>
            <ac:cxnSpMk id="338" creationId="{3F49170C-2A1F-8CCD-B10C-9E17062973FA}"/>
          </ac:cxnSpMkLst>
        </pc:cxnChg>
        <pc:cxnChg chg="del">
          <ac:chgData name="Kim Ji-Eun" userId="5d7677e0d52343ec" providerId="LiveId" clId="{F023BD75-3484-F245-B723-6E8D9C13CED4}" dt="2023-03-21T05:51:22.989" v="963" actId="478"/>
          <ac:cxnSpMkLst>
            <pc:docMk/>
            <pc:sldMk cId="2545416559" sldId="267"/>
            <ac:cxnSpMk id="340" creationId="{0A083106-B864-06EE-89DC-714B8C556C95}"/>
          </ac:cxnSpMkLst>
        </pc:cxnChg>
        <pc:cxnChg chg="mod">
          <ac:chgData name="Kim Ji-Eun" userId="5d7677e0d52343ec" providerId="LiveId" clId="{F023BD75-3484-F245-B723-6E8D9C13CED4}" dt="2023-03-21T06:29:47.528" v="1695" actId="1036"/>
          <ac:cxnSpMkLst>
            <pc:docMk/>
            <pc:sldMk cId="2545416559" sldId="267"/>
            <ac:cxnSpMk id="357" creationId="{AF8EA764-DB64-780F-24D9-46DA7C87D4EE}"/>
          </ac:cxnSpMkLst>
        </pc:cxnChg>
        <pc:cxnChg chg="mod">
          <ac:chgData name="Kim Ji-Eun" userId="5d7677e0d52343ec" providerId="LiveId" clId="{F023BD75-3484-F245-B723-6E8D9C13CED4}" dt="2023-03-21T06:29:47.528" v="1695" actId="1036"/>
          <ac:cxnSpMkLst>
            <pc:docMk/>
            <pc:sldMk cId="2545416559" sldId="267"/>
            <ac:cxnSpMk id="413" creationId="{4DA8B1ED-5B55-C0E1-0A34-6E8758FC9090}"/>
          </ac:cxnSpMkLst>
        </pc:cxnChg>
        <pc:cxnChg chg="mod">
          <ac:chgData name="Kim Ji-Eun" userId="5d7677e0d52343ec" providerId="LiveId" clId="{F023BD75-3484-F245-B723-6E8D9C13CED4}" dt="2023-03-21T06:29:47.528" v="1695" actId="1036"/>
          <ac:cxnSpMkLst>
            <pc:docMk/>
            <pc:sldMk cId="2545416559" sldId="267"/>
            <ac:cxnSpMk id="415" creationId="{3E521C56-9E7B-B4A5-AC09-2F4274B5FD84}"/>
          </ac:cxnSpMkLst>
        </pc:cxnChg>
        <pc:cxnChg chg="mod">
          <ac:chgData name="Kim Ji-Eun" userId="5d7677e0d52343ec" providerId="LiveId" clId="{F023BD75-3484-F245-B723-6E8D9C13CED4}" dt="2023-03-21T06:29:47.528" v="1695" actId="1036"/>
          <ac:cxnSpMkLst>
            <pc:docMk/>
            <pc:sldMk cId="2545416559" sldId="267"/>
            <ac:cxnSpMk id="416" creationId="{E475CD73-EBB8-C983-A30D-B94CB938CEA8}"/>
          </ac:cxnSpMkLst>
        </pc:cxnChg>
      </pc:sldChg>
      <pc:sldChg chg="modSp mod">
        <pc:chgData name="Kim Ji-Eun" userId="5d7677e0d52343ec" providerId="LiveId" clId="{F023BD75-3484-F245-B723-6E8D9C13CED4}" dt="2023-04-03T04:54:11.432" v="2969" actId="20577"/>
        <pc:sldMkLst>
          <pc:docMk/>
          <pc:sldMk cId="1502725139" sldId="268"/>
        </pc:sldMkLst>
        <pc:spChg chg="mod">
          <ac:chgData name="Kim Ji-Eun" userId="5d7677e0d52343ec" providerId="LiveId" clId="{F023BD75-3484-F245-B723-6E8D9C13CED4}" dt="2023-04-03T04:54:05.673" v="2964" actId="20577"/>
          <ac:spMkLst>
            <pc:docMk/>
            <pc:sldMk cId="1502725139" sldId="268"/>
            <ac:spMk id="6" creationId="{550F060E-A45A-4453-DCE9-526F1A1BD3A8}"/>
          </ac:spMkLst>
        </pc:spChg>
        <pc:spChg chg="mod">
          <ac:chgData name="Kim Ji-Eun" userId="5d7677e0d52343ec" providerId="LiveId" clId="{F023BD75-3484-F245-B723-6E8D9C13CED4}" dt="2023-04-03T04:54:11.432" v="2969" actId="20577"/>
          <ac:spMkLst>
            <pc:docMk/>
            <pc:sldMk cId="1502725139" sldId="268"/>
            <ac:spMk id="8" creationId="{BCCF4C39-0F13-30AC-3200-8C2E74B3D8DD}"/>
          </ac:spMkLst>
        </pc:spChg>
      </pc:sldChg>
      <pc:sldChg chg="ord">
        <pc:chgData name="Kim Ji-Eun" userId="5d7677e0d52343ec" providerId="LiveId" clId="{F023BD75-3484-F245-B723-6E8D9C13CED4}" dt="2023-03-27T05:16:22.641" v="1709" actId="20578"/>
        <pc:sldMkLst>
          <pc:docMk/>
          <pc:sldMk cId="3579611554" sldId="269"/>
        </pc:sldMkLst>
      </pc:sldChg>
      <pc:sldChg chg="addSp delSp modSp mod">
        <pc:chgData name="Kim Ji-Eun" userId="5d7677e0d52343ec" providerId="LiveId" clId="{F023BD75-3484-F245-B723-6E8D9C13CED4}" dt="2023-03-21T05:46:58.780" v="961" actId="1036"/>
        <pc:sldMkLst>
          <pc:docMk/>
          <pc:sldMk cId="2878931344" sldId="270"/>
        </pc:sldMkLst>
        <pc:spChg chg="add del mod">
          <ac:chgData name="Kim Ji-Eun" userId="5d7677e0d52343ec" providerId="LiveId" clId="{F023BD75-3484-F245-B723-6E8D9C13CED4}" dt="2023-03-21T05:09:37.132" v="233" actId="478"/>
          <ac:spMkLst>
            <pc:docMk/>
            <pc:sldMk cId="2878931344" sldId="270"/>
            <ac:spMk id="2" creationId="{EE9519F4-3B19-05F8-CCFD-496A980403A2}"/>
          </ac:spMkLst>
        </pc:spChg>
        <pc:spChg chg="del">
          <ac:chgData name="Kim Ji-Eun" userId="5d7677e0d52343ec" providerId="LiveId" clId="{F023BD75-3484-F245-B723-6E8D9C13CED4}" dt="2023-03-21T05:08:16.190" v="217" actId="478"/>
          <ac:spMkLst>
            <pc:docMk/>
            <pc:sldMk cId="2878931344" sldId="270"/>
            <ac:spMk id="4" creationId="{0096AAD4-23C1-A966-A2DA-823ED04163C6}"/>
          </ac:spMkLst>
        </pc:spChg>
        <pc:spChg chg="del">
          <ac:chgData name="Kim Ji-Eun" userId="5d7677e0d52343ec" providerId="LiveId" clId="{F023BD75-3484-F245-B723-6E8D9C13CED4}" dt="2023-03-21T05:08:16.190" v="217" actId="478"/>
          <ac:spMkLst>
            <pc:docMk/>
            <pc:sldMk cId="2878931344" sldId="270"/>
            <ac:spMk id="6" creationId="{41295CEF-BA45-6464-86F1-BD7E0E5262EF}"/>
          </ac:spMkLst>
        </pc:spChg>
        <pc:spChg chg="del">
          <ac:chgData name="Kim Ji-Eun" userId="5d7677e0d52343ec" providerId="LiveId" clId="{F023BD75-3484-F245-B723-6E8D9C13CED4}" dt="2023-03-21T05:08:16.190" v="217" actId="478"/>
          <ac:spMkLst>
            <pc:docMk/>
            <pc:sldMk cId="2878931344" sldId="270"/>
            <ac:spMk id="8" creationId="{5937D2B2-790D-9494-BEA6-B6E71A9429A6}"/>
          </ac:spMkLst>
        </pc:spChg>
        <pc:spChg chg="del">
          <ac:chgData name="Kim Ji-Eun" userId="5d7677e0d52343ec" providerId="LiveId" clId="{F023BD75-3484-F245-B723-6E8D9C13CED4}" dt="2023-03-21T05:08:16.190" v="217" actId="478"/>
          <ac:spMkLst>
            <pc:docMk/>
            <pc:sldMk cId="2878931344" sldId="270"/>
            <ac:spMk id="9" creationId="{E10FE34D-457A-4639-1B81-231586AA2284}"/>
          </ac:spMkLst>
        </pc:spChg>
        <pc:spChg chg="del">
          <ac:chgData name="Kim Ji-Eun" userId="5d7677e0d52343ec" providerId="LiveId" clId="{F023BD75-3484-F245-B723-6E8D9C13CED4}" dt="2023-03-21T05:08:16.190" v="217" actId="478"/>
          <ac:spMkLst>
            <pc:docMk/>
            <pc:sldMk cId="2878931344" sldId="270"/>
            <ac:spMk id="12" creationId="{51D1C716-BB8B-5B4A-3B03-AA378BF38C39}"/>
          </ac:spMkLst>
        </pc:spChg>
        <pc:spChg chg="del">
          <ac:chgData name="Kim Ji-Eun" userId="5d7677e0d52343ec" providerId="LiveId" clId="{F023BD75-3484-F245-B723-6E8D9C13CED4}" dt="2023-03-21T05:08:16.190" v="217" actId="478"/>
          <ac:spMkLst>
            <pc:docMk/>
            <pc:sldMk cId="2878931344" sldId="270"/>
            <ac:spMk id="14" creationId="{B71DAD2E-57CF-AA65-544A-71268E68D6F4}"/>
          </ac:spMkLst>
        </pc:spChg>
        <pc:spChg chg="del">
          <ac:chgData name="Kim Ji-Eun" userId="5d7677e0d52343ec" providerId="LiveId" clId="{F023BD75-3484-F245-B723-6E8D9C13CED4}" dt="2023-03-21T05:08:16.190" v="217" actId="478"/>
          <ac:spMkLst>
            <pc:docMk/>
            <pc:sldMk cId="2878931344" sldId="270"/>
            <ac:spMk id="15" creationId="{A16FE05F-D7F6-8BCD-29B5-6244367390D3}"/>
          </ac:spMkLst>
        </pc:spChg>
        <pc:spChg chg="mod topLvl">
          <ac:chgData name="Kim Ji-Eun" userId="5d7677e0d52343ec" providerId="LiveId" clId="{F023BD75-3484-F245-B723-6E8D9C13CED4}" dt="2023-03-21T05:09:17.453" v="230" actId="554"/>
          <ac:spMkLst>
            <pc:docMk/>
            <pc:sldMk cId="2878931344" sldId="270"/>
            <ac:spMk id="31" creationId="{B6D47F70-2771-A19E-30E9-2D8C4E4D7534}"/>
          </ac:spMkLst>
        </pc:spChg>
        <pc:spChg chg="mod topLvl">
          <ac:chgData name="Kim Ji-Eun" userId="5d7677e0d52343ec" providerId="LiveId" clId="{F023BD75-3484-F245-B723-6E8D9C13CED4}" dt="2023-03-21T05:07:46.326" v="216" actId="164"/>
          <ac:spMkLst>
            <pc:docMk/>
            <pc:sldMk cId="2878931344" sldId="270"/>
            <ac:spMk id="56" creationId="{57517BB7-39B9-E3E9-8FF2-DC1EBC92E8A2}"/>
          </ac:spMkLst>
        </pc:spChg>
        <pc:spChg chg="mod topLvl">
          <ac:chgData name="Kim Ji-Eun" userId="5d7677e0d52343ec" providerId="LiveId" clId="{F023BD75-3484-F245-B723-6E8D9C13CED4}" dt="2023-03-21T05:07:46.326" v="216" actId="164"/>
          <ac:spMkLst>
            <pc:docMk/>
            <pc:sldMk cId="2878931344" sldId="270"/>
            <ac:spMk id="57" creationId="{6E0306D2-AED0-3CD3-6AEC-E0E6D510B2C6}"/>
          </ac:spMkLst>
        </pc:spChg>
        <pc:spChg chg="mod topLvl">
          <ac:chgData name="Kim Ji-Eun" userId="5d7677e0d52343ec" providerId="LiveId" clId="{F023BD75-3484-F245-B723-6E8D9C13CED4}" dt="2023-03-21T05:07:46.326" v="216" actId="164"/>
          <ac:spMkLst>
            <pc:docMk/>
            <pc:sldMk cId="2878931344" sldId="270"/>
            <ac:spMk id="58" creationId="{09FB4787-2B58-B4D2-F5D7-51A7A43E155D}"/>
          </ac:spMkLst>
        </pc:spChg>
        <pc:spChg chg="mod topLvl">
          <ac:chgData name="Kim Ji-Eun" userId="5d7677e0d52343ec" providerId="LiveId" clId="{F023BD75-3484-F245-B723-6E8D9C13CED4}" dt="2023-03-21T05:07:46.326" v="216" actId="164"/>
          <ac:spMkLst>
            <pc:docMk/>
            <pc:sldMk cId="2878931344" sldId="270"/>
            <ac:spMk id="59" creationId="{19652ADE-4ADE-4FCB-7FD7-242CCB2F174C}"/>
          </ac:spMkLst>
        </pc:spChg>
        <pc:spChg chg="mod topLvl">
          <ac:chgData name="Kim Ji-Eun" userId="5d7677e0d52343ec" providerId="LiveId" clId="{F023BD75-3484-F245-B723-6E8D9C13CED4}" dt="2023-03-21T05:07:46.326" v="216" actId="164"/>
          <ac:spMkLst>
            <pc:docMk/>
            <pc:sldMk cId="2878931344" sldId="270"/>
            <ac:spMk id="60" creationId="{9C472454-BB35-7CFE-2EEA-C964D70B73F8}"/>
          </ac:spMkLst>
        </pc:spChg>
        <pc:spChg chg="mod topLvl">
          <ac:chgData name="Kim Ji-Eun" userId="5d7677e0d52343ec" providerId="LiveId" clId="{F023BD75-3484-F245-B723-6E8D9C13CED4}" dt="2023-03-21T05:07:46.326" v="216" actId="164"/>
          <ac:spMkLst>
            <pc:docMk/>
            <pc:sldMk cId="2878931344" sldId="270"/>
            <ac:spMk id="61" creationId="{ABDAE305-4265-F19D-3C80-12D80ECF759C}"/>
          </ac:spMkLst>
        </pc:spChg>
        <pc:spChg chg="mod topLvl">
          <ac:chgData name="Kim Ji-Eun" userId="5d7677e0d52343ec" providerId="LiveId" clId="{F023BD75-3484-F245-B723-6E8D9C13CED4}" dt="2023-03-21T05:07:46.326" v="216" actId="164"/>
          <ac:spMkLst>
            <pc:docMk/>
            <pc:sldMk cId="2878931344" sldId="270"/>
            <ac:spMk id="62" creationId="{E9491F7C-9BDE-2BE5-9634-14C7BE152866}"/>
          </ac:spMkLst>
        </pc:spChg>
        <pc:spChg chg="mod topLvl">
          <ac:chgData name="Kim Ji-Eun" userId="5d7677e0d52343ec" providerId="LiveId" clId="{F023BD75-3484-F245-B723-6E8D9C13CED4}" dt="2023-03-21T05:07:46.326" v="216" actId="164"/>
          <ac:spMkLst>
            <pc:docMk/>
            <pc:sldMk cId="2878931344" sldId="270"/>
            <ac:spMk id="63" creationId="{A0CACD89-7030-7857-B931-80379622E37D}"/>
          </ac:spMkLst>
        </pc:spChg>
        <pc:spChg chg="mod topLvl">
          <ac:chgData name="Kim Ji-Eun" userId="5d7677e0d52343ec" providerId="LiveId" clId="{F023BD75-3484-F245-B723-6E8D9C13CED4}" dt="2023-03-21T05:07:46.326" v="216" actId="164"/>
          <ac:spMkLst>
            <pc:docMk/>
            <pc:sldMk cId="2878931344" sldId="270"/>
            <ac:spMk id="64" creationId="{6D0DD93F-5171-0C7A-417E-35347A92BDF6}"/>
          </ac:spMkLst>
        </pc:spChg>
        <pc:spChg chg="mod topLvl">
          <ac:chgData name="Kim Ji-Eun" userId="5d7677e0d52343ec" providerId="LiveId" clId="{F023BD75-3484-F245-B723-6E8D9C13CED4}" dt="2023-03-21T05:07:46.326" v="216" actId="164"/>
          <ac:spMkLst>
            <pc:docMk/>
            <pc:sldMk cId="2878931344" sldId="270"/>
            <ac:spMk id="65" creationId="{7A12AB33-96A4-801A-8EAE-1614C164E4F1}"/>
          </ac:spMkLst>
        </pc:spChg>
        <pc:spChg chg="mod topLvl">
          <ac:chgData name="Kim Ji-Eun" userId="5d7677e0d52343ec" providerId="LiveId" clId="{F023BD75-3484-F245-B723-6E8D9C13CED4}" dt="2023-03-21T05:07:46.326" v="216" actId="164"/>
          <ac:spMkLst>
            <pc:docMk/>
            <pc:sldMk cId="2878931344" sldId="270"/>
            <ac:spMk id="66" creationId="{D6DC039A-9B09-0FFB-4FD2-49150AE5C9BF}"/>
          </ac:spMkLst>
        </pc:spChg>
        <pc:spChg chg="mod topLvl">
          <ac:chgData name="Kim Ji-Eun" userId="5d7677e0d52343ec" providerId="LiveId" clId="{F023BD75-3484-F245-B723-6E8D9C13CED4}" dt="2023-03-21T05:08:27.976" v="219" actId="14100"/>
          <ac:spMkLst>
            <pc:docMk/>
            <pc:sldMk cId="2878931344" sldId="270"/>
            <ac:spMk id="67" creationId="{F808DEC8-AD17-13F6-6301-3B6CB8D38C9F}"/>
          </ac:spMkLst>
        </pc:spChg>
        <pc:spChg chg="mod topLvl">
          <ac:chgData name="Kim Ji-Eun" userId="5d7677e0d52343ec" providerId="LiveId" clId="{F023BD75-3484-F245-B723-6E8D9C13CED4}" dt="2023-03-21T05:07:46.326" v="216" actId="164"/>
          <ac:spMkLst>
            <pc:docMk/>
            <pc:sldMk cId="2878931344" sldId="270"/>
            <ac:spMk id="73" creationId="{AF7C3318-0BB7-6562-154D-88BE9A099008}"/>
          </ac:spMkLst>
        </pc:spChg>
        <pc:spChg chg="mod topLvl">
          <ac:chgData name="Kim Ji-Eun" userId="5d7677e0d52343ec" providerId="LiveId" clId="{F023BD75-3484-F245-B723-6E8D9C13CED4}" dt="2023-03-21T05:09:17.453" v="230" actId="554"/>
          <ac:spMkLst>
            <pc:docMk/>
            <pc:sldMk cId="2878931344" sldId="270"/>
            <ac:spMk id="74" creationId="{A1B101E8-AADD-584D-265F-A16A74E86422}"/>
          </ac:spMkLst>
        </pc:spChg>
        <pc:spChg chg="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82" creationId="{93AF5948-6620-CA91-BA8D-09CF59CCA0F6}"/>
          </ac:spMkLst>
        </pc:spChg>
        <pc:spChg chg="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83" creationId="{0F94B999-67BF-69EB-DDD3-D53BD67C40FB}"/>
          </ac:spMkLst>
        </pc:spChg>
        <pc:spChg chg="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84" creationId="{525F6D02-0907-C779-210E-1A97A72843FE}"/>
          </ac:spMkLst>
        </pc:spChg>
        <pc:spChg chg="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85" creationId="{11AE2A84-73FD-4298-0E4A-83F8F129B7D2}"/>
          </ac:spMkLst>
        </pc:spChg>
        <pc:spChg chg="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86" creationId="{43322D68-E30B-B157-4DA2-B35A8EA005C7}"/>
          </ac:spMkLst>
        </pc:spChg>
        <pc:spChg chg="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87" creationId="{B626D976-CAF0-7556-CC08-266C5CEB4FF7}"/>
          </ac:spMkLst>
        </pc:spChg>
        <pc:spChg chg="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88" creationId="{CB633D61-9B5D-F269-90B3-30E65E377FF2}"/>
          </ac:spMkLst>
        </pc:spChg>
        <pc:spChg chg="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89" creationId="{50FD6AE6-B60F-4D16-84AC-A49A9D05C63A}"/>
          </ac:spMkLst>
        </pc:spChg>
        <pc:spChg chg="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90" creationId="{64F30233-3E02-2467-71D0-43251E65CDBD}"/>
          </ac:spMkLst>
        </pc:spChg>
        <pc:spChg chg="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91" creationId="{81E4E417-2B68-DB4B-410C-786F15234D94}"/>
          </ac:spMkLst>
        </pc:spChg>
        <pc:spChg chg="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92" creationId="{8B4BAE1B-DD24-5C80-51CB-F283133FFC79}"/>
          </ac:spMkLst>
        </pc:spChg>
        <pc:spChg chg="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93" creationId="{433B78C0-5575-1157-D601-F2E3AFDC863A}"/>
          </ac:spMkLst>
        </pc:spChg>
        <pc:spChg chg="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94" creationId="{EC02E33F-00F9-5D9E-AD32-3C0EE5E9BF05}"/>
          </ac:spMkLst>
        </pc:spChg>
        <pc:spChg chg="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95" creationId="{5146E418-0D7F-49B4-FAC7-34468EE948F9}"/>
          </ac:spMkLst>
        </pc:spChg>
        <pc:spChg chg="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96" creationId="{B98A7536-E6F3-A11B-C47F-50518780D5F4}"/>
          </ac:spMkLst>
        </pc:spChg>
        <pc:spChg chg="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97" creationId="{AABC6FF3-91B2-844E-4289-B256087272C4}"/>
          </ac:spMkLst>
        </pc:spChg>
        <pc:spChg chg="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98" creationId="{2DA09A5A-0CDD-645B-F051-C0B5D28F2DC0}"/>
          </ac:spMkLst>
        </pc:spChg>
        <pc:spChg chg="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99" creationId="{E3D73834-656C-AF09-D58B-17373EC1E433}"/>
          </ac:spMkLst>
        </pc:spChg>
        <pc:spChg chg="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100" creationId="{11586941-BA12-DE2B-4F45-23351EEB3CDF}"/>
          </ac:spMkLst>
        </pc:spChg>
        <pc:spChg chg="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101" creationId="{2430BB7A-A3E6-F483-84C0-6BDC506DCDC5}"/>
          </ac:spMkLst>
        </pc:spChg>
        <pc:spChg chg="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102" creationId="{0F877634-CA49-3E2B-5BED-3F492B05903E}"/>
          </ac:spMkLst>
        </pc:spChg>
        <pc:spChg chg="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103" creationId="{54533A27-6AC1-3D7B-93DA-FA9A4AA13BE1}"/>
          </ac:spMkLst>
        </pc:spChg>
        <pc:spChg chg="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104" creationId="{A388D69A-C4A1-C139-86A6-C0D1334A12CD}"/>
          </ac:spMkLst>
        </pc:spChg>
        <pc:spChg chg="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105" creationId="{16A86C3A-4235-FCFD-DFA6-3AC5DD8F087F}"/>
          </ac:spMkLst>
        </pc:spChg>
        <pc:spChg chg="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106" creationId="{D7FBCA9D-C7EC-150E-AA80-B8409F9C7DBD}"/>
          </ac:spMkLst>
        </pc:spChg>
        <pc:spChg chg="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107" creationId="{D0AD5FB0-792F-92B9-FB7D-67555B2C3DD7}"/>
          </ac:spMkLst>
        </pc:spChg>
        <pc:spChg chg="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108" creationId="{7D4F2466-E308-B5F2-7817-3A4CE87781B5}"/>
          </ac:spMkLst>
        </pc:spChg>
        <pc:spChg chg="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109" creationId="{7829A0BF-A585-7E21-747D-1A9E8FA6CD57}"/>
          </ac:spMkLst>
        </pc:spChg>
        <pc:spChg chg="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110" creationId="{B4D95DC4-E269-D1BC-3DB7-D470E444D9E9}"/>
          </ac:spMkLst>
        </pc:spChg>
        <pc:spChg chg="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111" creationId="{040905A6-9818-16E7-4E6B-14DA07043E1C}"/>
          </ac:spMkLst>
        </pc:spChg>
        <pc:spChg chg="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112" creationId="{F54D3546-8EDB-C536-FB3E-02C69920C8C4}"/>
          </ac:spMkLst>
        </pc:spChg>
        <pc:spChg chg="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113" creationId="{DCCF816B-EA62-0426-CCE6-B0041457DF7C}"/>
          </ac:spMkLst>
        </pc:spChg>
        <pc:spChg chg="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114" creationId="{BDEED0D5-096E-638C-E816-3225B737A47A}"/>
          </ac:spMkLst>
        </pc:spChg>
        <pc:spChg chg="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115" creationId="{48B59496-4D9A-3E73-FB66-C20E8AB9C5FC}"/>
          </ac:spMkLst>
        </pc:spChg>
        <pc:spChg chg="add del mod">
          <ac:chgData name="Kim Ji-Eun" userId="5d7677e0d52343ec" providerId="LiveId" clId="{F023BD75-3484-F245-B723-6E8D9C13CED4}" dt="2023-03-21T05:17:25.641" v="296" actId="478"/>
          <ac:spMkLst>
            <pc:docMk/>
            <pc:sldMk cId="2878931344" sldId="270"/>
            <ac:spMk id="129" creationId="{D9340B2E-F789-B6E0-376A-3D622CD42FDF}"/>
          </ac:spMkLst>
        </pc:spChg>
        <pc:spChg chg="add del mod">
          <ac:chgData name="Kim Ji-Eun" userId="5d7677e0d52343ec" providerId="LiveId" clId="{F023BD75-3484-F245-B723-6E8D9C13CED4}" dt="2023-03-21T05:16:56.033" v="263" actId="478"/>
          <ac:spMkLst>
            <pc:docMk/>
            <pc:sldMk cId="2878931344" sldId="270"/>
            <ac:spMk id="130" creationId="{31336F5D-9DC7-9907-B405-0CCBE07F04B1}"/>
          </ac:spMkLst>
        </pc:spChg>
        <pc:spChg chg="add 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131" creationId="{F21B0C99-D838-68AE-643E-A924823A5FD0}"/>
          </ac:spMkLst>
        </pc:spChg>
        <pc:spChg chg="add 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132" creationId="{DD49BC27-1C24-4536-5BE4-9311BF326251}"/>
          </ac:spMkLst>
        </pc:spChg>
        <pc:spChg chg="add 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133" creationId="{E9DD8ABD-AF33-8E9C-4436-3E9245EB2069}"/>
          </ac:spMkLst>
        </pc:spChg>
        <pc:spChg chg="add 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134" creationId="{1A59DBDA-EF7C-C69E-3645-6E146D54EF08}"/>
          </ac:spMkLst>
        </pc:spChg>
        <pc:spChg chg="add 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135" creationId="{C02D7879-D277-DE6E-AE2E-9D319C341FAC}"/>
          </ac:spMkLst>
        </pc:spChg>
        <pc:spChg chg="add 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136" creationId="{638122CD-BDA6-0925-A72C-D48D4C3E91E0}"/>
          </ac:spMkLst>
        </pc:spChg>
        <pc:spChg chg="add 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137" creationId="{B8CBB98F-AFBA-3218-C548-797CDCE3EE87}"/>
          </ac:spMkLst>
        </pc:spChg>
        <pc:spChg chg="add del mod">
          <ac:chgData name="Kim Ji-Eun" userId="5d7677e0d52343ec" providerId="LiveId" clId="{F023BD75-3484-F245-B723-6E8D9C13CED4}" dt="2023-03-21T05:17:24.657" v="295" actId="478"/>
          <ac:spMkLst>
            <pc:docMk/>
            <pc:sldMk cId="2878931344" sldId="270"/>
            <ac:spMk id="138" creationId="{2DD9CD6A-1D12-22EB-64F3-9D809F54EA94}"/>
          </ac:spMkLst>
        </pc:spChg>
        <pc:spChg chg="add del mod">
          <ac:chgData name="Kim Ji-Eun" userId="5d7677e0d52343ec" providerId="LiveId" clId="{F023BD75-3484-F245-B723-6E8D9C13CED4}" dt="2023-03-21T05:16:53.846" v="262"/>
          <ac:spMkLst>
            <pc:docMk/>
            <pc:sldMk cId="2878931344" sldId="270"/>
            <ac:spMk id="139" creationId="{28B5F6F3-0783-AAE3-FB90-6FFD14939BC2}"/>
          </ac:spMkLst>
        </pc:spChg>
        <pc:spChg chg="add del mod">
          <ac:chgData name="Kim Ji-Eun" userId="5d7677e0d52343ec" providerId="LiveId" clId="{F023BD75-3484-F245-B723-6E8D9C13CED4}" dt="2023-03-21T05:16:53.600" v="261"/>
          <ac:spMkLst>
            <pc:docMk/>
            <pc:sldMk cId="2878931344" sldId="270"/>
            <ac:spMk id="140" creationId="{C32D2C19-7184-15FB-66C3-07834CDA7778}"/>
          </ac:spMkLst>
        </pc:spChg>
        <pc:spChg chg="add del mod">
          <ac:chgData name="Kim Ji-Eun" userId="5d7677e0d52343ec" providerId="LiveId" clId="{F023BD75-3484-F245-B723-6E8D9C13CED4}" dt="2023-03-21T05:16:53.264" v="260"/>
          <ac:spMkLst>
            <pc:docMk/>
            <pc:sldMk cId="2878931344" sldId="270"/>
            <ac:spMk id="141" creationId="{7A811C4C-2C34-810E-DDC6-F46FEDD2E687}"/>
          </ac:spMkLst>
        </pc:spChg>
        <pc:spChg chg="add 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144" creationId="{E3A739BB-C4E3-EB64-EAA0-43A0886587BB}"/>
          </ac:spMkLst>
        </pc:spChg>
        <pc:spChg chg="add del mod">
          <ac:chgData name="Kim Ji-Eun" userId="5d7677e0d52343ec" providerId="LiveId" clId="{F023BD75-3484-F245-B723-6E8D9C13CED4}" dt="2023-03-21T05:20:34.947" v="395"/>
          <ac:spMkLst>
            <pc:docMk/>
            <pc:sldMk cId="2878931344" sldId="270"/>
            <ac:spMk id="145" creationId="{388D601C-2900-B9D8-C017-E0A9A4BF51A6}"/>
          </ac:spMkLst>
        </pc:spChg>
        <pc:spChg chg="add 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146" creationId="{88222312-6A87-B31F-36AA-F5AA40C8AC72}"/>
          </ac:spMkLst>
        </pc:spChg>
        <pc:spChg chg="add 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147" creationId="{23B3BFE9-0A38-A428-A6F4-E729FEA88C26}"/>
          </ac:spMkLst>
        </pc:spChg>
        <pc:spChg chg="add 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148" creationId="{217C0701-CC2D-CA92-0CDC-EAE710875090}"/>
          </ac:spMkLst>
        </pc:spChg>
        <pc:spChg chg="add 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149" creationId="{1162B1F8-5C13-570E-CBC2-0EEDF75428A0}"/>
          </ac:spMkLst>
        </pc:spChg>
        <pc:spChg chg="add 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150" creationId="{9B384C0C-288D-A200-634D-AFDE63859840}"/>
          </ac:spMkLst>
        </pc:spChg>
        <pc:spChg chg="add 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151" creationId="{47BBCE17-4E6D-5928-1046-E471402B44EE}"/>
          </ac:spMkLst>
        </pc:spChg>
        <pc:spChg chg="add 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152" creationId="{608F05F7-5708-3599-1F3E-CC8FB8B2737F}"/>
          </ac:spMkLst>
        </pc:spChg>
        <pc:spChg chg="add 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153" creationId="{3DFF8AB8-8DB9-756A-3CF6-08C310BBD150}"/>
          </ac:spMkLst>
        </pc:spChg>
        <pc:spChg chg="add 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154" creationId="{55386BA6-596B-6C3F-F47D-D9A530252BEF}"/>
          </ac:spMkLst>
        </pc:spChg>
        <pc:spChg chg="add 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155" creationId="{09565062-3200-EC07-F972-AB19E45F4621}"/>
          </ac:spMkLst>
        </pc:spChg>
        <pc:spChg chg="add 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156" creationId="{653F35E4-5CB1-2C13-7F00-09F8892ECF65}"/>
          </ac:spMkLst>
        </pc:spChg>
        <pc:spChg chg="add 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157" creationId="{7E688D2B-6706-F288-C549-0E47712F1EB0}"/>
          </ac:spMkLst>
        </pc:spChg>
        <pc:spChg chg="add 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158" creationId="{3D24777A-B3E8-5F6B-2A3C-FD14BC405631}"/>
          </ac:spMkLst>
        </pc:spChg>
        <pc:spChg chg="add 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159" creationId="{1665BBAE-E0A0-2FC2-2FC1-4EB6CF4488F1}"/>
          </ac:spMkLst>
        </pc:spChg>
        <pc:spChg chg="add 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160" creationId="{503C3FE1-4300-0B60-2195-155DAB507CF2}"/>
          </ac:spMkLst>
        </pc:spChg>
        <pc:spChg chg="add 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161" creationId="{9C273241-01C2-4A33-A006-BBE972B857EC}"/>
          </ac:spMkLst>
        </pc:spChg>
        <pc:spChg chg="add 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162" creationId="{27B3637C-2915-6D76-B197-255F54CF1055}"/>
          </ac:spMkLst>
        </pc:spChg>
        <pc:spChg chg="add 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163" creationId="{476D20B2-FEC8-EC48-9493-E449BEE1DCBE}"/>
          </ac:spMkLst>
        </pc:spChg>
        <pc:spChg chg="add 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164" creationId="{7805B179-F518-3FB5-F572-0A040638FFE1}"/>
          </ac:spMkLst>
        </pc:spChg>
        <pc:spChg chg="add 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165" creationId="{E8279AAF-C092-E6D5-5530-88A30F894A1C}"/>
          </ac:spMkLst>
        </pc:spChg>
        <pc:spChg chg="add 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166" creationId="{07972B82-E2DF-8B63-BE59-6164119C147E}"/>
          </ac:spMkLst>
        </pc:spChg>
        <pc:spChg chg="add 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167" creationId="{2E9116B0-AB85-98C6-8F6E-3380C8A4DE9B}"/>
          </ac:spMkLst>
        </pc:spChg>
        <pc:spChg chg="add 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168" creationId="{2E98C67F-20E8-894A-33FE-936FB8C9EEFC}"/>
          </ac:spMkLst>
        </pc:spChg>
        <pc:spChg chg="add 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169" creationId="{77512C16-8E79-8A0D-B47B-21DE2A87B9AF}"/>
          </ac:spMkLst>
        </pc:spChg>
        <pc:spChg chg="add 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170" creationId="{5DC0775C-9F37-9893-BCAC-D1782457E74A}"/>
          </ac:spMkLst>
        </pc:spChg>
        <pc:spChg chg="add mod topLvl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171" creationId="{02E0720E-3A08-723D-DAC8-A08181000D5D}"/>
          </ac:spMkLst>
        </pc:spChg>
        <pc:spChg chg="add mod">
          <ac:chgData name="Kim Ji-Eun" userId="5d7677e0d52343ec" providerId="LiveId" clId="{F023BD75-3484-F245-B723-6E8D9C13CED4}" dt="2023-03-21T05:45:21.867" v="940" actId="164"/>
          <ac:spMkLst>
            <pc:docMk/>
            <pc:sldMk cId="2878931344" sldId="270"/>
            <ac:spMk id="206" creationId="{69E21CBA-4E56-3943-0BC0-8E2E1695BA17}"/>
          </ac:spMkLst>
        </pc:spChg>
        <pc:grpChg chg="add del mod">
          <ac:chgData name="Kim Ji-Eun" userId="5d7677e0d52343ec" providerId="LiveId" clId="{F023BD75-3484-F245-B723-6E8D9C13CED4}" dt="2023-03-21T05:05:02.731" v="107" actId="165"/>
          <ac:grpSpMkLst>
            <pc:docMk/>
            <pc:sldMk cId="2878931344" sldId="270"/>
            <ac:grpSpMk id="10" creationId="{5ECC78AD-FD67-0A6A-2DB5-DF137EEA5043}"/>
          </ac:grpSpMkLst>
        </pc:grpChg>
        <pc:grpChg chg="del">
          <ac:chgData name="Kim Ji-Eun" userId="5d7677e0d52343ec" providerId="LiveId" clId="{F023BD75-3484-F245-B723-6E8D9C13CED4}" dt="2023-03-21T05:45:24.249" v="941" actId="478"/>
          <ac:grpSpMkLst>
            <pc:docMk/>
            <pc:sldMk cId="2878931344" sldId="270"/>
            <ac:grpSpMk id="72" creationId="{E7E50712-3163-7287-BCB1-B4B6822A3DA1}"/>
          </ac:grpSpMkLst>
        </pc:grpChg>
        <pc:grpChg chg="add del mod">
          <ac:chgData name="Kim Ji-Eun" userId="5d7677e0d52343ec" providerId="LiveId" clId="{F023BD75-3484-F245-B723-6E8D9C13CED4}" dt="2023-03-21T05:18:42.654" v="305" actId="165"/>
          <ac:grpSpMkLst>
            <pc:docMk/>
            <pc:sldMk cId="2878931344" sldId="270"/>
            <ac:grpSpMk id="76" creationId="{BC0B7D83-BB59-5ED9-5215-79EF1214613E}"/>
          </ac:grpSpMkLst>
        </pc:grpChg>
        <pc:grpChg chg="add mod">
          <ac:chgData name="Kim Ji-Eun" userId="5d7677e0d52343ec" providerId="LiveId" clId="{F023BD75-3484-F245-B723-6E8D9C13CED4}" dt="2023-03-21T05:46:50.441" v="943" actId="164"/>
          <ac:grpSpMkLst>
            <pc:docMk/>
            <pc:sldMk cId="2878931344" sldId="270"/>
            <ac:grpSpMk id="127" creationId="{9EAF3C81-A795-7EC2-9602-577A89956EA1}"/>
          </ac:grpSpMkLst>
        </pc:grpChg>
        <pc:grpChg chg="add mod">
          <ac:chgData name="Kim Ji-Eun" userId="5d7677e0d52343ec" providerId="LiveId" clId="{F023BD75-3484-F245-B723-6E8D9C13CED4}" dt="2023-03-21T05:20:21.148" v="390" actId="164"/>
          <ac:grpSpMkLst>
            <pc:docMk/>
            <pc:sldMk cId="2878931344" sldId="270"/>
            <ac:grpSpMk id="142" creationId="{CF9838B0-D242-B699-40B9-40A6AD662FED}"/>
          </ac:grpSpMkLst>
        </pc:grpChg>
        <pc:grpChg chg="add mod">
          <ac:chgData name="Kim Ji-Eun" userId="5d7677e0d52343ec" providerId="LiveId" clId="{F023BD75-3484-F245-B723-6E8D9C13CED4}" dt="2023-03-21T05:20:20.884" v="389" actId="164"/>
          <ac:grpSpMkLst>
            <pc:docMk/>
            <pc:sldMk cId="2878931344" sldId="270"/>
            <ac:grpSpMk id="143" creationId="{E34F6B25-9F4E-42B1-A617-C19FA7F15D22}"/>
          </ac:grpSpMkLst>
        </pc:grpChg>
        <pc:grpChg chg="add del mod">
          <ac:chgData name="Kim Ji-Eun" userId="5d7677e0d52343ec" providerId="LiveId" clId="{F023BD75-3484-F245-B723-6E8D9C13CED4}" dt="2023-03-21T05:40:46.314" v="765" actId="165"/>
          <ac:grpSpMkLst>
            <pc:docMk/>
            <pc:sldMk cId="2878931344" sldId="270"/>
            <ac:grpSpMk id="172" creationId="{9D164CCC-BA88-9F05-696C-ADB5BA34BF28}"/>
          </ac:grpSpMkLst>
        </pc:grpChg>
        <pc:grpChg chg="add del mod">
          <ac:chgData name="Kim Ji-Eun" userId="5d7677e0d52343ec" providerId="LiveId" clId="{F023BD75-3484-F245-B723-6E8D9C13CED4}" dt="2023-03-21T05:40:46.314" v="765" actId="165"/>
          <ac:grpSpMkLst>
            <pc:docMk/>
            <pc:sldMk cId="2878931344" sldId="270"/>
            <ac:grpSpMk id="173" creationId="{2EBE192C-2994-594C-3B82-AD58D5B0E9A9}"/>
          </ac:grpSpMkLst>
        </pc:grpChg>
        <pc:grpChg chg="add del mod">
          <ac:chgData name="Kim Ji-Eun" userId="5d7677e0d52343ec" providerId="LiveId" clId="{F023BD75-3484-F245-B723-6E8D9C13CED4}" dt="2023-03-21T05:40:46.314" v="765" actId="165"/>
          <ac:grpSpMkLst>
            <pc:docMk/>
            <pc:sldMk cId="2878931344" sldId="270"/>
            <ac:grpSpMk id="174" creationId="{F1AF5624-8BD2-CB5D-78A6-025FBFBACD44}"/>
          </ac:grpSpMkLst>
        </pc:grpChg>
        <pc:grpChg chg="add del mod">
          <ac:chgData name="Kim Ji-Eun" userId="5d7677e0d52343ec" providerId="LiveId" clId="{F023BD75-3484-F245-B723-6E8D9C13CED4}" dt="2023-03-21T05:40:46.314" v="765" actId="165"/>
          <ac:grpSpMkLst>
            <pc:docMk/>
            <pc:sldMk cId="2878931344" sldId="270"/>
            <ac:grpSpMk id="175" creationId="{1550A736-3429-8777-DF19-5328EBA0E9BC}"/>
          </ac:grpSpMkLst>
        </pc:grpChg>
        <pc:grpChg chg="add del mod">
          <ac:chgData name="Kim Ji-Eun" userId="5d7677e0d52343ec" providerId="LiveId" clId="{F023BD75-3484-F245-B723-6E8D9C13CED4}" dt="2023-03-21T05:40:46.314" v="765" actId="165"/>
          <ac:grpSpMkLst>
            <pc:docMk/>
            <pc:sldMk cId="2878931344" sldId="270"/>
            <ac:grpSpMk id="176" creationId="{3FB6282E-12B5-9FAD-8ACA-27F2B4A0DD63}"/>
          </ac:grpSpMkLst>
        </pc:grpChg>
        <pc:grpChg chg="add del mod">
          <ac:chgData name="Kim Ji-Eun" userId="5d7677e0d52343ec" providerId="LiveId" clId="{F023BD75-3484-F245-B723-6E8D9C13CED4}" dt="2023-03-21T05:40:46.314" v="765" actId="165"/>
          <ac:grpSpMkLst>
            <pc:docMk/>
            <pc:sldMk cId="2878931344" sldId="270"/>
            <ac:grpSpMk id="177" creationId="{9C92914C-5B9D-14AE-9618-2C2ADB6D6C6E}"/>
          </ac:grpSpMkLst>
        </pc:grpChg>
        <pc:grpChg chg="add del mod">
          <ac:chgData name="Kim Ji-Eun" userId="5d7677e0d52343ec" providerId="LiveId" clId="{F023BD75-3484-F245-B723-6E8D9C13CED4}" dt="2023-03-21T05:40:46.314" v="765" actId="165"/>
          <ac:grpSpMkLst>
            <pc:docMk/>
            <pc:sldMk cId="2878931344" sldId="270"/>
            <ac:grpSpMk id="178" creationId="{A138AED2-9B33-E39E-C1F8-22A54A6EB8C2}"/>
          </ac:grpSpMkLst>
        </pc:grpChg>
        <pc:grpChg chg="add del mod">
          <ac:chgData name="Kim Ji-Eun" userId="5d7677e0d52343ec" providerId="LiveId" clId="{F023BD75-3484-F245-B723-6E8D9C13CED4}" dt="2023-03-21T05:40:46.314" v="765" actId="165"/>
          <ac:grpSpMkLst>
            <pc:docMk/>
            <pc:sldMk cId="2878931344" sldId="270"/>
            <ac:grpSpMk id="179" creationId="{1FF5DEF7-159B-0E2B-58EA-2B60879D2265}"/>
          </ac:grpSpMkLst>
        </pc:grpChg>
        <pc:grpChg chg="add del mod">
          <ac:chgData name="Kim Ji-Eun" userId="5d7677e0d52343ec" providerId="LiveId" clId="{F023BD75-3484-F245-B723-6E8D9C13CED4}" dt="2023-03-21T05:40:46.314" v="765" actId="165"/>
          <ac:grpSpMkLst>
            <pc:docMk/>
            <pc:sldMk cId="2878931344" sldId="270"/>
            <ac:grpSpMk id="180" creationId="{57198573-1D70-AB40-3AF4-0EFB4AF5BF23}"/>
          </ac:grpSpMkLst>
        </pc:grpChg>
        <pc:grpChg chg="add del mod">
          <ac:chgData name="Kim Ji-Eun" userId="5d7677e0d52343ec" providerId="LiveId" clId="{F023BD75-3484-F245-B723-6E8D9C13CED4}" dt="2023-03-21T05:40:46.314" v="765" actId="165"/>
          <ac:grpSpMkLst>
            <pc:docMk/>
            <pc:sldMk cId="2878931344" sldId="270"/>
            <ac:grpSpMk id="181" creationId="{59533DE8-8FF6-4B90-A007-3842E17DBDC5}"/>
          </ac:grpSpMkLst>
        </pc:grpChg>
        <pc:grpChg chg="add del mod">
          <ac:chgData name="Kim Ji-Eun" userId="5d7677e0d52343ec" providerId="LiveId" clId="{F023BD75-3484-F245-B723-6E8D9C13CED4}" dt="2023-03-21T05:40:46.314" v="765" actId="165"/>
          <ac:grpSpMkLst>
            <pc:docMk/>
            <pc:sldMk cId="2878931344" sldId="270"/>
            <ac:grpSpMk id="182" creationId="{5255400F-01B3-21F2-BAF4-C12008C8EEC3}"/>
          </ac:grpSpMkLst>
        </pc:grpChg>
        <pc:grpChg chg="add del mod">
          <ac:chgData name="Kim Ji-Eun" userId="5d7677e0d52343ec" providerId="LiveId" clId="{F023BD75-3484-F245-B723-6E8D9C13CED4}" dt="2023-03-21T05:40:46.314" v="765" actId="165"/>
          <ac:grpSpMkLst>
            <pc:docMk/>
            <pc:sldMk cId="2878931344" sldId="270"/>
            <ac:grpSpMk id="183" creationId="{9655D6B2-9B30-0644-FE99-B4EE84EA1C65}"/>
          </ac:grpSpMkLst>
        </pc:grpChg>
        <pc:grpChg chg="add del mod">
          <ac:chgData name="Kim Ji-Eun" userId="5d7677e0d52343ec" providerId="LiveId" clId="{F023BD75-3484-F245-B723-6E8D9C13CED4}" dt="2023-03-21T05:40:46.314" v="765" actId="165"/>
          <ac:grpSpMkLst>
            <pc:docMk/>
            <pc:sldMk cId="2878931344" sldId="270"/>
            <ac:grpSpMk id="184" creationId="{260F00EB-AB11-0EE7-390C-3DFA93E0F5D0}"/>
          </ac:grpSpMkLst>
        </pc:grpChg>
        <pc:grpChg chg="add del mod">
          <ac:chgData name="Kim Ji-Eun" userId="5d7677e0d52343ec" providerId="LiveId" clId="{F023BD75-3484-F245-B723-6E8D9C13CED4}" dt="2023-03-21T05:41:22.303" v="770" actId="165"/>
          <ac:grpSpMkLst>
            <pc:docMk/>
            <pc:sldMk cId="2878931344" sldId="270"/>
            <ac:grpSpMk id="185" creationId="{8E2FE12C-B671-31A7-FE4F-50D88ABFB67B}"/>
          </ac:grpSpMkLst>
        </pc:grpChg>
        <pc:grpChg chg="add del mod">
          <ac:chgData name="Kim Ji-Eun" userId="5d7677e0d52343ec" providerId="LiveId" clId="{F023BD75-3484-F245-B723-6E8D9C13CED4}" dt="2023-03-21T05:40:46.314" v="765" actId="165"/>
          <ac:grpSpMkLst>
            <pc:docMk/>
            <pc:sldMk cId="2878931344" sldId="270"/>
            <ac:grpSpMk id="186" creationId="{A4929A75-CE3C-88A8-36F9-1D73CB35B18F}"/>
          </ac:grpSpMkLst>
        </pc:grpChg>
        <pc:grpChg chg="add del mod">
          <ac:chgData name="Kim Ji-Eun" userId="5d7677e0d52343ec" providerId="LiveId" clId="{F023BD75-3484-F245-B723-6E8D9C13CED4}" dt="2023-03-21T05:41:22.303" v="770" actId="165"/>
          <ac:grpSpMkLst>
            <pc:docMk/>
            <pc:sldMk cId="2878931344" sldId="270"/>
            <ac:grpSpMk id="187" creationId="{AE407874-048A-80F6-8E97-0E8C197DC446}"/>
          </ac:grpSpMkLst>
        </pc:grpChg>
        <pc:grpChg chg="add del mod">
          <ac:chgData name="Kim Ji-Eun" userId="5d7677e0d52343ec" providerId="LiveId" clId="{F023BD75-3484-F245-B723-6E8D9C13CED4}" dt="2023-03-21T05:40:46.314" v="765" actId="165"/>
          <ac:grpSpMkLst>
            <pc:docMk/>
            <pc:sldMk cId="2878931344" sldId="270"/>
            <ac:grpSpMk id="188" creationId="{55138C70-717D-DE4B-397B-32EC3CEB8315}"/>
          </ac:grpSpMkLst>
        </pc:grpChg>
        <pc:grpChg chg="add del mod">
          <ac:chgData name="Kim Ji-Eun" userId="5d7677e0d52343ec" providerId="LiveId" clId="{F023BD75-3484-F245-B723-6E8D9C13CED4}" dt="2023-03-21T05:40:46.314" v="765" actId="165"/>
          <ac:grpSpMkLst>
            <pc:docMk/>
            <pc:sldMk cId="2878931344" sldId="270"/>
            <ac:grpSpMk id="189" creationId="{2CE2CF82-DDAD-A22B-FF5C-65A801FF6150}"/>
          </ac:grpSpMkLst>
        </pc:grpChg>
        <pc:grpChg chg="add del mod">
          <ac:chgData name="Kim Ji-Eun" userId="5d7677e0d52343ec" providerId="LiveId" clId="{F023BD75-3484-F245-B723-6E8D9C13CED4}" dt="2023-03-21T05:40:46.314" v="765" actId="165"/>
          <ac:grpSpMkLst>
            <pc:docMk/>
            <pc:sldMk cId="2878931344" sldId="270"/>
            <ac:grpSpMk id="190" creationId="{0276E34E-6BBD-4F67-C3FD-FAF93F5F953B}"/>
          </ac:grpSpMkLst>
        </pc:grpChg>
        <pc:grpChg chg="add del mod">
          <ac:chgData name="Kim Ji-Eun" userId="5d7677e0d52343ec" providerId="LiveId" clId="{F023BD75-3484-F245-B723-6E8D9C13CED4}" dt="2023-03-21T05:41:22.303" v="770" actId="165"/>
          <ac:grpSpMkLst>
            <pc:docMk/>
            <pc:sldMk cId="2878931344" sldId="270"/>
            <ac:grpSpMk id="191" creationId="{7A354B72-68B9-8FD3-B9A7-82F3F24881BB}"/>
          </ac:grpSpMkLst>
        </pc:grpChg>
        <pc:grpChg chg="add del mod">
          <ac:chgData name="Kim Ji-Eun" userId="5d7677e0d52343ec" providerId="LiveId" clId="{F023BD75-3484-F245-B723-6E8D9C13CED4}" dt="2023-03-21T05:40:46.314" v="765" actId="165"/>
          <ac:grpSpMkLst>
            <pc:docMk/>
            <pc:sldMk cId="2878931344" sldId="270"/>
            <ac:grpSpMk id="192" creationId="{380E614C-7C0B-EAC0-737A-128A00570BF7}"/>
          </ac:grpSpMkLst>
        </pc:grpChg>
        <pc:grpChg chg="add del mod">
          <ac:chgData name="Kim Ji-Eun" userId="5d7677e0d52343ec" providerId="LiveId" clId="{F023BD75-3484-F245-B723-6E8D9C13CED4}" dt="2023-03-21T05:40:46.314" v="765" actId="165"/>
          <ac:grpSpMkLst>
            <pc:docMk/>
            <pc:sldMk cId="2878931344" sldId="270"/>
            <ac:grpSpMk id="193" creationId="{49B76E8F-311C-4DA3-D55B-968F672E4CA5}"/>
          </ac:grpSpMkLst>
        </pc:grpChg>
        <pc:grpChg chg="add del mod">
          <ac:chgData name="Kim Ji-Eun" userId="5d7677e0d52343ec" providerId="LiveId" clId="{F023BD75-3484-F245-B723-6E8D9C13CED4}" dt="2023-03-21T05:40:46.314" v="765" actId="165"/>
          <ac:grpSpMkLst>
            <pc:docMk/>
            <pc:sldMk cId="2878931344" sldId="270"/>
            <ac:grpSpMk id="194" creationId="{77C7E04E-8496-ACCC-E591-A1373EB001C4}"/>
          </ac:grpSpMkLst>
        </pc:grpChg>
        <pc:grpChg chg="add del mod">
          <ac:chgData name="Kim Ji-Eun" userId="5d7677e0d52343ec" providerId="LiveId" clId="{F023BD75-3484-F245-B723-6E8D9C13CED4}" dt="2023-03-21T05:40:46.314" v="765" actId="165"/>
          <ac:grpSpMkLst>
            <pc:docMk/>
            <pc:sldMk cId="2878931344" sldId="270"/>
            <ac:grpSpMk id="195" creationId="{74237809-AADC-5378-D7D9-EA8BA6D2BAE5}"/>
          </ac:grpSpMkLst>
        </pc:grpChg>
        <pc:grpChg chg="add del mod">
          <ac:chgData name="Kim Ji-Eun" userId="5d7677e0d52343ec" providerId="LiveId" clId="{F023BD75-3484-F245-B723-6E8D9C13CED4}" dt="2023-03-21T05:40:46.314" v="765" actId="165"/>
          <ac:grpSpMkLst>
            <pc:docMk/>
            <pc:sldMk cId="2878931344" sldId="270"/>
            <ac:grpSpMk id="196" creationId="{491DD901-C932-BFBD-E730-FDF14796BB81}"/>
          </ac:grpSpMkLst>
        </pc:grpChg>
        <pc:grpChg chg="add del mod">
          <ac:chgData name="Kim Ji-Eun" userId="5d7677e0d52343ec" providerId="LiveId" clId="{F023BD75-3484-F245-B723-6E8D9C13CED4}" dt="2023-03-21T05:40:46.314" v="765" actId="165"/>
          <ac:grpSpMkLst>
            <pc:docMk/>
            <pc:sldMk cId="2878931344" sldId="270"/>
            <ac:grpSpMk id="197" creationId="{B4820C09-FDC9-44F5-D4A5-066A2281F6EA}"/>
          </ac:grpSpMkLst>
        </pc:grpChg>
        <pc:grpChg chg="add del mod">
          <ac:chgData name="Kim Ji-Eun" userId="5d7677e0d52343ec" providerId="LiveId" clId="{F023BD75-3484-F245-B723-6E8D9C13CED4}" dt="2023-03-21T05:40:46.314" v="765" actId="165"/>
          <ac:grpSpMkLst>
            <pc:docMk/>
            <pc:sldMk cId="2878931344" sldId="270"/>
            <ac:grpSpMk id="198" creationId="{B76B1518-367F-B238-55F3-14A91ADC50A2}"/>
          </ac:grpSpMkLst>
        </pc:grpChg>
        <pc:grpChg chg="add del mod">
          <ac:chgData name="Kim Ji-Eun" userId="5d7677e0d52343ec" providerId="LiveId" clId="{F023BD75-3484-F245-B723-6E8D9C13CED4}" dt="2023-03-21T05:40:46.314" v="765" actId="165"/>
          <ac:grpSpMkLst>
            <pc:docMk/>
            <pc:sldMk cId="2878931344" sldId="270"/>
            <ac:grpSpMk id="199" creationId="{1E95BA1F-AC4E-B0EA-B4FE-4992C65129EC}"/>
          </ac:grpSpMkLst>
        </pc:grpChg>
        <pc:grpChg chg="add del mod">
          <ac:chgData name="Kim Ji-Eun" userId="5d7677e0d52343ec" providerId="LiveId" clId="{F023BD75-3484-F245-B723-6E8D9C13CED4}" dt="2023-03-21T05:40:46.314" v="765" actId="165"/>
          <ac:grpSpMkLst>
            <pc:docMk/>
            <pc:sldMk cId="2878931344" sldId="270"/>
            <ac:grpSpMk id="200" creationId="{433C2666-29C7-CDB7-BFCC-FC4D2049252B}"/>
          </ac:grpSpMkLst>
        </pc:grpChg>
        <pc:grpChg chg="add del mod">
          <ac:chgData name="Kim Ji-Eun" userId="5d7677e0d52343ec" providerId="LiveId" clId="{F023BD75-3484-F245-B723-6E8D9C13CED4}" dt="2023-03-21T05:40:46.314" v="765" actId="165"/>
          <ac:grpSpMkLst>
            <pc:docMk/>
            <pc:sldMk cId="2878931344" sldId="270"/>
            <ac:grpSpMk id="201" creationId="{4BB6B28C-12AB-31DD-A0F3-ACF247E2BF41}"/>
          </ac:grpSpMkLst>
        </pc:grpChg>
        <pc:grpChg chg="add del mod">
          <ac:chgData name="Kim Ji-Eun" userId="5d7677e0d52343ec" providerId="LiveId" clId="{F023BD75-3484-F245-B723-6E8D9C13CED4}" dt="2023-03-21T05:40:46.314" v="765" actId="165"/>
          <ac:grpSpMkLst>
            <pc:docMk/>
            <pc:sldMk cId="2878931344" sldId="270"/>
            <ac:grpSpMk id="202" creationId="{5E2A976C-553E-4456-F40D-E15DAF47F041}"/>
          </ac:grpSpMkLst>
        </pc:grpChg>
        <pc:grpChg chg="add del mod">
          <ac:chgData name="Kim Ji-Eun" userId="5d7677e0d52343ec" providerId="LiveId" clId="{F023BD75-3484-F245-B723-6E8D9C13CED4}" dt="2023-03-21T05:40:46.314" v="765" actId="165"/>
          <ac:grpSpMkLst>
            <pc:docMk/>
            <pc:sldMk cId="2878931344" sldId="270"/>
            <ac:grpSpMk id="203" creationId="{63EB7EEC-04F5-6D6A-4CC4-B1A7BEB71BC7}"/>
          </ac:grpSpMkLst>
        </pc:grpChg>
        <pc:grpChg chg="add del mod">
          <ac:chgData name="Kim Ji-Eun" userId="5d7677e0d52343ec" providerId="LiveId" clId="{F023BD75-3484-F245-B723-6E8D9C13CED4}" dt="2023-03-21T05:40:46.314" v="765" actId="165"/>
          <ac:grpSpMkLst>
            <pc:docMk/>
            <pc:sldMk cId="2878931344" sldId="270"/>
            <ac:grpSpMk id="204" creationId="{204CE35D-A8A1-F70B-25F9-C79C6376B109}"/>
          </ac:grpSpMkLst>
        </pc:grpChg>
        <pc:grpChg chg="add del mod">
          <ac:chgData name="Kim Ji-Eun" userId="5d7677e0d52343ec" providerId="LiveId" clId="{F023BD75-3484-F245-B723-6E8D9C13CED4}" dt="2023-03-21T05:40:46.314" v="765" actId="165"/>
          <ac:grpSpMkLst>
            <pc:docMk/>
            <pc:sldMk cId="2878931344" sldId="270"/>
            <ac:grpSpMk id="205" creationId="{13D50713-95A9-D5DA-944E-43312E1019C8}"/>
          </ac:grpSpMkLst>
        </pc:grpChg>
        <pc:grpChg chg="add mod">
          <ac:chgData name="Kim Ji-Eun" userId="5d7677e0d52343ec" providerId="LiveId" clId="{F023BD75-3484-F245-B723-6E8D9C13CED4}" dt="2023-03-21T05:46:50.441" v="943" actId="164"/>
          <ac:grpSpMkLst>
            <pc:docMk/>
            <pc:sldMk cId="2878931344" sldId="270"/>
            <ac:grpSpMk id="207" creationId="{CDC04DB6-CBAB-B9BA-6735-B45851572961}"/>
          </ac:grpSpMkLst>
        </pc:grpChg>
        <pc:grpChg chg="add mod">
          <ac:chgData name="Kim Ji-Eun" userId="5d7677e0d52343ec" providerId="LiveId" clId="{F023BD75-3484-F245-B723-6E8D9C13CED4}" dt="2023-03-21T05:46:58.780" v="961" actId="1036"/>
          <ac:grpSpMkLst>
            <pc:docMk/>
            <pc:sldMk cId="2878931344" sldId="270"/>
            <ac:grpSpMk id="208" creationId="{5CEC84BB-6EA1-60EC-2E54-EE44D4914118}"/>
          </ac:grpSpMkLst>
        </pc:grpChg>
        <pc:picChg chg="del">
          <ac:chgData name="Kim Ji-Eun" userId="5d7677e0d52343ec" providerId="LiveId" clId="{F023BD75-3484-F245-B723-6E8D9C13CED4}" dt="2023-03-21T05:08:16.190" v="217" actId="478"/>
          <ac:picMkLst>
            <pc:docMk/>
            <pc:sldMk cId="2878931344" sldId="270"/>
            <ac:picMk id="3" creationId="{3EA509D2-1D10-982B-A0E0-56127554BB30}"/>
          </ac:picMkLst>
        </pc:picChg>
        <pc:picChg chg="del">
          <ac:chgData name="Kim Ji-Eun" userId="5d7677e0d52343ec" providerId="LiveId" clId="{F023BD75-3484-F245-B723-6E8D9C13CED4}" dt="2023-03-21T05:08:16.190" v="217" actId="478"/>
          <ac:picMkLst>
            <pc:docMk/>
            <pc:sldMk cId="2878931344" sldId="270"/>
            <ac:picMk id="11" creationId="{BD750D79-0F37-7F30-4224-EAFA8BB7C34A}"/>
          </ac:picMkLst>
        </pc:picChg>
        <pc:picChg chg="mod topLvl modCrop">
          <ac:chgData name="Kim Ji-Eun" userId="5d7677e0d52343ec" providerId="LiveId" clId="{F023BD75-3484-F245-B723-6E8D9C13CED4}" dt="2023-03-21T05:07:46.326" v="216" actId="164"/>
          <ac:picMkLst>
            <pc:docMk/>
            <pc:sldMk cId="2878931344" sldId="270"/>
            <ac:picMk id="30" creationId="{EE88B68D-9F11-6062-82E2-48E1937B820C}"/>
          </ac:picMkLst>
        </pc:picChg>
        <pc:picChg chg="del mod topLvl">
          <ac:chgData name="Kim Ji-Eun" userId="5d7677e0d52343ec" providerId="LiveId" clId="{F023BD75-3484-F245-B723-6E8D9C13CED4}" dt="2023-03-21T05:18:46.903" v="306" actId="478"/>
          <ac:picMkLst>
            <pc:docMk/>
            <pc:sldMk cId="2878931344" sldId="270"/>
            <ac:picMk id="77" creationId="{B354E5B6-82D7-7289-C353-F7D3ADA6A900}"/>
          </ac:picMkLst>
        </pc:picChg>
        <pc:picChg chg="del mod topLvl">
          <ac:chgData name="Kim Ji-Eun" userId="5d7677e0d52343ec" providerId="LiveId" clId="{F023BD75-3484-F245-B723-6E8D9C13CED4}" dt="2023-03-21T05:21:59.369" v="410" actId="478"/>
          <ac:picMkLst>
            <pc:docMk/>
            <pc:sldMk cId="2878931344" sldId="270"/>
            <ac:picMk id="78" creationId="{63B5C0A1-0B05-6AF5-C81F-1BE73E2DF165}"/>
          </ac:picMkLst>
        </pc:picChg>
        <pc:picChg chg="del mod topLvl">
          <ac:chgData name="Kim Ji-Eun" userId="5d7677e0d52343ec" providerId="LiveId" clId="{F023BD75-3484-F245-B723-6E8D9C13CED4}" dt="2023-03-21T05:32:26.864" v="580" actId="478"/>
          <ac:picMkLst>
            <pc:docMk/>
            <pc:sldMk cId="2878931344" sldId="270"/>
            <ac:picMk id="79" creationId="{698BCDFD-CD1B-753D-5391-CF5A943445D9}"/>
          </ac:picMkLst>
        </pc:picChg>
        <pc:picChg chg="del mod topLvl">
          <ac:chgData name="Kim Ji-Eun" userId="5d7677e0d52343ec" providerId="LiveId" clId="{F023BD75-3484-F245-B723-6E8D9C13CED4}" dt="2023-03-21T05:29:43.612" v="496" actId="478"/>
          <ac:picMkLst>
            <pc:docMk/>
            <pc:sldMk cId="2878931344" sldId="270"/>
            <ac:picMk id="80" creationId="{86874A85-F563-0E44-A44B-626212B05FA3}"/>
          </ac:picMkLst>
        </pc:picChg>
        <pc:picChg chg="del mod topLvl">
          <ac:chgData name="Kim Ji-Eun" userId="5d7677e0d52343ec" providerId="LiveId" clId="{F023BD75-3484-F245-B723-6E8D9C13CED4}" dt="2023-03-21T05:35:36.245" v="702" actId="478"/>
          <ac:picMkLst>
            <pc:docMk/>
            <pc:sldMk cId="2878931344" sldId="270"/>
            <ac:picMk id="81" creationId="{FE88F38C-7441-B873-5D07-A78D20DE0401}"/>
          </ac:picMkLst>
        </pc:picChg>
        <pc:picChg chg="add mod modCrop">
          <ac:chgData name="Kim Ji-Eun" userId="5d7677e0d52343ec" providerId="LiveId" clId="{F023BD75-3484-F245-B723-6E8D9C13CED4}" dt="2023-03-21T05:07:46.326" v="216" actId="164"/>
          <ac:picMkLst>
            <pc:docMk/>
            <pc:sldMk cId="2878931344" sldId="270"/>
            <ac:picMk id="122" creationId="{244FFBE5-F095-26E7-567A-368ED36FE738}"/>
          </ac:picMkLst>
        </pc:picChg>
        <pc:cxnChg chg="del">
          <ac:chgData name="Kim Ji-Eun" userId="5d7677e0d52343ec" providerId="LiveId" clId="{F023BD75-3484-F245-B723-6E8D9C13CED4}" dt="2023-03-21T05:08:16.190" v="217" actId="478"/>
          <ac:cxnSpMkLst>
            <pc:docMk/>
            <pc:sldMk cId="2878931344" sldId="270"/>
            <ac:cxnSpMk id="5" creationId="{C86D3F59-74E4-D4AB-E28E-27316AE55DE1}"/>
          </ac:cxnSpMkLst>
        </pc:cxnChg>
        <pc:cxnChg chg="del">
          <ac:chgData name="Kim Ji-Eun" userId="5d7677e0d52343ec" providerId="LiveId" clId="{F023BD75-3484-F245-B723-6E8D9C13CED4}" dt="2023-03-21T05:08:16.190" v="217" actId="478"/>
          <ac:cxnSpMkLst>
            <pc:docMk/>
            <pc:sldMk cId="2878931344" sldId="270"/>
            <ac:cxnSpMk id="7" creationId="{3E9657C6-4A42-572D-E558-B794A0565A2A}"/>
          </ac:cxnSpMkLst>
        </pc:cxnChg>
        <pc:cxnChg chg="del">
          <ac:chgData name="Kim Ji-Eun" userId="5d7677e0d52343ec" providerId="LiveId" clId="{F023BD75-3484-F245-B723-6E8D9C13CED4}" dt="2023-03-21T05:08:16.190" v="217" actId="478"/>
          <ac:cxnSpMkLst>
            <pc:docMk/>
            <pc:sldMk cId="2878931344" sldId="270"/>
            <ac:cxnSpMk id="13" creationId="{F105AFFD-9CF5-329B-5B3F-5D36574DB0BB}"/>
          </ac:cxnSpMkLst>
        </pc:cxnChg>
        <pc:cxnChg chg="mod topLvl">
          <ac:chgData name="Kim Ji-Eun" userId="5d7677e0d52343ec" providerId="LiveId" clId="{F023BD75-3484-F245-B723-6E8D9C13CED4}" dt="2023-03-21T05:07:46.326" v="216" actId="164"/>
          <ac:cxnSpMkLst>
            <pc:docMk/>
            <pc:sldMk cId="2878931344" sldId="270"/>
            <ac:cxnSpMk id="32" creationId="{0F88E2FC-6AE7-4F4B-5820-2E3EE2138B38}"/>
          </ac:cxnSpMkLst>
        </pc:cxnChg>
        <pc:cxnChg chg="mod topLvl">
          <ac:chgData name="Kim Ji-Eun" userId="5d7677e0d52343ec" providerId="LiveId" clId="{F023BD75-3484-F245-B723-6E8D9C13CED4}" dt="2023-03-21T05:07:46.326" v="216" actId="164"/>
          <ac:cxnSpMkLst>
            <pc:docMk/>
            <pc:sldMk cId="2878931344" sldId="270"/>
            <ac:cxnSpMk id="43" creationId="{CF1A404B-C61E-EDAB-563E-9D41D142816B}"/>
          </ac:cxnSpMkLst>
        </pc:cxnChg>
        <pc:cxnChg chg="mod topLvl">
          <ac:chgData name="Kim Ji-Eun" userId="5d7677e0d52343ec" providerId="LiveId" clId="{F023BD75-3484-F245-B723-6E8D9C13CED4}" dt="2023-03-21T05:09:21.224" v="231" actId="14100"/>
          <ac:cxnSpMkLst>
            <pc:docMk/>
            <pc:sldMk cId="2878931344" sldId="270"/>
            <ac:cxnSpMk id="75" creationId="{EDDB5EE6-7728-8B6D-AB7B-2EFB0EEC8FC8}"/>
          </ac:cxnSpMkLst>
        </pc:cxnChg>
      </pc:sldChg>
      <pc:sldChg chg="addSp delSp modSp mod">
        <pc:chgData name="Kim Ji-Eun" userId="5d7677e0d52343ec" providerId="LiveId" clId="{F023BD75-3484-F245-B723-6E8D9C13CED4}" dt="2023-04-17T01:26:04.749" v="3066" actId="1076"/>
        <pc:sldMkLst>
          <pc:docMk/>
          <pc:sldMk cId="2171006734" sldId="271"/>
        </pc:sldMkLst>
        <pc:picChg chg="add del mod">
          <ac:chgData name="Kim Ji-Eun" userId="5d7677e0d52343ec" providerId="LiveId" clId="{F023BD75-3484-F245-B723-6E8D9C13CED4}" dt="2023-04-17T01:25:43.132" v="3060" actId="478"/>
          <ac:picMkLst>
            <pc:docMk/>
            <pc:sldMk cId="2171006734" sldId="271"/>
            <ac:picMk id="3" creationId="{1FAEF8A4-5E54-9972-73C7-AD88CBF9E2DC}"/>
          </ac:picMkLst>
        </pc:picChg>
        <pc:picChg chg="del">
          <ac:chgData name="Kim Ji-Eun" userId="5d7677e0d52343ec" providerId="LiveId" clId="{F023BD75-3484-F245-B723-6E8D9C13CED4}" dt="2023-04-03T06:55:34.430" v="3039" actId="478"/>
          <ac:picMkLst>
            <pc:docMk/>
            <pc:sldMk cId="2171006734" sldId="271"/>
            <ac:picMk id="3" creationId="{D57A86C2-016E-B2F2-6B5D-08CC1E92A3C2}"/>
          </ac:picMkLst>
        </pc:picChg>
        <pc:picChg chg="add del mod">
          <ac:chgData name="Kim Ji-Eun" userId="5d7677e0d52343ec" providerId="LiveId" clId="{F023BD75-3484-F245-B723-6E8D9C13CED4}" dt="2023-04-17T01:15:22.136" v="3055" actId="478"/>
          <ac:picMkLst>
            <pc:docMk/>
            <pc:sldMk cId="2171006734" sldId="271"/>
            <ac:picMk id="4" creationId="{F2923FF5-F163-1D01-1FA8-3F1067FDD87D}"/>
          </ac:picMkLst>
        </pc:picChg>
        <pc:picChg chg="add mod modCrop">
          <ac:chgData name="Kim Ji-Eun" userId="5d7677e0d52343ec" providerId="LiveId" clId="{F023BD75-3484-F245-B723-6E8D9C13CED4}" dt="2023-04-17T01:26:04.749" v="3066" actId="1076"/>
          <ac:picMkLst>
            <pc:docMk/>
            <pc:sldMk cId="2171006734" sldId="271"/>
            <ac:picMk id="5" creationId="{6BE20365-C836-E669-AD43-6696BA6F2494}"/>
          </ac:picMkLst>
        </pc:picChg>
      </pc:sldChg>
      <pc:sldChg chg="modSp mod">
        <pc:chgData name="Kim Ji-Eun" userId="5d7677e0d52343ec" providerId="LiveId" clId="{F023BD75-3484-F245-B723-6E8D9C13CED4}" dt="2023-04-03T04:52:11.836" v="2923" actId="20577"/>
        <pc:sldMkLst>
          <pc:docMk/>
          <pc:sldMk cId="2469665838" sldId="272"/>
        </pc:sldMkLst>
        <pc:spChg chg="mod">
          <ac:chgData name="Kim Ji-Eun" userId="5d7677e0d52343ec" providerId="LiveId" clId="{F023BD75-3484-F245-B723-6E8D9C13CED4}" dt="2023-04-03T04:51:26.782" v="2889" actId="20577"/>
          <ac:spMkLst>
            <pc:docMk/>
            <pc:sldMk cId="2469665838" sldId="272"/>
            <ac:spMk id="6" creationId="{FD176A60-5914-7F43-5346-BCD23B35E69F}"/>
          </ac:spMkLst>
        </pc:spChg>
        <pc:spChg chg="mod">
          <ac:chgData name="Kim Ji-Eun" userId="5d7677e0d52343ec" providerId="LiveId" clId="{F023BD75-3484-F245-B723-6E8D9C13CED4}" dt="2023-04-03T04:51:28.430" v="2890" actId="20577"/>
          <ac:spMkLst>
            <pc:docMk/>
            <pc:sldMk cId="2469665838" sldId="272"/>
            <ac:spMk id="7" creationId="{88F8B991-3B95-9EB6-2664-4324E670F748}"/>
          </ac:spMkLst>
        </pc:spChg>
        <pc:spChg chg="mod">
          <ac:chgData name="Kim Ji-Eun" userId="5d7677e0d52343ec" providerId="LiveId" clId="{F023BD75-3484-F245-B723-6E8D9C13CED4}" dt="2023-04-03T04:51:31.532" v="2892" actId="20577"/>
          <ac:spMkLst>
            <pc:docMk/>
            <pc:sldMk cId="2469665838" sldId="272"/>
            <ac:spMk id="8" creationId="{96C3BECF-FC99-1FC7-6247-3D2934C1886D}"/>
          </ac:spMkLst>
        </pc:spChg>
        <pc:spChg chg="mod">
          <ac:chgData name="Kim Ji-Eun" userId="5d7677e0d52343ec" providerId="LiveId" clId="{F023BD75-3484-F245-B723-6E8D9C13CED4}" dt="2023-04-03T04:51:34.687" v="2894" actId="20577"/>
          <ac:spMkLst>
            <pc:docMk/>
            <pc:sldMk cId="2469665838" sldId="272"/>
            <ac:spMk id="9" creationId="{8FEB7608-4E94-6CF4-6644-DB7DBB2B055C}"/>
          </ac:spMkLst>
        </pc:spChg>
        <pc:spChg chg="mod">
          <ac:chgData name="Kim Ji-Eun" userId="5d7677e0d52343ec" providerId="LiveId" clId="{F023BD75-3484-F245-B723-6E8D9C13CED4}" dt="2023-04-03T04:51:43.694" v="2900" actId="20577"/>
          <ac:spMkLst>
            <pc:docMk/>
            <pc:sldMk cId="2469665838" sldId="272"/>
            <ac:spMk id="27" creationId="{9AD0E7E2-A288-287A-6FA9-6DCD29D8C3AD}"/>
          </ac:spMkLst>
        </pc:spChg>
        <pc:spChg chg="mod">
          <ac:chgData name="Kim Ji-Eun" userId="5d7677e0d52343ec" providerId="LiveId" clId="{F023BD75-3484-F245-B723-6E8D9C13CED4}" dt="2023-04-03T04:51:47.428" v="2902" actId="20577"/>
          <ac:spMkLst>
            <pc:docMk/>
            <pc:sldMk cId="2469665838" sldId="272"/>
            <ac:spMk id="28" creationId="{7512E2BC-2C03-3AA2-52C5-0388E5478D1D}"/>
          </ac:spMkLst>
        </pc:spChg>
        <pc:spChg chg="mod">
          <ac:chgData name="Kim Ji-Eun" userId="5d7677e0d52343ec" providerId="LiveId" clId="{F023BD75-3484-F245-B723-6E8D9C13CED4}" dt="2023-04-03T04:51:50.463" v="2904" actId="20577"/>
          <ac:spMkLst>
            <pc:docMk/>
            <pc:sldMk cId="2469665838" sldId="272"/>
            <ac:spMk id="29" creationId="{9C2AC3CC-FB5F-9509-697A-9D75A518125F}"/>
          </ac:spMkLst>
        </pc:spChg>
        <pc:spChg chg="mod">
          <ac:chgData name="Kim Ji-Eun" userId="5d7677e0d52343ec" providerId="LiveId" clId="{F023BD75-3484-F245-B723-6E8D9C13CED4}" dt="2023-04-03T04:51:52.996" v="2906" actId="20577"/>
          <ac:spMkLst>
            <pc:docMk/>
            <pc:sldMk cId="2469665838" sldId="272"/>
            <ac:spMk id="30" creationId="{978E4BEE-6A6F-7217-9997-858422CCEF94}"/>
          </ac:spMkLst>
        </pc:spChg>
        <pc:spChg chg="mod">
          <ac:chgData name="Kim Ji-Eun" userId="5d7677e0d52343ec" providerId="LiveId" clId="{F023BD75-3484-F245-B723-6E8D9C13CED4}" dt="2023-04-03T04:51:37.657" v="2896" actId="20577"/>
          <ac:spMkLst>
            <pc:docMk/>
            <pc:sldMk cId="2469665838" sldId="272"/>
            <ac:spMk id="51" creationId="{12090AA1-55E7-39BA-C2D7-561A1E4258C9}"/>
          </ac:spMkLst>
        </pc:spChg>
        <pc:spChg chg="mod">
          <ac:chgData name="Kim Ji-Eun" userId="5d7677e0d52343ec" providerId="LiveId" clId="{F023BD75-3484-F245-B723-6E8D9C13CED4}" dt="2023-04-03T04:51:40.645" v="2898" actId="20577"/>
          <ac:spMkLst>
            <pc:docMk/>
            <pc:sldMk cId="2469665838" sldId="272"/>
            <ac:spMk id="52" creationId="{52D9D25D-EA02-C69C-920F-5A9BD3CD8165}"/>
          </ac:spMkLst>
        </pc:spChg>
        <pc:spChg chg="mod">
          <ac:chgData name="Kim Ji-Eun" userId="5d7677e0d52343ec" providerId="LiveId" clId="{F023BD75-3484-F245-B723-6E8D9C13CED4}" dt="2023-04-03T04:52:02.232" v="2913" actId="20577"/>
          <ac:spMkLst>
            <pc:docMk/>
            <pc:sldMk cId="2469665838" sldId="272"/>
            <ac:spMk id="63" creationId="{346DCD13-44A9-F6F3-5443-08F462BB1E86}"/>
          </ac:spMkLst>
        </pc:spChg>
        <pc:spChg chg="mod">
          <ac:chgData name="Kim Ji-Eun" userId="5d7677e0d52343ec" providerId="LiveId" clId="{F023BD75-3484-F245-B723-6E8D9C13CED4}" dt="2023-04-03T04:52:11.836" v="2923" actId="20577"/>
          <ac:spMkLst>
            <pc:docMk/>
            <pc:sldMk cId="2469665838" sldId="272"/>
            <ac:spMk id="65" creationId="{47934F80-F2C3-2D7C-B485-9810A655CF17}"/>
          </ac:spMkLst>
        </pc:spChg>
        <pc:spChg chg="mod">
          <ac:chgData name="Kim Ji-Eun" userId="5d7677e0d52343ec" providerId="LiveId" clId="{F023BD75-3484-F245-B723-6E8D9C13CED4}" dt="2023-04-03T04:51:18.118" v="2886" actId="20577"/>
          <ac:spMkLst>
            <pc:docMk/>
            <pc:sldMk cId="2469665838" sldId="272"/>
            <ac:spMk id="70" creationId="{CBCADBAF-FB2C-00DD-677D-FCC407D1DB38}"/>
          </ac:spMkLst>
        </pc:spChg>
        <pc:spChg chg="mod">
          <ac:chgData name="Kim Ji-Eun" userId="5d7677e0d52343ec" providerId="LiveId" clId="{F023BD75-3484-F245-B723-6E8D9C13CED4}" dt="2023-04-03T04:51:14.848" v="2884" actId="20577"/>
          <ac:spMkLst>
            <pc:docMk/>
            <pc:sldMk cId="2469665838" sldId="272"/>
            <ac:spMk id="72" creationId="{45D28B0E-F279-9622-EDDA-A25E4E3BB5DC}"/>
          </ac:spMkLst>
        </pc:spChg>
      </pc:sldChg>
      <pc:sldChg chg="addSp delSp modSp new del mod">
        <pc:chgData name="Kim Ji-Eun" userId="5d7677e0d52343ec" providerId="LiveId" clId="{F023BD75-3484-F245-B723-6E8D9C13CED4}" dt="2023-03-21T06:21:49.378" v="1636" actId="2696"/>
        <pc:sldMkLst>
          <pc:docMk/>
          <pc:sldMk cId="2701221680" sldId="273"/>
        </pc:sldMkLst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3" creationId="{26397EB8-29B1-6264-437B-F7AB89BE9916}"/>
          </ac:spMkLst>
        </pc:spChg>
        <pc:spChg chg="add del mod">
          <ac:chgData name="Kim Ji-Eun" userId="5d7677e0d52343ec" providerId="LiveId" clId="{F023BD75-3484-F245-B723-6E8D9C13CED4}" dt="2023-03-21T05:58:51.426" v="1191" actId="478"/>
          <ac:spMkLst>
            <pc:docMk/>
            <pc:sldMk cId="2701221680" sldId="273"/>
            <ac:spMk id="4" creationId="{8C47804F-EBE0-7022-CC6B-3141308AA4FE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9" creationId="{E4C4A726-F9D9-56A9-ABE4-F886EAA3FD89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10" creationId="{675622FC-4D73-21A6-C9F6-8533F9AE8718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11" creationId="{6D2701E5-EB90-4860-8E4B-371AFE3067CF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12" creationId="{8140C33F-4300-0043-2298-FACF174B095D}"/>
          </ac:spMkLst>
        </pc:spChg>
        <pc:spChg chg="mod topLvl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19" creationId="{7BC8CA45-A420-680C-03E0-2DD8D81FF5D7}"/>
          </ac:spMkLst>
        </pc:spChg>
        <pc:spChg chg="mod topLvl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20" creationId="{AB849E6E-D24E-8C83-8D3D-ECA4919EDC03}"/>
          </ac:spMkLst>
        </pc:spChg>
        <pc:spChg chg="mod topLvl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21" creationId="{A281C766-7387-245B-F423-8CFDEE9E89E4}"/>
          </ac:spMkLst>
        </pc:spChg>
        <pc:spChg chg="mod topLvl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22" creationId="{AF2A1906-4AA2-B63B-CECF-25F1B629905D}"/>
          </ac:spMkLst>
        </pc:spChg>
        <pc:spChg chg="mod topLvl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23" creationId="{E8844753-419A-72C7-28BF-D1C7D9569D80}"/>
          </ac:spMkLst>
        </pc:spChg>
        <pc:spChg chg="mod topLvl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24" creationId="{2CE3E2EE-14A9-60F4-8E3E-C65CBB68958F}"/>
          </ac:spMkLst>
        </pc:spChg>
        <pc:spChg chg="mod topLvl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25" creationId="{B7867423-681E-F00A-4F52-7083927C57B6}"/>
          </ac:spMkLst>
        </pc:spChg>
        <pc:spChg chg="mod topLvl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26" creationId="{2D839AF9-57F6-EB87-67DB-F84836BA8959}"/>
          </ac:spMkLst>
        </pc:spChg>
        <pc:spChg chg="mod topLvl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27" creationId="{3F4EBF6A-4C5B-35F3-143C-8140AFF0F9F0}"/>
          </ac:spMkLst>
        </pc:spChg>
        <pc:spChg chg="mod topLvl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28" creationId="{DA77A1E3-D93F-C300-4AE2-73AACB0FD7B1}"/>
          </ac:spMkLst>
        </pc:spChg>
        <pc:spChg chg="mod topLvl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29" creationId="{65388F4B-19A2-5D83-ED57-BB9B3836731A}"/>
          </ac:spMkLst>
        </pc:spChg>
        <pc:spChg chg="mod topLvl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30" creationId="{5A8FB488-90DB-D8C1-699D-3E7094AA7351}"/>
          </ac:spMkLst>
        </pc:spChg>
        <pc:spChg chg="mod topLvl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31" creationId="{2C86C3A0-96F6-DE55-AC8C-4482CBE514E9}"/>
          </ac:spMkLst>
        </pc:spChg>
        <pc:spChg chg="mod topLvl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32" creationId="{D71DE82A-D57B-AEB4-6F30-80024793260C}"/>
          </ac:spMkLst>
        </pc:spChg>
        <pc:spChg chg="mod topLvl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33" creationId="{F5C5BBBA-E530-1454-1754-BF42140F14FD}"/>
          </ac:spMkLst>
        </pc:spChg>
        <pc:spChg chg="mod topLvl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34" creationId="{FE899C5D-7683-8E55-497E-F5B94C5FFAAC}"/>
          </ac:spMkLst>
        </pc:spChg>
        <pc:spChg chg="mod topLvl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35" creationId="{DA903A01-320E-52C3-D1A4-9B8ECB189A1B}"/>
          </ac:spMkLst>
        </pc:spChg>
        <pc:spChg chg="mod topLvl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36" creationId="{283F96AD-9225-DCE0-5940-165D88449B63}"/>
          </ac:spMkLst>
        </pc:spChg>
        <pc:spChg chg="mod topLvl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37" creationId="{EE66548A-234C-61CB-E487-6E10AEB40C00}"/>
          </ac:spMkLst>
        </pc:spChg>
        <pc:spChg chg="mod topLvl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38" creationId="{5F4EC8F0-63E1-ECBC-826E-F033372DF7F3}"/>
          </ac:spMkLst>
        </pc:spChg>
        <pc:spChg chg="mod topLvl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39" creationId="{663DA47E-FF39-E5DE-6C24-E6EC23C9016D}"/>
          </ac:spMkLst>
        </pc:spChg>
        <pc:spChg chg="mod topLvl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40" creationId="{875AE5FD-2767-EE56-C146-893A9460FEA6}"/>
          </ac:spMkLst>
        </pc:spChg>
        <pc:spChg chg="mod topLvl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41" creationId="{F3AFAFA1-53ED-310E-6381-C49449CFA17A}"/>
          </ac:spMkLst>
        </pc:spChg>
        <pc:spChg chg="mod topLvl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42" creationId="{D4FB3547-E688-34D4-B50B-A5547F5A13C0}"/>
          </ac:spMkLst>
        </pc:spChg>
        <pc:spChg chg="mod topLvl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43" creationId="{E61184FE-84D9-6EB8-A4D9-89A1BFE81DB7}"/>
          </ac:spMkLst>
        </pc:spChg>
        <pc:spChg chg="mod topLvl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44" creationId="{D8F9D256-A8AD-4A43-B02B-732E269A04C9}"/>
          </ac:spMkLst>
        </pc:spChg>
        <pc:spChg chg="mod topLvl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45" creationId="{4B1E57CB-CC0B-7B21-8ADD-ABC45264C1C2}"/>
          </ac:spMkLst>
        </pc:spChg>
        <pc:spChg chg="mod topLvl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46" creationId="{8D38C31B-43C7-C71D-D093-40B35F030132}"/>
          </ac:spMkLst>
        </pc:spChg>
        <pc:spChg chg="mod topLvl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47" creationId="{069716A1-F7DC-A76F-CF8D-5F4132C1AF52}"/>
          </ac:spMkLst>
        </pc:spChg>
        <pc:spChg chg="mod topLvl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48" creationId="{67B10145-C6B0-1A68-C569-024C4C6C21E4}"/>
          </ac:spMkLst>
        </pc:spChg>
        <pc:spChg chg="mod topLvl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49" creationId="{B55F2E39-3328-960F-823E-ED911595D066}"/>
          </ac:spMkLst>
        </pc:spChg>
        <pc:spChg chg="mod topLvl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50" creationId="{D9DED85C-D591-1BB4-5828-965F5AA64941}"/>
          </ac:spMkLst>
        </pc:spChg>
        <pc:spChg chg="mod topLvl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51" creationId="{21B32EE2-6F2F-07E5-BCAA-CCA8869C5D76}"/>
          </ac:spMkLst>
        </pc:spChg>
        <pc:spChg chg="mod topLvl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52" creationId="{2373085D-2947-1213-B035-803B3024DB3A}"/>
          </ac:spMkLst>
        </pc:spChg>
        <pc:spChg chg="mod topLvl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53" creationId="{120FEC60-A32C-616B-740D-DCD2B7632881}"/>
          </ac:spMkLst>
        </pc:spChg>
        <pc:spChg chg="mod topLvl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54" creationId="{D05A943F-F5EE-F65B-1AC4-46C1BAA4B8A3}"/>
          </ac:spMkLst>
        </pc:spChg>
        <pc:spChg chg="mod topLvl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55" creationId="{EDD35CEE-5F6E-BC99-DFE2-AED3D4DC0B71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56" creationId="{F866F76E-67C2-FE5D-872F-D7606D8C1DB6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57" creationId="{69637865-4140-B203-8EE0-4674709EA398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58" creationId="{D5383DF9-9E87-4C68-B947-44D2A15E8431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59" creationId="{387B3465-D197-10D7-6A33-B5D667A751A1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60" creationId="{60D534A8-6B6E-16A8-71F2-F449BD014B7A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61" creationId="{E14F54D7-D05B-931F-5C87-6B608895B17E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62" creationId="{9C3D4529-642A-C659-35ED-0A27B43AE6DD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63" creationId="{9E2530B1-E267-5694-655D-568B0FAA3E64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64" creationId="{FCD2A493-8607-7986-14FA-82575BCA16A1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65" creationId="{E53C6D37-7964-1BFF-B4E9-58C9D703A020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66" creationId="{78A0F828-1B80-196A-359E-BDC5CB4376DD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79" creationId="{2A046835-8B88-9E9E-9B2B-555D0473F4FE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83" creationId="{6C4D3CE8-05DE-91B6-9550-45D92643BE45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84" creationId="{0D641BA3-48E0-D8D1-1E2A-7FC2FBDCBB5F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85" creationId="{DF9AAF64-C936-3AA7-71F8-DC138ACFA2B4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86" creationId="{996795A8-F6D1-A8DF-BA0E-CDC4EE655D03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87" creationId="{81138993-03ED-8355-2506-A01D9E1D982F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88" creationId="{C415FCE1-28D2-4366-5BB5-40BC3DD850E2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89" creationId="{61BA0DBF-4E6F-5057-768F-1A3CD0EC6354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90" creationId="{0EE3DE60-64EB-4B2B-BB14-C810FC6FEB53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91" creationId="{8963CCFF-EA2F-C7EB-9449-D33455462DE5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92" creationId="{B798538B-3A38-B3B8-5795-43D47B761EFB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93" creationId="{A2009094-F8EA-2984-E34B-DD5A635CFD04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94" creationId="{8C32B70E-7E06-C2A3-59DD-C8AB5D7AF76A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95" creationId="{D860D6F7-0AC7-C223-29F5-003842132240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96" creationId="{1976D9C0-23AB-4A4A-9E73-698B7DCED767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97" creationId="{AFEF198C-793D-28C6-804D-8069BE7C4456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98" creationId="{1A22E442-47AA-B416-2AD2-0E3DD3BD2EBF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99" creationId="{6DAC75B7-298C-4896-D17D-1E183CD4502A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100" creationId="{FDA4E74E-D895-33C4-37A5-8FF0BEF85846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101" creationId="{9033C88C-6343-8138-CB7E-1B9FA5B4C233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102" creationId="{FA27949A-7EA5-9838-D392-392AE39F0BBE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103" creationId="{D9C38082-7A1E-77D9-C25B-53EF6900391D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104" creationId="{EA062626-7FF5-15F7-A13D-1BA085A19F2A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105" creationId="{EC8445BD-CFA8-9765-CF07-CC42EDC08802}"/>
          </ac:spMkLst>
        </pc:spChg>
        <pc:spChg chg="add del mod">
          <ac:chgData name="Kim Ji-Eun" userId="5d7677e0d52343ec" providerId="LiveId" clId="{F023BD75-3484-F245-B723-6E8D9C13CED4}" dt="2023-03-21T06:08:42.370" v="1250" actId="478"/>
          <ac:spMkLst>
            <pc:docMk/>
            <pc:sldMk cId="2701221680" sldId="273"/>
            <ac:spMk id="106" creationId="{6F9A4172-0920-A691-E8A0-379368063CF0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107" creationId="{B37B6AC2-58C1-2692-4A0E-0285905E8CFC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108" creationId="{DDF7EADC-682E-B586-1906-56E9978ADF3D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109" creationId="{38D91B9F-BDE0-7E00-8285-644F59492DEA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110" creationId="{F01C1A1A-2865-4B12-BB34-3C00A4E568BA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111" creationId="{B06B4AFE-9CDB-BD05-F982-11E2F9E69433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112" creationId="{D8A91CEB-5A0D-F4FE-6CC4-654C6FFCB9CF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113" creationId="{B7CDDAD3-DD92-BC1E-BB17-6315ADB87410}"/>
          </ac:spMkLst>
        </pc:spChg>
        <pc:spChg chg="add del mod">
          <ac:chgData name="Kim Ji-Eun" userId="5d7677e0d52343ec" providerId="LiveId" clId="{F023BD75-3484-F245-B723-6E8D9C13CED4}" dt="2023-03-21T06:08:43.771" v="1251" actId="478"/>
          <ac:spMkLst>
            <pc:docMk/>
            <pc:sldMk cId="2701221680" sldId="273"/>
            <ac:spMk id="114" creationId="{636FB313-91CD-78DA-D36C-E659EB0B988A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115" creationId="{DC52D55E-E2FB-3B6A-BBE6-E52F0C9359A5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116" creationId="{33336A21-9167-33B7-3D2F-C4EA1AEB5FCB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117" creationId="{5B2B4C9A-FAB9-73B8-764F-9A4D3CF8665F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118" creationId="{6F3A5F89-8BEB-336F-6BCF-D65D99E1027F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119" creationId="{C3681120-5B36-DF61-3708-D83384953293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120" creationId="{35C99BB2-AB82-3FD9-46B0-939AB2EE3701}"/>
          </ac:spMkLst>
        </pc:spChg>
        <pc:spChg chg="add mod">
          <ac:chgData name="Kim Ji-Eun" userId="5d7677e0d52343ec" providerId="LiveId" clId="{F023BD75-3484-F245-B723-6E8D9C13CED4}" dt="2023-03-21T06:20:15.582" v="1630" actId="164"/>
          <ac:spMkLst>
            <pc:docMk/>
            <pc:sldMk cId="2701221680" sldId="273"/>
            <ac:spMk id="121" creationId="{2A877BBB-B79F-8D52-D598-A6945E6010F6}"/>
          </ac:spMkLst>
        </pc:spChg>
        <pc:spChg chg="add del mod">
          <ac:chgData name="Kim Ji-Eun" userId="5d7677e0d52343ec" providerId="LiveId" clId="{F023BD75-3484-F245-B723-6E8D9C13CED4}" dt="2023-03-21T06:08:44.727" v="1252" actId="478"/>
          <ac:spMkLst>
            <pc:docMk/>
            <pc:sldMk cId="2701221680" sldId="273"/>
            <ac:spMk id="122" creationId="{FE2925B3-A952-7BE8-EFF2-692A7CD427E5}"/>
          </ac:spMkLst>
        </pc:spChg>
        <pc:spChg chg="add del mod">
          <ac:chgData name="Kim Ji-Eun" userId="5d7677e0d52343ec" providerId="LiveId" clId="{F023BD75-3484-F245-B723-6E8D9C13CED4}" dt="2023-03-21T06:19:33.528" v="1611"/>
          <ac:spMkLst>
            <pc:docMk/>
            <pc:sldMk cId="2701221680" sldId="273"/>
            <ac:spMk id="123" creationId="{ECBE99CE-6F3D-FB3A-E9E4-055593EE84B5}"/>
          </ac:spMkLst>
        </pc:spChg>
        <pc:grpChg chg="add del mod">
          <ac:chgData name="Kim Ji-Eun" userId="5d7677e0d52343ec" providerId="LiveId" clId="{F023BD75-3484-F245-B723-6E8D9C13CED4}" dt="2023-03-21T06:00:00.070" v="1203" actId="165"/>
          <ac:grpSpMkLst>
            <pc:docMk/>
            <pc:sldMk cId="2701221680" sldId="273"/>
            <ac:grpSpMk id="13" creationId="{9DE54D66-E3AD-FFA6-5411-5045EE9803DA}"/>
          </ac:grpSpMkLst>
        </pc:grpChg>
        <pc:grpChg chg="add mod">
          <ac:chgData name="Kim Ji-Eun" userId="5d7677e0d52343ec" providerId="LiveId" clId="{F023BD75-3484-F245-B723-6E8D9C13CED4}" dt="2023-03-21T06:20:15.582" v="1630" actId="164"/>
          <ac:grpSpMkLst>
            <pc:docMk/>
            <pc:sldMk cId="2701221680" sldId="273"/>
            <ac:grpSpMk id="124" creationId="{E833E7FD-D505-67AC-968B-65AB5BA92C62}"/>
          </ac:grpSpMkLst>
        </pc:grpChg>
        <pc:picChg chg="add mod modCrop">
          <ac:chgData name="Kim Ji-Eun" userId="5d7677e0d52343ec" providerId="LiveId" clId="{F023BD75-3484-F245-B723-6E8D9C13CED4}" dt="2023-03-21T06:20:15.582" v="1630" actId="164"/>
          <ac:picMkLst>
            <pc:docMk/>
            <pc:sldMk cId="2701221680" sldId="273"/>
            <ac:picMk id="2" creationId="{5C5129CD-4724-D657-4AF5-F10A1837C2AA}"/>
          </ac:picMkLst>
        </pc:picChg>
        <pc:picChg chg="del mod topLvl">
          <ac:chgData name="Kim Ji-Eun" userId="5d7677e0d52343ec" providerId="LiveId" clId="{F023BD75-3484-F245-B723-6E8D9C13CED4}" dt="2023-03-21T06:12:34.101" v="1329" actId="478"/>
          <ac:picMkLst>
            <pc:docMk/>
            <pc:sldMk cId="2701221680" sldId="273"/>
            <ac:picMk id="14" creationId="{3136D8F3-2445-762F-6B2D-315412BF3A46}"/>
          </ac:picMkLst>
        </pc:picChg>
        <pc:picChg chg="del mod topLvl">
          <ac:chgData name="Kim Ji-Eun" userId="5d7677e0d52343ec" providerId="LiveId" clId="{F023BD75-3484-F245-B723-6E8D9C13CED4}" dt="2023-03-21T06:19:08.805" v="1584" actId="478"/>
          <ac:picMkLst>
            <pc:docMk/>
            <pc:sldMk cId="2701221680" sldId="273"/>
            <ac:picMk id="15" creationId="{66CE801D-4BE7-4718-8EBD-24A2959D206E}"/>
          </ac:picMkLst>
        </pc:picChg>
        <pc:picChg chg="del mod topLvl">
          <ac:chgData name="Kim Ji-Eun" userId="5d7677e0d52343ec" providerId="LiveId" clId="{F023BD75-3484-F245-B723-6E8D9C13CED4}" dt="2023-03-21T06:19:08.805" v="1584" actId="478"/>
          <ac:picMkLst>
            <pc:docMk/>
            <pc:sldMk cId="2701221680" sldId="273"/>
            <ac:picMk id="16" creationId="{1A5EA88A-4BFE-1479-8632-3ABF278E0830}"/>
          </ac:picMkLst>
        </pc:picChg>
        <pc:picChg chg="del mod topLvl">
          <ac:chgData name="Kim Ji-Eun" userId="5d7677e0d52343ec" providerId="LiveId" clId="{F023BD75-3484-F245-B723-6E8D9C13CED4}" dt="2023-03-21T06:19:08.805" v="1584" actId="478"/>
          <ac:picMkLst>
            <pc:docMk/>
            <pc:sldMk cId="2701221680" sldId="273"/>
            <ac:picMk id="17" creationId="{9C8DB801-9939-EEED-E2E5-EC1BDA47517B}"/>
          </ac:picMkLst>
        </pc:picChg>
        <pc:picChg chg="del mod topLvl">
          <ac:chgData name="Kim Ji-Eun" userId="5d7677e0d52343ec" providerId="LiveId" clId="{F023BD75-3484-F245-B723-6E8D9C13CED4}" dt="2023-03-21T06:19:08.805" v="1584" actId="478"/>
          <ac:picMkLst>
            <pc:docMk/>
            <pc:sldMk cId="2701221680" sldId="273"/>
            <ac:picMk id="18" creationId="{93FABB5B-9E97-1435-F560-30F6B914D65F}"/>
          </ac:picMkLst>
        </pc:picChg>
        <pc:picChg chg="add del mod">
          <ac:chgData name="Kim Ji-Eun" userId="5d7677e0d52343ec" providerId="LiveId" clId="{F023BD75-3484-F245-B723-6E8D9C13CED4}" dt="2023-03-21T05:52:31.456" v="973" actId="478"/>
          <ac:picMkLst>
            <pc:docMk/>
            <pc:sldMk cId="2701221680" sldId="273"/>
            <ac:picMk id="67" creationId="{DD6E2467-4916-982B-105A-DF707DFAE2BC}"/>
          </ac:picMkLst>
        </pc:picChg>
        <pc:picChg chg="add mod modCrop">
          <ac:chgData name="Kim Ji-Eun" userId="5d7677e0d52343ec" providerId="LiveId" clId="{F023BD75-3484-F245-B723-6E8D9C13CED4}" dt="2023-03-21T06:20:15.582" v="1630" actId="164"/>
          <ac:picMkLst>
            <pc:docMk/>
            <pc:sldMk cId="2701221680" sldId="273"/>
            <ac:picMk id="68" creationId="{B74331C0-D414-5853-615C-716708C758E4}"/>
          </ac:picMkLst>
        </pc:picChg>
        <pc:picChg chg="add mod modCrop">
          <ac:chgData name="Kim Ji-Eun" userId="5d7677e0d52343ec" providerId="LiveId" clId="{F023BD75-3484-F245-B723-6E8D9C13CED4}" dt="2023-03-21T06:20:15.582" v="1630" actId="164"/>
          <ac:picMkLst>
            <pc:docMk/>
            <pc:sldMk cId="2701221680" sldId="273"/>
            <ac:picMk id="69" creationId="{3138F42E-686D-82D1-BD20-5C9834FFF118}"/>
          </ac:picMkLst>
        </pc:picChg>
        <pc:picChg chg="add mod modCrop">
          <ac:chgData name="Kim Ji-Eun" userId="5d7677e0d52343ec" providerId="LiveId" clId="{F023BD75-3484-F245-B723-6E8D9C13CED4}" dt="2023-03-21T06:20:15.582" v="1630" actId="164"/>
          <ac:picMkLst>
            <pc:docMk/>
            <pc:sldMk cId="2701221680" sldId="273"/>
            <ac:picMk id="70" creationId="{03680341-1086-7853-3A1B-088B838DE550}"/>
          </ac:picMkLst>
        </pc:picChg>
        <pc:cxnChg chg="add mod">
          <ac:chgData name="Kim Ji-Eun" userId="5d7677e0d52343ec" providerId="LiveId" clId="{F023BD75-3484-F245-B723-6E8D9C13CED4}" dt="2023-03-21T06:20:15.582" v="1630" actId="164"/>
          <ac:cxnSpMkLst>
            <pc:docMk/>
            <pc:sldMk cId="2701221680" sldId="273"/>
            <ac:cxnSpMk id="5" creationId="{905FF90A-64C4-6807-C466-D530BC293770}"/>
          </ac:cxnSpMkLst>
        </pc:cxnChg>
        <pc:cxnChg chg="add mod">
          <ac:chgData name="Kim Ji-Eun" userId="5d7677e0d52343ec" providerId="LiveId" clId="{F023BD75-3484-F245-B723-6E8D9C13CED4}" dt="2023-03-21T06:20:15.582" v="1630" actId="164"/>
          <ac:cxnSpMkLst>
            <pc:docMk/>
            <pc:sldMk cId="2701221680" sldId="273"/>
            <ac:cxnSpMk id="6" creationId="{2B6508CE-9F7C-29B5-557B-C74FECF8880C}"/>
          </ac:cxnSpMkLst>
        </pc:cxnChg>
        <pc:cxnChg chg="add del mod">
          <ac:chgData name="Kim Ji-Eun" userId="5d7677e0d52343ec" providerId="LiveId" clId="{F023BD75-3484-F245-B723-6E8D9C13CED4}" dt="2023-03-21T05:59:29.816" v="1200" actId="478"/>
          <ac:cxnSpMkLst>
            <pc:docMk/>
            <pc:sldMk cId="2701221680" sldId="273"/>
            <ac:cxnSpMk id="7" creationId="{FC73FE0D-1F2F-166D-F3C5-D7FBBE26A004}"/>
          </ac:cxnSpMkLst>
        </pc:cxnChg>
        <pc:cxnChg chg="add del mod">
          <ac:chgData name="Kim Ji-Eun" userId="5d7677e0d52343ec" providerId="LiveId" clId="{F023BD75-3484-F245-B723-6E8D9C13CED4}" dt="2023-03-21T05:59:29.816" v="1200" actId="478"/>
          <ac:cxnSpMkLst>
            <pc:docMk/>
            <pc:sldMk cId="2701221680" sldId="273"/>
            <ac:cxnSpMk id="8" creationId="{775A01BC-63AC-E73A-820E-2190C90233FD}"/>
          </ac:cxnSpMkLst>
        </pc:cxnChg>
        <pc:cxnChg chg="add mod">
          <ac:chgData name="Kim Ji-Eun" userId="5d7677e0d52343ec" providerId="LiveId" clId="{F023BD75-3484-F245-B723-6E8D9C13CED4}" dt="2023-03-21T06:20:15.582" v="1630" actId="164"/>
          <ac:cxnSpMkLst>
            <pc:docMk/>
            <pc:sldMk cId="2701221680" sldId="273"/>
            <ac:cxnSpMk id="80" creationId="{595440D5-8D42-C334-B187-49E6782AE17D}"/>
          </ac:cxnSpMkLst>
        </pc:cxnChg>
        <pc:cxnChg chg="add mod">
          <ac:chgData name="Kim Ji-Eun" userId="5d7677e0d52343ec" providerId="LiveId" clId="{F023BD75-3484-F245-B723-6E8D9C13CED4}" dt="2023-03-21T06:20:15.582" v="1630" actId="164"/>
          <ac:cxnSpMkLst>
            <pc:docMk/>
            <pc:sldMk cId="2701221680" sldId="273"/>
            <ac:cxnSpMk id="81" creationId="{5A836586-460C-2A9D-0FDF-8312B6F1A5F9}"/>
          </ac:cxnSpMkLst>
        </pc:cxnChg>
      </pc:sldChg>
      <pc:sldChg chg="addSp delSp modSp new mod">
        <pc:chgData name="Kim Ji-Eun" userId="5d7677e0d52343ec" providerId="LiveId" clId="{F023BD75-3484-F245-B723-6E8D9C13CED4}" dt="2023-04-03T07:56:52.362" v="3054" actId="14100"/>
        <pc:sldMkLst>
          <pc:docMk/>
          <pc:sldMk cId="3045183798" sldId="273"/>
        </pc:sldMkLst>
        <pc:spChg chg="mod">
          <ac:chgData name="Kim Ji-Eun" userId="5d7677e0d52343ec" providerId="LiveId" clId="{F023BD75-3484-F245-B723-6E8D9C13CED4}" dt="2023-03-27T07:34:26.613" v="1716"/>
          <ac:spMkLst>
            <pc:docMk/>
            <pc:sldMk cId="3045183798" sldId="273"/>
            <ac:spMk id="3" creationId="{EE45D0D0-E9C4-73E8-75A4-D08FB4C7483B}"/>
          </ac:spMkLst>
        </pc:spChg>
        <pc:spChg chg="mod">
          <ac:chgData name="Kim Ji-Eun" userId="5d7677e0d52343ec" providerId="LiveId" clId="{F023BD75-3484-F245-B723-6E8D9C13CED4}" dt="2023-03-27T07:34:26.613" v="1716"/>
          <ac:spMkLst>
            <pc:docMk/>
            <pc:sldMk cId="3045183798" sldId="273"/>
            <ac:spMk id="4" creationId="{0477C1F0-FAE9-E899-C0E3-969972CB0E8F}"/>
          </ac:spMkLst>
        </pc:spChg>
        <pc:spChg chg="mod">
          <ac:chgData name="Kim Ji-Eun" userId="5d7677e0d52343ec" providerId="LiveId" clId="{F023BD75-3484-F245-B723-6E8D9C13CED4}" dt="2023-03-27T07:34:26.613" v="1716"/>
          <ac:spMkLst>
            <pc:docMk/>
            <pc:sldMk cId="3045183798" sldId="273"/>
            <ac:spMk id="5" creationId="{0F63E942-7E02-2FA3-9A5F-A539B79C2FC2}"/>
          </ac:spMkLst>
        </pc:spChg>
        <pc:spChg chg="add del mod">
          <ac:chgData name="Kim Ji-Eun" userId="5d7677e0d52343ec" providerId="LiveId" clId="{F023BD75-3484-F245-B723-6E8D9C13CED4}" dt="2023-04-03T04:01:30.486" v="1961"/>
          <ac:spMkLst>
            <pc:docMk/>
            <pc:sldMk cId="3045183798" sldId="273"/>
            <ac:spMk id="5" creationId="{35CA8558-CB9E-A864-A330-CE0E945CFB25}"/>
          </ac:spMkLst>
        </pc:spChg>
        <pc:spChg chg="mod">
          <ac:chgData name="Kim Ji-Eun" userId="5d7677e0d52343ec" providerId="LiveId" clId="{F023BD75-3484-F245-B723-6E8D9C13CED4}" dt="2023-03-27T07:34:26.613" v="1716"/>
          <ac:spMkLst>
            <pc:docMk/>
            <pc:sldMk cId="3045183798" sldId="273"/>
            <ac:spMk id="6" creationId="{323BDD1A-5B79-2FE1-FF15-B76C38EDBF93}"/>
          </ac:spMkLst>
        </pc:spChg>
        <pc:spChg chg="mod">
          <ac:chgData name="Kim Ji-Eun" userId="5d7677e0d52343ec" providerId="LiveId" clId="{F023BD75-3484-F245-B723-6E8D9C13CED4}" dt="2023-03-27T07:34:26.613" v="1716"/>
          <ac:spMkLst>
            <pc:docMk/>
            <pc:sldMk cId="3045183798" sldId="273"/>
            <ac:spMk id="7" creationId="{C565D34B-B20A-8265-E9E0-5742AD2DEB5C}"/>
          </ac:spMkLst>
        </pc:spChg>
        <pc:spChg chg="add del mod">
          <ac:chgData name="Kim Ji-Eun" userId="5d7677e0d52343ec" providerId="LiveId" clId="{F023BD75-3484-F245-B723-6E8D9C13CED4}" dt="2023-04-03T04:03:51.540" v="2024"/>
          <ac:spMkLst>
            <pc:docMk/>
            <pc:sldMk cId="3045183798" sldId="273"/>
            <ac:spMk id="7" creationId="{E7496E54-01C8-3DEB-B7E8-EB5256271AB5}"/>
          </ac:spMkLst>
        </pc:spChg>
        <pc:spChg chg="mod">
          <ac:chgData name="Kim Ji-Eun" userId="5d7677e0d52343ec" providerId="LiveId" clId="{F023BD75-3484-F245-B723-6E8D9C13CED4}" dt="2023-03-27T07:34:26.613" v="1716"/>
          <ac:spMkLst>
            <pc:docMk/>
            <pc:sldMk cId="3045183798" sldId="273"/>
            <ac:spMk id="8" creationId="{B20E3864-9C25-1D57-837C-6FEDF220DBFD}"/>
          </ac:spMkLst>
        </pc:spChg>
        <pc:spChg chg="add mod">
          <ac:chgData name="Kim Ji-Eun" userId="5d7677e0d52343ec" providerId="LiveId" clId="{F023BD75-3484-F245-B723-6E8D9C13CED4}" dt="2023-04-03T04:45:02.914" v="2861" actId="1036"/>
          <ac:spMkLst>
            <pc:docMk/>
            <pc:sldMk cId="3045183798" sldId="273"/>
            <ac:spMk id="8" creationId="{FAEA0657-A4C6-5CEE-B6F1-94703411039B}"/>
          </ac:spMkLst>
        </pc:spChg>
        <pc:spChg chg="add mod">
          <ac:chgData name="Kim Ji-Eun" userId="5d7677e0d52343ec" providerId="LiveId" clId="{F023BD75-3484-F245-B723-6E8D9C13CED4}" dt="2023-03-27T07:35:36.241" v="1760" actId="1037"/>
          <ac:spMkLst>
            <pc:docMk/>
            <pc:sldMk cId="3045183798" sldId="273"/>
            <ac:spMk id="9" creationId="{41A055FE-452F-EE30-76F4-E99B534BA857}"/>
          </ac:spMkLst>
        </pc:spChg>
        <pc:spChg chg="add mod">
          <ac:chgData name="Kim Ji-Eun" userId="5d7677e0d52343ec" providerId="LiveId" clId="{F023BD75-3484-F245-B723-6E8D9C13CED4}" dt="2023-04-03T04:45:02.914" v="2861" actId="1036"/>
          <ac:spMkLst>
            <pc:docMk/>
            <pc:sldMk cId="3045183798" sldId="273"/>
            <ac:spMk id="11" creationId="{B0B0428E-F8B3-ABF1-82F6-71B0B9C7321E}"/>
          </ac:spMkLst>
        </pc:spChg>
        <pc:spChg chg="mod">
          <ac:chgData name="Kim Ji-Eun" userId="5d7677e0d52343ec" providerId="LiveId" clId="{F023BD75-3484-F245-B723-6E8D9C13CED4}" dt="2023-03-27T07:34:26.613" v="1716"/>
          <ac:spMkLst>
            <pc:docMk/>
            <pc:sldMk cId="3045183798" sldId="273"/>
            <ac:spMk id="11" creationId="{B645D6EE-D2C2-B39A-2D86-BBA68A31E34E}"/>
          </ac:spMkLst>
        </pc:spChg>
        <pc:spChg chg="mod">
          <ac:chgData name="Kim Ji-Eun" userId="5d7677e0d52343ec" providerId="LiveId" clId="{F023BD75-3484-F245-B723-6E8D9C13CED4}" dt="2023-03-27T07:34:26.613" v="1716"/>
          <ac:spMkLst>
            <pc:docMk/>
            <pc:sldMk cId="3045183798" sldId="273"/>
            <ac:spMk id="12" creationId="{E90BF315-9B2A-BAB4-F9DF-CE1C9F194D5C}"/>
          </ac:spMkLst>
        </pc:spChg>
        <pc:spChg chg="mod">
          <ac:chgData name="Kim Ji-Eun" userId="5d7677e0d52343ec" providerId="LiveId" clId="{F023BD75-3484-F245-B723-6E8D9C13CED4}" dt="2023-03-27T07:34:26.613" v="1716"/>
          <ac:spMkLst>
            <pc:docMk/>
            <pc:sldMk cId="3045183798" sldId="273"/>
            <ac:spMk id="13" creationId="{56490ED5-7FA9-E43A-853B-66781FEBE78C}"/>
          </ac:spMkLst>
        </pc:spChg>
        <pc:spChg chg="mod">
          <ac:chgData name="Kim Ji-Eun" userId="5d7677e0d52343ec" providerId="LiveId" clId="{F023BD75-3484-F245-B723-6E8D9C13CED4}" dt="2023-03-27T07:34:26.613" v="1716"/>
          <ac:spMkLst>
            <pc:docMk/>
            <pc:sldMk cId="3045183798" sldId="273"/>
            <ac:spMk id="14" creationId="{25AB7AE0-81CA-D1EB-4811-69DFBE222A7E}"/>
          </ac:spMkLst>
        </pc:spChg>
        <pc:spChg chg="mod">
          <ac:chgData name="Kim Ji-Eun" userId="5d7677e0d52343ec" providerId="LiveId" clId="{F023BD75-3484-F245-B723-6E8D9C13CED4}" dt="2023-03-27T07:34:26.613" v="1716"/>
          <ac:spMkLst>
            <pc:docMk/>
            <pc:sldMk cId="3045183798" sldId="273"/>
            <ac:spMk id="17" creationId="{3B401019-AE17-CFDB-3966-4ED27AA18A8E}"/>
          </ac:spMkLst>
        </pc:spChg>
        <pc:spChg chg="mod">
          <ac:chgData name="Kim Ji-Eun" userId="5d7677e0d52343ec" providerId="LiveId" clId="{F023BD75-3484-F245-B723-6E8D9C13CED4}" dt="2023-04-03T04:45:00.015" v="2860" actId="1035"/>
          <ac:spMkLst>
            <pc:docMk/>
            <pc:sldMk cId="3045183798" sldId="273"/>
            <ac:spMk id="17" creationId="{B04580C2-44B8-3313-31D1-56D224F5AC2C}"/>
          </ac:spMkLst>
        </pc:spChg>
        <pc:spChg chg="mod">
          <ac:chgData name="Kim Ji-Eun" userId="5d7677e0d52343ec" providerId="LiveId" clId="{F023BD75-3484-F245-B723-6E8D9C13CED4}" dt="2023-04-03T04:45:00.015" v="2860" actId="1035"/>
          <ac:spMkLst>
            <pc:docMk/>
            <pc:sldMk cId="3045183798" sldId="273"/>
            <ac:spMk id="18" creationId="{787240E9-6130-36C5-86E4-8549381B17F9}"/>
          </ac:spMkLst>
        </pc:spChg>
        <pc:spChg chg="mod">
          <ac:chgData name="Kim Ji-Eun" userId="5d7677e0d52343ec" providerId="LiveId" clId="{F023BD75-3484-F245-B723-6E8D9C13CED4}" dt="2023-03-27T07:34:26.613" v="1716"/>
          <ac:spMkLst>
            <pc:docMk/>
            <pc:sldMk cId="3045183798" sldId="273"/>
            <ac:spMk id="18" creationId="{7D507FB7-476A-CB35-3D52-661C0663B28B}"/>
          </ac:spMkLst>
        </pc:spChg>
        <pc:spChg chg="mod">
          <ac:chgData name="Kim Ji-Eun" userId="5d7677e0d52343ec" providerId="LiveId" clId="{F023BD75-3484-F245-B723-6E8D9C13CED4}" dt="2023-03-27T07:34:26.613" v="1716"/>
          <ac:spMkLst>
            <pc:docMk/>
            <pc:sldMk cId="3045183798" sldId="273"/>
            <ac:spMk id="20" creationId="{90C83B96-49A1-DEF7-35B3-7421C70D5CDF}"/>
          </ac:spMkLst>
        </pc:spChg>
        <pc:spChg chg="mod">
          <ac:chgData name="Kim Ji-Eun" userId="5d7677e0d52343ec" providerId="LiveId" clId="{F023BD75-3484-F245-B723-6E8D9C13CED4}" dt="2023-04-03T04:13:11.941" v="2309" actId="1037"/>
          <ac:spMkLst>
            <pc:docMk/>
            <pc:sldMk cId="3045183798" sldId="273"/>
            <ac:spMk id="20" creationId="{D41446BF-DAFF-1611-C002-0879B2221E22}"/>
          </ac:spMkLst>
        </pc:spChg>
        <pc:spChg chg="mod">
          <ac:chgData name="Kim Ji-Eun" userId="5d7677e0d52343ec" providerId="LiveId" clId="{F023BD75-3484-F245-B723-6E8D9C13CED4}" dt="2023-04-03T04:12:56.441" v="2300" actId="1038"/>
          <ac:spMkLst>
            <pc:docMk/>
            <pc:sldMk cId="3045183798" sldId="273"/>
            <ac:spMk id="21" creationId="{4B1B0B95-47E7-02CC-221B-C5C9AE64806A}"/>
          </ac:spMkLst>
        </pc:spChg>
        <pc:spChg chg="mod">
          <ac:chgData name="Kim Ji-Eun" userId="5d7677e0d52343ec" providerId="LiveId" clId="{F023BD75-3484-F245-B723-6E8D9C13CED4}" dt="2023-03-27T07:34:26.613" v="1716"/>
          <ac:spMkLst>
            <pc:docMk/>
            <pc:sldMk cId="3045183798" sldId="273"/>
            <ac:spMk id="21" creationId="{D3340C64-9405-6941-1946-63FB91E448FA}"/>
          </ac:spMkLst>
        </pc:spChg>
        <pc:spChg chg="mod">
          <ac:chgData name="Kim Ji-Eun" userId="5d7677e0d52343ec" providerId="LiveId" clId="{F023BD75-3484-F245-B723-6E8D9C13CED4}" dt="2023-03-27T07:34:26.613" v="1716"/>
          <ac:spMkLst>
            <pc:docMk/>
            <pc:sldMk cId="3045183798" sldId="273"/>
            <ac:spMk id="22" creationId="{ECFE9551-BB2D-8CF1-51D5-8FA3E8C5349C}"/>
          </ac:spMkLst>
        </pc:spChg>
        <pc:spChg chg="mod">
          <ac:chgData name="Kim Ji-Eun" userId="5d7677e0d52343ec" providerId="LiveId" clId="{F023BD75-3484-F245-B723-6E8D9C13CED4}" dt="2023-03-27T07:34:26.613" v="1716"/>
          <ac:spMkLst>
            <pc:docMk/>
            <pc:sldMk cId="3045183798" sldId="273"/>
            <ac:spMk id="23" creationId="{DE8511E6-33BD-698C-A026-56F41EA62508}"/>
          </ac:spMkLst>
        </pc:spChg>
        <pc:spChg chg="mod">
          <ac:chgData name="Kim Ji-Eun" userId="5d7677e0d52343ec" providerId="LiveId" clId="{F023BD75-3484-F245-B723-6E8D9C13CED4}" dt="2023-04-03T04:44:54.266" v="2857" actId="1036"/>
          <ac:spMkLst>
            <pc:docMk/>
            <pc:sldMk cId="3045183798" sldId="273"/>
            <ac:spMk id="23" creationId="{EB7A7A1A-822A-2CF9-8B8A-C5DDE96B24EE}"/>
          </ac:spMkLst>
        </pc:spChg>
        <pc:spChg chg="add mod">
          <ac:chgData name="Kim Ji-Eun" userId="5d7677e0d52343ec" providerId="LiveId" clId="{F023BD75-3484-F245-B723-6E8D9C13CED4}" dt="2023-04-03T04:04:12.817" v="2027" actId="164"/>
          <ac:spMkLst>
            <pc:docMk/>
            <pc:sldMk cId="3045183798" sldId="273"/>
            <ac:spMk id="26" creationId="{503E3F4D-8BDD-41ED-DC9B-D8548392A10D}"/>
          </ac:spMkLst>
        </pc:spChg>
        <pc:spChg chg="mod">
          <ac:chgData name="Kim Ji-Eun" userId="5d7677e0d52343ec" providerId="LiveId" clId="{F023BD75-3484-F245-B723-6E8D9C13CED4}" dt="2023-03-27T07:34:26.613" v="1716"/>
          <ac:spMkLst>
            <pc:docMk/>
            <pc:sldMk cId="3045183798" sldId="273"/>
            <ac:spMk id="26" creationId="{E014F956-36B3-51B0-75B0-CD07E8B67EB4}"/>
          </ac:spMkLst>
        </pc:spChg>
        <pc:spChg chg="mod">
          <ac:chgData name="Kim Ji-Eun" userId="5d7677e0d52343ec" providerId="LiveId" clId="{F023BD75-3484-F245-B723-6E8D9C13CED4}" dt="2023-03-27T07:34:26.613" v="1716"/>
          <ac:spMkLst>
            <pc:docMk/>
            <pc:sldMk cId="3045183798" sldId="273"/>
            <ac:spMk id="27" creationId="{A3AB7056-BB75-91F0-4911-9BDACB8BEBBA}"/>
          </ac:spMkLst>
        </pc:spChg>
        <pc:spChg chg="add mod">
          <ac:chgData name="Kim Ji-Eun" userId="5d7677e0d52343ec" providerId="LiveId" clId="{F023BD75-3484-F245-B723-6E8D9C13CED4}" dt="2023-04-03T04:04:12.817" v="2027" actId="164"/>
          <ac:spMkLst>
            <pc:docMk/>
            <pc:sldMk cId="3045183798" sldId="273"/>
            <ac:spMk id="27" creationId="{CAE12980-A053-2D2A-3081-B87C497B7B73}"/>
          </ac:spMkLst>
        </pc:spChg>
        <pc:spChg chg="mod">
          <ac:chgData name="Kim Ji-Eun" userId="5d7677e0d52343ec" providerId="LiveId" clId="{F023BD75-3484-F245-B723-6E8D9C13CED4}" dt="2023-04-03T04:44:54.266" v="2857" actId="1036"/>
          <ac:spMkLst>
            <pc:docMk/>
            <pc:sldMk cId="3045183798" sldId="273"/>
            <ac:spMk id="28" creationId="{6A893307-BCE5-A28E-30B1-7C1C55A38695}"/>
          </ac:spMkLst>
        </pc:spChg>
        <pc:spChg chg="mod">
          <ac:chgData name="Kim Ji-Eun" userId="5d7677e0d52343ec" providerId="LiveId" clId="{F023BD75-3484-F245-B723-6E8D9C13CED4}" dt="2023-03-27T07:34:26.613" v="1716"/>
          <ac:spMkLst>
            <pc:docMk/>
            <pc:sldMk cId="3045183798" sldId="273"/>
            <ac:spMk id="28" creationId="{B0A237E2-1BA0-7AF3-1472-601A03301DA8}"/>
          </ac:spMkLst>
        </pc:spChg>
        <pc:spChg chg="mod">
          <ac:chgData name="Kim Ji-Eun" userId="5d7677e0d52343ec" providerId="LiveId" clId="{F023BD75-3484-F245-B723-6E8D9C13CED4}" dt="2023-03-27T07:34:26.613" v="1716"/>
          <ac:spMkLst>
            <pc:docMk/>
            <pc:sldMk cId="3045183798" sldId="273"/>
            <ac:spMk id="29" creationId="{2EF5CD89-49D5-4AE0-A305-87B7B65819C5}"/>
          </ac:spMkLst>
        </pc:spChg>
        <pc:spChg chg="mod">
          <ac:chgData name="Kim Ji-Eun" userId="5d7677e0d52343ec" providerId="LiveId" clId="{F023BD75-3484-F245-B723-6E8D9C13CED4}" dt="2023-04-03T04:44:50.186" v="2856" actId="1036"/>
          <ac:spMkLst>
            <pc:docMk/>
            <pc:sldMk cId="3045183798" sldId="273"/>
            <ac:spMk id="30" creationId="{03704851-3A3B-5F2F-FA06-0B2F147205AE}"/>
          </ac:spMkLst>
        </pc:spChg>
        <pc:spChg chg="mod">
          <ac:chgData name="Kim Ji-Eun" userId="5d7677e0d52343ec" providerId="LiveId" clId="{F023BD75-3484-F245-B723-6E8D9C13CED4}" dt="2023-03-27T07:34:26.613" v="1716"/>
          <ac:spMkLst>
            <pc:docMk/>
            <pc:sldMk cId="3045183798" sldId="273"/>
            <ac:spMk id="30" creationId="{C85A780B-28D9-17CF-0888-AA752D88C5FE}"/>
          </ac:spMkLst>
        </pc:spChg>
        <pc:spChg chg="mod">
          <ac:chgData name="Kim Ji-Eun" userId="5d7677e0d52343ec" providerId="LiveId" clId="{F023BD75-3484-F245-B723-6E8D9C13CED4}" dt="2023-04-03T04:44:50.186" v="2856" actId="1036"/>
          <ac:spMkLst>
            <pc:docMk/>
            <pc:sldMk cId="3045183798" sldId="273"/>
            <ac:spMk id="31" creationId="{10B3DA26-F10C-FCBC-0CFD-DC3529A38ECF}"/>
          </ac:spMkLst>
        </pc:spChg>
        <pc:spChg chg="mod">
          <ac:chgData name="Kim Ji-Eun" userId="5d7677e0d52343ec" providerId="LiveId" clId="{F023BD75-3484-F245-B723-6E8D9C13CED4}" dt="2023-03-27T07:34:26.613" v="1716"/>
          <ac:spMkLst>
            <pc:docMk/>
            <pc:sldMk cId="3045183798" sldId="273"/>
            <ac:spMk id="31" creationId="{C2C35981-F233-7B87-712F-0796F9BA57AD}"/>
          </ac:spMkLst>
        </pc:spChg>
        <pc:spChg chg="mod">
          <ac:chgData name="Kim Ji-Eun" userId="5d7677e0d52343ec" providerId="LiveId" clId="{F023BD75-3484-F245-B723-6E8D9C13CED4}" dt="2023-03-27T07:34:26.613" v="1716"/>
          <ac:spMkLst>
            <pc:docMk/>
            <pc:sldMk cId="3045183798" sldId="273"/>
            <ac:spMk id="32" creationId="{A00E58A1-4201-523F-0F5A-7DC88531DF09}"/>
          </ac:spMkLst>
        </pc:spChg>
        <pc:spChg chg="mod">
          <ac:chgData name="Kim Ji-Eun" userId="5d7677e0d52343ec" providerId="LiveId" clId="{F023BD75-3484-F245-B723-6E8D9C13CED4}" dt="2023-03-27T07:34:26.613" v="1716"/>
          <ac:spMkLst>
            <pc:docMk/>
            <pc:sldMk cId="3045183798" sldId="273"/>
            <ac:spMk id="33" creationId="{757DFD72-E747-39CC-DBD3-292CD3E5FCAE}"/>
          </ac:spMkLst>
        </pc:spChg>
        <pc:spChg chg="mod">
          <ac:chgData name="Kim Ji-Eun" userId="5d7677e0d52343ec" providerId="LiveId" clId="{F023BD75-3484-F245-B723-6E8D9C13CED4}" dt="2023-04-03T04:13:11.941" v="2309" actId="1037"/>
          <ac:spMkLst>
            <pc:docMk/>
            <pc:sldMk cId="3045183798" sldId="273"/>
            <ac:spMk id="33" creationId="{B8906D60-D11E-9F5F-571B-18C8CF1F191D}"/>
          </ac:spMkLst>
        </pc:spChg>
        <pc:spChg chg="mod">
          <ac:chgData name="Kim Ji-Eun" userId="5d7677e0d52343ec" providerId="LiveId" clId="{F023BD75-3484-F245-B723-6E8D9C13CED4}" dt="2023-04-03T04:12:56.441" v="2300" actId="1038"/>
          <ac:spMkLst>
            <pc:docMk/>
            <pc:sldMk cId="3045183798" sldId="273"/>
            <ac:spMk id="34" creationId="{ACC18B32-5A0D-D800-C315-C39C95F33BB8}"/>
          </ac:spMkLst>
        </pc:spChg>
        <pc:spChg chg="mod">
          <ac:chgData name="Kim Ji-Eun" userId="5d7677e0d52343ec" providerId="LiveId" clId="{F023BD75-3484-F245-B723-6E8D9C13CED4}" dt="2023-03-27T07:34:26.613" v="1716"/>
          <ac:spMkLst>
            <pc:docMk/>
            <pc:sldMk cId="3045183798" sldId="273"/>
            <ac:spMk id="34" creationId="{F58D3D16-2A17-77A9-A011-4FDF9F4EE2F8}"/>
          </ac:spMkLst>
        </pc:spChg>
        <pc:spChg chg="mod">
          <ac:chgData name="Kim Ji-Eun" userId="5d7677e0d52343ec" providerId="LiveId" clId="{F023BD75-3484-F245-B723-6E8D9C13CED4}" dt="2023-03-27T07:34:26.613" v="1716"/>
          <ac:spMkLst>
            <pc:docMk/>
            <pc:sldMk cId="3045183798" sldId="273"/>
            <ac:spMk id="35" creationId="{D443D1F0-E60E-FEA0-BCD4-5620C332D0FE}"/>
          </ac:spMkLst>
        </pc:spChg>
        <pc:spChg chg="mod">
          <ac:chgData name="Kim Ji-Eun" userId="5d7677e0d52343ec" providerId="LiveId" clId="{F023BD75-3484-F245-B723-6E8D9C13CED4}" dt="2023-04-03T04:45:08.141" v="2862" actId="1036"/>
          <ac:spMkLst>
            <pc:docMk/>
            <pc:sldMk cId="3045183798" sldId="273"/>
            <ac:spMk id="36" creationId="{0F6D4C86-F71A-5E56-3923-22E592211EC1}"/>
          </ac:spMkLst>
        </pc:spChg>
        <pc:spChg chg="mod">
          <ac:chgData name="Kim Ji-Eun" userId="5d7677e0d52343ec" providerId="LiveId" clId="{F023BD75-3484-F245-B723-6E8D9C13CED4}" dt="2023-03-27T07:34:26.613" v="1716"/>
          <ac:spMkLst>
            <pc:docMk/>
            <pc:sldMk cId="3045183798" sldId="273"/>
            <ac:spMk id="36" creationId="{E28982BB-4525-977B-6D1E-5F1FDF8B558D}"/>
          </ac:spMkLst>
        </pc:spChg>
        <pc:spChg chg="mod">
          <ac:chgData name="Kim Ji-Eun" userId="5d7677e0d52343ec" providerId="LiveId" clId="{F023BD75-3484-F245-B723-6E8D9C13CED4}" dt="2023-03-27T07:34:26.613" v="1716"/>
          <ac:spMkLst>
            <pc:docMk/>
            <pc:sldMk cId="3045183798" sldId="273"/>
            <ac:spMk id="37" creationId="{3A746C9C-D6B6-8EF4-3658-964A2C400E26}"/>
          </ac:spMkLst>
        </pc:spChg>
        <pc:spChg chg="mod">
          <ac:chgData name="Kim Ji-Eun" userId="5d7677e0d52343ec" providerId="LiveId" clId="{F023BD75-3484-F245-B723-6E8D9C13CED4}" dt="2023-04-03T04:45:08.141" v="2862" actId="1036"/>
          <ac:spMkLst>
            <pc:docMk/>
            <pc:sldMk cId="3045183798" sldId="273"/>
            <ac:spMk id="37" creationId="{D0273C08-D2A4-205E-EDF4-876C301DF85C}"/>
          </ac:spMkLst>
        </pc:spChg>
        <pc:spChg chg="mod">
          <ac:chgData name="Kim Ji-Eun" userId="5d7677e0d52343ec" providerId="LiveId" clId="{F023BD75-3484-F245-B723-6E8D9C13CED4}" dt="2023-03-27T07:34:26.613" v="1716"/>
          <ac:spMkLst>
            <pc:docMk/>
            <pc:sldMk cId="3045183798" sldId="273"/>
            <ac:spMk id="38" creationId="{1264B975-1313-F4F9-4152-F3703A23409B}"/>
          </ac:spMkLst>
        </pc:spChg>
        <pc:spChg chg="mod">
          <ac:chgData name="Kim Ji-Eun" userId="5d7677e0d52343ec" providerId="LiveId" clId="{F023BD75-3484-F245-B723-6E8D9C13CED4}" dt="2023-04-03T04:13:11.941" v="2309" actId="1037"/>
          <ac:spMkLst>
            <pc:docMk/>
            <pc:sldMk cId="3045183798" sldId="273"/>
            <ac:spMk id="39" creationId="{CA5029C8-CA30-04F8-1468-95EFF37FDF86}"/>
          </ac:spMkLst>
        </pc:spChg>
        <pc:spChg chg="mod">
          <ac:chgData name="Kim Ji-Eun" userId="5d7677e0d52343ec" providerId="LiveId" clId="{F023BD75-3484-F245-B723-6E8D9C13CED4}" dt="2023-03-27T07:34:26.613" v="1716"/>
          <ac:spMkLst>
            <pc:docMk/>
            <pc:sldMk cId="3045183798" sldId="273"/>
            <ac:spMk id="39" creationId="{D11127B9-6806-33B5-8074-74673FAAD715}"/>
          </ac:spMkLst>
        </pc:spChg>
        <pc:spChg chg="mod">
          <ac:chgData name="Kim Ji-Eun" userId="5d7677e0d52343ec" providerId="LiveId" clId="{F023BD75-3484-F245-B723-6E8D9C13CED4}" dt="2023-03-27T07:34:26.613" v="1716"/>
          <ac:spMkLst>
            <pc:docMk/>
            <pc:sldMk cId="3045183798" sldId="273"/>
            <ac:spMk id="40" creationId="{032E533F-1CB3-7780-6699-0E2D71D9D7B6}"/>
          </ac:spMkLst>
        </pc:spChg>
        <pc:spChg chg="mod">
          <ac:chgData name="Kim Ji-Eun" userId="5d7677e0d52343ec" providerId="LiveId" clId="{F023BD75-3484-F245-B723-6E8D9C13CED4}" dt="2023-04-03T04:12:56.441" v="2300" actId="1038"/>
          <ac:spMkLst>
            <pc:docMk/>
            <pc:sldMk cId="3045183798" sldId="273"/>
            <ac:spMk id="40" creationId="{B661A3B6-733E-BAEB-9044-1A0AF3DA860F}"/>
          </ac:spMkLst>
        </pc:spChg>
        <pc:spChg chg="mod">
          <ac:chgData name="Kim Ji-Eun" userId="5d7677e0d52343ec" providerId="LiveId" clId="{F023BD75-3484-F245-B723-6E8D9C13CED4}" dt="2023-03-27T07:34:26.613" v="1716"/>
          <ac:spMkLst>
            <pc:docMk/>
            <pc:sldMk cId="3045183798" sldId="273"/>
            <ac:spMk id="41" creationId="{A4352D59-F869-0E3B-FF47-31C0E8A86DC0}"/>
          </ac:spMkLst>
        </pc:spChg>
        <pc:spChg chg="add del mod">
          <ac:chgData name="Kim Ji-Eun" userId="5d7677e0d52343ec" providerId="LiveId" clId="{F023BD75-3484-F245-B723-6E8D9C13CED4}" dt="2023-04-03T04:13:18.021" v="2312"/>
          <ac:spMkLst>
            <pc:docMk/>
            <pc:sldMk cId="3045183798" sldId="273"/>
            <ac:spMk id="42" creationId="{363BB8FB-9147-C905-AC20-F60D6A50EEF8}"/>
          </ac:spMkLst>
        </pc:spChg>
        <pc:spChg chg="mod">
          <ac:chgData name="Kim Ji-Eun" userId="5d7677e0d52343ec" providerId="LiveId" clId="{F023BD75-3484-F245-B723-6E8D9C13CED4}" dt="2023-03-27T07:34:26.613" v="1716"/>
          <ac:spMkLst>
            <pc:docMk/>
            <pc:sldMk cId="3045183798" sldId="273"/>
            <ac:spMk id="42" creationId="{74122F08-7E19-F369-4F98-6368E6302ADA}"/>
          </ac:spMkLst>
        </pc:spChg>
        <pc:spChg chg="add del mod">
          <ac:chgData name="Kim Ji-Eun" userId="5d7677e0d52343ec" providerId="LiveId" clId="{F023BD75-3484-F245-B723-6E8D9C13CED4}" dt="2023-04-03T04:13:47.932" v="2332"/>
          <ac:spMkLst>
            <pc:docMk/>
            <pc:sldMk cId="3045183798" sldId="273"/>
            <ac:spMk id="43" creationId="{75BFF0FC-0B7C-9F1C-9307-8FD546BC1F16}"/>
          </ac:spMkLst>
        </pc:spChg>
        <pc:spChg chg="mod">
          <ac:chgData name="Kim Ji-Eun" userId="5d7677e0d52343ec" providerId="LiveId" clId="{F023BD75-3484-F245-B723-6E8D9C13CED4}" dt="2023-03-27T07:34:26.613" v="1716"/>
          <ac:spMkLst>
            <pc:docMk/>
            <pc:sldMk cId="3045183798" sldId="273"/>
            <ac:spMk id="43" creationId="{A3820921-1576-7387-B761-762242E6FC8B}"/>
          </ac:spMkLst>
        </pc:spChg>
        <pc:spChg chg="mod">
          <ac:chgData name="Kim Ji-Eun" userId="5d7677e0d52343ec" providerId="LiveId" clId="{F023BD75-3484-F245-B723-6E8D9C13CED4}" dt="2023-03-27T07:34:26.613" v="1716"/>
          <ac:spMkLst>
            <pc:docMk/>
            <pc:sldMk cId="3045183798" sldId="273"/>
            <ac:spMk id="44" creationId="{9820F5EC-836A-54EB-164E-ED4705C91416}"/>
          </ac:spMkLst>
        </pc:spChg>
        <pc:spChg chg="add mod">
          <ac:chgData name="Kim Ji-Eun" userId="5d7677e0d52343ec" providerId="LiveId" clId="{F023BD75-3484-F245-B723-6E8D9C13CED4}" dt="2023-04-03T04:40:54.296" v="2789" actId="1035"/>
          <ac:spMkLst>
            <pc:docMk/>
            <pc:sldMk cId="3045183798" sldId="273"/>
            <ac:spMk id="44" creationId="{E5AE1198-6EA9-FD75-7AC8-0360460154F9}"/>
          </ac:spMkLst>
        </pc:spChg>
        <pc:spChg chg="add del mod">
          <ac:chgData name="Kim Ji-Eun" userId="5d7677e0d52343ec" providerId="LiveId" clId="{F023BD75-3484-F245-B723-6E8D9C13CED4}" dt="2023-04-03T04:15:01.560" v="2336" actId="478"/>
          <ac:spMkLst>
            <pc:docMk/>
            <pc:sldMk cId="3045183798" sldId="273"/>
            <ac:spMk id="45" creationId="{6F5F04CB-4789-0772-D9A3-D0AA3D886D33}"/>
          </ac:spMkLst>
        </pc:spChg>
        <pc:spChg chg="mod">
          <ac:chgData name="Kim Ji-Eun" userId="5d7677e0d52343ec" providerId="LiveId" clId="{F023BD75-3484-F245-B723-6E8D9C13CED4}" dt="2023-03-27T07:34:26.613" v="1716"/>
          <ac:spMkLst>
            <pc:docMk/>
            <pc:sldMk cId="3045183798" sldId="273"/>
            <ac:spMk id="45" creationId="{C8DC4231-BFE0-BEAF-20B8-6BE2ECCB096F}"/>
          </ac:spMkLst>
        </pc:spChg>
        <pc:spChg chg="mod">
          <ac:chgData name="Kim Ji-Eun" userId="5d7677e0d52343ec" providerId="LiveId" clId="{F023BD75-3484-F245-B723-6E8D9C13CED4}" dt="2023-03-27T07:34:26.613" v="1716"/>
          <ac:spMkLst>
            <pc:docMk/>
            <pc:sldMk cId="3045183798" sldId="273"/>
            <ac:spMk id="46" creationId="{9538F25C-9A1C-FBA7-041F-2F05042AD54C}"/>
          </ac:spMkLst>
        </pc:spChg>
        <pc:spChg chg="mod">
          <ac:chgData name="Kim Ji-Eun" userId="5d7677e0d52343ec" providerId="LiveId" clId="{F023BD75-3484-F245-B723-6E8D9C13CED4}" dt="2023-03-27T07:34:26.613" v="1716"/>
          <ac:spMkLst>
            <pc:docMk/>
            <pc:sldMk cId="3045183798" sldId="273"/>
            <ac:spMk id="47" creationId="{56727E7D-6575-AA8D-FF17-BF962D9AFD0E}"/>
          </ac:spMkLst>
        </pc:spChg>
        <pc:spChg chg="add mod">
          <ac:chgData name="Kim Ji-Eun" userId="5d7677e0d52343ec" providerId="LiveId" clId="{F023BD75-3484-F245-B723-6E8D9C13CED4}" dt="2023-04-03T04:48:26.935" v="2878" actId="1037"/>
          <ac:spMkLst>
            <pc:docMk/>
            <pc:sldMk cId="3045183798" sldId="273"/>
            <ac:spMk id="48" creationId="{02A3730D-D4A6-7EB0-9BAE-69C95C1FAC4C}"/>
          </ac:spMkLst>
        </pc:spChg>
        <pc:spChg chg="mod">
          <ac:chgData name="Kim Ji-Eun" userId="5d7677e0d52343ec" providerId="LiveId" clId="{F023BD75-3484-F245-B723-6E8D9C13CED4}" dt="2023-03-27T07:34:26.613" v="1716"/>
          <ac:spMkLst>
            <pc:docMk/>
            <pc:sldMk cId="3045183798" sldId="273"/>
            <ac:spMk id="48" creationId="{62A945EA-EE7D-F240-D11F-C60566CF44DE}"/>
          </ac:spMkLst>
        </pc:spChg>
        <pc:spChg chg="add mod">
          <ac:chgData name="Kim Ji-Eun" userId="5d7677e0d52343ec" providerId="LiveId" clId="{F023BD75-3484-F245-B723-6E8D9C13CED4}" dt="2023-03-27T07:34:46.075" v="1717"/>
          <ac:spMkLst>
            <pc:docMk/>
            <pc:sldMk cId="3045183798" sldId="273"/>
            <ac:spMk id="49" creationId="{2ED757B3-A8D2-EF68-EAA5-F9BFB95F05E1}"/>
          </ac:spMkLst>
        </pc:spChg>
        <pc:spChg chg="add mod">
          <ac:chgData name="Kim Ji-Eun" userId="5d7677e0d52343ec" providerId="LiveId" clId="{F023BD75-3484-F245-B723-6E8D9C13CED4}" dt="2023-03-27T07:34:46.075" v="1717"/>
          <ac:spMkLst>
            <pc:docMk/>
            <pc:sldMk cId="3045183798" sldId="273"/>
            <ac:spMk id="50" creationId="{8A83B094-BB52-E2BB-4D1C-B0C503B04B6C}"/>
          </ac:spMkLst>
        </pc:spChg>
        <pc:spChg chg="mod topLvl">
          <ac:chgData name="Kim Ji-Eun" userId="5d7677e0d52343ec" providerId="LiveId" clId="{F023BD75-3484-F245-B723-6E8D9C13CED4}" dt="2023-04-03T04:37:02.589" v="2619" actId="165"/>
          <ac:spMkLst>
            <pc:docMk/>
            <pc:sldMk cId="3045183798" sldId="273"/>
            <ac:spMk id="53" creationId="{64383929-BAD8-F128-119C-EFA3F65CE671}"/>
          </ac:spMkLst>
        </pc:spChg>
        <pc:spChg chg="mod topLvl">
          <ac:chgData name="Kim Ji-Eun" userId="5d7677e0d52343ec" providerId="LiveId" clId="{F023BD75-3484-F245-B723-6E8D9C13CED4}" dt="2023-04-03T04:37:02.589" v="2619" actId="165"/>
          <ac:spMkLst>
            <pc:docMk/>
            <pc:sldMk cId="3045183798" sldId="273"/>
            <ac:spMk id="55" creationId="{5EA6C38E-5AA6-B904-A6F9-EB43D3A8D98E}"/>
          </ac:spMkLst>
        </pc:spChg>
        <pc:spChg chg="mod topLvl">
          <ac:chgData name="Kim Ji-Eun" userId="5d7677e0d52343ec" providerId="LiveId" clId="{F023BD75-3484-F245-B723-6E8D9C13CED4}" dt="2023-04-03T07:56:45.542" v="3051" actId="20577"/>
          <ac:spMkLst>
            <pc:docMk/>
            <pc:sldMk cId="3045183798" sldId="273"/>
            <ac:spMk id="56" creationId="{67097FBD-113B-DB58-E55C-3EA3B3DDEDF2}"/>
          </ac:spMkLst>
        </pc:spChg>
        <pc:spChg chg="mod topLvl">
          <ac:chgData name="Kim Ji-Eun" userId="5d7677e0d52343ec" providerId="LiveId" clId="{F023BD75-3484-F245-B723-6E8D9C13CED4}" dt="2023-04-03T04:37:02.589" v="2619" actId="165"/>
          <ac:spMkLst>
            <pc:docMk/>
            <pc:sldMk cId="3045183798" sldId="273"/>
            <ac:spMk id="57" creationId="{AAB6F493-E968-4549-5DA1-F9EAA58E22F3}"/>
          </ac:spMkLst>
        </pc:spChg>
        <pc:spChg chg="mod topLvl">
          <ac:chgData name="Kim Ji-Eun" userId="5d7677e0d52343ec" providerId="LiveId" clId="{F023BD75-3484-F245-B723-6E8D9C13CED4}" dt="2023-04-03T07:56:52.362" v="3054" actId="14100"/>
          <ac:spMkLst>
            <pc:docMk/>
            <pc:sldMk cId="3045183798" sldId="273"/>
            <ac:spMk id="58" creationId="{68CEACE2-F2E5-F9CE-3EFA-ECC857D72BB6}"/>
          </ac:spMkLst>
        </pc:spChg>
        <pc:spChg chg="mod topLvl">
          <ac:chgData name="Kim Ji-Eun" userId="5d7677e0d52343ec" providerId="LiveId" clId="{F023BD75-3484-F245-B723-6E8D9C13CED4}" dt="2023-04-03T04:38:34.670" v="2651" actId="164"/>
          <ac:spMkLst>
            <pc:docMk/>
            <pc:sldMk cId="3045183798" sldId="273"/>
            <ac:spMk id="59" creationId="{4DA331E2-8973-6936-34F0-08D5BF179DC4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60" creationId="{D3519000-64A6-28D6-C509-EB38859D10AA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61" creationId="{CCE8AE45-5FD5-316B-70AF-581B53687194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62" creationId="{1F1CE104-06CF-F238-2090-6685EEA10552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63" creationId="{3414C2FE-54DC-F738-E72B-BF828AF93185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64" creationId="{21E2F956-6439-8A95-89BE-7924C0CD7957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65" creationId="{F849DAEA-0235-E3E9-530F-E265D1E347BC}"/>
          </ac:spMkLst>
        </pc:spChg>
        <pc:spChg chg="mod topLvl">
          <ac:chgData name="Kim Ji-Eun" userId="5d7677e0d52343ec" providerId="LiveId" clId="{F023BD75-3484-F245-B723-6E8D9C13CED4}" dt="2023-04-03T04:40:18.001" v="2739" actId="164"/>
          <ac:spMkLst>
            <pc:docMk/>
            <pc:sldMk cId="3045183798" sldId="273"/>
            <ac:spMk id="66" creationId="{531FA8A2-7B76-96AF-719D-E63A6C66C8F7}"/>
          </ac:spMkLst>
        </pc:spChg>
        <pc:spChg chg="mod topLvl">
          <ac:chgData name="Kim Ji-Eun" userId="5d7677e0d52343ec" providerId="LiveId" clId="{F023BD75-3484-F245-B723-6E8D9C13CED4}" dt="2023-04-03T04:38:34.670" v="2651" actId="164"/>
          <ac:spMkLst>
            <pc:docMk/>
            <pc:sldMk cId="3045183798" sldId="273"/>
            <ac:spMk id="67" creationId="{30C016DF-A349-6A1D-FCD5-8D85C8AFEBE1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68" creationId="{0ED0D6E4-4669-E5DA-F254-2236AEE9DB04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69" creationId="{F175B773-60C2-479F-5D9A-B87E899EADB9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70" creationId="{C4F7CAA0-C9C3-AF20-C12C-50E0903B66E1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71" creationId="{24500451-76EB-4584-5588-C0C2BBBC2A75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72" creationId="{1D5ABE08-C707-6978-D6D7-0D26EA3FDBA4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73" creationId="{22BB5F76-508D-CE9F-E62A-3EE577350461}"/>
          </ac:spMkLst>
        </pc:spChg>
        <pc:spChg chg="mod topLvl">
          <ac:chgData name="Kim Ji-Eun" userId="5d7677e0d52343ec" providerId="LiveId" clId="{F023BD75-3484-F245-B723-6E8D9C13CED4}" dt="2023-04-03T04:40:18.001" v="2739" actId="164"/>
          <ac:spMkLst>
            <pc:docMk/>
            <pc:sldMk cId="3045183798" sldId="273"/>
            <ac:spMk id="74" creationId="{A580D982-6156-3A6A-03BC-CD919FAAA39E}"/>
          </ac:spMkLst>
        </pc:spChg>
        <pc:spChg chg="mod topLvl">
          <ac:chgData name="Kim Ji-Eun" userId="5d7677e0d52343ec" providerId="LiveId" clId="{F023BD75-3484-F245-B723-6E8D9C13CED4}" dt="2023-04-03T04:38:34.670" v="2651" actId="164"/>
          <ac:spMkLst>
            <pc:docMk/>
            <pc:sldMk cId="3045183798" sldId="273"/>
            <ac:spMk id="75" creationId="{F08FAFDE-4326-F9AE-66DF-A9191BF0EFD1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76" creationId="{B52DB694-D82A-CE15-66EA-88F684EAD425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77" creationId="{8549DAF3-55BD-B91A-46CD-05974DDAA732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78" creationId="{1BF93651-D540-8839-9F05-75F8F7730543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79" creationId="{212C517E-A213-F429-9C83-88FA7A927C6F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80" creationId="{3BB02861-1453-564C-A240-EF22AA2FD951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81" creationId="{C0265D2E-CFB8-382C-7E60-42D2F212765E}"/>
          </ac:spMkLst>
        </pc:spChg>
        <pc:spChg chg="mod topLvl">
          <ac:chgData name="Kim Ji-Eun" userId="5d7677e0d52343ec" providerId="LiveId" clId="{F023BD75-3484-F245-B723-6E8D9C13CED4}" dt="2023-04-03T04:38:34.670" v="2651" actId="164"/>
          <ac:spMkLst>
            <pc:docMk/>
            <pc:sldMk cId="3045183798" sldId="273"/>
            <ac:spMk id="82" creationId="{45D5F9E4-2115-010F-A3F7-E5BBB2EACDCE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83" creationId="{0F81795B-9430-EDEA-14B4-50FF58921ED2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84" creationId="{639168CB-C025-6E6D-880B-4A40F301B7F4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85" creationId="{A49CE925-DC01-CDEE-A11E-123F6707DC2F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86" creationId="{2C392BA9-A9E1-03FB-75D4-9C36970C423D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87" creationId="{88384AFA-4FBF-49B8-5869-DC3FD3C8A487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88" creationId="{DBDDC317-F034-009A-14DD-822D356E6CA6}"/>
          </ac:spMkLst>
        </pc:spChg>
        <pc:spChg chg="mod topLvl">
          <ac:chgData name="Kim Ji-Eun" userId="5d7677e0d52343ec" providerId="LiveId" clId="{F023BD75-3484-F245-B723-6E8D9C13CED4}" dt="2023-04-03T04:38:34.670" v="2651" actId="164"/>
          <ac:spMkLst>
            <pc:docMk/>
            <pc:sldMk cId="3045183798" sldId="273"/>
            <ac:spMk id="89" creationId="{2AD12CEA-F9E8-A0FB-A33D-32F4E8F96F0B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90" creationId="{925BB42C-D6A9-9148-4B0E-921AA596C9FC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91" creationId="{B73CE063-349F-DCFB-078D-48A7C67D3DCD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92" creationId="{EDF28E56-9389-C389-94A8-EEE657892378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93" creationId="{D7DB606F-3AE2-ADD7-C257-2BC55FF4FB39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94" creationId="{17B8E197-AF36-E7ED-1D8A-6C217E2BBD10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95" creationId="{65ECECF6-3E98-2032-DDC1-007736387CEB}"/>
          </ac:spMkLst>
        </pc:spChg>
        <pc:spChg chg="mod topLvl">
          <ac:chgData name="Kim Ji-Eun" userId="5d7677e0d52343ec" providerId="LiveId" clId="{F023BD75-3484-F245-B723-6E8D9C13CED4}" dt="2023-04-03T04:37:02.589" v="2619" actId="165"/>
          <ac:spMkLst>
            <pc:docMk/>
            <pc:sldMk cId="3045183798" sldId="273"/>
            <ac:spMk id="96" creationId="{62EDFCB2-CAA6-9508-2F3F-CCBACE083E89}"/>
          </ac:spMkLst>
        </pc:spChg>
        <pc:spChg chg="mod topLvl">
          <ac:chgData name="Kim Ji-Eun" userId="5d7677e0d52343ec" providerId="LiveId" clId="{F023BD75-3484-F245-B723-6E8D9C13CED4}" dt="2023-04-03T04:37:02.589" v="2619" actId="165"/>
          <ac:spMkLst>
            <pc:docMk/>
            <pc:sldMk cId="3045183798" sldId="273"/>
            <ac:spMk id="97" creationId="{DD1B1709-F7A6-B4A9-0EB4-A8358754AEEB}"/>
          </ac:spMkLst>
        </pc:spChg>
        <pc:spChg chg="mod topLvl">
          <ac:chgData name="Kim Ji-Eun" userId="5d7677e0d52343ec" providerId="LiveId" clId="{F023BD75-3484-F245-B723-6E8D9C13CED4}" dt="2023-04-03T04:37:02.589" v="2619" actId="165"/>
          <ac:spMkLst>
            <pc:docMk/>
            <pc:sldMk cId="3045183798" sldId="273"/>
            <ac:spMk id="98" creationId="{5B213547-468A-D063-0298-4B85BDE31B36}"/>
          </ac:spMkLst>
        </pc:spChg>
        <pc:spChg chg="mod topLvl">
          <ac:chgData name="Kim Ji-Eun" userId="5d7677e0d52343ec" providerId="LiveId" clId="{F023BD75-3484-F245-B723-6E8D9C13CED4}" dt="2023-04-03T04:37:02.589" v="2619" actId="165"/>
          <ac:spMkLst>
            <pc:docMk/>
            <pc:sldMk cId="3045183798" sldId="273"/>
            <ac:spMk id="99" creationId="{0F6E2074-9398-3EC8-0541-BCB633A37110}"/>
          </ac:spMkLst>
        </pc:spChg>
        <pc:spChg chg="mod topLvl">
          <ac:chgData name="Kim Ji-Eun" userId="5d7677e0d52343ec" providerId="LiveId" clId="{F023BD75-3484-F245-B723-6E8D9C13CED4}" dt="2023-04-03T04:37:02.589" v="2619" actId="165"/>
          <ac:spMkLst>
            <pc:docMk/>
            <pc:sldMk cId="3045183798" sldId="273"/>
            <ac:spMk id="100" creationId="{19387A8E-9D71-97AC-B8B5-98C30E5AA491}"/>
          </ac:spMkLst>
        </pc:spChg>
        <pc:spChg chg="mod topLvl">
          <ac:chgData name="Kim Ji-Eun" userId="5d7677e0d52343ec" providerId="LiveId" clId="{F023BD75-3484-F245-B723-6E8D9C13CED4}" dt="2023-04-03T04:37:02.589" v="2619" actId="165"/>
          <ac:spMkLst>
            <pc:docMk/>
            <pc:sldMk cId="3045183798" sldId="273"/>
            <ac:spMk id="101" creationId="{F3BE0C54-79DF-A58B-9289-693A98A29392}"/>
          </ac:spMkLst>
        </pc:spChg>
        <pc:spChg chg="mod topLvl">
          <ac:chgData name="Kim Ji-Eun" userId="5d7677e0d52343ec" providerId="LiveId" clId="{F023BD75-3484-F245-B723-6E8D9C13CED4}" dt="2023-04-03T04:37:02.589" v="2619" actId="165"/>
          <ac:spMkLst>
            <pc:docMk/>
            <pc:sldMk cId="3045183798" sldId="273"/>
            <ac:spMk id="102" creationId="{2BBDA465-E226-24C4-79D3-E7D789317688}"/>
          </ac:spMkLst>
        </pc:spChg>
        <pc:spChg chg="mod topLvl">
          <ac:chgData name="Kim Ji-Eun" userId="5d7677e0d52343ec" providerId="LiveId" clId="{F023BD75-3484-F245-B723-6E8D9C13CED4}" dt="2023-04-03T04:37:02.589" v="2619" actId="165"/>
          <ac:spMkLst>
            <pc:docMk/>
            <pc:sldMk cId="3045183798" sldId="273"/>
            <ac:spMk id="103" creationId="{D9C9EA8B-3E70-3B30-2510-A659D3745CE4}"/>
          </ac:spMkLst>
        </pc:spChg>
        <pc:spChg chg="mod topLvl">
          <ac:chgData name="Kim Ji-Eun" userId="5d7677e0d52343ec" providerId="LiveId" clId="{F023BD75-3484-F245-B723-6E8D9C13CED4}" dt="2023-04-03T04:37:02.589" v="2619" actId="165"/>
          <ac:spMkLst>
            <pc:docMk/>
            <pc:sldMk cId="3045183798" sldId="273"/>
            <ac:spMk id="104" creationId="{D33E5DC6-C1CB-1E94-CED7-65E39F3A9B93}"/>
          </ac:spMkLst>
        </pc:spChg>
        <pc:spChg chg="mod topLvl">
          <ac:chgData name="Kim Ji-Eun" userId="5d7677e0d52343ec" providerId="LiveId" clId="{F023BD75-3484-F245-B723-6E8D9C13CED4}" dt="2023-04-03T04:37:02.589" v="2619" actId="165"/>
          <ac:spMkLst>
            <pc:docMk/>
            <pc:sldMk cId="3045183798" sldId="273"/>
            <ac:spMk id="105" creationId="{C3AE4690-C44B-D0E4-0A84-0B7590C7C44B}"/>
          </ac:spMkLst>
        </pc:spChg>
        <pc:spChg chg="mod topLvl">
          <ac:chgData name="Kim Ji-Eun" userId="5d7677e0d52343ec" providerId="LiveId" clId="{F023BD75-3484-F245-B723-6E8D9C13CED4}" dt="2023-04-03T04:37:02.589" v="2619" actId="165"/>
          <ac:spMkLst>
            <pc:docMk/>
            <pc:sldMk cId="3045183798" sldId="273"/>
            <ac:spMk id="106" creationId="{4964A620-6D3B-9976-D21C-4E8D88923BB4}"/>
          </ac:spMkLst>
        </pc:spChg>
        <pc:spChg chg="mod topLvl">
          <ac:chgData name="Kim Ji-Eun" userId="5d7677e0d52343ec" providerId="LiveId" clId="{F023BD75-3484-F245-B723-6E8D9C13CED4}" dt="2023-04-03T04:37:02.589" v="2619" actId="165"/>
          <ac:spMkLst>
            <pc:docMk/>
            <pc:sldMk cId="3045183798" sldId="273"/>
            <ac:spMk id="111" creationId="{DBD3C35C-8FBD-87D6-D912-C06A890B9542}"/>
          </ac:spMkLst>
        </pc:spChg>
        <pc:spChg chg="mod topLvl">
          <ac:chgData name="Kim Ji-Eun" userId="5d7677e0d52343ec" providerId="LiveId" clId="{F023BD75-3484-F245-B723-6E8D9C13CED4}" dt="2023-04-03T04:38:34.670" v="2651" actId="164"/>
          <ac:spMkLst>
            <pc:docMk/>
            <pc:sldMk cId="3045183798" sldId="273"/>
            <ac:spMk id="114" creationId="{A023F4CA-92CA-6F2B-5713-BCBC9D921760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115" creationId="{3BEB0728-88A0-892C-1C9B-DBAE4475B449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116" creationId="{C17F493E-924E-19F2-88D9-C8F83EE6ADFD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117" creationId="{B2CB6D21-D8D7-AA98-55AA-F6A58DF3033C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118" creationId="{8B594897-207C-2E7E-AAE2-A6509709C70B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119" creationId="{81F6C6AB-43E4-E67E-971C-A1BBED31AB16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120" creationId="{2586E74F-3389-D35E-5627-8CA10F519C94}"/>
          </ac:spMkLst>
        </pc:spChg>
        <pc:spChg chg="mod topLvl">
          <ac:chgData name="Kim Ji-Eun" userId="5d7677e0d52343ec" providerId="LiveId" clId="{F023BD75-3484-F245-B723-6E8D9C13CED4}" dt="2023-04-03T04:40:18.001" v="2739" actId="164"/>
          <ac:spMkLst>
            <pc:docMk/>
            <pc:sldMk cId="3045183798" sldId="273"/>
            <ac:spMk id="121" creationId="{250AB102-DCAD-D499-6E9D-8674012D2DEA}"/>
          </ac:spMkLst>
        </pc:spChg>
        <pc:spChg chg="mod topLvl">
          <ac:chgData name="Kim Ji-Eun" userId="5d7677e0d52343ec" providerId="LiveId" clId="{F023BD75-3484-F245-B723-6E8D9C13CED4}" dt="2023-04-03T04:38:34.670" v="2651" actId="164"/>
          <ac:spMkLst>
            <pc:docMk/>
            <pc:sldMk cId="3045183798" sldId="273"/>
            <ac:spMk id="122" creationId="{AE118793-DF51-DCC2-6B66-B37C60B171EB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123" creationId="{0CC0E165-D7FC-D5CB-B112-91F628DCE85C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124" creationId="{CA4575CC-DF90-AC0C-9820-BC4812F93A4F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125" creationId="{5285E4E4-9D42-CA49-49D4-598B11E9982C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126" creationId="{DB5A825E-E624-F546-4767-EB766F750676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127" creationId="{B9761616-F591-667C-F7DE-661972580308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128" creationId="{799182DE-1616-6FAF-D7F5-A045CD5A9403}"/>
          </ac:spMkLst>
        </pc:spChg>
        <pc:spChg chg="mod topLvl">
          <ac:chgData name="Kim Ji-Eun" userId="5d7677e0d52343ec" providerId="LiveId" clId="{F023BD75-3484-F245-B723-6E8D9C13CED4}" dt="2023-04-03T04:40:18.001" v="2739" actId="164"/>
          <ac:spMkLst>
            <pc:docMk/>
            <pc:sldMk cId="3045183798" sldId="273"/>
            <ac:spMk id="129" creationId="{42F30223-ACD3-B31C-128B-DCCFE4B013C8}"/>
          </ac:spMkLst>
        </pc:spChg>
        <pc:spChg chg="mod topLvl">
          <ac:chgData name="Kim Ji-Eun" userId="5d7677e0d52343ec" providerId="LiveId" clId="{F023BD75-3484-F245-B723-6E8D9C13CED4}" dt="2023-04-03T04:38:34.670" v="2651" actId="164"/>
          <ac:spMkLst>
            <pc:docMk/>
            <pc:sldMk cId="3045183798" sldId="273"/>
            <ac:spMk id="130" creationId="{81586F16-EB8D-C826-4419-F79411C0A513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131" creationId="{4CFFF28D-70E4-3150-7C0D-DD5F3AC1094B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132" creationId="{0A4FDAFC-B068-850E-1022-0874870B9249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133" creationId="{4416637C-4470-C146-F026-78D2DE0577DA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134" creationId="{46F8126A-B516-C3A1-34FE-7CBE766046D2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135" creationId="{EF72A03B-C77C-B1F9-FF0C-E987829E759C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136" creationId="{0EEEF7BA-70E7-E77D-7C5C-6F477EB69920}"/>
          </ac:spMkLst>
        </pc:spChg>
        <pc:spChg chg="mod topLvl">
          <ac:chgData name="Kim Ji-Eun" userId="5d7677e0d52343ec" providerId="LiveId" clId="{F023BD75-3484-F245-B723-6E8D9C13CED4}" dt="2023-04-03T04:38:34.670" v="2651" actId="164"/>
          <ac:spMkLst>
            <pc:docMk/>
            <pc:sldMk cId="3045183798" sldId="273"/>
            <ac:spMk id="137" creationId="{7EC3E4B4-368B-DD07-9E42-DCBF18D1D1D3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138" creationId="{39D2CE88-C9FF-00CB-3E4F-B0557BD746A8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139" creationId="{9459BD6F-3433-E29B-E707-B6AEC5C2857D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140" creationId="{62BFC56E-C3F2-06AC-645B-10F4243B26E9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141" creationId="{5CF2FFB4-CCDB-1715-E7F0-EF968029FD95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142" creationId="{3BEDDDC4-30DE-C8BC-0C28-029FDE9ABBD3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143" creationId="{E7FE9122-97C1-3FBE-8249-3147054ADE15}"/>
          </ac:spMkLst>
        </pc:spChg>
        <pc:spChg chg="mod topLvl">
          <ac:chgData name="Kim Ji-Eun" userId="5d7677e0d52343ec" providerId="LiveId" clId="{F023BD75-3484-F245-B723-6E8D9C13CED4}" dt="2023-04-03T04:38:34.670" v="2651" actId="164"/>
          <ac:spMkLst>
            <pc:docMk/>
            <pc:sldMk cId="3045183798" sldId="273"/>
            <ac:spMk id="144" creationId="{D5C33B3F-A1AC-4511-FB31-0B0D5E8B9C42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145" creationId="{0FE55B8E-B4B1-5885-7D09-72CB0313CB15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146" creationId="{767C99B5-48B1-974E-C86F-E6830CA19417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147" creationId="{2B3D1CAD-9F74-4D6F-42F8-C17A0FC87B07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148" creationId="{752E1C76-A157-A1B4-43B5-23C8FBD2EDCC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149" creationId="{09F18278-D08D-631E-EE9F-B4B1728A35AA}"/>
          </ac:spMkLst>
        </pc:spChg>
        <pc:spChg chg="mod topLvl">
          <ac:chgData name="Kim Ji-Eun" userId="5d7677e0d52343ec" providerId="LiveId" clId="{F023BD75-3484-F245-B723-6E8D9C13CED4}" dt="2023-04-03T04:40:33.386" v="2756" actId="465"/>
          <ac:spMkLst>
            <pc:docMk/>
            <pc:sldMk cId="3045183798" sldId="273"/>
            <ac:spMk id="150" creationId="{2CE4802D-F9C2-7425-58E6-907365B8F063}"/>
          </ac:spMkLst>
        </pc:spChg>
        <pc:spChg chg="add mod">
          <ac:chgData name="Kim Ji-Eun" userId="5d7677e0d52343ec" providerId="LiveId" clId="{F023BD75-3484-F245-B723-6E8D9C13CED4}" dt="2023-04-03T04:40:54.296" v="2789" actId="1035"/>
          <ac:spMkLst>
            <pc:docMk/>
            <pc:sldMk cId="3045183798" sldId="273"/>
            <ac:spMk id="151" creationId="{22D10BCD-EAE3-6305-84C7-D88A26EC63F0}"/>
          </ac:spMkLst>
        </pc:spChg>
        <pc:spChg chg="add mod">
          <ac:chgData name="Kim Ji-Eun" userId="5d7677e0d52343ec" providerId="LiveId" clId="{F023BD75-3484-F245-B723-6E8D9C13CED4}" dt="2023-04-03T04:48:26.935" v="2878" actId="1037"/>
          <ac:spMkLst>
            <pc:docMk/>
            <pc:sldMk cId="3045183798" sldId="273"/>
            <ac:spMk id="152" creationId="{14638999-CC76-9915-063A-64D8A9BC2DB1}"/>
          </ac:spMkLst>
        </pc:spChg>
        <pc:spChg chg="add del mod">
          <ac:chgData name="Kim Ji-Eun" userId="5d7677e0d52343ec" providerId="LiveId" clId="{F023BD75-3484-F245-B723-6E8D9C13CED4}" dt="2023-03-27T07:35:42.634" v="1763"/>
          <ac:spMkLst>
            <pc:docMk/>
            <pc:sldMk cId="3045183798" sldId="273"/>
            <ac:spMk id="153" creationId="{AF231794-6EE2-1705-0420-C7175E12CC28}"/>
          </ac:spMkLst>
        </pc:spChg>
        <pc:spChg chg="add del mod">
          <ac:chgData name="Kim Ji-Eun" userId="5d7677e0d52343ec" providerId="LiveId" clId="{F023BD75-3484-F245-B723-6E8D9C13CED4}" dt="2023-03-28T07:57:03.094" v="1774"/>
          <ac:spMkLst>
            <pc:docMk/>
            <pc:sldMk cId="3045183798" sldId="273"/>
            <ac:spMk id="153" creationId="{EBBA43D5-E4B7-4C14-E942-507807C330D7}"/>
          </ac:spMkLst>
        </pc:spChg>
        <pc:spChg chg="mod topLvl">
          <ac:chgData name="Kim Ji-Eun" userId="5d7677e0d52343ec" providerId="LiveId" clId="{F023BD75-3484-F245-B723-6E8D9C13CED4}" dt="2023-04-03T04:13:27.306" v="2323" actId="1037"/>
          <ac:spMkLst>
            <pc:docMk/>
            <pc:sldMk cId="3045183798" sldId="273"/>
            <ac:spMk id="155" creationId="{15B15077-A296-CFA6-3EB2-26A53D04AA92}"/>
          </ac:spMkLst>
        </pc:spChg>
        <pc:spChg chg="del mod topLvl">
          <ac:chgData name="Kim Ji-Eun" userId="5d7677e0d52343ec" providerId="LiveId" clId="{F023BD75-3484-F245-B723-6E8D9C13CED4}" dt="2023-04-03T04:03:19.872" v="2010" actId="478"/>
          <ac:spMkLst>
            <pc:docMk/>
            <pc:sldMk cId="3045183798" sldId="273"/>
            <ac:spMk id="156" creationId="{42E360C5-72A6-7129-E6B2-D9959A29AD24}"/>
          </ac:spMkLst>
        </pc:spChg>
        <pc:spChg chg="del mod topLvl">
          <ac:chgData name="Kim Ji-Eun" userId="5d7677e0d52343ec" providerId="LiveId" clId="{F023BD75-3484-F245-B723-6E8D9C13CED4}" dt="2023-04-03T04:03:19.872" v="2010" actId="478"/>
          <ac:spMkLst>
            <pc:docMk/>
            <pc:sldMk cId="3045183798" sldId="273"/>
            <ac:spMk id="157" creationId="{31A7DC9F-6453-93D1-2647-9EF2A5B7C52D}"/>
          </ac:spMkLst>
        </pc:spChg>
        <pc:spChg chg="del mod topLvl">
          <ac:chgData name="Kim Ji-Eun" userId="5d7677e0d52343ec" providerId="LiveId" clId="{F023BD75-3484-F245-B723-6E8D9C13CED4}" dt="2023-04-03T04:03:19.872" v="2010" actId="478"/>
          <ac:spMkLst>
            <pc:docMk/>
            <pc:sldMk cId="3045183798" sldId="273"/>
            <ac:spMk id="158" creationId="{F7C142D0-C33D-605D-EEEA-DEB8630C1527}"/>
          </ac:spMkLst>
        </pc:spChg>
        <pc:spChg chg="del mod topLvl">
          <ac:chgData name="Kim Ji-Eun" userId="5d7677e0d52343ec" providerId="LiveId" clId="{F023BD75-3484-F245-B723-6E8D9C13CED4}" dt="2023-04-03T04:03:19.872" v="2010" actId="478"/>
          <ac:spMkLst>
            <pc:docMk/>
            <pc:sldMk cId="3045183798" sldId="273"/>
            <ac:spMk id="159" creationId="{18FBF50C-3D17-8493-AB32-B789764FAF12}"/>
          </ac:spMkLst>
        </pc:spChg>
        <pc:spChg chg="mod topLvl">
          <ac:chgData name="Kim Ji-Eun" userId="5d7677e0d52343ec" providerId="LiveId" clId="{F023BD75-3484-F245-B723-6E8D9C13CED4}" dt="2023-04-03T04:13:27.306" v="2323" actId="1037"/>
          <ac:spMkLst>
            <pc:docMk/>
            <pc:sldMk cId="3045183798" sldId="273"/>
            <ac:spMk id="160" creationId="{57265296-5B74-50EE-DBCE-17C2D20E5F1C}"/>
          </ac:spMkLst>
        </pc:spChg>
        <pc:spChg chg="mod topLvl">
          <ac:chgData name="Kim Ji-Eun" userId="5d7677e0d52343ec" providerId="LiveId" clId="{F023BD75-3484-F245-B723-6E8D9C13CED4}" dt="2023-04-03T04:13:27.306" v="2323" actId="1037"/>
          <ac:spMkLst>
            <pc:docMk/>
            <pc:sldMk cId="3045183798" sldId="273"/>
            <ac:spMk id="161" creationId="{B061436A-7E0B-7EAD-5825-AEDF3007A9A3}"/>
          </ac:spMkLst>
        </pc:spChg>
        <pc:spChg chg="mod topLvl">
          <ac:chgData name="Kim Ji-Eun" userId="5d7677e0d52343ec" providerId="LiveId" clId="{F023BD75-3484-F245-B723-6E8D9C13CED4}" dt="2023-04-03T04:04:12.817" v="2027" actId="164"/>
          <ac:spMkLst>
            <pc:docMk/>
            <pc:sldMk cId="3045183798" sldId="273"/>
            <ac:spMk id="164" creationId="{609E800F-8CA4-A186-040B-E8B4949CCF76}"/>
          </ac:spMkLst>
        </pc:spChg>
        <pc:spChg chg="mod topLvl">
          <ac:chgData name="Kim Ji-Eun" userId="5d7677e0d52343ec" providerId="LiveId" clId="{F023BD75-3484-F245-B723-6E8D9C13CED4}" dt="2023-04-03T04:04:12.817" v="2027" actId="164"/>
          <ac:spMkLst>
            <pc:docMk/>
            <pc:sldMk cId="3045183798" sldId="273"/>
            <ac:spMk id="165" creationId="{C5CD7BE1-2BC6-323F-A119-39A7B0EE842C}"/>
          </ac:spMkLst>
        </pc:spChg>
        <pc:spChg chg="mod topLvl">
          <ac:chgData name="Kim Ji-Eun" userId="5d7677e0d52343ec" providerId="LiveId" clId="{F023BD75-3484-F245-B723-6E8D9C13CED4}" dt="2023-04-03T04:04:12.817" v="2027" actId="164"/>
          <ac:spMkLst>
            <pc:docMk/>
            <pc:sldMk cId="3045183798" sldId="273"/>
            <ac:spMk id="166" creationId="{8453AB1E-FDE1-868C-BA11-AB760C3C6317}"/>
          </ac:spMkLst>
        </pc:spChg>
        <pc:spChg chg="mod topLvl">
          <ac:chgData name="Kim Ji-Eun" userId="5d7677e0d52343ec" providerId="LiveId" clId="{F023BD75-3484-F245-B723-6E8D9C13CED4}" dt="2023-04-03T04:04:12.817" v="2027" actId="164"/>
          <ac:spMkLst>
            <pc:docMk/>
            <pc:sldMk cId="3045183798" sldId="273"/>
            <ac:spMk id="167" creationId="{F16FC9C8-FC1F-429E-6DF3-8BCD9505032F}"/>
          </ac:spMkLst>
        </pc:spChg>
        <pc:spChg chg="mod topLvl">
          <ac:chgData name="Kim Ji-Eun" userId="5d7677e0d52343ec" providerId="LiveId" clId="{F023BD75-3484-F245-B723-6E8D9C13CED4}" dt="2023-04-03T04:04:12.817" v="2027" actId="164"/>
          <ac:spMkLst>
            <pc:docMk/>
            <pc:sldMk cId="3045183798" sldId="273"/>
            <ac:spMk id="168" creationId="{D925F77F-2310-6570-6BDB-4B1F8BA39F3C}"/>
          </ac:spMkLst>
        </pc:spChg>
        <pc:spChg chg="mod topLvl">
          <ac:chgData name="Kim Ji-Eun" userId="5d7677e0d52343ec" providerId="LiveId" clId="{F023BD75-3484-F245-B723-6E8D9C13CED4}" dt="2023-04-03T04:04:12.817" v="2027" actId="164"/>
          <ac:spMkLst>
            <pc:docMk/>
            <pc:sldMk cId="3045183798" sldId="273"/>
            <ac:spMk id="169" creationId="{68D5BD8E-EB6D-30BE-4840-794C2A80E279}"/>
          </ac:spMkLst>
        </pc:spChg>
        <pc:spChg chg="mod topLvl">
          <ac:chgData name="Kim Ji-Eun" userId="5d7677e0d52343ec" providerId="LiveId" clId="{F023BD75-3484-F245-B723-6E8D9C13CED4}" dt="2023-04-03T04:04:12.817" v="2027" actId="164"/>
          <ac:spMkLst>
            <pc:docMk/>
            <pc:sldMk cId="3045183798" sldId="273"/>
            <ac:spMk id="170" creationId="{42AB489F-0C07-5214-2B9C-2C37714F6B08}"/>
          </ac:spMkLst>
        </pc:spChg>
        <pc:spChg chg="mod topLvl">
          <ac:chgData name="Kim Ji-Eun" userId="5d7677e0d52343ec" providerId="LiveId" clId="{F023BD75-3484-F245-B723-6E8D9C13CED4}" dt="2023-04-03T04:04:12.817" v="2027" actId="164"/>
          <ac:spMkLst>
            <pc:docMk/>
            <pc:sldMk cId="3045183798" sldId="273"/>
            <ac:spMk id="171" creationId="{EE2D0CFE-ED64-0CDE-F074-51D6B2BFD773}"/>
          </ac:spMkLst>
        </pc:spChg>
        <pc:spChg chg="mod topLvl">
          <ac:chgData name="Kim Ji-Eun" userId="5d7677e0d52343ec" providerId="LiveId" clId="{F023BD75-3484-F245-B723-6E8D9C13CED4}" dt="2023-04-03T04:04:12.817" v="2027" actId="164"/>
          <ac:spMkLst>
            <pc:docMk/>
            <pc:sldMk cId="3045183798" sldId="273"/>
            <ac:spMk id="172" creationId="{C4A475EB-A5EB-814E-0BF8-6E8957B4672E}"/>
          </ac:spMkLst>
        </pc:spChg>
        <pc:spChg chg="mod topLvl">
          <ac:chgData name="Kim Ji-Eun" userId="5d7677e0d52343ec" providerId="LiveId" clId="{F023BD75-3484-F245-B723-6E8D9C13CED4}" dt="2023-04-03T04:04:12.817" v="2027" actId="164"/>
          <ac:spMkLst>
            <pc:docMk/>
            <pc:sldMk cId="3045183798" sldId="273"/>
            <ac:spMk id="173" creationId="{498687A0-4BE1-D57C-5FC7-034A36D6C3C9}"/>
          </ac:spMkLst>
        </pc:spChg>
        <pc:spChg chg="mod topLvl">
          <ac:chgData name="Kim Ji-Eun" userId="5d7677e0d52343ec" providerId="LiveId" clId="{F023BD75-3484-F245-B723-6E8D9C13CED4}" dt="2023-04-03T04:04:12.817" v="2027" actId="164"/>
          <ac:spMkLst>
            <pc:docMk/>
            <pc:sldMk cId="3045183798" sldId="273"/>
            <ac:spMk id="174" creationId="{CFBD82E3-BDB9-DA4B-7D20-7880CFDE600C}"/>
          </ac:spMkLst>
        </pc:spChg>
        <pc:spChg chg="mod topLvl">
          <ac:chgData name="Kim Ji-Eun" userId="5d7677e0d52343ec" providerId="LiveId" clId="{F023BD75-3484-F245-B723-6E8D9C13CED4}" dt="2023-04-03T04:04:12.817" v="2027" actId="164"/>
          <ac:spMkLst>
            <pc:docMk/>
            <pc:sldMk cId="3045183798" sldId="273"/>
            <ac:spMk id="175" creationId="{2AB356AA-563F-EDE0-2B89-AB5EAF135E50}"/>
          </ac:spMkLst>
        </pc:spChg>
        <pc:spChg chg="mod topLvl">
          <ac:chgData name="Kim Ji-Eun" userId="5d7677e0d52343ec" providerId="LiveId" clId="{F023BD75-3484-F245-B723-6E8D9C13CED4}" dt="2023-04-03T04:04:12.817" v="2027" actId="164"/>
          <ac:spMkLst>
            <pc:docMk/>
            <pc:sldMk cId="3045183798" sldId="273"/>
            <ac:spMk id="176" creationId="{28FE43D4-3C58-BB01-E2A1-58CECFA79FC0}"/>
          </ac:spMkLst>
        </pc:spChg>
        <pc:spChg chg="mod topLvl">
          <ac:chgData name="Kim Ji-Eun" userId="5d7677e0d52343ec" providerId="LiveId" clId="{F023BD75-3484-F245-B723-6E8D9C13CED4}" dt="2023-04-03T04:04:12.817" v="2027" actId="164"/>
          <ac:spMkLst>
            <pc:docMk/>
            <pc:sldMk cId="3045183798" sldId="273"/>
            <ac:spMk id="177" creationId="{44DC1015-EC96-3597-8BC7-B7229CDB1C0C}"/>
          </ac:spMkLst>
        </pc:spChg>
        <pc:spChg chg="mod topLvl">
          <ac:chgData name="Kim Ji-Eun" userId="5d7677e0d52343ec" providerId="LiveId" clId="{F023BD75-3484-F245-B723-6E8D9C13CED4}" dt="2023-04-03T04:04:12.817" v="2027" actId="164"/>
          <ac:spMkLst>
            <pc:docMk/>
            <pc:sldMk cId="3045183798" sldId="273"/>
            <ac:spMk id="178" creationId="{CBA38C3C-4BF6-E76B-B3DF-729BDFC840FA}"/>
          </ac:spMkLst>
        </pc:spChg>
        <pc:spChg chg="mod topLvl">
          <ac:chgData name="Kim Ji-Eun" userId="5d7677e0d52343ec" providerId="LiveId" clId="{F023BD75-3484-F245-B723-6E8D9C13CED4}" dt="2023-04-03T04:04:12.817" v="2027" actId="164"/>
          <ac:spMkLst>
            <pc:docMk/>
            <pc:sldMk cId="3045183798" sldId="273"/>
            <ac:spMk id="179" creationId="{A8902C75-52EA-97DB-DDB6-B3E9C5E14864}"/>
          </ac:spMkLst>
        </pc:spChg>
        <pc:spChg chg="mod topLvl">
          <ac:chgData name="Kim Ji-Eun" userId="5d7677e0d52343ec" providerId="LiveId" clId="{F023BD75-3484-F245-B723-6E8D9C13CED4}" dt="2023-04-03T04:04:12.817" v="2027" actId="164"/>
          <ac:spMkLst>
            <pc:docMk/>
            <pc:sldMk cId="3045183798" sldId="273"/>
            <ac:spMk id="180" creationId="{AA947859-4645-596F-3D47-2E251D6AE754}"/>
          </ac:spMkLst>
        </pc:spChg>
        <pc:spChg chg="mod topLvl">
          <ac:chgData name="Kim Ji-Eun" userId="5d7677e0d52343ec" providerId="LiveId" clId="{F023BD75-3484-F245-B723-6E8D9C13CED4}" dt="2023-04-03T04:04:12.817" v="2027" actId="164"/>
          <ac:spMkLst>
            <pc:docMk/>
            <pc:sldMk cId="3045183798" sldId="273"/>
            <ac:spMk id="181" creationId="{BFF5A93E-6ED8-4405-9C7E-BF44696210D4}"/>
          </ac:spMkLst>
        </pc:spChg>
        <pc:spChg chg="mod topLvl">
          <ac:chgData name="Kim Ji-Eun" userId="5d7677e0d52343ec" providerId="LiveId" clId="{F023BD75-3484-F245-B723-6E8D9C13CED4}" dt="2023-04-03T04:04:12.817" v="2027" actId="164"/>
          <ac:spMkLst>
            <pc:docMk/>
            <pc:sldMk cId="3045183798" sldId="273"/>
            <ac:spMk id="182" creationId="{E13C5D24-4C44-AC94-643D-1ADB01909295}"/>
          </ac:spMkLst>
        </pc:spChg>
        <pc:spChg chg="mod topLvl">
          <ac:chgData name="Kim Ji-Eun" userId="5d7677e0d52343ec" providerId="LiveId" clId="{F023BD75-3484-F245-B723-6E8D9C13CED4}" dt="2023-04-03T04:04:12.817" v="2027" actId="164"/>
          <ac:spMkLst>
            <pc:docMk/>
            <pc:sldMk cId="3045183798" sldId="273"/>
            <ac:spMk id="183" creationId="{4E7BF3CC-A627-B442-5AFD-1BF7FAFCD3A0}"/>
          </ac:spMkLst>
        </pc:spChg>
        <pc:spChg chg="mod topLvl">
          <ac:chgData name="Kim Ji-Eun" userId="5d7677e0d52343ec" providerId="LiveId" clId="{F023BD75-3484-F245-B723-6E8D9C13CED4}" dt="2023-04-03T04:04:12.817" v="2027" actId="164"/>
          <ac:spMkLst>
            <pc:docMk/>
            <pc:sldMk cId="3045183798" sldId="273"/>
            <ac:spMk id="184" creationId="{96D0833C-C4CC-B9E0-908F-956A67D5B0A4}"/>
          </ac:spMkLst>
        </pc:spChg>
        <pc:spChg chg="mod topLvl">
          <ac:chgData name="Kim Ji-Eun" userId="5d7677e0d52343ec" providerId="LiveId" clId="{F023BD75-3484-F245-B723-6E8D9C13CED4}" dt="2023-04-03T04:04:12.817" v="2027" actId="164"/>
          <ac:spMkLst>
            <pc:docMk/>
            <pc:sldMk cId="3045183798" sldId="273"/>
            <ac:spMk id="185" creationId="{F1D31A6B-D1E9-EEF7-88B9-BC999E4CF605}"/>
          </ac:spMkLst>
        </pc:spChg>
        <pc:spChg chg="mod topLvl">
          <ac:chgData name="Kim Ji-Eun" userId="5d7677e0d52343ec" providerId="LiveId" clId="{F023BD75-3484-F245-B723-6E8D9C13CED4}" dt="2023-04-03T04:04:12.817" v="2027" actId="164"/>
          <ac:spMkLst>
            <pc:docMk/>
            <pc:sldMk cId="3045183798" sldId="273"/>
            <ac:spMk id="187" creationId="{CC088570-0642-7A21-AC52-8FA2D5071885}"/>
          </ac:spMkLst>
        </pc:spChg>
        <pc:spChg chg="mod topLvl">
          <ac:chgData name="Kim Ji-Eun" userId="5d7677e0d52343ec" providerId="LiveId" clId="{F023BD75-3484-F245-B723-6E8D9C13CED4}" dt="2023-04-03T04:04:12.817" v="2027" actId="164"/>
          <ac:spMkLst>
            <pc:docMk/>
            <pc:sldMk cId="3045183798" sldId="273"/>
            <ac:spMk id="188" creationId="{2D95B37C-E84F-0639-1A71-D8634CA1DF80}"/>
          </ac:spMkLst>
        </pc:spChg>
        <pc:spChg chg="mod topLvl">
          <ac:chgData name="Kim Ji-Eun" userId="5d7677e0d52343ec" providerId="LiveId" clId="{F023BD75-3484-F245-B723-6E8D9C13CED4}" dt="2023-04-03T04:04:12.817" v="2027" actId="164"/>
          <ac:spMkLst>
            <pc:docMk/>
            <pc:sldMk cId="3045183798" sldId="273"/>
            <ac:spMk id="189" creationId="{1DFC5541-0F73-9A25-3A29-67A4CCB97FC8}"/>
          </ac:spMkLst>
        </pc:spChg>
        <pc:spChg chg="mod topLvl">
          <ac:chgData name="Kim Ji-Eun" userId="5d7677e0d52343ec" providerId="LiveId" clId="{F023BD75-3484-F245-B723-6E8D9C13CED4}" dt="2023-04-03T04:04:12.817" v="2027" actId="164"/>
          <ac:spMkLst>
            <pc:docMk/>
            <pc:sldMk cId="3045183798" sldId="273"/>
            <ac:spMk id="190" creationId="{186D46E1-911D-FE2F-7EEA-5DB5E0ED16AE}"/>
          </ac:spMkLst>
        </pc:spChg>
        <pc:spChg chg="mod topLvl">
          <ac:chgData name="Kim Ji-Eun" userId="5d7677e0d52343ec" providerId="LiveId" clId="{F023BD75-3484-F245-B723-6E8D9C13CED4}" dt="2023-04-03T04:04:12.817" v="2027" actId="164"/>
          <ac:spMkLst>
            <pc:docMk/>
            <pc:sldMk cId="3045183798" sldId="273"/>
            <ac:spMk id="191" creationId="{338F9E91-57F8-7E68-E336-7DFFE1770B79}"/>
          </ac:spMkLst>
        </pc:spChg>
        <pc:spChg chg="mod topLvl">
          <ac:chgData name="Kim Ji-Eun" userId="5d7677e0d52343ec" providerId="LiveId" clId="{F023BD75-3484-F245-B723-6E8D9C13CED4}" dt="2023-04-03T04:04:12.817" v="2027" actId="164"/>
          <ac:spMkLst>
            <pc:docMk/>
            <pc:sldMk cId="3045183798" sldId="273"/>
            <ac:spMk id="192" creationId="{67567BBB-2BC2-4460-604B-0C14048E3630}"/>
          </ac:spMkLst>
        </pc:spChg>
        <pc:spChg chg="mod topLvl">
          <ac:chgData name="Kim Ji-Eun" userId="5d7677e0d52343ec" providerId="LiveId" clId="{F023BD75-3484-F245-B723-6E8D9C13CED4}" dt="2023-04-03T04:04:12.817" v="2027" actId="164"/>
          <ac:spMkLst>
            <pc:docMk/>
            <pc:sldMk cId="3045183798" sldId="273"/>
            <ac:spMk id="193" creationId="{A0A0305F-708A-9A17-9E56-21F4606C42BF}"/>
          </ac:spMkLst>
        </pc:spChg>
        <pc:spChg chg="mod topLvl">
          <ac:chgData name="Kim Ji-Eun" userId="5d7677e0d52343ec" providerId="LiveId" clId="{F023BD75-3484-F245-B723-6E8D9C13CED4}" dt="2023-04-03T04:04:12.817" v="2027" actId="164"/>
          <ac:spMkLst>
            <pc:docMk/>
            <pc:sldMk cId="3045183798" sldId="273"/>
            <ac:spMk id="194" creationId="{D4FDE3A8-8FAE-D94D-1142-CEB9D8378094}"/>
          </ac:spMkLst>
        </pc:spChg>
        <pc:spChg chg="mod">
          <ac:chgData name="Kim Ji-Eun" userId="5d7677e0d52343ec" providerId="LiveId" clId="{F023BD75-3484-F245-B723-6E8D9C13CED4}" dt="2023-04-03T04:01:54.499" v="1965" actId="165"/>
          <ac:spMkLst>
            <pc:docMk/>
            <pc:sldMk cId="3045183798" sldId="273"/>
            <ac:spMk id="195" creationId="{C3CC8D3C-C146-069C-7C02-17F200CF127C}"/>
          </ac:spMkLst>
        </pc:spChg>
        <pc:spChg chg="mod">
          <ac:chgData name="Kim Ji-Eun" userId="5d7677e0d52343ec" providerId="LiveId" clId="{F023BD75-3484-F245-B723-6E8D9C13CED4}" dt="2023-04-03T04:01:54.499" v="1965" actId="165"/>
          <ac:spMkLst>
            <pc:docMk/>
            <pc:sldMk cId="3045183798" sldId="273"/>
            <ac:spMk id="196" creationId="{08CFD24D-54BC-9384-35B8-96C40E371D74}"/>
          </ac:spMkLst>
        </pc:spChg>
        <pc:spChg chg="mod">
          <ac:chgData name="Kim Ji-Eun" userId="5d7677e0d52343ec" providerId="LiveId" clId="{F023BD75-3484-F245-B723-6E8D9C13CED4}" dt="2023-04-03T04:01:54.499" v="1965" actId="165"/>
          <ac:spMkLst>
            <pc:docMk/>
            <pc:sldMk cId="3045183798" sldId="273"/>
            <ac:spMk id="197" creationId="{EF0D3563-B35A-639C-732F-AB556A31A3E5}"/>
          </ac:spMkLst>
        </pc:spChg>
        <pc:spChg chg="mod">
          <ac:chgData name="Kim Ji-Eun" userId="5d7677e0d52343ec" providerId="LiveId" clId="{F023BD75-3484-F245-B723-6E8D9C13CED4}" dt="2023-04-03T04:01:54.499" v="1965" actId="165"/>
          <ac:spMkLst>
            <pc:docMk/>
            <pc:sldMk cId="3045183798" sldId="273"/>
            <ac:spMk id="198" creationId="{B29A6C82-3C54-F4E2-455F-B074C8F69E06}"/>
          </ac:spMkLst>
        </pc:spChg>
        <pc:spChg chg="mod">
          <ac:chgData name="Kim Ji-Eun" userId="5d7677e0d52343ec" providerId="LiveId" clId="{F023BD75-3484-F245-B723-6E8D9C13CED4}" dt="2023-04-03T04:29:16.240" v="2473" actId="20577"/>
          <ac:spMkLst>
            <pc:docMk/>
            <pc:sldMk cId="3045183798" sldId="273"/>
            <ac:spMk id="199" creationId="{BB3A340C-39ED-749F-0076-431768914B66}"/>
          </ac:spMkLst>
        </pc:spChg>
        <pc:spChg chg="mod">
          <ac:chgData name="Kim Ji-Eun" userId="5d7677e0d52343ec" providerId="LiveId" clId="{F023BD75-3484-F245-B723-6E8D9C13CED4}" dt="2023-04-03T04:29:14.179" v="2472" actId="20577"/>
          <ac:spMkLst>
            <pc:docMk/>
            <pc:sldMk cId="3045183798" sldId="273"/>
            <ac:spMk id="200" creationId="{A94E1AAA-10E3-B8BD-AF80-EF8F170BC023}"/>
          </ac:spMkLst>
        </pc:spChg>
        <pc:spChg chg="mod">
          <ac:chgData name="Kim Ji-Eun" userId="5d7677e0d52343ec" providerId="LiveId" clId="{F023BD75-3484-F245-B723-6E8D9C13CED4}" dt="2023-04-03T04:29:12.476" v="2471" actId="20577"/>
          <ac:spMkLst>
            <pc:docMk/>
            <pc:sldMk cId="3045183798" sldId="273"/>
            <ac:spMk id="201" creationId="{DADFE279-16E1-C0E5-E99D-0751F58A48A8}"/>
          </ac:spMkLst>
        </pc:spChg>
        <pc:spChg chg="mod">
          <ac:chgData name="Kim Ji-Eun" userId="5d7677e0d52343ec" providerId="LiveId" clId="{F023BD75-3484-F245-B723-6E8D9C13CED4}" dt="2023-04-03T04:29:10.632" v="2470" actId="20577"/>
          <ac:spMkLst>
            <pc:docMk/>
            <pc:sldMk cId="3045183798" sldId="273"/>
            <ac:spMk id="202" creationId="{62517CED-9568-535F-B9C3-97AB4B8E0172}"/>
          </ac:spMkLst>
        </pc:spChg>
        <pc:spChg chg="mod">
          <ac:chgData name="Kim Ji-Eun" userId="5d7677e0d52343ec" providerId="LiveId" clId="{F023BD75-3484-F245-B723-6E8D9C13CED4}" dt="2023-04-03T04:12:28.992" v="2288" actId="1037"/>
          <ac:spMkLst>
            <pc:docMk/>
            <pc:sldMk cId="3045183798" sldId="273"/>
            <ac:spMk id="205" creationId="{AD44D0B8-888D-502C-2C8A-06B968903B1A}"/>
          </ac:spMkLst>
        </pc:spChg>
        <pc:spChg chg="mod">
          <ac:chgData name="Kim Ji-Eun" userId="5d7677e0d52343ec" providerId="LiveId" clId="{F023BD75-3484-F245-B723-6E8D9C13CED4}" dt="2023-04-03T04:12:33.546" v="2297" actId="1037"/>
          <ac:spMkLst>
            <pc:docMk/>
            <pc:sldMk cId="3045183798" sldId="273"/>
            <ac:spMk id="206" creationId="{0ACA7848-7103-EBDD-B2BB-C56DB427B251}"/>
          </ac:spMkLst>
        </pc:spChg>
        <pc:spChg chg="add mod">
          <ac:chgData name="Kim Ji-Eun" userId="5d7677e0d52343ec" providerId="LiveId" clId="{F023BD75-3484-F245-B723-6E8D9C13CED4}" dt="2023-04-03T04:48:26.935" v="2878" actId="1037"/>
          <ac:spMkLst>
            <pc:docMk/>
            <pc:sldMk cId="3045183798" sldId="273"/>
            <ac:spMk id="207" creationId="{F55B124A-BDF1-00BC-E9EE-8C4B51A8C98E}"/>
          </ac:spMkLst>
        </pc:spChg>
        <pc:spChg chg="add del mod">
          <ac:chgData name="Kim Ji-Eun" userId="5d7677e0d52343ec" providerId="LiveId" clId="{F023BD75-3484-F245-B723-6E8D9C13CED4}" dt="2023-04-03T04:38:48.570" v="2667"/>
          <ac:spMkLst>
            <pc:docMk/>
            <pc:sldMk cId="3045183798" sldId="273"/>
            <ac:spMk id="214" creationId="{A7EB623F-33D2-DA90-B37F-CD2AE1909070}"/>
          </ac:spMkLst>
        </pc:spChg>
        <pc:spChg chg="add del mod">
          <ac:chgData name="Kim Ji-Eun" userId="5d7677e0d52343ec" providerId="LiveId" clId="{F023BD75-3484-F245-B723-6E8D9C13CED4}" dt="2023-04-03T04:40:36.230" v="2758"/>
          <ac:spMkLst>
            <pc:docMk/>
            <pc:sldMk cId="3045183798" sldId="273"/>
            <ac:spMk id="219" creationId="{7DABA3BB-CE72-910B-8895-EB86CF7AC6F4}"/>
          </ac:spMkLst>
        </pc:spChg>
        <pc:spChg chg="add del mod">
          <ac:chgData name="Kim Ji-Eun" userId="5d7677e0d52343ec" providerId="LiveId" clId="{F023BD75-3484-F245-B723-6E8D9C13CED4}" dt="2023-04-03T04:43:35.973" v="2850"/>
          <ac:spMkLst>
            <pc:docMk/>
            <pc:sldMk cId="3045183798" sldId="273"/>
            <ac:spMk id="221" creationId="{89FA8ACC-D4F4-1E72-008D-AE127B0E9CEF}"/>
          </ac:spMkLst>
        </pc:spChg>
        <pc:spChg chg="add del mod">
          <ac:chgData name="Kim Ji-Eun" userId="5d7677e0d52343ec" providerId="LiveId" clId="{F023BD75-3484-F245-B723-6E8D9C13CED4}" dt="2023-04-03T04:43:28.454" v="2839"/>
          <ac:spMkLst>
            <pc:docMk/>
            <pc:sldMk cId="3045183798" sldId="273"/>
            <ac:spMk id="222" creationId="{6F984DCF-47E9-DF49-0B25-76FBE8B2C286}"/>
          </ac:spMkLst>
        </pc:spChg>
        <pc:spChg chg="add del mod">
          <ac:chgData name="Kim Ji-Eun" userId="5d7677e0d52343ec" providerId="LiveId" clId="{F023BD75-3484-F245-B723-6E8D9C13CED4}" dt="2023-04-03T04:45:19.689" v="2865"/>
          <ac:spMkLst>
            <pc:docMk/>
            <pc:sldMk cId="3045183798" sldId="273"/>
            <ac:spMk id="223" creationId="{C8ABCB49-9205-C9C0-C6BD-92FA32F6BBB9}"/>
          </ac:spMkLst>
        </pc:spChg>
        <pc:grpChg chg="add mod">
          <ac:chgData name="Kim Ji-Eun" userId="5d7677e0d52343ec" providerId="LiveId" clId="{F023BD75-3484-F245-B723-6E8D9C13CED4}" dt="2023-03-27T07:35:14.154" v="1755" actId="164"/>
          <ac:grpSpMkLst>
            <pc:docMk/>
            <pc:sldMk cId="3045183798" sldId="273"/>
            <ac:grpSpMk id="2" creationId="{3763F226-4EB2-CCEE-1615-49572E13AC9D}"/>
          </ac:grpSpMkLst>
        </pc:grpChg>
        <pc:grpChg chg="add mod">
          <ac:chgData name="Kim Ji-Eun" userId="5d7677e0d52343ec" providerId="LiveId" clId="{F023BD75-3484-F245-B723-6E8D9C13CED4}" dt="2023-04-03T04:04:12.817" v="2027" actId="164"/>
          <ac:grpSpMkLst>
            <pc:docMk/>
            <pc:sldMk cId="3045183798" sldId="273"/>
            <ac:grpSpMk id="6" creationId="{9BBAB619-B14B-BDC0-CBE7-8C613639E136}"/>
          </ac:grpSpMkLst>
        </pc:grpChg>
        <pc:grpChg chg="add mod">
          <ac:chgData name="Kim Ji-Eun" userId="5d7677e0d52343ec" providerId="LiveId" clId="{F023BD75-3484-F245-B723-6E8D9C13CED4}" dt="2023-04-03T04:11:08.926" v="2217" actId="164"/>
          <ac:grpSpMkLst>
            <pc:docMk/>
            <pc:sldMk cId="3045183798" sldId="273"/>
            <ac:grpSpMk id="10" creationId="{0FFE6630-47AA-E8C6-6CF7-96BD05A4C709}"/>
          </ac:grpSpMkLst>
        </pc:grpChg>
        <pc:grpChg chg="add mod">
          <ac:chgData name="Kim Ji-Eun" userId="5d7677e0d52343ec" providerId="LiveId" clId="{F023BD75-3484-F245-B723-6E8D9C13CED4}" dt="2023-03-27T07:35:14.154" v="1755" actId="164"/>
          <ac:grpSpMkLst>
            <pc:docMk/>
            <pc:sldMk cId="3045183798" sldId="273"/>
            <ac:grpSpMk id="10" creationId="{AA71FCB6-B60C-BDDD-6328-897CD8871C2A}"/>
          </ac:grpSpMkLst>
        </pc:grpChg>
        <pc:grpChg chg="add mod">
          <ac:chgData name="Kim Ji-Eun" userId="5d7677e0d52343ec" providerId="LiveId" clId="{F023BD75-3484-F245-B723-6E8D9C13CED4}" dt="2023-04-03T04:11:08.926" v="2217" actId="164"/>
          <ac:grpSpMkLst>
            <pc:docMk/>
            <pc:sldMk cId="3045183798" sldId="273"/>
            <ac:grpSpMk id="15" creationId="{E6CA7EF3-9A66-3DD6-6775-AEFD9ADD20AC}"/>
          </ac:grpSpMkLst>
        </pc:grpChg>
        <pc:grpChg chg="add mod">
          <ac:chgData name="Kim Ji-Eun" userId="5d7677e0d52343ec" providerId="LiveId" clId="{F023BD75-3484-F245-B723-6E8D9C13CED4}" dt="2023-04-03T04:11:08.926" v="2217" actId="164"/>
          <ac:grpSpMkLst>
            <pc:docMk/>
            <pc:sldMk cId="3045183798" sldId="273"/>
            <ac:grpSpMk id="16" creationId="{4EF89C88-1BFF-A93E-566E-4BF154E0ED59}"/>
          </ac:grpSpMkLst>
        </pc:grpChg>
        <pc:grpChg chg="add mod">
          <ac:chgData name="Kim Ji-Eun" userId="5d7677e0d52343ec" providerId="LiveId" clId="{F023BD75-3484-F245-B723-6E8D9C13CED4}" dt="2023-03-27T07:35:14.154" v="1755" actId="164"/>
          <ac:grpSpMkLst>
            <pc:docMk/>
            <pc:sldMk cId="3045183798" sldId="273"/>
            <ac:grpSpMk id="19" creationId="{46766D08-6A64-D335-DFA0-037C381C480B}"/>
          </ac:grpSpMkLst>
        </pc:grpChg>
        <pc:grpChg chg="add mod">
          <ac:chgData name="Kim Ji-Eun" userId="5d7677e0d52343ec" providerId="LiveId" clId="{F023BD75-3484-F245-B723-6E8D9C13CED4}" dt="2023-04-03T04:11:08.926" v="2217" actId="164"/>
          <ac:grpSpMkLst>
            <pc:docMk/>
            <pc:sldMk cId="3045183798" sldId="273"/>
            <ac:grpSpMk id="19" creationId="{8C4C6CCC-64A5-0F99-6ACC-673D393977BD}"/>
          </ac:grpSpMkLst>
        </pc:grpChg>
        <pc:grpChg chg="add mod">
          <ac:chgData name="Kim Ji-Eun" userId="5d7677e0d52343ec" providerId="LiveId" clId="{F023BD75-3484-F245-B723-6E8D9C13CED4}" dt="2023-04-03T04:11:08.926" v="2217" actId="164"/>
          <ac:grpSpMkLst>
            <pc:docMk/>
            <pc:sldMk cId="3045183798" sldId="273"/>
            <ac:grpSpMk id="22" creationId="{B2EFAD7D-3369-009A-7388-87C74CE67AFC}"/>
          </ac:grpSpMkLst>
        </pc:grpChg>
        <pc:grpChg chg="add del mod">
          <ac:chgData name="Kim Ji-Eun" userId="5d7677e0d52343ec" providerId="LiveId" clId="{F023BD75-3484-F245-B723-6E8D9C13CED4}" dt="2023-03-29T03:58:32.109" v="1926" actId="478"/>
          <ac:grpSpMkLst>
            <pc:docMk/>
            <pc:sldMk cId="3045183798" sldId="273"/>
            <ac:grpSpMk id="23" creationId="{3F1ED73B-6F45-AC09-A7C3-9B31083E4005}"/>
          </ac:grpSpMkLst>
        </pc:grpChg>
        <pc:grpChg chg="add mod">
          <ac:chgData name="Kim Ji-Eun" userId="5d7677e0d52343ec" providerId="LiveId" clId="{F023BD75-3484-F245-B723-6E8D9C13CED4}" dt="2023-04-03T04:04:12.817" v="2027" actId="164"/>
          <ac:grpSpMkLst>
            <pc:docMk/>
            <pc:sldMk cId="3045183798" sldId="273"/>
            <ac:grpSpMk id="24" creationId="{3FF4F162-1D9F-8F47-6EE7-280FDF1DDAF8}"/>
          </ac:grpSpMkLst>
        </pc:grpChg>
        <pc:grpChg chg="add mod">
          <ac:chgData name="Kim Ji-Eun" userId="5d7677e0d52343ec" providerId="LiveId" clId="{F023BD75-3484-F245-B723-6E8D9C13CED4}" dt="2023-03-27T07:35:14.154" v="1755" actId="164"/>
          <ac:grpSpMkLst>
            <pc:docMk/>
            <pc:sldMk cId="3045183798" sldId="273"/>
            <ac:grpSpMk id="25" creationId="{442FEE06-9B03-E6FE-F31F-A7E2469269C1}"/>
          </ac:grpSpMkLst>
        </pc:grpChg>
        <pc:grpChg chg="add mod">
          <ac:chgData name="Kim Ji-Eun" userId="5d7677e0d52343ec" providerId="LiveId" clId="{F023BD75-3484-F245-B723-6E8D9C13CED4}" dt="2023-04-03T04:04:12.817" v="2027" actId="164"/>
          <ac:grpSpMkLst>
            <pc:docMk/>
            <pc:sldMk cId="3045183798" sldId="273"/>
            <ac:grpSpMk id="25" creationId="{C96F286F-272B-8167-FAC4-DA51648627CC}"/>
          </ac:grpSpMkLst>
        </pc:grpChg>
        <pc:grpChg chg="add mod">
          <ac:chgData name="Kim Ji-Eun" userId="5d7677e0d52343ec" providerId="LiveId" clId="{F023BD75-3484-F245-B723-6E8D9C13CED4}" dt="2023-04-03T04:11:08.926" v="2217" actId="164"/>
          <ac:grpSpMkLst>
            <pc:docMk/>
            <pc:sldMk cId="3045183798" sldId="273"/>
            <ac:grpSpMk id="29" creationId="{8C6C44CD-B343-2551-026A-8529B2F7D94A}"/>
          </ac:grpSpMkLst>
        </pc:grpChg>
        <pc:grpChg chg="add mod">
          <ac:chgData name="Kim Ji-Eun" userId="5d7677e0d52343ec" providerId="LiveId" clId="{F023BD75-3484-F245-B723-6E8D9C13CED4}" dt="2023-04-03T04:11:08.926" v="2217" actId="164"/>
          <ac:grpSpMkLst>
            <pc:docMk/>
            <pc:sldMk cId="3045183798" sldId="273"/>
            <ac:grpSpMk id="32" creationId="{893E3670-F992-FE40-3237-9F6B1721BCBD}"/>
          </ac:grpSpMkLst>
        </pc:grpChg>
        <pc:grpChg chg="add mod">
          <ac:chgData name="Kim Ji-Eun" userId="5d7677e0d52343ec" providerId="LiveId" clId="{F023BD75-3484-F245-B723-6E8D9C13CED4}" dt="2023-04-03T04:11:08.926" v="2217" actId="164"/>
          <ac:grpSpMkLst>
            <pc:docMk/>
            <pc:sldMk cId="3045183798" sldId="273"/>
            <ac:grpSpMk id="35" creationId="{BA3AAD0F-0244-A116-3FE2-7C9E4D43B734}"/>
          </ac:grpSpMkLst>
        </pc:grpChg>
        <pc:grpChg chg="add mod">
          <ac:chgData name="Kim Ji-Eun" userId="5d7677e0d52343ec" providerId="LiveId" clId="{F023BD75-3484-F245-B723-6E8D9C13CED4}" dt="2023-04-03T04:11:08.926" v="2217" actId="164"/>
          <ac:grpSpMkLst>
            <pc:docMk/>
            <pc:sldMk cId="3045183798" sldId="273"/>
            <ac:grpSpMk id="38" creationId="{34211945-4DC8-6F34-264D-14168B63B8EF}"/>
          </ac:grpSpMkLst>
        </pc:grpChg>
        <pc:grpChg chg="add mod">
          <ac:chgData name="Kim Ji-Eun" userId="5d7677e0d52343ec" providerId="LiveId" clId="{F023BD75-3484-F245-B723-6E8D9C13CED4}" dt="2023-04-03T04:40:47.419" v="2779" actId="1035"/>
          <ac:grpSpMkLst>
            <pc:docMk/>
            <pc:sldMk cId="3045183798" sldId="273"/>
            <ac:grpSpMk id="41" creationId="{BF89C501-C5BD-7D9E-1301-443BAC324220}"/>
          </ac:grpSpMkLst>
        </pc:grpChg>
        <pc:grpChg chg="add del mod">
          <ac:chgData name="Kim Ji-Eun" userId="5d7677e0d52343ec" providerId="LiveId" clId="{F023BD75-3484-F245-B723-6E8D9C13CED4}" dt="2023-04-03T04:37:02.589" v="2619" actId="165"/>
          <ac:grpSpMkLst>
            <pc:docMk/>
            <pc:sldMk cId="3045183798" sldId="273"/>
            <ac:grpSpMk id="51" creationId="{ABD1832E-6401-E5BE-2E16-B0EAEB688616}"/>
          </ac:grpSpMkLst>
        </pc:grpChg>
        <pc:grpChg chg="add del mod">
          <ac:chgData name="Kim Ji-Eun" userId="5d7677e0d52343ec" providerId="LiveId" clId="{F023BD75-3484-F245-B723-6E8D9C13CED4}" dt="2023-03-28T07:57:25.591" v="1775" actId="478"/>
          <ac:grpSpMkLst>
            <pc:docMk/>
            <pc:sldMk cId="3045183798" sldId="273"/>
            <ac:grpSpMk id="152" creationId="{660A9D6D-C904-B25C-CD03-F40F612ADDCF}"/>
          </ac:grpSpMkLst>
        </pc:grpChg>
        <pc:grpChg chg="add del mod">
          <ac:chgData name="Kim Ji-Eun" userId="5d7677e0d52343ec" providerId="LiveId" clId="{F023BD75-3484-F245-B723-6E8D9C13CED4}" dt="2023-04-03T04:01:54.499" v="1965" actId="165"/>
          <ac:grpSpMkLst>
            <pc:docMk/>
            <pc:sldMk cId="3045183798" sldId="273"/>
            <ac:grpSpMk id="154" creationId="{AC3B7A10-B3A0-3F9C-5B98-A1B2D1CB5409}"/>
          </ac:grpSpMkLst>
        </pc:grpChg>
        <pc:grpChg chg="mod topLvl">
          <ac:chgData name="Kim Ji-Eun" userId="5d7677e0d52343ec" providerId="LiveId" clId="{F023BD75-3484-F245-B723-6E8D9C13CED4}" dt="2023-04-03T04:04:12.817" v="2027" actId="164"/>
          <ac:grpSpMkLst>
            <pc:docMk/>
            <pc:sldMk cId="3045183798" sldId="273"/>
            <ac:grpSpMk id="162" creationId="{5879F8DA-95BB-083C-86A4-0E9263234613}"/>
          </ac:grpSpMkLst>
        </pc:grpChg>
        <pc:grpChg chg="mod topLvl">
          <ac:chgData name="Kim Ji-Eun" userId="5d7677e0d52343ec" providerId="LiveId" clId="{F023BD75-3484-F245-B723-6E8D9C13CED4}" dt="2023-04-03T04:04:12.817" v="2027" actId="164"/>
          <ac:grpSpMkLst>
            <pc:docMk/>
            <pc:sldMk cId="3045183798" sldId="273"/>
            <ac:grpSpMk id="163" creationId="{187DDD1B-D549-CEED-2444-098D0D214506}"/>
          </ac:grpSpMkLst>
        </pc:grpChg>
        <pc:grpChg chg="add del mod">
          <ac:chgData name="Kim Ji-Eun" userId="5d7677e0d52343ec" providerId="LiveId" clId="{F023BD75-3484-F245-B723-6E8D9C13CED4}" dt="2023-04-03T04:38:27.120" v="2649" actId="165"/>
          <ac:grpSpMkLst>
            <pc:docMk/>
            <pc:sldMk cId="3045183798" sldId="273"/>
            <ac:grpSpMk id="208" creationId="{9968E91C-74D3-8A43-1D56-AC8C2BCDD57F}"/>
          </ac:grpSpMkLst>
        </pc:grpChg>
        <pc:grpChg chg="add del mod">
          <ac:chgData name="Kim Ji-Eun" userId="5d7677e0d52343ec" providerId="LiveId" clId="{F023BD75-3484-F245-B723-6E8D9C13CED4}" dt="2023-04-03T04:38:12.200" v="2646" actId="165"/>
          <ac:grpSpMkLst>
            <pc:docMk/>
            <pc:sldMk cId="3045183798" sldId="273"/>
            <ac:grpSpMk id="209" creationId="{EE5570B5-3BEA-CBB3-E6E2-13FE7B4A4D78}"/>
          </ac:grpSpMkLst>
        </pc:grpChg>
        <pc:grpChg chg="add mod">
          <ac:chgData name="Kim Ji-Eun" userId="5d7677e0d52343ec" providerId="LiveId" clId="{F023BD75-3484-F245-B723-6E8D9C13CED4}" dt="2023-04-03T04:37:49.429" v="2642" actId="164"/>
          <ac:grpSpMkLst>
            <pc:docMk/>
            <pc:sldMk cId="3045183798" sldId="273"/>
            <ac:grpSpMk id="210" creationId="{27A05698-0979-0347-D88F-791B92188F24}"/>
          </ac:grpSpMkLst>
        </pc:grpChg>
        <pc:grpChg chg="add mod">
          <ac:chgData name="Kim Ji-Eun" userId="5d7677e0d52343ec" providerId="LiveId" clId="{F023BD75-3484-F245-B723-6E8D9C13CED4}" dt="2023-04-03T04:40:33.386" v="2756" actId="465"/>
          <ac:grpSpMkLst>
            <pc:docMk/>
            <pc:sldMk cId="3045183798" sldId="273"/>
            <ac:grpSpMk id="211" creationId="{AE8A50DD-B66D-4919-F9BA-4A80A35F4A05}"/>
          </ac:grpSpMkLst>
        </pc:grpChg>
        <pc:grpChg chg="add mod">
          <ac:chgData name="Kim Ji-Eun" userId="5d7677e0d52343ec" providerId="LiveId" clId="{F023BD75-3484-F245-B723-6E8D9C13CED4}" dt="2023-04-03T04:40:33.386" v="2756" actId="465"/>
          <ac:grpSpMkLst>
            <pc:docMk/>
            <pc:sldMk cId="3045183798" sldId="273"/>
            <ac:grpSpMk id="212" creationId="{084A7437-873C-009D-6556-A4C96E2CE997}"/>
          </ac:grpSpMkLst>
        </pc:grpChg>
        <pc:grpChg chg="add mod">
          <ac:chgData name="Kim Ji-Eun" userId="5d7677e0d52343ec" providerId="LiveId" clId="{F023BD75-3484-F245-B723-6E8D9C13CED4}" dt="2023-04-03T04:40:33.386" v="2756" actId="465"/>
          <ac:grpSpMkLst>
            <pc:docMk/>
            <pc:sldMk cId="3045183798" sldId="273"/>
            <ac:grpSpMk id="213" creationId="{6A729973-D2FB-3FA3-322C-4A8D225D4FB2}"/>
          </ac:grpSpMkLst>
        </pc:grpChg>
        <pc:grpChg chg="add mod">
          <ac:chgData name="Kim Ji-Eun" userId="5d7677e0d52343ec" providerId="LiveId" clId="{F023BD75-3484-F245-B723-6E8D9C13CED4}" dt="2023-04-03T04:40:33.386" v="2756" actId="465"/>
          <ac:grpSpMkLst>
            <pc:docMk/>
            <pc:sldMk cId="3045183798" sldId="273"/>
            <ac:grpSpMk id="215" creationId="{49B8870A-877A-3DDB-6DE1-E80331A5A2DF}"/>
          </ac:grpSpMkLst>
        </pc:grpChg>
        <pc:grpChg chg="add mod">
          <ac:chgData name="Kim Ji-Eun" userId="5d7677e0d52343ec" providerId="LiveId" clId="{F023BD75-3484-F245-B723-6E8D9C13CED4}" dt="2023-04-03T04:40:33.386" v="2756" actId="465"/>
          <ac:grpSpMkLst>
            <pc:docMk/>
            <pc:sldMk cId="3045183798" sldId="273"/>
            <ac:grpSpMk id="216" creationId="{7C9E5ADD-6A9F-1837-DAE2-BE6E2411DA4E}"/>
          </ac:grpSpMkLst>
        </pc:grpChg>
        <pc:grpChg chg="add mod">
          <ac:chgData name="Kim Ji-Eun" userId="5d7677e0d52343ec" providerId="LiveId" clId="{F023BD75-3484-F245-B723-6E8D9C13CED4}" dt="2023-04-03T04:40:33.386" v="2756" actId="465"/>
          <ac:grpSpMkLst>
            <pc:docMk/>
            <pc:sldMk cId="3045183798" sldId="273"/>
            <ac:grpSpMk id="217" creationId="{56595680-4DEE-307B-433A-3862EB7ADB4A}"/>
          </ac:grpSpMkLst>
        </pc:grpChg>
        <pc:grpChg chg="add mod">
          <ac:chgData name="Kim Ji-Eun" userId="5d7677e0d52343ec" providerId="LiveId" clId="{F023BD75-3484-F245-B723-6E8D9C13CED4}" dt="2023-04-03T04:40:33.386" v="2756" actId="465"/>
          <ac:grpSpMkLst>
            <pc:docMk/>
            <pc:sldMk cId="3045183798" sldId="273"/>
            <ac:grpSpMk id="218" creationId="{55064988-D01C-1359-D00F-A03E37DD8D78}"/>
          </ac:grpSpMkLst>
        </pc:grpChg>
        <pc:grpChg chg="add mod">
          <ac:chgData name="Kim Ji-Eun" userId="5d7677e0d52343ec" providerId="LiveId" clId="{F023BD75-3484-F245-B723-6E8D9C13CED4}" dt="2023-04-03T04:40:33.386" v="2756" actId="465"/>
          <ac:grpSpMkLst>
            <pc:docMk/>
            <pc:sldMk cId="3045183798" sldId="273"/>
            <ac:grpSpMk id="220" creationId="{3C7EB696-FF9D-1700-FB94-2AA02DA9F90E}"/>
          </ac:grpSpMkLst>
        </pc:grpChg>
        <pc:graphicFrameChg chg="add del">
          <ac:chgData name="Kim Ji-Eun" userId="5d7677e0d52343ec" providerId="LiveId" clId="{F023BD75-3484-F245-B723-6E8D9C13CED4}" dt="2023-04-03T04:16:17.999" v="2338" actId="3680"/>
          <ac:graphicFrameMkLst>
            <pc:docMk/>
            <pc:sldMk cId="3045183798" sldId="273"/>
            <ac:graphicFrameMk id="46" creationId="{34E3949B-921C-0D30-751A-D7F361FBCBEA}"/>
          </ac:graphicFrameMkLst>
        </pc:graphicFrameChg>
        <pc:graphicFrameChg chg="add mod modGraphic">
          <ac:chgData name="Kim Ji-Eun" userId="5d7677e0d52343ec" providerId="LiveId" clId="{F023BD75-3484-F245-B723-6E8D9C13CED4}" dt="2023-04-03T04:48:26.935" v="2878" actId="1037"/>
          <ac:graphicFrameMkLst>
            <pc:docMk/>
            <pc:sldMk cId="3045183798" sldId="273"/>
            <ac:graphicFrameMk id="47" creationId="{72D21BB0-2CB6-9728-FAC1-5A5B1B7DCDCD}"/>
          </ac:graphicFrameMkLst>
        </pc:graphicFrameChg>
        <pc:picChg chg="add mod modCrop">
          <ac:chgData name="Kim Ji-Eun" userId="5d7677e0d52343ec" providerId="LiveId" clId="{F023BD75-3484-F245-B723-6E8D9C13CED4}" dt="2023-04-03T04:13:27.306" v="2323" actId="1037"/>
          <ac:picMkLst>
            <pc:docMk/>
            <pc:sldMk cId="3045183798" sldId="273"/>
            <ac:picMk id="2" creationId="{EAEE1581-EF1D-4371-7ACA-26BC9BEFF5F9}"/>
          </ac:picMkLst>
        </pc:picChg>
        <pc:picChg chg="add mod">
          <ac:chgData name="Kim Ji-Eun" userId="5d7677e0d52343ec" providerId="LiveId" clId="{F023BD75-3484-F245-B723-6E8D9C13CED4}" dt="2023-03-27T07:35:14.154" v="1755" actId="164"/>
          <ac:picMkLst>
            <pc:docMk/>
            <pc:sldMk cId="3045183798" sldId="273"/>
            <ac:picMk id="24" creationId="{7AF02E21-679E-17B1-FBDD-E7607A5CF1C8}"/>
          </ac:picMkLst>
        </pc:picChg>
        <pc:picChg chg="mod topLvl">
          <ac:chgData name="Kim Ji-Eun" userId="5d7677e0d52343ec" providerId="LiveId" clId="{F023BD75-3484-F245-B723-6E8D9C13CED4}" dt="2023-04-03T04:37:02.589" v="2619" actId="165"/>
          <ac:picMkLst>
            <pc:docMk/>
            <pc:sldMk cId="3045183798" sldId="273"/>
            <ac:picMk id="52" creationId="{C277E464-7F79-C6DF-92E1-0BBF9A543E59}"/>
          </ac:picMkLst>
        </pc:picChg>
        <pc:picChg chg="mod topLvl">
          <ac:chgData name="Kim Ji-Eun" userId="5d7677e0d52343ec" providerId="LiveId" clId="{F023BD75-3484-F245-B723-6E8D9C13CED4}" dt="2023-04-03T04:37:02.589" v="2619" actId="165"/>
          <ac:picMkLst>
            <pc:docMk/>
            <pc:sldMk cId="3045183798" sldId="273"/>
            <ac:picMk id="107" creationId="{DB648D3E-67DB-434E-7A63-8B39091E0FE8}"/>
          </ac:picMkLst>
        </pc:picChg>
        <pc:picChg chg="mod topLvl">
          <ac:chgData name="Kim Ji-Eun" userId="5d7677e0d52343ec" providerId="LiveId" clId="{F023BD75-3484-F245-B723-6E8D9C13CED4}" dt="2023-04-03T04:37:02.589" v="2619" actId="165"/>
          <ac:picMkLst>
            <pc:docMk/>
            <pc:sldMk cId="3045183798" sldId="273"/>
            <ac:picMk id="108" creationId="{20B0EF0A-535E-27F5-B1B7-C469448B2728}"/>
          </ac:picMkLst>
        </pc:picChg>
        <pc:picChg chg="mod topLvl">
          <ac:chgData name="Kim Ji-Eun" userId="5d7677e0d52343ec" providerId="LiveId" clId="{F023BD75-3484-F245-B723-6E8D9C13CED4}" dt="2023-04-03T04:37:02.589" v="2619" actId="165"/>
          <ac:picMkLst>
            <pc:docMk/>
            <pc:sldMk cId="3045183798" sldId="273"/>
            <ac:picMk id="109" creationId="{4A7A2B66-E9BA-F461-F8AC-65E1C81A0A36}"/>
          </ac:picMkLst>
        </pc:picChg>
        <pc:picChg chg="mod topLvl modCrop">
          <ac:chgData name="Kim Ji-Eun" userId="5d7677e0d52343ec" providerId="LiveId" clId="{F023BD75-3484-F245-B723-6E8D9C13CED4}" dt="2023-04-03T04:11:30.837" v="2236" actId="14100"/>
          <ac:picMkLst>
            <pc:docMk/>
            <pc:sldMk cId="3045183798" sldId="273"/>
            <ac:picMk id="186" creationId="{364E1764-3CF4-CC2F-45F0-C14292015174}"/>
          </ac:picMkLst>
        </pc:picChg>
        <pc:cxnChg chg="add mod">
          <ac:chgData name="Kim Ji-Eun" userId="5d7677e0d52343ec" providerId="LiveId" clId="{F023BD75-3484-F245-B723-6E8D9C13CED4}" dt="2023-03-29T03:56:55.247" v="1889" actId="164"/>
          <ac:cxnSpMkLst>
            <pc:docMk/>
            <pc:sldMk cId="3045183798" sldId="273"/>
            <ac:cxnSpMk id="3" creationId="{B95F881C-2ADA-4CA9-FD98-B0F6DFCED0FE}"/>
          </ac:cxnSpMkLst>
        </pc:cxnChg>
        <pc:cxnChg chg="add mod">
          <ac:chgData name="Kim Ji-Eun" userId="5d7677e0d52343ec" providerId="LiveId" clId="{F023BD75-3484-F245-B723-6E8D9C13CED4}" dt="2023-03-29T03:57:01.802" v="1890" actId="164"/>
          <ac:cxnSpMkLst>
            <pc:docMk/>
            <pc:sldMk cId="3045183798" sldId="273"/>
            <ac:cxnSpMk id="4" creationId="{B2846E1F-7DD1-A694-BDEA-9DED0BCABCAA}"/>
          </ac:cxnSpMkLst>
        </pc:cxnChg>
        <pc:cxnChg chg="add mod">
          <ac:chgData name="Kim Ji-Eun" userId="5d7677e0d52343ec" providerId="LiveId" clId="{F023BD75-3484-F245-B723-6E8D9C13CED4}" dt="2023-03-29T03:56:46.932" v="1888" actId="164"/>
          <ac:cxnSpMkLst>
            <pc:docMk/>
            <pc:sldMk cId="3045183798" sldId="273"/>
            <ac:cxnSpMk id="6" creationId="{DA681EB8-5A11-7134-961E-4AC28BB51F45}"/>
          </ac:cxnSpMkLst>
        </pc:cxnChg>
        <pc:cxnChg chg="add mod">
          <ac:chgData name="Kim Ji-Eun" userId="5d7677e0d52343ec" providerId="LiveId" clId="{F023BD75-3484-F245-B723-6E8D9C13CED4}" dt="2023-03-29T03:56:55.247" v="1889" actId="164"/>
          <ac:cxnSpMkLst>
            <pc:docMk/>
            <pc:sldMk cId="3045183798" sldId="273"/>
            <ac:cxnSpMk id="9" creationId="{EEE3805D-4703-0F39-6C02-1F06D6A79658}"/>
          </ac:cxnSpMkLst>
        </pc:cxnChg>
        <pc:cxnChg chg="add mod">
          <ac:chgData name="Kim Ji-Eun" userId="5d7677e0d52343ec" providerId="LiveId" clId="{F023BD75-3484-F245-B723-6E8D9C13CED4}" dt="2023-03-29T03:56:55.247" v="1889" actId="164"/>
          <ac:cxnSpMkLst>
            <pc:docMk/>
            <pc:sldMk cId="3045183798" sldId="273"/>
            <ac:cxnSpMk id="12" creationId="{7068B1C4-9435-C1E6-1678-E7B3F6EAB53D}"/>
          </ac:cxnSpMkLst>
        </pc:cxnChg>
        <pc:cxnChg chg="add mod">
          <ac:chgData name="Kim Ji-Eun" userId="5d7677e0d52343ec" providerId="LiveId" clId="{F023BD75-3484-F245-B723-6E8D9C13CED4}" dt="2023-03-29T03:57:01.802" v="1890" actId="164"/>
          <ac:cxnSpMkLst>
            <pc:docMk/>
            <pc:sldMk cId="3045183798" sldId="273"/>
            <ac:cxnSpMk id="13" creationId="{01C85666-B727-19F9-4994-014B7AF01F60}"/>
          </ac:cxnSpMkLst>
        </pc:cxnChg>
        <pc:cxnChg chg="add mod">
          <ac:chgData name="Kim Ji-Eun" userId="5d7677e0d52343ec" providerId="LiveId" clId="{F023BD75-3484-F245-B723-6E8D9C13CED4}" dt="2023-03-29T03:57:01.802" v="1890" actId="164"/>
          <ac:cxnSpMkLst>
            <pc:docMk/>
            <pc:sldMk cId="3045183798" sldId="273"/>
            <ac:cxnSpMk id="14" creationId="{561A6CC6-D2CF-7EF6-C154-433D0F7CBCD6}"/>
          </ac:cxnSpMkLst>
        </pc:cxnChg>
        <pc:cxnChg chg="mod">
          <ac:chgData name="Kim Ji-Eun" userId="5d7677e0d52343ec" providerId="LiveId" clId="{F023BD75-3484-F245-B723-6E8D9C13CED4}" dt="2023-03-27T07:34:26.613" v="1716"/>
          <ac:cxnSpMkLst>
            <pc:docMk/>
            <pc:sldMk cId="3045183798" sldId="273"/>
            <ac:cxnSpMk id="15" creationId="{1051D714-0107-50DB-0380-D498A17908D7}"/>
          </ac:cxnSpMkLst>
        </pc:cxnChg>
        <pc:cxnChg chg="mod">
          <ac:chgData name="Kim Ji-Eun" userId="5d7677e0d52343ec" providerId="LiveId" clId="{F023BD75-3484-F245-B723-6E8D9C13CED4}" dt="2023-03-27T07:34:26.613" v="1716"/>
          <ac:cxnSpMkLst>
            <pc:docMk/>
            <pc:sldMk cId="3045183798" sldId="273"/>
            <ac:cxnSpMk id="16" creationId="{6191CBF6-BD16-9844-084F-DD3EE51A68EC}"/>
          </ac:cxnSpMkLst>
        </pc:cxnChg>
        <pc:cxnChg chg="add mod">
          <ac:chgData name="Kim Ji-Eun" userId="5d7677e0d52343ec" providerId="LiveId" clId="{F023BD75-3484-F245-B723-6E8D9C13CED4}" dt="2023-03-29T03:56:46.932" v="1888" actId="164"/>
          <ac:cxnSpMkLst>
            <pc:docMk/>
            <pc:sldMk cId="3045183798" sldId="273"/>
            <ac:cxnSpMk id="16" creationId="{A1F66371-6EF7-94DA-AD2F-6CBCE8F64628}"/>
          </ac:cxnSpMkLst>
        </pc:cxnChg>
        <pc:cxnChg chg="add mod">
          <ac:chgData name="Kim Ji-Eun" userId="5d7677e0d52343ec" providerId="LiveId" clId="{F023BD75-3484-F245-B723-6E8D9C13CED4}" dt="2023-03-29T03:56:46.932" v="1888" actId="164"/>
          <ac:cxnSpMkLst>
            <pc:docMk/>
            <pc:sldMk cId="3045183798" sldId="273"/>
            <ac:cxnSpMk id="17" creationId="{01B7DECA-D987-099D-DE48-7C068CC41008}"/>
          </ac:cxnSpMkLst>
        </pc:cxnChg>
        <pc:cxnChg chg="mod topLvl">
          <ac:chgData name="Kim Ji-Eun" userId="5d7677e0d52343ec" providerId="LiveId" clId="{F023BD75-3484-F245-B723-6E8D9C13CED4}" dt="2023-04-03T04:37:02.589" v="2619" actId="165"/>
          <ac:cxnSpMkLst>
            <pc:docMk/>
            <pc:sldMk cId="3045183798" sldId="273"/>
            <ac:cxnSpMk id="54" creationId="{460B60FF-6480-729C-DAA0-5A806D295064}"/>
          </ac:cxnSpMkLst>
        </pc:cxnChg>
        <pc:cxnChg chg="mod topLvl">
          <ac:chgData name="Kim Ji-Eun" userId="5d7677e0d52343ec" providerId="LiveId" clId="{F023BD75-3484-F245-B723-6E8D9C13CED4}" dt="2023-04-03T04:37:02.589" v="2619" actId="165"/>
          <ac:cxnSpMkLst>
            <pc:docMk/>
            <pc:sldMk cId="3045183798" sldId="273"/>
            <ac:cxnSpMk id="110" creationId="{348F329F-CE95-0BAA-708A-AEFB2CB86CFF}"/>
          </ac:cxnSpMkLst>
        </pc:cxnChg>
        <pc:cxnChg chg="mod topLvl">
          <ac:chgData name="Kim Ji-Eun" userId="5d7677e0d52343ec" providerId="LiveId" clId="{F023BD75-3484-F245-B723-6E8D9C13CED4}" dt="2023-04-03T04:37:02.589" v="2619" actId="165"/>
          <ac:cxnSpMkLst>
            <pc:docMk/>
            <pc:sldMk cId="3045183798" sldId="273"/>
            <ac:cxnSpMk id="112" creationId="{0926CA2C-B45C-5C07-DE5D-A7D94A9D5FC0}"/>
          </ac:cxnSpMkLst>
        </pc:cxnChg>
        <pc:cxnChg chg="mod topLvl">
          <ac:chgData name="Kim Ji-Eun" userId="5d7677e0d52343ec" providerId="LiveId" clId="{F023BD75-3484-F245-B723-6E8D9C13CED4}" dt="2023-04-03T04:37:02.589" v="2619" actId="165"/>
          <ac:cxnSpMkLst>
            <pc:docMk/>
            <pc:sldMk cId="3045183798" sldId="273"/>
            <ac:cxnSpMk id="113" creationId="{4C5B9086-9B76-63EE-A5B2-8F76FF573A8C}"/>
          </ac:cxnSpMkLst>
        </pc:cxnChg>
        <pc:cxnChg chg="add mod">
          <ac:chgData name="Kim Ji-Eun" userId="5d7677e0d52343ec" providerId="LiveId" clId="{F023BD75-3484-F245-B723-6E8D9C13CED4}" dt="2023-04-03T04:48:26.935" v="2878" actId="1037"/>
          <ac:cxnSpMkLst>
            <pc:docMk/>
            <pc:sldMk cId="3045183798" sldId="273"/>
            <ac:cxnSpMk id="153" creationId="{57EA90F6-9FA9-0855-0D24-159742026BF7}"/>
          </ac:cxnSpMkLst>
        </pc:cxnChg>
        <pc:cxnChg chg="mod">
          <ac:chgData name="Kim Ji-Eun" userId="5d7677e0d52343ec" providerId="LiveId" clId="{F023BD75-3484-F245-B723-6E8D9C13CED4}" dt="2023-04-03T04:12:09.777" v="2272" actId="14100"/>
          <ac:cxnSpMkLst>
            <pc:docMk/>
            <pc:sldMk cId="3045183798" sldId="273"/>
            <ac:cxnSpMk id="203" creationId="{9E667488-C608-29C4-C445-FB7D001755E9}"/>
          </ac:cxnSpMkLst>
        </pc:cxnChg>
        <pc:cxnChg chg="mod">
          <ac:chgData name="Kim Ji-Eun" userId="5d7677e0d52343ec" providerId="LiveId" clId="{F023BD75-3484-F245-B723-6E8D9C13CED4}" dt="2023-04-03T04:12:24.098" v="2282" actId="1038"/>
          <ac:cxnSpMkLst>
            <pc:docMk/>
            <pc:sldMk cId="3045183798" sldId="273"/>
            <ac:cxnSpMk id="204" creationId="{CBD64D7B-9FCC-4155-5642-BE0859466434}"/>
          </ac:cxnSpMkLst>
        </pc:cxnChg>
      </pc:sldChg>
      <pc:sldChg chg="addSp modSp new add del mod">
        <pc:chgData name="Kim Ji-Eun" userId="5d7677e0d52343ec" providerId="LiveId" clId="{F023BD75-3484-F245-B723-6E8D9C13CED4}" dt="2023-04-17T06:24:38.391" v="3068" actId="2696"/>
        <pc:sldMkLst>
          <pc:docMk/>
          <pc:sldMk cId="2827103247" sldId="274"/>
        </pc:sldMkLst>
        <pc:spChg chg="add mod">
          <ac:chgData name="Kim Ji-Eun" userId="5d7677e0d52343ec" providerId="LiveId" clId="{F023BD75-3484-F245-B723-6E8D9C13CED4}" dt="2023-03-28T03:31:31.788" v="1771" actId="20577"/>
          <ac:spMkLst>
            <pc:docMk/>
            <pc:sldMk cId="2827103247" sldId="274"/>
            <ac:spMk id="3" creationId="{9D06C9D6-154C-6E2A-9C52-3D9399AA91A8}"/>
          </ac:spMkLst>
        </pc:spChg>
        <pc:picChg chg="add mod">
          <ac:chgData name="Kim Ji-Eun" userId="5d7677e0d52343ec" providerId="LiveId" clId="{F023BD75-3484-F245-B723-6E8D9C13CED4}" dt="2023-03-28T03:30:57.157" v="1768" actId="1076"/>
          <ac:picMkLst>
            <pc:docMk/>
            <pc:sldMk cId="2827103247" sldId="274"/>
            <ac:picMk id="2" creationId="{1D2497E6-7952-72D9-24C8-8AE867763E5F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BEDE795-7703-4D2C-80C4-FD5595654820}" type="datetimeFigureOut">
              <a:rPr lang="ko-KR" altLang="en-US" smtClean="0"/>
              <a:t>2023-05-10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D95723D-1424-49D9-B873-EFC4FAA20F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73738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D95723D-1424-49D9-B873-EFC4FAA20F67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8172921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F99B1-F43A-4C95-9D22-EF4AF31DEBC4}" type="datetimeFigureOut">
              <a:rPr lang="ko-KR" altLang="en-US" smtClean="0"/>
              <a:t>2023-05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555AD-D60E-4A91-82C5-B1D8614C82F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331171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F99B1-F43A-4C95-9D22-EF4AF31DEBC4}" type="datetimeFigureOut">
              <a:rPr lang="ko-KR" altLang="en-US" smtClean="0"/>
              <a:t>2023-05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555AD-D60E-4A91-82C5-B1D8614C82F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171917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F99B1-F43A-4C95-9D22-EF4AF31DEBC4}" type="datetimeFigureOut">
              <a:rPr lang="ko-KR" altLang="en-US" smtClean="0"/>
              <a:t>2023-05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555AD-D60E-4A91-82C5-B1D8614C82F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002451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F99B1-F43A-4C95-9D22-EF4AF31DEBC4}" type="datetimeFigureOut">
              <a:rPr lang="ko-KR" altLang="en-US" smtClean="0"/>
              <a:t>2023-05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555AD-D60E-4A91-82C5-B1D8614C82F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441432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F99B1-F43A-4C95-9D22-EF4AF31DEBC4}" type="datetimeFigureOut">
              <a:rPr lang="ko-KR" altLang="en-US" smtClean="0"/>
              <a:t>2023-05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555AD-D60E-4A91-82C5-B1D8614C82F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02633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F99B1-F43A-4C95-9D22-EF4AF31DEBC4}" type="datetimeFigureOut">
              <a:rPr lang="ko-KR" altLang="en-US" smtClean="0"/>
              <a:t>2023-05-1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555AD-D60E-4A91-82C5-B1D8614C82F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400295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F99B1-F43A-4C95-9D22-EF4AF31DEBC4}" type="datetimeFigureOut">
              <a:rPr lang="ko-KR" altLang="en-US" smtClean="0"/>
              <a:t>2023-05-10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555AD-D60E-4A91-82C5-B1D8614C82F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456801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F99B1-F43A-4C95-9D22-EF4AF31DEBC4}" type="datetimeFigureOut">
              <a:rPr lang="ko-KR" altLang="en-US" smtClean="0"/>
              <a:t>2023-05-10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555AD-D60E-4A91-82C5-B1D8614C82F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318301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F99B1-F43A-4C95-9D22-EF4AF31DEBC4}" type="datetimeFigureOut">
              <a:rPr lang="ko-KR" altLang="en-US" smtClean="0"/>
              <a:t>2023-05-10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555AD-D60E-4A91-82C5-B1D8614C82F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025036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F99B1-F43A-4C95-9D22-EF4AF31DEBC4}" type="datetimeFigureOut">
              <a:rPr lang="ko-KR" altLang="en-US" smtClean="0"/>
              <a:t>2023-05-1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555AD-D60E-4A91-82C5-B1D8614C82F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322181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F99B1-F43A-4C95-9D22-EF4AF31DEBC4}" type="datetimeFigureOut">
              <a:rPr lang="ko-KR" altLang="en-US" smtClean="0"/>
              <a:t>2023-05-1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555AD-D60E-4A91-82C5-B1D8614C82F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596810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5F99B1-F43A-4C95-9D22-EF4AF31DEBC4}" type="datetimeFigureOut">
              <a:rPr lang="ko-KR" altLang="en-US" smtClean="0"/>
              <a:t>2023-05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0555AD-D60E-4A91-82C5-B1D8614C82F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211262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B89708E6-E5E2-9FCE-F5EA-7A133FEC8B4F}"/>
              </a:ext>
            </a:extLst>
          </p:cNvPr>
          <p:cNvSpPr txBox="1"/>
          <p:nvPr/>
        </p:nvSpPr>
        <p:spPr>
          <a:xfrm>
            <a:off x="-10460" y="312572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F7152C4-61E7-80A4-3BA8-E127A7DEDD66}"/>
              </a:ext>
            </a:extLst>
          </p:cNvPr>
          <p:cNvSpPr txBox="1"/>
          <p:nvPr/>
        </p:nvSpPr>
        <p:spPr>
          <a:xfrm>
            <a:off x="-10460" y="59622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55427EC9-302F-E425-F3F3-D5066F65199F}"/>
              </a:ext>
            </a:extLst>
          </p:cNvPr>
          <p:cNvSpPr txBox="1"/>
          <p:nvPr/>
        </p:nvSpPr>
        <p:spPr>
          <a:xfrm>
            <a:off x="83563" y="44297"/>
            <a:ext cx="1149674" cy="4925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ore-KR" sz="2601">
                <a:latin typeface="Arial" panose="020B0604020202020204" pitchFamily="34" charset="0"/>
                <a:cs typeface="Arial" panose="020B0604020202020204" pitchFamily="34" charset="0"/>
              </a:rPr>
              <a:t>Fig S1</a:t>
            </a:r>
            <a:endParaRPr kumimoji="1" lang="ko-Kore-KR" altLang="en-US" sz="260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표 2">
            <a:extLst>
              <a:ext uri="{FF2B5EF4-FFF2-40B4-BE49-F238E27FC236}">
                <a16:creationId xmlns:a16="http://schemas.microsoft.com/office/drawing/2014/main" id="{6F5908A4-2FF8-65A1-DDBD-44D65550CEA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89350191"/>
              </p:ext>
            </p:extLst>
          </p:nvPr>
        </p:nvGraphicFramePr>
        <p:xfrm>
          <a:off x="398073" y="922759"/>
          <a:ext cx="1529875" cy="731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62268">
                  <a:extLst>
                    <a:ext uri="{9D8B030D-6E8A-4147-A177-3AD203B41FA5}">
                      <a16:colId xmlns:a16="http://schemas.microsoft.com/office/drawing/2014/main" val="4217295789"/>
                    </a:ext>
                  </a:extLst>
                </a:gridCol>
                <a:gridCol w="1167607">
                  <a:extLst>
                    <a:ext uri="{9D8B030D-6E8A-4147-A177-3AD203B41FA5}">
                      <a16:colId xmlns:a16="http://schemas.microsoft.com/office/drawing/2014/main" val="66219249"/>
                    </a:ext>
                  </a:extLst>
                </a:gridCol>
              </a:tblGrid>
              <a:tr h="243840">
                <a:tc row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/>
                        <a:t>NC</a:t>
                      </a:r>
                      <a:endParaRPr lang="ko-KR" altLang="en-US" sz="10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>
                          <a:solidFill>
                            <a:sysClr val="windowText" lastClr="000000"/>
                          </a:solidFill>
                        </a:rPr>
                        <a:t>1X PBS</a:t>
                      </a:r>
                      <a:endParaRPr lang="ko-KR" altLang="en-US" sz="1000" b="1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90338370"/>
                  </a:ext>
                </a:extLst>
              </a:tr>
              <a:tr h="24384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i="1">
                          <a:solidFill>
                            <a:srgbClr val="FF0000"/>
                          </a:solidFill>
                        </a:rPr>
                        <a:t>K. alysoides</a:t>
                      </a:r>
                      <a:endParaRPr lang="ko-KR" altLang="en-US" sz="1000" b="1" i="1">
                        <a:solidFill>
                          <a:srgbClr val="FF0000"/>
                        </a:solidFill>
                      </a:endParaRP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785133"/>
                  </a:ext>
                </a:extLst>
              </a:tr>
              <a:tr h="24384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i="1">
                          <a:solidFill>
                            <a:srgbClr val="008000"/>
                          </a:solidFill>
                        </a:rPr>
                        <a:t>T. sanguinis</a:t>
                      </a:r>
                      <a:endParaRPr lang="ko-KR" altLang="en-US" sz="1000" b="1" i="1">
                        <a:solidFill>
                          <a:srgbClr val="008000"/>
                        </a:solidFill>
                      </a:endParaRP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42596506"/>
                  </a:ext>
                </a:extLst>
              </a:tr>
            </a:tbl>
          </a:graphicData>
        </a:graphic>
      </p:graphicFrame>
      <p:graphicFrame>
        <p:nvGraphicFramePr>
          <p:cNvPr id="8" name="표 2">
            <a:extLst>
              <a:ext uri="{FF2B5EF4-FFF2-40B4-BE49-F238E27FC236}">
                <a16:creationId xmlns:a16="http://schemas.microsoft.com/office/drawing/2014/main" id="{CAE67C4F-496E-1D89-9DDC-0EEC6DF4AF5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1283606"/>
              </p:ext>
            </p:extLst>
          </p:nvPr>
        </p:nvGraphicFramePr>
        <p:xfrm>
          <a:off x="398075" y="1710070"/>
          <a:ext cx="1532325" cy="742911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63925">
                  <a:extLst>
                    <a:ext uri="{9D8B030D-6E8A-4147-A177-3AD203B41FA5}">
                      <a16:colId xmlns:a16="http://schemas.microsoft.com/office/drawing/2014/main" val="4217295789"/>
                    </a:ext>
                  </a:extLst>
                </a:gridCol>
                <a:gridCol w="1168400">
                  <a:extLst>
                    <a:ext uri="{9D8B030D-6E8A-4147-A177-3AD203B41FA5}">
                      <a16:colId xmlns:a16="http://schemas.microsoft.com/office/drawing/2014/main" val="66219249"/>
                    </a:ext>
                  </a:extLst>
                </a:gridCol>
              </a:tblGrid>
              <a:tr h="247637">
                <a:tc row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/>
                        <a:t>HF</a:t>
                      </a:r>
                      <a:endParaRPr lang="ko-KR" altLang="en-US" sz="10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>
                          <a:solidFill>
                            <a:schemeClr val="bg1"/>
                          </a:solidFill>
                        </a:rPr>
                        <a:t>1X PBS</a:t>
                      </a:r>
                      <a:endParaRPr lang="ko-KR" altLang="en-US" sz="1000" b="1">
                        <a:solidFill>
                          <a:schemeClr val="bg1"/>
                        </a:solidFill>
                      </a:endParaRPr>
                    </a:p>
                  </a:txBody>
                  <a:tcPr anchor="ctr"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90338370"/>
                  </a:ext>
                </a:extLst>
              </a:tr>
              <a:tr h="247637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i="1">
                          <a:solidFill>
                            <a:schemeClr val="bg1"/>
                          </a:solidFill>
                        </a:rPr>
                        <a:t>K. alysoides</a:t>
                      </a:r>
                      <a:endParaRPr lang="ko-KR" altLang="en-US" sz="1000" b="1" i="1">
                        <a:solidFill>
                          <a:schemeClr val="bg1"/>
                        </a:solidFill>
                      </a:endParaRPr>
                    </a:p>
                  </a:txBody>
                  <a:tcPr anchor="ctr"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785133"/>
                  </a:ext>
                </a:extLst>
              </a:tr>
              <a:tr h="247637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i="1">
                          <a:solidFill>
                            <a:schemeClr val="bg1"/>
                          </a:solidFill>
                        </a:rPr>
                        <a:t>T. sanguinis</a:t>
                      </a:r>
                      <a:endParaRPr lang="ko-KR" altLang="en-US" sz="1000" b="1" i="1">
                        <a:solidFill>
                          <a:schemeClr val="bg1"/>
                        </a:solidFill>
                      </a:endParaRPr>
                    </a:p>
                  </a:txBody>
                  <a:tcPr anchor="ctr">
                    <a:solidFill>
                      <a:srgbClr val="008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42596506"/>
                  </a:ext>
                </a:extLst>
              </a:tr>
            </a:tbl>
          </a:graphicData>
        </a:graphic>
      </p:graphicFrame>
      <p:cxnSp>
        <p:nvCxnSpPr>
          <p:cNvPr id="17" name="직선 화살표 연결선 16">
            <a:extLst>
              <a:ext uri="{FF2B5EF4-FFF2-40B4-BE49-F238E27FC236}">
                <a16:creationId xmlns:a16="http://schemas.microsoft.com/office/drawing/2014/main" id="{AD3EA088-3D80-37F5-1556-29D2AB1B2834}"/>
              </a:ext>
            </a:extLst>
          </p:cNvPr>
          <p:cNvCxnSpPr>
            <a:cxnSpLocks/>
          </p:cNvCxnSpPr>
          <p:nvPr/>
        </p:nvCxnSpPr>
        <p:spPr>
          <a:xfrm>
            <a:off x="303619" y="2616289"/>
            <a:ext cx="1916694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직선 연결선 17">
            <a:extLst>
              <a:ext uri="{FF2B5EF4-FFF2-40B4-BE49-F238E27FC236}">
                <a16:creationId xmlns:a16="http://schemas.microsoft.com/office/drawing/2014/main" id="{FB17C945-FBBC-65F2-A18F-7FA28373F089}"/>
              </a:ext>
            </a:extLst>
          </p:cNvPr>
          <p:cNvCxnSpPr>
            <a:cxnSpLocks/>
          </p:cNvCxnSpPr>
          <p:nvPr/>
        </p:nvCxnSpPr>
        <p:spPr>
          <a:xfrm>
            <a:off x="401080" y="2515311"/>
            <a:ext cx="0" cy="20195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F40928FC-C45C-9534-AD42-4E39D2764197}"/>
              </a:ext>
            </a:extLst>
          </p:cNvPr>
          <p:cNvSpPr txBox="1"/>
          <p:nvPr/>
        </p:nvSpPr>
        <p:spPr>
          <a:xfrm>
            <a:off x="259703" y="2710755"/>
            <a:ext cx="29623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9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EFF0C4E-07AC-AE86-9E58-9928612E1584}"/>
              </a:ext>
            </a:extLst>
          </p:cNvPr>
          <p:cNvSpPr txBox="1"/>
          <p:nvPr/>
        </p:nvSpPr>
        <p:spPr>
          <a:xfrm>
            <a:off x="1738262" y="2710755"/>
            <a:ext cx="3844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ko-KR" altLang="en-US" sz="9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32F9535-80AC-0839-53A0-F934A2EEE132}"/>
              </a:ext>
            </a:extLst>
          </p:cNvPr>
          <p:cNvSpPr txBox="1"/>
          <p:nvPr/>
        </p:nvSpPr>
        <p:spPr>
          <a:xfrm>
            <a:off x="667658" y="2793496"/>
            <a:ext cx="11886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Weeks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직선 연결선 21">
            <a:extLst>
              <a:ext uri="{FF2B5EF4-FFF2-40B4-BE49-F238E27FC236}">
                <a16:creationId xmlns:a16="http://schemas.microsoft.com/office/drawing/2014/main" id="{8ADB2044-7234-6D26-F316-67392B15002A}"/>
              </a:ext>
            </a:extLst>
          </p:cNvPr>
          <p:cNvCxnSpPr>
            <a:cxnSpLocks/>
          </p:cNvCxnSpPr>
          <p:nvPr/>
        </p:nvCxnSpPr>
        <p:spPr>
          <a:xfrm>
            <a:off x="1931224" y="2521267"/>
            <a:ext cx="0" cy="20195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E14B1923-6005-AC1B-5960-E74F123FF5DB}"/>
              </a:ext>
            </a:extLst>
          </p:cNvPr>
          <p:cNvSpPr txBox="1"/>
          <p:nvPr/>
        </p:nvSpPr>
        <p:spPr>
          <a:xfrm>
            <a:off x="613310" y="2717268"/>
            <a:ext cx="29623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ko-KR" altLang="en-US" sz="9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직선 연결선 24">
            <a:extLst>
              <a:ext uri="{FF2B5EF4-FFF2-40B4-BE49-F238E27FC236}">
                <a16:creationId xmlns:a16="http://schemas.microsoft.com/office/drawing/2014/main" id="{27BDAEDE-BD20-E47E-943B-2F2D4CFC0A39}"/>
              </a:ext>
            </a:extLst>
          </p:cNvPr>
          <p:cNvCxnSpPr>
            <a:cxnSpLocks/>
          </p:cNvCxnSpPr>
          <p:nvPr/>
        </p:nvCxnSpPr>
        <p:spPr>
          <a:xfrm>
            <a:off x="757360" y="2521824"/>
            <a:ext cx="0" cy="20195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" name="TextBox 122">
            <a:extLst>
              <a:ext uri="{FF2B5EF4-FFF2-40B4-BE49-F238E27FC236}">
                <a16:creationId xmlns:a16="http://schemas.microsoft.com/office/drawing/2014/main" id="{8F64F1B8-B890-6104-305D-4375BB597776}"/>
              </a:ext>
            </a:extLst>
          </p:cNvPr>
          <p:cNvSpPr txBox="1"/>
          <p:nvPr/>
        </p:nvSpPr>
        <p:spPr>
          <a:xfrm>
            <a:off x="2759420" y="59622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0" name="그룹 29">
            <a:extLst>
              <a:ext uri="{FF2B5EF4-FFF2-40B4-BE49-F238E27FC236}">
                <a16:creationId xmlns:a16="http://schemas.microsoft.com/office/drawing/2014/main" id="{C607888C-9345-66D6-B7EE-DE2A7059C853}"/>
              </a:ext>
            </a:extLst>
          </p:cNvPr>
          <p:cNvGrpSpPr/>
          <p:nvPr/>
        </p:nvGrpSpPr>
        <p:grpSpPr>
          <a:xfrm>
            <a:off x="0" y="3487655"/>
            <a:ext cx="2325785" cy="1705178"/>
            <a:chOff x="89961" y="3563954"/>
            <a:chExt cx="2325785" cy="1705178"/>
          </a:xfrm>
        </p:grpSpPr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8C2D2C65-4517-2441-BD32-FB1F8DC9257C}"/>
                </a:ext>
              </a:extLst>
            </p:cNvPr>
            <p:cNvSpPr txBox="1"/>
            <p:nvPr/>
          </p:nvSpPr>
          <p:spPr>
            <a:xfrm rot="16200000">
              <a:off x="-378757" y="4139200"/>
              <a:ext cx="119135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b="1">
                  <a:solidFill>
                    <a:srgbClr val="0D0E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ody weight (g)</a:t>
              </a:r>
              <a:endParaRPr lang="ko-KR" altLang="en-US" sz="1000" b="1">
                <a:solidFill>
                  <a:srgbClr val="0D0E1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8" name="그룹 27">
              <a:extLst>
                <a:ext uri="{FF2B5EF4-FFF2-40B4-BE49-F238E27FC236}">
                  <a16:creationId xmlns:a16="http://schemas.microsoft.com/office/drawing/2014/main" id="{EF6D5BBA-ABED-C4F9-BFAE-9BDDFC7B2324}"/>
                </a:ext>
              </a:extLst>
            </p:cNvPr>
            <p:cNvGrpSpPr/>
            <p:nvPr/>
          </p:nvGrpSpPr>
          <p:grpSpPr>
            <a:xfrm>
              <a:off x="257323" y="3563954"/>
              <a:ext cx="2158423" cy="1705178"/>
              <a:chOff x="-12363" y="3550781"/>
              <a:chExt cx="2158423" cy="1705178"/>
            </a:xfrm>
          </p:grpSpPr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3A807818-A494-5ACD-90D4-B508E0713600}"/>
                  </a:ext>
                </a:extLst>
              </p:cNvPr>
              <p:cNvSpPr txBox="1"/>
              <p:nvPr/>
            </p:nvSpPr>
            <p:spPr>
              <a:xfrm>
                <a:off x="879694" y="5009738"/>
                <a:ext cx="67017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000" b="1">
                    <a:latin typeface="Arial" panose="020B0604020202020204" pitchFamily="34" charset="0"/>
                    <a:cs typeface="Arial" panose="020B0604020202020204" pitchFamily="34" charset="0"/>
                  </a:rPr>
                  <a:t>Weeks</a:t>
                </a:r>
                <a:endParaRPr lang="ko-KR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15" name="그룹 114">
                <a:extLst>
                  <a:ext uri="{FF2B5EF4-FFF2-40B4-BE49-F238E27FC236}">
                    <a16:creationId xmlns:a16="http://schemas.microsoft.com/office/drawing/2014/main" id="{5D95EC91-A733-02FB-C950-981AA4EF6E89}"/>
                  </a:ext>
                </a:extLst>
              </p:cNvPr>
              <p:cNvGrpSpPr/>
              <p:nvPr/>
            </p:nvGrpSpPr>
            <p:grpSpPr>
              <a:xfrm>
                <a:off x="-12363" y="3550781"/>
                <a:ext cx="2158423" cy="1521943"/>
                <a:chOff x="219266" y="3259319"/>
                <a:chExt cx="2158423" cy="1521943"/>
              </a:xfrm>
            </p:grpSpPr>
            <p:sp>
              <p:nvSpPr>
                <p:cNvPr id="40" name="TextBox 39">
                  <a:extLst>
                    <a:ext uri="{FF2B5EF4-FFF2-40B4-BE49-F238E27FC236}">
                      <a16:creationId xmlns:a16="http://schemas.microsoft.com/office/drawing/2014/main" id="{9DC6EA2D-5FC1-0FE8-33B1-AF62CAB93ED9}"/>
                    </a:ext>
                  </a:extLst>
                </p:cNvPr>
                <p:cNvSpPr txBox="1"/>
                <p:nvPr/>
              </p:nvSpPr>
              <p:spPr>
                <a:xfrm>
                  <a:off x="2027638" y="4550430"/>
                  <a:ext cx="35005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just"/>
                  <a:r>
                    <a:rPr lang="en-US" altLang="ko-KR" sz="9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12 </a:t>
                  </a:r>
                  <a:endParaRPr lang="ko-KR" altLang="en-US" sz="9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04" name="그룹 103">
                  <a:extLst>
                    <a:ext uri="{FF2B5EF4-FFF2-40B4-BE49-F238E27FC236}">
                      <a16:creationId xmlns:a16="http://schemas.microsoft.com/office/drawing/2014/main" id="{F3D7B883-14B3-3164-BCC3-4B06A02AB7C3}"/>
                    </a:ext>
                  </a:extLst>
                </p:cNvPr>
                <p:cNvGrpSpPr/>
                <p:nvPr/>
              </p:nvGrpSpPr>
              <p:grpSpPr>
                <a:xfrm>
                  <a:off x="219266" y="3259319"/>
                  <a:ext cx="2066734" cy="1521943"/>
                  <a:chOff x="219266" y="3259319"/>
                  <a:chExt cx="2066734" cy="1521943"/>
                </a:xfrm>
              </p:grpSpPr>
              <p:pic>
                <p:nvPicPr>
                  <p:cNvPr id="27" name="그림 26">
                    <a:extLst>
                      <a:ext uri="{FF2B5EF4-FFF2-40B4-BE49-F238E27FC236}">
                        <a16:creationId xmlns:a16="http://schemas.microsoft.com/office/drawing/2014/main" id="{49FF7D3B-72A4-8778-AB37-4E498F5BEC8D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4190" t="7387" r="28021" b="19922"/>
                  <a:stretch/>
                </p:blipFill>
                <p:spPr>
                  <a:xfrm>
                    <a:off x="445530" y="3337865"/>
                    <a:ext cx="1840470" cy="1259039"/>
                  </a:xfrm>
                  <a:prstGeom prst="rect">
                    <a:avLst/>
                  </a:prstGeom>
                </p:spPr>
              </p:pic>
              <p:grpSp>
                <p:nvGrpSpPr>
                  <p:cNvPr id="99" name="그룹 98">
                    <a:extLst>
                      <a:ext uri="{FF2B5EF4-FFF2-40B4-BE49-F238E27FC236}">
                        <a16:creationId xmlns:a16="http://schemas.microsoft.com/office/drawing/2014/main" id="{60C2CE9A-A99F-E167-C738-8825180A5FC0}"/>
                      </a:ext>
                    </a:extLst>
                  </p:cNvPr>
                  <p:cNvGrpSpPr/>
                  <p:nvPr/>
                </p:nvGrpSpPr>
                <p:grpSpPr>
                  <a:xfrm>
                    <a:off x="469214" y="4550430"/>
                    <a:ext cx="1758539" cy="230832"/>
                    <a:chOff x="469214" y="4550430"/>
                    <a:chExt cx="1758539" cy="230832"/>
                  </a:xfrm>
                </p:grpSpPr>
                <p:sp>
                  <p:nvSpPr>
                    <p:cNvPr id="38" name="TextBox 37">
                      <a:extLst>
                        <a:ext uri="{FF2B5EF4-FFF2-40B4-BE49-F238E27FC236}">
                          <a16:creationId xmlns:a16="http://schemas.microsoft.com/office/drawing/2014/main" id="{D97F03D7-FD82-3840-5139-11768A1E13A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96953" y="4550430"/>
                      <a:ext cx="247986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just"/>
                      <a:r>
                        <a:rPr lang="en-US" altLang="ko-KR" sz="9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</a:t>
                      </a:r>
                      <a:endParaRPr lang="ko-KR" altLang="en-US" sz="9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9" name="TextBox 38">
                      <a:extLst>
                        <a:ext uri="{FF2B5EF4-FFF2-40B4-BE49-F238E27FC236}">
                          <a16:creationId xmlns:a16="http://schemas.microsoft.com/office/drawing/2014/main" id="{33FEA96D-14B7-34D1-37B7-BE18F89D3B6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33780" y="4550430"/>
                      <a:ext cx="247986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just"/>
                      <a:r>
                        <a:rPr lang="en-US" altLang="ko-KR" sz="9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</a:t>
                      </a:r>
                      <a:endParaRPr lang="ko-KR" altLang="en-US" sz="9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1" name="TextBox 40">
                      <a:extLst>
                        <a:ext uri="{FF2B5EF4-FFF2-40B4-BE49-F238E27FC236}">
                          <a16:creationId xmlns:a16="http://schemas.microsoft.com/office/drawing/2014/main" id="{649B1676-1378-5644-D448-24C114BA870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894692" y="4550430"/>
                      <a:ext cx="333061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just"/>
                      <a:r>
                        <a:rPr lang="en-US" altLang="ko-KR" sz="9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 </a:t>
                      </a:r>
                      <a:endParaRPr lang="ko-KR" altLang="en-US" sz="9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2" name="TextBox 41">
                      <a:extLst>
                        <a:ext uri="{FF2B5EF4-FFF2-40B4-BE49-F238E27FC236}">
                          <a16:creationId xmlns:a16="http://schemas.microsoft.com/office/drawing/2014/main" id="{2F711E41-E365-80E9-CB8A-7E4CD8FAA36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48384" y="4550430"/>
                      <a:ext cx="333061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just"/>
                      <a:r>
                        <a:rPr lang="en-US" altLang="ko-KR" sz="9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</a:t>
                      </a:r>
                      <a:endParaRPr lang="ko-KR" altLang="en-US" sz="9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3" name="TextBox 42">
                      <a:extLst>
                        <a:ext uri="{FF2B5EF4-FFF2-40B4-BE49-F238E27FC236}">
                          <a16:creationId xmlns:a16="http://schemas.microsoft.com/office/drawing/2014/main" id="{645F5899-A260-5329-A508-81EE49E8F23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653298" y="4550430"/>
                      <a:ext cx="247986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just"/>
                      <a:r>
                        <a:rPr lang="en-US" altLang="ko-KR" sz="9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 </a:t>
                      </a:r>
                      <a:endParaRPr lang="ko-KR" altLang="en-US" sz="9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4" name="TextBox 43">
                      <a:extLst>
                        <a:ext uri="{FF2B5EF4-FFF2-40B4-BE49-F238E27FC236}">
                          <a16:creationId xmlns:a16="http://schemas.microsoft.com/office/drawing/2014/main" id="{24408610-FF05-1372-7F6B-3828BE55092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519171" y="4550430"/>
                      <a:ext cx="247986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just"/>
                      <a:r>
                        <a:rPr lang="en-US" altLang="ko-KR" sz="9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ko-KR" altLang="en-US" sz="9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5" name="TextBox 44">
                      <a:extLst>
                        <a:ext uri="{FF2B5EF4-FFF2-40B4-BE49-F238E27FC236}">
                          <a16:creationId xmlns:a16="http://schemas.microsoft.com/office/drawing/2014/main" id="{1C94BA2B-5844-7308-3462-F94377B85A4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391720" y="4550430"/>
                      <a:ext cx="247986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just"/>
                      <a:r>
                        <a:rPr lang="en-US" altLang="ko-KR" sz="9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 </a:t>
                      </a:r>
                      <a:endParaRPr lang="ko-KR" altLang="en-US" sz="9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6" name="TextBox 45">
                      <a:extLst>
                        <a:ext uri="{FF2B5EF4-FFF2-40B4-BE49-F238E27FC236}">
                          <a16:creationId xmlns:a16="http://schemas.microsoft.com/office/drawing/2014/main" id="{5E3435BC-181A-F2D8-C806-AD04A9D97E3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258963" y="4550430"/>
                      <a:ext cx="247986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just"/>
                      <a:r>
                        <a:rPr lang="en-US" altLang="ko-KR" sz="9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</a:t>
                      </a:r>
                      <a:endParaRPr lang="ko-KR" altLang="en-US" sz="9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7" name="TextBox 46">
                      <a:extLst>
                        <a:ext uri="{FF2B5EF4-FFF2-40B4-BE49-F238E27FC236}">
                          <a16:creationId xmlns:a16="http://schemas.microsoft.com/office/drawing/2014/main" id="{70AAB9E4-B84B-6680-88B7-A70D6B7204E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127163" y="4550430"/>
                      <a:ext cx="247986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just"/>
                      <a:r>
                        <a:rPr lang="en-US" altLang="ko-KR" sz="9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</a:t>
                      </a:r>
                      <a:endParaRPr lang="ko-KR" altLang="en-US" sz="9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8" name="TextBox 47">
                      <a:extLst>
                        <a:ext uri="{FF2B5EF4-FFF2-40B4-BE49-F238E27FC236}">
                          <a16:creationId xmlns:a16="http://schemas.microsoft.com/office/drawing/2014/main" id="{E531279D-E492-0C09-DBFE-CCE175A7EAF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990090" y="4550430"/>
                      <a:ext cx="247986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just"/>
                      <a:r>
                        <a:rPr lang="en-US" altLang="ko-KR" sz="9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</a:t>
                      </a:r>
                      <a:endParaRPr lang="ko-KR" altLang="en-US" sz="9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9" name="TextBox 48">
                      <a:extLst>
                        <a:ext uri="{FF2B5EF4-FFF2-40B4-BE49-F238E27FC236}">
                          <a16:creationId xmlns:a16="http://schemas.microsoft.com/office/drawing/2014/main" id="{71841A47-53CB-4270-23B1-CF9F53E0CC9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64083" y="4550430"/>
                      <a:ext cx="247986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just"/>
                      <a:r>
                        <a:rPr lang="en-US" altLang="ko-KR" sz="9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</a:t>
                      </a:r>
                      <a:endParaRPr lang="ko-KR" altLang="en-US" sz="9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0" name="TextBox 49">
                      <a:extLst>
                        <a:ext uri="{FF2B5EF4-FFF2-40B4-BE49-F238E27FC236}">
                          <a16:creationId xmlns:a16="http://schemas.microsoft.com/office/drawing/2014/main" id="{CD233C0B-D443-5107-BBA4-8802FB499CC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69214" y="4550430"/>
                      <a:ext cx="247986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just"/>
                      <a:r>
                        <a:rPr lang="en-US" altLang="ko-KR" sz="9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</a:t>
                      </a:r>
                      <a:endParaRPr lang="ko-KR" altLang="en-US" sz="9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101" name="그룹 100">
                    <a:extLst>
                      <a:ext uri="{FF2B5EF4-FFF2-40B4-BE49-F238E27FC236}">
                        <a16:creationId xmlns:a16="http://schemas.microsoft.com/office/drawing/2014/main" id="{E6A9F474-9EBD-FA9D-FD58-19BAC959F3C8}"/>
                      </a:ext>
                    </a:extLst>
                  </p:cNvPr>
                  <p:cNvGrpSpPr/>
                  <p:nvPr/>
                </p:nvGrpSpPr>
                <p:grpSpPr>
                  <a:xfrm>
                    <a:off x="219266" y="3259319"/>
                    <a:ext cx="315982" cy="1393540"/>
                    <a:chOff x="219266" y="3259319"/>
                    <a:chExt cx="315982" cy="1393540"/>
                  </a:xfrm>
                </p:grpSpPr>
                <p:sp>
                  <p:nvSpPr>
                    <p:cNvPr id="51" name="TextBox 50">
                      <a:extLst>
                        <a:ext uri="{FF2B5EF4-FFF2-40B4-BE49-F238E27FC236}">
                          <a16:creationId xmlns:a16="http://schemas.microsoft.com/office/drawing/2014/main" id="{7F8D668B-F470-053F-6738-24C13765F4B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19266" y="4422027"/>
                      <a:ext cx="315982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ko-KR" sz="9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 </a:t>
                      </a:r>
                      <a:endParaRPr lang="ko-KR" altLang="en-US" sz="9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2" name="TextBox 51">
                      <a:extLst>
                        <a:ext uri="{FF2B5EF4-FFF2-40B4-BE49-F238E27FC236}">
                          <a16:creationId xmlns:a16="http://schemas.microsoft.com/office/drawing/2014/main" id="{3EADEB11-46AE-A4E0-C0B5-F7673293E74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19266" y="4221600"/>
                      <a:ext cx="315982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ko-KR" sz="9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 </a:t>
                      </a:r>
                      <a:endParaRPr lang="ko-KR" altLang="en-US" sz="9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3" name="TextBox 52">
                      <a:extLst>
                        <a:ext uri="{FF2B5EF4-FFF2-40B4-BE49-F238E27FC236}">
                          <a16:creationId xmlns:a16="http://schemas.microsoft.com/office/drawing/2014/main" id="{EA184513-8880-1DC8-2537-43FA195DBC2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19266" y="4032315"/>
                      <a:ext cx="315982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ko-KR" sz="9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 </a:t>
                      </a:r>
                      <a:endParaRPr lang="ko-KR" altLang="en-US" sz="9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4" name="TextBox 53">
                      <a:extLst>
                        <a:ext uri="{FF2B5EF4-FFF2-40B4-BE49-F238E27FC236}">
                          <a16:creationId xmlns:a16="http://schemas.microsoft.com/office/drawing/2014/main" id="{AFD1D901-6F22-F5E4-1A3F-707A7B6C8AB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19266" y="3843835"/>
                      <a:ext cx="315982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ko-KR" sz="9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 </a:t>
                      </a:r>
                      <a:endParaRPr lang="ko-KR" altLang="en-US" sz="9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5" name="TextBox 54">
                      <a:extLst>
                        <a:ext uri="{FF2B5EF4-FFF2-40B4-BE49-F238E27FC236}">
                          <a16:creationId xmlns:a16="http://schemas.microsoft.com/office/drawing/2014/main" id="{8111F71A-BA1F-C9EF-7980-6FA59B6A8BB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19266" y="3654550"/>
                      <a:ext cx="315982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ko-KR" sz="9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 </a:t>
                      </a:r>
                      <a:endParaRPr lang="ko-KR" altLang="en-US" sz="9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6" name="TextBox 55">
                      <a:extLst>
                        <a:ext uri="{FF2B5EF4-FFF2-40B4-BE49-F238E27FC236}">
                          <a16:creationId xmlns:a16="http://schemas.microsoft.com/office/drawing/2014/main" id="{55C21AF3-1321-CACD-0A41-70C2E64FAAE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19266" y="3465141"/>
                      <a:ext cx="315982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ko-KR" sz="9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 </a:t>
                      </a:r>
                      <a:endParaRPr lang="ko-KR" altLang="en-US" sz="9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7" name="TextBox 56">
                      <a:extLst>
                        <a:ext uri="{FF2B5EF4-FFF2-40B4-BE49-F238E27FC236}">
                          <a16:creationId xmlns:a16="http://schemas.microsoft.com/office/drawing/2014/main" id="{9BDACF1D-72A7-BBF4-5D40-9851683790E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19266" y="3259319"/>
                      <a:ext cx="315982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ko-KR" sz="9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 </a:t>
                      </a:r>
                      <a:endParaRPr lang="ko-KR" altLang="en-US" sz="9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</p:grpSp>
          </p:grpSp>
          <p:cxnSp>
            <p:nvCxnSpPr>
              <p:cNvPr id="124" name="직선 화살표 연결선 123">
                <a:extLst>
                  <a:ext uri="{FF2B5EF4-FFF2-40B4-BE49-F238E27FC236}">
                    <a16:creationId xmlns:a16="http://schemas.microsoft.com/office/drawing/2014/main" id="{C613EA80-A214-A528-57C5-69C18066735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408077" y="3633375"/>
                <a:ext cx="0" cy="162565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stealth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24" name="그룹 223">
            <a:extLst>
              <a:ext uri="{FF2B5EF4-FFF2-40B4-BE49-F238E27FC236}">
                <a16:creationId xmlns:a16="http://schemas.microsoft.com/office/drawing/2014/main" id="{4A9BB518-E43A-525B-7AFB-B7A982C57C8D}"/>
              </a:ext>
            </a:extLst>
          </p:cNvPr>
          <p:cNvGrpSpPr/>
          <p:nvPr/>
        </p:nvGrpSpPr>
        <p:grpSpPr>
          <a:xfrm>
            <a:off x="2269519" y="3445382"/>
            <a:ext cx="2352765" cy="1715561"/>
            <a:chOff x="2327421" y="3547068"/>
            <a:chExt cx="2352765" cy="1715561"/>
          </a:xfrm>
        </p:grpSpPr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0A124499-29B5-6B0D-1F33-FBC8FB1DF708}"/>
                </a:ext>
              </a:extLst>
            </p:cNvPr>
            <p:cNvSpPr txBox="1"/>
            <p:nvPr/>
          </p:nvSpPr>
          <p:spPr>
            <a:xfrm rot="16200000">
              <a:off x="1756756" y="4117733"/>
              <a:ext cx="139524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>
                  <a:solidFill>
                    <a:srgbClr val="0D0E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eight gain (%)</a:t>
              </a:r>
              <a:endParaRPr lang="ko-KR" altLang="en-US" sz="1000" b="1">
                <a:solidFill>
                  <a:srgbClr val="0D0E1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6" name="그룹 25">
              <a:extLst>
                <a:ext uri="{FF2B5EF4-FFF2-40B4-BE49-F238E27FC236}">
                  <a16:creationId xmlns:a16="http://schemas.microsoft.com/office/drawing/2014/main" id="{4CC3D017-A38C-C763-7618-5435DE82EEAD}"/>
                </a:ext>
              </a:extLst>
            </p:cNvPr>
            <p:cNvGrpSpPr/>
            <p:nvPr/>
          </p:nvGrpSpPr>
          <p:grpSpPr>
            <a:xfrm>
              <a:off x="2464714" y="3571778"/>
              <a:ext cx="2215472" cy="1690851"/>
              <a:chOff x="1980228" y="3565694"/>
              <a:chExt cx="2215472" cy="1690851"/>
            </a:xfrm>
          </p:grpSpPr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F1F458E9-7D12-5F48-8B92-0BA5770FEF99}"/>
                  </a:ext>
                </a:extLst>
              </p:cNvPr>
              <p:cNvSpPr txBox="1"/>
              <p:nvPr/>
            </p:nvSpPr>
            <p:spPr>
              <a:xfrm>
                <a:off x="2951503" y="5010324"/>
                <a:ext cx="67017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000" b="1">
                    <a:latin typeface="Arial" panose="020B0604020202020204" pitchFamily="34" charset="0"/>
                    <a:cs typeface="Arial" panose="020B0604020202020204" pitchFamily="34" charset="0"/>
                  </a:rPr>
                  <a:t>Weeks</a:t>
                </a:r>
                <a:endParaRPr lang="ko-KR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3" name="그룹 22">
                <a:extLst>
                  <a:ext uri="{FF2B5EF4-FFF2-40B4-BE49-F238E27FC236}">
                    <a16:creationId xmlns:a16="http://schemas.microsoft.com/office/drawing/2014/main" id="{D0F76FAF-D052-C505-8750-53AE491AE4E0}"/>
                  </a:ext>
                </a:extLst>
              </p:cNvPr>
              <p:cNvGrpSpPr/>
              <p:nvPr/>
            </p:nvGrpSpPr>
            <p:grpSpPr>
              <a:xfrm>
                <a:off x="1980228" y="3565694"/>
                <a:ext cx="2215472" cy="1523724"/>
                <a:chOff x="1980228" y="3565694"/>
                <a:chExt cx="2215472" cy="1523724"/>
              </a:xfrm>
            </p:grpSpPr>
            <p:grpSp>
              <p:nvGrpSpPr>
                <p:cNvPr id="105" name="그룹 104">
                  <a:extLst>
                    <a:ext uri="{FF2B5EF4-FFF2-40B4-BE49-F238E27FC236}">
                      <a16:creationId xmlns:a16="http://schemas.microsoft.com/office/drawing/2014/main" id="{F80E61EF-6EEB-DDB0-276A-DD831F810C3A}"/>
                    </a:ext>
                  </a:extLst>
                </p:cNvPr>
                <p:cNvGrpSpPr/>
                <p:nvPr/>
              </p:nvGrpSpPr>
              <p:grpSpPr>
                <a:xfrm>
                  <a:off x="1980228" y="3565694"/>
                  <a:ext cx="2215472" cy="1523724"/>
                  <a:chOff x="2345577" y="3262300"/>
                  <a:chExt cx="2215472" cy="1523724"/>
                </a:xfrm>
              </p:grpSpPr>
              <p:pic>
                <p:nvPicPr>
                  <p:cNvPr id="31" name="그림 30">
                    <a:extLst>
                      <a:ext uri="{FF2B5EF4-FFF2-40B4-BE49-F238E27FC236}">
                        <a16:creationId xmlns:a16="http://schemas.microsoft.com/office/drawing/2014/main" id="{3DE6C527-E289-8CE7-BF62-1E7A98AE84D8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2733" t="5554" r="28831" b="19980"/>
                  <a:stretch/>
                </p:blipFill>
                <p:spPr>
                  <a:xfrm>
                    <a:off x="2653124" y="3319969"/>
                    <a:ext cx="1800000" cy="1271774"/>
                  </a:xfrm>
                  <a:prstGeom prst="rect">
                    <a:avLst/>
                  </a:prstGeom>
                </p:spPr>
              </p:pic>
              <p:grpSp>
                <p:nvGrpSpPr>
                  <p:cNvPr id="102" name="그룹 101">
                    <a:extLst>
                      <a:ext uri="{FF2B5EF4-FFF2-40B4-BE49-F238E27FC236}">
                        <a16:creationId xmlns:a16="http://schemas.microsoft.com/office/drawing/2014/main" id="{902AF231-FDE0-F3F7-9FF1-DB6EBB02FFEE}"/>
                      </a:ext>
                    </a:extLst>
                  </p:cNvPr>
                  <p:cNvGrpSpPr/>
                  <p:nvPr/>
                </p:nvGrpSpPr>
                <p:grpSpPr>
                  <a:xfrm>
                    <a:off x="2345577" y="3262300"/>
                    <a:ext cx="386054" cy="1225300"/>
                    <a:chOff x="2345577" y="3262300"/>
                    <a:chExt cx="386054" cy="1225300"/>
                  </a:xfrm>
                </p:grpSpPr>
                <p:sp>
                  <p:nvSpPr>
                    <p:cNvPr id="59" name="TextBox 58">
                      <a:extLst>
                        <a:ext uri="{FF2B5EF4-FFF2-40B4-BE49-F238E27FC236}">
                          <a16:creationId xmlns:a16="http://schemas.microsoft.com/office/drawing/2014/main" id="{BECC6ECB-11BF-B881-C0ED-0F510E2F29C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415649" y="4256768"/>
                      <a:ext cx="315982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ko-KR" sz="9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 </a:t>
                      </a:r>
                      <a:endParaRPr lang="ko-KR" altLang="en-US" sz="9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60" name="TextBox 59">
                      <a:extLst>
                        <a:ext uri="{FF2B5EF4-FFF2-40B4-BE49-F238E27FC236}">
                          <a16:creationId xmlns:a16="http://schemas.microsoft.com/office/drawing/2014/main" id="{01BBF556-C204-EB0E-E81B-97B90806A1D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415649" y="4091298"/>
                      <a:ext cx="315982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ko-KR" sz="9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 </a:t>
                      </a:r>
                      <a:endParaRPr lang="ko-KR" altLang="en-US" sz="9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61" name="TextBox 60">
                      <a:extLst>
                        <a:ext uri="{FF2B5EF4-FFF2-40B4-BE49-F238E27FC236}">
                          <a16:creationId xmlns:a16="http://schemas.microsoft.com/office/drawing/2014/main" id="{16BD406C-C210-AF1A-0183-E2829878086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415649" y="3926633"/>
                      <a:ext cx="315982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ko-KR" sz="9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 </a:t>
                      </a:r>
                      <a:endParaRPr lang="ko-KR" altLang="en-US" sz="9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62" name="TextBox 61">
                      <a:extLst>
                        <a:ext uri="{FF2B5EF4-FFF2-40B4-BE49-F238E27FC236}">
                          <a16:creationId xmlns:a16="http://schemas.microsoft.com/office/drawing/2014/main" id="{B65DFDBE-5649-5A2F-FA71-7F90779A571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415649" y="3761161"/>
                      <a:ext cx="315982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ko-KR" sz="9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0 </a:t>
                      </a:r>
                      <a:endParaRPr lang="ko-KR" altLang="en-US" sz="9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63" name="TextBox 62">
                      <a:extLst>
                        <a:ext uri="{FF2B5EF4-FFF2-40B4-BE49-F238E27FC236}">
                          <a16:creationId xmlns:a16="http://schemas.microsoft.com/office/drawing/2014/main" id="{0ED3CE8E-9A56-7C29-6EC3-9CA3E415F0B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345577" y="3586037"/>
                      <a:ext cx="386054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ko-KR" sz="9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 </a:t>
                      </a:r>
                      <a:endParaRPr lang="ko-KR" altLang="en-US" sz="9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65" name="TextBox 64">
                      <a:extLst>
                        <a:ext uri="{FF2B5EF4-FFF2-40B4-BE49-F238E27FC236}">
                          <a16:creationId xmlns:a16="http://schemas.microsoft.com/office/drawing/2014/main" id="{C17EF215-B43F-0EE1-72B6-56D85E98483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345577" y="3431024"/>
                      <a:ext cx="386054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ko-KR" sz="9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0 </a:t>
                      </a:r>
                      <a:endParaRPr lang="ko-KR" altLang="en-US" sz="9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66" name="TextBox 65">
                      <a:extLst>
                        <a:ext uri="{FF2B5EF4-FFF2-40B4-BE49-F238E27FC236}">
                          <a16:creationId xmlns:a16="http://schemas.microsoft.com/office/drawing/2014/main" id="{41FC6AAF-AA68-D926-D268-088C7E53AE9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345577" y="3262300"/>
                      <a:ext cx="386054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ko-KR" sz="9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0 </a:t>
                      </a:r>
                      <a:endParaRPr lang="ko-KR" altLang="en-US" sz="9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98" name="그룹 97">
                    <a:extLst>
                      <a:ext uri="{FF2B5EF4-FFF2-40B4-BE49-F238E27FC236}">
                        <a16:creationId xmlns:a16="http://schemas.microsoft.com/office/drawing/2014/main" id="{F77B8908-D843-CFC9-4CF1-9E5C0C69E2CD}"/>
                      </a:ext>
                    </a:extLst>
                  </p:cNvPr>
                  <p:cNvGrpSpPr/>
                  <p:nvPr/>
                </p:nvGrpSpPr>
                <p:grpSpPr>
                  <a:xfrm>
                    <a:off x="2670375" y="4553834"/>
                    <a:ext cx="1890674" cy="232190"/>
                    <a:chOff x="2670375" y="4553834"/>
                    <a:chExt cx="1890674" cy="232190"/>
                  </a:xfrm>
                </p:grpSpPr>
                <p:sp>
                  <p:nvSpPr>
                    <p:cNvPr id="68" name="TextBox 67">
                      <a:extLst>
                        <a:ext uri="{FF2B5EF4-FFF2-40B4-BE49-F238E27FC236}">
                          <a16:creationId xmlns:a16="http://schemas.microsoft.com/office/drawing/2014/main" id="{227E841A-325C-1C60-17B9-66D9CFABE3C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785076" y="4555192"/>
                      <a:ext cx="247986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just"/>
                      <a:r>
                        <a:rPr lang="en-US" altLang="ko-KR" sz="9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</a:t>
                      </a:r>
                      <a:endParaRPr lang="ko-KR" altLang="en-US" sz="9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69" name="TextBox 68">
                      <a:extLst>
                        <a:ext uri="{FF2B5EF4-FFF2-40B4-BE49-F238E27FC236}">
                          <a16:creationId xmlns:a16="http://schemas.microsoft.com/office/drawing/2014/main" id="{FE4D6126-447A-D91C-D560-6954D37E8BE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921903" y="4555192"/>
                      <a:ext cx="247986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just"/>
                      <a:r>
                        <a:rPr lang="en-US" altLang="ko-KR" sz="9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</a:t>
                      </a:r>
                      <a:endParaRPr lang="ko-KR" altLang="en-US" sz="9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70" name="TextBox 69">
                      <a:extLst>
                        <a:ext uri="{FF2B5EF4-FFF2-40B4-BE49-F238E27FC236}">
                          <a16:creationId xmlns:a16="http://schemas.microsoft.com/office/drawing/2014/main" id="{8CA937A3-FCF4-967E-5831-E1C30AFC070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210998" y="4555192"/>
                      <a:ext cx="350051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just"/>
                      <a:r>
                        <a:rPr lang="en-US" altLang="ko-KR" sz="9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 </a:t>
                      </a:r>
                      <a:endParaRPr lang="ko-KR" altLang="en-US" sz="9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71" name="TextBox 70">
                      <a:extLst>
                        <a:ext uri="{FF2B5EF4-FFF2-40B4-BE49-F238E27FC236}">
                          <a16:creationId xmlns:a16="http://schemas.microsoft.com/office/drawing/2014/main" id="{4D7A6170-BEF0-B1F8-A024-D3C1FE89D09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073289" y="4555192"/>
                      <a:ext cx="333061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just"/>
                      <a:r>
                        <a:rPr lang="en-US" altLang="ko-KR" sz="9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 </a:t>
                      </a:r>
                      <a:endParaRPr lang="ko-KR" altLang="en-US" sz="9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72" name="TextBox 71">
                      <a:extLst>
                        <a:ext uri="{FF2B5EF4-FFF2-40B4-BE49-F238E27FC236}">
                          <a16:creationId xmlns:a16="http://schemas.microsoft.com/office/drawing/2014/main" id="{C1D44966-BE7E-37DF-7C31-312CB9AEC76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931744" y="4555192"/>
                      <a:ext cx="333061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just"/>
                      <a:r>
                        <a:rPr lang="en-US" altLang="ko-KR" sz="9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</a:t>
                      </a:r>
                      <a:endParaRPr lang="ko-KR" altLang="en-US" sz="9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73" name="TextBox 72">
                      <a:extLst>
                        <a:ext uri="{FF2B5EF4-FFF2-40B4-BE49-F238E27FC236}">
                          <a16:creationId xmlns:a16="http://schemas.microsoft.com/office/drawing/2014/main" id="{14D78130-6899-A0ED-75AE-7E3E61DEF6C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836658" y="4555192"/>
                      <a:ext cx="247986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just"/>
                      <a:r>
                        <a:rPr lang="en-US" altLang="ko-KR" sz="9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 </a:t>
                      </a:r>
                      <a:endParaRPr lang="ko-KR" altLang="en-US" sz="9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74" name="TextBox 73">
                      <a:extLst>
                        <a:ext uri="{FF2B5EF4-FFF2-40B4-BE49-F238E27FC236}">
                          <a16:creationId xmlns:a16="http://schemas.microsoft.com/office/drawing/2014/main" id="{ECA149CF-8F6E-FC5C-E909-930C6CDE2F2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707294" y="4555192"/>
                      <a:ext cx="247986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just"/>
                      <a:r>
                        <a:rPr lang="en-US" altLang="ko-KR" sz="9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ko-KR" altLang="en-US" sz="9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75" name="TextBox 74">
                      <a:extLst>
                        <a:ext uri="{FF2B5EF4-FFF2-40B4-BE49-F238E27FC236}">
                          <a16:creationId xmlns:a16="http://schemas.microsoft.com/office/drawing/2014/main" id="{EA8F073E-9CE3-0E19-A48F-A18B4CD9E41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579843" y="4555192"/>
                      <a:ext cx="247986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just"/>
                      <a:r>
                        <a:rPr lang="en-US" altLang="ko-KR" sz="9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 </a:t>
                      </a:r>
                      <a:endParaRPr lang="ko-KR" altLang="en-US" sz="9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76" name="TextBox 75">
                      <a:extLst>
                        <a:ext uri="{FF2B5EF4-FFF2-40B4-BE49-F238E27FC236}">
                          <a16:creationId xmlns:a16="http://schemas.microsoft.com/office/drawing/2014/main" id="{A348A433-BAC3-2A61-4FCE-9788099EA65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447086" y="4555192"/>
                      <a:ext cx="247986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just"/>
                      <a:r>
                        <a:rPr lang="en-US" altLang="ko-KR" sz="9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</a:t>
                      </a:r>
                      <a:endParaRPr lang="ko-KR" altLang="en-US" sz="9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77" name="TextBox 76">
                      <a:extLst>
                        <a:ext uri="{FF2B5EF4-FFF2-40B4-BE49-F238E27FC236}">
                          <a16:creationId xmlns:a16="http://schemas.microsoft.com/office/drawing/2014/main" id="{84A6A959-21E9-1477-DA95-39D7A6D2F05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315286" y="4555192"/>
                      <a:ext cx="247986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just"/>
                      <a:r>
                        <a:rPr lang="en-US" altLang="ko-KR" sz="9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</a:t>
                      </a:r>
                      <a:endParaRPr lang="ko-KR" altLang="en-US" sz="9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78" name="TextBox 77">
                      <a:extLst>
                        <a:ext uri="{FF2B5EF4-FFF2-40B4-BE49-F238E27FC236}">
                          <a16:creationId xmlns:a16="http://schemas.microsoft.com/office/drawing/2014/main" id="{7F7D4BB9-3E9C-038B-707D-015F22EC189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178213" y="4555192"/>
                      <a:ext cx="247986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just"/>
                      <a:r>
                        <a:rPr lang="en-US" altLang="ko-KR" sz="9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</a:t>
                      </a:r>
                      <a:endParaRPr lang="ko-KR" altLang="en-US" sz="9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79" name="TextBox 78">
                      <a:extLst>
                        <a:ext uri="{FF2B5EF4-FFF2-40B4-BE49-F238E27FC236}">
                          <a16:creationId xmlns:a16="http://schemas.microsoft.com/office/drawing/2014/main" id="{2C356F34-5BB4-66F0-7E15-F5713F18385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052206" y="4555192"/>
                      <a:ext cx="247986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just"/>
                      <a:r>
                        <a:rPr lang="en-US" altLang="ko-KR" sz="9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</a:t>
                      </a:r>
                      <a:endParaRPr lang="ko-KR" altLang="en-US" sz="9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80" name="TextBox 79">
                      <a:extLst>
                        <a:ext uri="{FF2B5EF4-FFF2-40B4-BE49-F238E27FC236}">
                          <a16:creationId xmlns:a16="http://schemas.microsoft.com/office/drawing/2014/main" id="{2B5B3E76-CF54-8A6E-46F8-013555792F9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670375" y="4553834"/>
                      <a:ext cx="247986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just"/>
                      <a:r>
                        <a:rPr lang="en-US" altLang="ko-KR" sz="9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</a:t>
                      </a:r>
                      <a:endParaRPr lang="ko-KR" altLang="en-US" sz="9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</p:grpSp>
            <p:cxnSp>
              <p:nvCxnSpPr>
                <p:cNvPr id="127" name="직선 화살표 연결선 126">
                  <a:extLst>
                    <a:ext uri="{FF2B5EF4-FFF2-40B4-BE49-F238E27FC236}">
                      <a16:creationId xmlns:a16="http://schemas.microsoft.com/office/drawing/2014/main" id="{93C4DA79-24E2-6809-6B75-9C7AFDFDA1C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462480" y="3705847"/>
                  <a:ext cx="0" cy="162565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stealth" w="med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3" name="그룹 2">
            <a:extLst>
              <a:ext uri="{FF2B5EF4-FFF2-40B4-BE49-F238E27FC236}">
                <a16:creationId xmlns:a16="http://schemas.microsoft.com/office/drawing/2014/main" id="{A5694A4A-AA21-E0EC-4EEF-ED7B0B5CF405}"/>
              </a:ext>
            </a:extLst>
          </p:cNvPr>
          <p:cNvGrpSpPr/>
          <p:nvPr/>
        </p:nvGrpSpPr>
        <p:grpSpPr>
          <a:xfrm>
            <a:off x="3002912" y="774238"/>
            <a:ext cx="2223435" cy="2126388"/>
            <a:chOff x="4715393" y="2793496"/>
            <a:chExt cx="2223435" cy="2126388"/>
          </a:xfrm>
        </p:grpSpPr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D8924DAF-1E80-5A8B-B42A-D4A88D5832B7}"/>
                </a:ext>
              </a:extLst>
            </p:cNvPr>
            <p:cNvSpPr txBox="1"/>
            <p:nvPr/>
          </p:nvSpPr>
          <p:spPr>
            <a:xfrm>
              <a:off x="5684403" y="4533000"/>
              <a:ext cx="67017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>
                  <a:latin typeface="Arial" panose="020B0604020202020204" pitchFamily="34" charset="0"/>
                  <a:cs typeface="Arial" panose="020B0604020202020204" pitchFamily="34" charset="0"/>
                </a:rPr>
                <a:t>Weeks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14" name="그룹 113">
              <a:extLst>
                <a:ext uri="{FF2B5EF4-FFF2-40B4-BE49-F238E27FC236}">
                  <a16:creationId xmlns:a16="http://schemas.microsoft.com/office/drawing/2014/main" id="{B0C05A46-BCF5-A868-A5C3-E9546E0754B5}"/>
                </a:ext>
              </a:extLst>
            </p:cNvPr>
            <p:cNvGrpSpPr/>
            <p:nvPr/>
          </p:nvGrpSpPr>
          <p:grpSpPr>
            <a:xfrm>
              <a:off x="4893657" y="3088370"/>
              <a:ext cx="2045171" cy="1502381"/>
              <a:chOff x="4599803" y="3109459"/>
              <a:chExt cx="2045171" cy="1502381"/>
            </a:xfrm>
          </p:grpSpPr>
          <p:pic>
            <p:nvPicPr>
              <p:cNvPr id="29" name="그림 28">
                <a:extLst>
                  <a:ext uri="{FF2B5EF4-FFF2-40B4-BE49-F238E27FC236}">
                    <a16:creationId xmlns:a16="http://schemas.microsoft.com/office/drawing/2014/main" id="{B1CE3C50-783F-17D5-568D-528348DD3F0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949" t="6831" r="28641" b="20092"/>
              <a:stretch/>
            </p:blipFill>
            <p:spPr>
              <a:xfrm>
                <a:off x="4760671" y="3190652"/>
                <a:ext cx="1800000" cy="1243804"/>
              </a:xfrm>
              <a:prstGeom prst="rect">
                <a:avLst/>
              </a:prstGeom>
            </p:spPr>
          </p:pic>
          <p:grpSp>
            <p:nvGrpSpPr>
              <p:cNvPr id="97" name="그룹 96">
                <a:extLst>
                  <a:ext uri="{FF2B5EF4-FFF2-40B4-BE49-F238E27FC236}">
                    <a16:creationId xmlns:a16="http://schemas.microsoft.com/office/drawing/2014/main" id="{5DB33E54-1ADA-E1FE-C32A-8FF91BFFF0A8}"/>
                  </a:ext>
                </a:extLst>
              </p:cNvPr>
              <p:cNvGrpSpPr/>
              <p:nvPr/>
            </p:nvGrpSpPr>
            <p:grpSpPr>
              <a:xfrm>
                <a:off x="4788035" y="4381008"/>
                <a:ext cx="1856939" cy="230832"/>
                <a:chOff x="4788035" y="4381008"/>
                <a:chExt cx="1856939" cy="230832"/>
              </a:xfrm>
            </p:grpSpPr>
            <p:sp>
              <p:nvSpPr>
                <p:cNvPr id="84" name="TextBox 83">
                  <a:extLst>
                    <a:ext uri="{FF2B5EF4-FFF2-40B4-BE49-F238E27FC236}">
                      <a16:creationId xmlns:a16="http://schemas.microsoft.com/office/drawing/2014/main" id="{88BB6C07-D089-7C8F-7E7C-A2ACC56329B3}"/>
                    </a:ext>
                  </a:extLst>
                </p:cNvPr>
                <p:cNvSpPr txBox="1"/>
                <p:nvPr/>
              </p:nvSpPr>
              <p:spPr>
                <a:xfrm>
                  <a:off x="4788035" y="4381008"/>
                  <a:ext cx="247986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just"/>
                  <a:r>
                    <a:rPr lang="en-US" altLang="ko-KR" sz="9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1 </a:t>
                  </a:r>
                  <a:endParaRPr lang="ko-KR" altLang="en-US" sz="9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5" name="TextBox 84">
                  <a:extLst>
                    <a:ext uri="{FF2B5EF4-FFF2-40B4-BE49-F238E27FC236}">
                      <a16:creationId xmlns:a16="http://schemas.microsoft.com/office/drawing/2014/main" id="{D3E8CB66-592A-12A6-3C03-FB6D1E953266}"/>
                    </a:ext>
                  </a:extLst>
                </p:cNvPr>
                <p:cNvSpPr txBox="1"/>
                <p:nvPr/>
              </p:nvSpPr>
              <p:spPr>
                <a:xfrm>
                  <a:off x="4929625" y="4381008"/>
                  <a:ext cx="247986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just"/>
                  <a:r>
                    <a:rPr lang="en-US" altLang="ko-KR" sz="9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2 </a:t>
                  </a:r>
                  <a:endParaRPr lang="ko-KR" altLang="en-US" sz="9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6" name="TextBox 85">
                  <a:extLst>
                    <a:ext uri="{FF2B5EF4-FFF2-40B4-BE49-F238E27FC236}">
                      <a16:creationId xmlns:a16="http://schemas.microsoft.com/office/drawing/2014/main" id="{17494A30-BCCB-6D24-E70C-4F4AECFA3819}"/>
                    </a:ext>
                  </a:extLst>
                </p:cNvPr>
                <p:cNvSpPr txBox="1"/>
                <p:nvPr/>
              </p:nvSpPr>
              <p:spPr>
                <a:xfrm>
                  <a:off x="6294923" y="4381008"/>
                  <a:ext cx="35005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just"/>
                  <a:r>
                    <a:rPr lang="en-US" altLang="ko-KR" sz="9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12 </a:t>
                  </a:r>
                  <a:endParaRPr lang="ko-KR" altLang="en-US" sz="9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7" name="TextBox 86">
                  <a:extLst>
                    <a:ext uri="{FF2B5EF4-FFF2-40B4-BE49-F238E27FC236}">
                      <a16:creationId xmlns:a16="http://schemas.microsoft.com/office/drawing/2014/main" id="{7C55C648-06D9-5219-6F39-C3A10565A1AC}"/>
                    </a:ext>
                  </a:extLst>
                </p:cNvPr>
                <p:cNvSpPr txBox="1"/>
                <p:nvPr/>
              </p:nvSpPr>
              <p:spPr>
                <a:xfrm>
                  <a:off x="6152453" y="4381008"/>
                  <a:ext cx="33306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just"/>
                  <a:r>
                    <a:rPr lang="en-US" altLang="ko-KR" sz="9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11 </a:t>
                  </a:r>
                  <a:endParaRPr lang="ko-KR" altLang="en-US" sz="9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8" name="TextBox 87">
                  <a:extLst>
                    <a:ext uri="{FF2B5EF4-FFF2-40B4-BE49-F238E27FC236}">
                      <a16:creationId xmlns:a16="http://schemas.microsoft.com/office/drawing/2014/main" id="{FA88E0A4-598D-9F63-193C-FBB1E778E982}"/>
                    </a:ext>
                  </a:extLst>
                </p:cNvPr>
                <p:cNvSpPr txBox="1"/>
                <p:nvPr/>
              </p:nvSpPr>
              <p:spPr>
                <a:xfrm>
                  <a:off x="6010907" y="4381008"/>
                  <a:ext cx="33306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just"/>
                  <a:r>
                    <a:rPr lang="en-US" altLang="ko-KR" sz="9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10 </a:t>
                  </a:r>
                  <a:endParaRPr lang="ko-KR" altLang="en-US" sz="9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9" name="TextBox 88">
                  <a:extLst>
                    <a:ext uri="{FF2B5EF4-FFF2-40B4-BE49-F238E27FC236}">
                      <a16:creationId xmlns:a16="http://schemas.microsoft.com/office/drawing/2014/main" id="{16D4A052-3B7A-468E-44B2-6DAED7179640}"/>
                    </a:ext>
                  </a:extLst>
                </p:cNvPr>
                <p:cNvSpPr txBox="1"/>
                <p:nvPr/>
              </p:nvSpPr>
              <p:spPr>
                <a:xfrm>
                  <a:off x="5911061" y="4381008"/>
                  <a:ext cx="247986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just"/>
                  <a:r>
                    <a:rPr lang="en-US" altLang="ko-KR" sz="9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9 </a:t>
                  </a:r>
                  <a:endParaRPr lang="ko-KR" altLang="en-US" sz="9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0" name="TextBox 89">
                  <a:extLst>
                    <a:ext uri="{FF2B5EF4-FFF2-40B4-BE49-F238E27FC236}">
                      <a16:creationId xmlns:a16="http://schemas.microsoft.com/office/drawing/2014/main" id="{EE819CD9-0154-83EC-A38D-A58E602F3D63}"/>
                    </a:ext>
                  </a:extLst>
                </p:cNvPr>
                <p:cNvSpPr txBox="1"/>
                <p:nvPr/>
              </p:nvSpPr>
              <p:spPr>
                <a:xfrm>
                  <a:off x="5767407" y="4381008"/>
                  <a:ext cx="247986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just"/>
                  <a:r>
                    <a:rPr lang="en-US" altLang="ko-KR" sz="9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8</a:t>
                  </a:r>
                  <a:endParaRPr lang="ko-KR" altLang="en-US" sz="9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1" name="TextBox 90">
                  <a:extLst>
                    <a:ext uri="{FF2B5EF4-FFF2-40B4-BE49-F238E27FC236}">
                      <a16:creationId xmlns:a16="http://schemas.microsoft.com/office/drawing/2014/main" id="{A8F3371C-FC90-ECA1-99CA-50D23DED2512}"/>
                    </a:ext>
                  </a:extLst>
                </p:cNvPr>
                <p:cNvSpPr txBox="1"/>
                <p:nvPr/>
              </p:nvSpPr>
              <p:spPr>
                <a:xfrm>
                  <a:off x="5630428" y="4381008"/>
                  <a:ext cx="247986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just"/>
                  <a:r>
                    <a:rPr lang="en-US" altLang="ko-KR" sz="9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7 </a:t>
                  </a:r>
                  <a:endParaRPr lang="ko-KR" altLang="en-US" sz="9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2" name="TextBox 91">
                  <a:extLst>
                    <a:ext uri="{FF2B5EF4-FFF2-40B4-BE49-F238E27FC236}">
                      <a16:creationId xmlns:a16="http://schemas.microsoft.com/office/drawing/2014/main" id="{A745C700-F85B-A0DE-2528-36800DBC94DE}"/>
                    </a:ext>
                  </a:extLst>
                </p:cNvPr>
                <p:cNvSpPr txBox="1"/>
                <p:nvPr/>
              </p:nvSpPr>
              <p:spPr>
                <a:xfrm>
                  <a:off x="5488147" y="4381008"/>
                  <a:ext cx="247986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just"/>
                  <a:r>
                    <a:rPr lang="en-US" altLang="ko-KR" sz="9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6 </a:t>
                  </a:r>
                  <a:endParaRPr lang="ko-KR" altLang="en-US" sz="9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3" name="TextBox 92">
                  <a:extLst>
                    <a:ext uri="{FF2B5EF4-FFF2-40B4-BE49-F238E27FC236}">
                      <a16:creationId xmlns:a16="http://schemas.microsoft.com/office/drawing/2014/main" id="{B79D2F29-1D18-AFD3-52B5-1B9B48865FC9}"/>
                    </a:ext>
                  </a:extLst>
                </p:cNvPr>
                <p:cNvSpPr txBox="1"/>
                <p:nvPr/>
              </p:nvSpPr>
              <p:spPr>
                <a:xfrm>
                  <a:off x="5342060" y="4381008"/>
                  <a:ext cx="247986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just"/>
                  <a:r>
                    <a:rPr lang="en-US" altLang="ko-KR" sz="9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5 </a:t>
                  </a:r>
                  <a:endParaRPr lang="ko-KR" altLang="en-US" sz="9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4" name="TextBox 93">
                  <a:extLst>
                    <a:ext uri="{FF2B5EF4-FFF2-40B4-BE49-F238E27FC236}">
                      <a16:creationId xmlns:a16="http://schemas.microsoft.com/office/drawing/2014/main" id="{8EF3A6DF-6008-34A2-5584-AB017E75393B}"/>
                    </a:ext>
                  </a:extLst>
                </p:cNvPr>
                <p:cNvSpPr txBox="1"/>
                <p:nvPr/>
              </p:nvSpPr>
              <p:spPr>
                <a:xfrm>
                  <a:off x="5200223" y="4381008"/>
                  <a:ext cx="247986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just"/>
                  <a:r>
                    <a:rPr lang="en-US" altLang="ko-KR" sz="9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4 </a:t>
                  </a:r>
                  <a:endParaRPr lang="ko-KR" altLang="en-US" sz="9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5" name="TextBox 94">
                  <a:extLst>
                    <a:ext uri="{FF2B5EF4-FFF2-40B4-BE49-F238E27FC236}">
                      <a16:creationId xmlns:a16="http://schemas.microsoft.com/office/drawing/2014/main" id="{A24667A1-66BA-B16C-7149-075506914FC1}"/>
                    </a:ext>
                  </a:extLst>
                </p:cNvPr>
                <p:cNvSpPr txBox="1"/>
                <p:nvPr/>
              </p:nvSpPr>
              <p:spPr>
                <a:xfrm>
                  <a:off x="5064691" y="4381008"/>
                  <a:ext cx="247986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just"/>
                  <a:r>
                    <a:rPr lang="en-US" altLang="ko-KR" sz="9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3 </a:t>
                  </a:r>
                  <a:endParaRPr lang="ko-KR" altLang="en-US" sz="9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12" name="그룹 111">
                <a:extLst>
                  <a:ext uri="{FF2B5EF4-FFF2-40B4-BE49-F238E27FC236}">
                    <a16:creationId xmlns:a16="http://schemas.microsoft.com/office/drawing/2014/main" id="{AC696499-17DE-F58A-F38F-94F695196ACB}"/>
                  </a:ext>
                </a:extLst>
              </p:cNvPr>
              <p:cNvGrpSpPr/>
              <p:nvPr/>
            </p:nvGrpSpPr>
            <p:grpSpPr>
              <a:xfrm>
                <a:off x="4599803" y="3109459"/>
                <a:ext cx="247986" cy="1378141"/>
                <a:chOff x="4599803" y="3109459"/>
                <a:chExt cx="247986" cy="1378141"/>
              </a:xfrm>
            </p:grpSpPr>
            <p:sp>
              <p:nvSpPr>
                <p:cNvPr id="106" name="TextBox 105">
                  <a:extLst>
                    <a:ext uri="{FF2B5EF4-FFF2-40B4-BE49-F238E27FC236}">
                      <a16:creationId xmlns:a16="http://schemas.microsoft.com/office/drawing/2014/main" id="{2DCD631A-4B31-33AE-EA00-183EAC5B6295}"/>
                    </a:ext>
                  </a:extLst>
                </p:cNvPr>
                <p:cNvSpPr txBox="1"/>
                <p:nvPr/>
              </p:nvSpPr>
              <p:spPr>
                <a:xfrm>
                  <a:off x="4599803" y="4256768"/>
                  <a:ext cx="247986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just"/>
                  <a:r>
                    <a:rPr lang="en-US" altLang="ko-KR" sz="9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0 </a:t>
                  </a:r>
                  <a:endParaRPr lang="ko-KR" altLang="en-US" sz="9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7" name="TextBox 106">
                  <a:extLst>
                    <a:ext uri="{FF2B5EF4-FFF2-40B4-BE49-F238E27FC236}">
                      <a16:creationId xmlns:a16="http://schemas.microsoft.com/office/drawing/2014/main" id="{F228578B-157A-41EF-BE50-2B9D94DE3016}"/>
                    </a:ext>
                  </a:extLst>
                </p:cNvPr>
                <p:cNvSpPr txBox="1"/>
                <p:nvPr/>
              </p:nvSpPr>
              <p:spPr>
                <a:xfrm>
                  <a:off x="4599803" y="4048966"/>
                  <a:ext cx="247986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just"/>
                  <a:r>
                    <a:rPr lang="en-US" altLang="ko-KR" sz="9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1 </a:t>
                  </a:r>
                  <a:endParaRPr lang="ko-KR" altLang="en-US" sz="9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8" name="TextBox 107">
                  <a:extLst>
                    <a:ext uri="{FF2B5EF4-FFF2-40B4-BE49-F238E27FC236}">
                      <a16:creationId xmlns:a16="http://schemas.microsoft.com/office/drawing/2014/main" id="{5154FB5A-20DD-4397-F0CB-4D15430A6E1D}"/>
                    </a:ext>
                  </a:extLst>
                </p:cNvPr>
                <p:cNvSpPr txBox="1"/>
                <p:nvPr/>
              </p:nvSpPr>
              <p:spPr>
                <a:xfrm>
                  <a:off x="4599803" y="3809310"/>
                  <a:ext cx="247986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just"/>
                  <a:r>
                    <a:rPr lang="en-US" altLang="ko-KR" sz="9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2 </a:t>
                  </a:r>
                  <a:endParaRPr lang="ko-KR" altLang="en-US" sz="9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9" name="TextBox 108">
                  <a:extLst>
                    <a:ext uri="{FF2B5EF4-FFF2-40B4-BE49-F238E27FC236}">
                      <a16:creationId xmlns:a16="http://schemas.microsoft.com/office/drawing/2014/main" id="{5FC0E663-5E18-8111-177A-6573550D5DCB}"/>
                    </a:ext>
                  </a:extLst>
                </p:cNvPr>
                <p:cNvSpPr txBox="1"/>
                <p:nvPr/>
              </p:nvSpPr>
              <p:spPr>
                <a:xfrm>
                  <a:off x="4599803" y="3580557"/>
                  <a:ext cx="247986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just"/>
                  <a:r>
                    <a:rPr lang="en-US" altLang="ko-KR" sz="9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3 </a:t>
                  </a:r>
                  <a:endParaRPr lang="ko-KR" altLang="en-US" sz="9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0" name="TextBox 109">
                  <a:extLst>
                    <a:ext uri="{FF2B5EF4-FFF2-40B4-BE49-F238E27FC236}">
                      <a16:creationId xmlns:a16="http://schemas.microsoft.com/office/drawing/2014/main" id="{E05E501A-3474-D31F-E618-1CFB69A43FCD}"/>
                    </a:ext>
                  </a:extLst>
                </p:cNvPr>
                <p:cNvSpPr txBox="1"/>
                <p:nvPr/>
              </p:nvSpPr>
              <p:spPr>
                <a:xfrm>
                  <a:off x="4599803" y="3347036"/>
                  <a:ext cx="247986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just"/>
                  <a:r>
                    <a:rPr lang="en-US" altLang="ko-KR" sz="9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4 </a:t>
                  </a:r>
                  <a:endParaRPr lang="ko-KR" altLang="en-US" sz="9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1" name="TextBox 110">
                  <a:extLst>
                    <a:ext uri="{FF2B5EF4-FFF2-40B4-BE49-F238E27FC236}">
                      <a16:creationId xmlns:a16="http://schemas.microsoft.com/office/drawing/2014/main" id="{F22BFA8B-C841-5E5E-477F-72EA9F7FA3BB}"/>
                    </a:ext>
                  </a:extLst>
                </p:cNvPr>
                <p:cNvSpPr txBox="1"/>
                <p:nvPr/>
              </p:nvSpPr>
              <p:spPr>
                <a:xfrm>
                  <a:off x="4599803" y="3109459"/>
                  <a:ext cx="247986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just"/>
                  <a:r>
                    <a:rPr lang="en-US" altLang="ko-KR" sz="9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5 </a:t>
                  </a:r>
                  <a:endParaRPr lang="ko-KR" altLang="en-US" sz="9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C553ECB9-0C6A-4914-EC13-04C058BF899E}"/>
                </a:ext>
              </a:extLst>
            </p:cNvPr>
            <p:cNvSpPr txBox="1"/>
            <p:nvPr/>
          </p:nvSpPr>
          <p:spPr>
            <a:xfrm rot="16200000">
              <a:off x="3775310" y="3733579"/>
              <a:ext cx="212638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>
                  <a:solidFill>
                    <a:srgbClr val="0D0E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ood intake (g/mouse/day)</a:t>
              </a:r>
              <a:endParaRPr lang="ko-KR" altLang="en-US" sz="1000" b="1">
                <a:solidFill>
                  <a:srgbClr val="0D0E1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8" name="직선 화살표 연결선 127">
              <a:extLst>
                <a:ext uri="{FF2B5EF4-FFF2-40B4-BE49-F238E27FC236}">
                  <a16:creationId xmlns:a16="http://schemas.microsoft.com/office/drawing/2014/main" id="{1E243F3B-3349-D112-9695-32804E496307}"/>
                </a:ext>
              </a:extLst>
            </p:cNvPr>
            <p:cNvCxnSpPr>
              <a:cxnSpLocks/>
            </p:cNvCxnSpPr>
            <p:nvPr/>
          </p:nvCxnSpPr>
          <p:spPr>
            <a:xfrm>
              <a:off x="6180170" y="3304875"/>
              <a:ext cx="0" cy="162565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stealth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61" name="그룹 160">
            <a:extLst>
              <a:ext uri="{FF2B5EF4-FFF2-40B4-BE49-F238E27FC236}">
                <a16:creationId xmlns:a16="http://schemas.microsoft.com/office/drawing/2014/main" id="{D85A1A8F-67F0-151B-B791-DA059B9C01A3}"/>
              </a:ext>
            </a:extLst>
          </p:cNvPr>
          <p:cNvGrpSpPr/>
          <p:nvPr/>
        </p:nvGrpSpPr>
        <p:grpSpPr>
          <a:xfrm>
            <a:off x="5288502" y="1111523"/>
            <a:ext cx="903984" cy="1164362"/>
            <a:chOff x="6108364" y="3473732"/>
            <a:chExt cx="903984" cy="1164362"/>
          </a:xfrm>
        </p:grpSpPr>
        <p:pic>
          <p:nvPicPr>
            <p:cNvPr id="34" name="그림 33">
              <a:extLst>
                <a:ext uri="{FF2B5EF4-FFF2-40B4-BE49-F238E27FC236}">
                  <a16:creationId xmlns:a16="http://schemas.microsoft.com/office/drawing/2014/main" id="{48A7F51C-930E-9794-92F8-5AC56FE9612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8760" t="10021" r="16646" b="36786"/>
            <a:stretch/>
          </p:blipFill>
          <p:spPr>
            <a:xfrm>
              <a:off x="6108364" y="3529043"/>
              <a:ext cx="166179" cy="1062737"/>
            </a:xfrm>
            <a:prstGeom prst="rect">
              <a:avLst/>
            </a:prstGeom>
          </p:spPr>
        </p:pic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id="{AFB2C29A-6EA6-0BA2-B970-8FC564CD94D0}"/>
                </a:ext>
              </a:extLst>
            </p:cNvPr>
            <p:cNvSpPr txBox="1"/>
            <p:nvPr/>
          </p:nvSpPr>
          <p:spPr>
            <a:xfrm>
              <a:off x="6218737" y="3473732"/>
              <a:ext cx="79361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NC CON</a:t>
              </a:r>
              <a:endParaRPr lang="ko-KR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TextBox 140">
              <a:extLst>
                <a:ext uri="{FF2B5EF4-FFF2-40B4-BE49-F238E27FC236}">
                  <a16:creationId xmlns:a16="http://schemas.microsoft.com/office/drawing/2014/main" id="{B084F296-2319-7423-C58D-460B3D555F76}"/>
                </a:ext>
              </a:extLst>
            </p:cNvPr>
            <p:cNvSpPr txBox="1"/>
            <p:nvPr/>
          </p:nvSpPr>
          <p:spPr>
            <a:xfrm>
              <a:off x="6218737" y="3673030"/>
              <a:ext cx="79361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  <a:r>
                <a: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K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EF6D6D81-31C7-7B6C-8EB0-4C3D2A563BB3}"/>
                </a:ext>
              </a:extLst>
            </p:cNvPr>
            <p:cNvSpPr txBox="1"/>
            <p:nvPr/>
          </p:nvSpPr>
          <p:spPr>
            <a:xfrm>
              <a:off x="6218737" y="3848335"/>
              <a:ext cx="79361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  <a:r>
                <a: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Ts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3" name="TextBox 142">
              <a:extLst>
                <a:ext uri="{FF2B5EF4-FFF2-40B4-BE49-F238E27FC236}">
                  <a16:creationId xmlns:a16="http://schemas.microsoft.com/office/drawing/2014/main" id="{F03068BC-15F7-FF75-1751-68870C6D6C27}"/>
                </a:ext>
              </a:extLst>
            </p:cNvPr>
            <p:cNvSpPr txBox="1"/>
            <p:nvPr/>
          </p:nvSpPr>
          <p:spPr>
            <a:xfrm>
              <a:off x="6218737" y="4029210"/>
              <a:ext cx="79361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HF CON</a:t>
              </a:r>
              <a:endParaRPr lang="ko-KR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E6DBE705-92A0-97CD-649F-9B88D93C27C8}"/>
                </a:ext>
              </a:extLst>
            </p:cNvPr>
            <p:cNvSpPr txBox="1"/>
            <p:nvPr/>
          </p:nvSpPr>
          <p:spPr>
            <a:xfrm>
              <a:off x="6218737" y="4224186"/>
              <a:ext cx="79361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HF</a:t>
              </a:r>
              <a:r>
                <a: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K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5" name="TextBox 144">
              <a:extLst>
                <a:ext uri="{FF2B5EF4-FFF2-40B4-BE49-F238E27FC236}">
                  <a16:creationId xmlns:a16="http://schemas.microsoft.com/office/drawing/2014/main" id="{9ACC509F-422E-61EF-F6A4-391C2B9518DD}"/>
                </a:ext>
              </a:extLst>
            </p:cNvPr>
            <p:cNvSpPr txBox="1"/>
            <p:nvPr/>
          </p:nvSpPr>
          <p:spPr>
            <a:xfrm>
              <a:off x="6218737" y="4407262"/>
              <a:ext cx="79361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HF</a:t>
              </a:r>
              <a:r>
                <a: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Ts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6" name="그룹 15">
            <a:extLst>
              <a:ext uri="{FF2B5EF4-FFF2-40B4-BE49-F238E27FC236}">
                <a16:creationId xmlns:a16="http://schemas.microsoft.com/office/drawing/2014/main" id="{D41447B0-673A-78BD-FB43-3AB20863E477}"/>
              </a:ext>
            </a:extLst>
          </p:cNvPr>
          <p:cNvGrpSpPr/>
          <p:nvPr/>
        </p:nvGrpSpPr>
        <p:grpSpPr>
          <a:xfrm>
            <a:off x="2850851" y="3224959"/>
            <a:ext cx="866284" cy="516535"/>
            <a:chOff x="7345502" y="3006132"/>
            <a:chExt cx="866284" cy="516535"/>
          </a:xfrm>
        </p:grpSpPr>
        <p:pic>
          <p:nvPicPr>
            <p:cNvPr id="9" name="그림 8">
              <a:extLst>
                <a:ext uri="{FF2B5EF4-FFF2-40B4-BE49-F238E27FC236}">
                  <a16:creationId xmlns:a16="http://schemas.microsoft.com/office/drawing/2014/main" id="{0F175FAE-F8D5-185B-EFF4-5B6FA0ED4B9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8760" t="10021" r="16328" b="61902"/>
            <a:stretch/>
          </p:blipFill>
          <p:spPr>
            <a:xfrm>
              <a:off x="7345502" y="3067794"/>
              <a:ext cx="137363" cy="433689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B99F9A58-64C0-02E6-ACDD-9CE7E552489F}"/>
                </a:ext>
              </a:extLst>
            </p:cNvPr>
            <p:cNvSpPr txBox="1"/>
            <p:nvPr/>
          </p:nvSpPr>
          <p:spPr>
            <a:xfrm>
              <a:off x="7418175" y="3006132"/>
              <a:ext cx="79361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NC CON</a:t>
              </a:r>
              <a:endParaRPr lang="ko-KR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082DD465-D69E-DA9B-588F-9BAD1CF9DE55}"/>
                </a:ext>
              </a:extLst>
            </p:cNvPr>
            <p:cNvSpPr txBox="1"/>
            <p:nvPr/>
          </p:nvSpPr>
          <p:spPr>
            <a:xfrm>
              <a:off x="7418175" y="3160980"/>
              <a:ext cx="79361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  <a:r>
                <a: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K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B077927E-6F17-9D74-A515-CDA598E7028A}"/>
                </a:ext>
              </a:extLst>
            </p:cNvPr>
            <p:cNvSpPr txBox="1"/>
            <p:nvPr/>
          </p:nvSpPr>
          <p:spPr>
            <a:xfrm>
              <a:off x="7418175" y="3291835"/>
              <a:ext cx="79361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  <a:r>
                <a: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Ts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28" name="그룹 227">
            <a:extLst>
              <a:ext uri="{FF2B5EF4-FFF2-40B4-BE49-F238E27FC236}">
                <a16:creationId xmlns:a16="http://schemas.microsoft.com/office/drawing/2014/main" id="{C0AADFC2-E455-E22D-AF90-97D1BA139696}"/>
              </a:ext>
            </a:extLst>
          </p:cNvPr>
          <p:cNvGrpSpPr/>
          <p:nvPr/>
        </p:nvGrpSpPr>
        <p:grpSpPr>
          <a:xfrm>
            <a:off x="2870803" y="3675610"/>
            <a:ext cx="846103" cy="507284"/>
            <a:chOff x="7365683" y="3440960"/>
            <a:chExt cx="846103" cy="507284"/>
          </a:xfrm>
        </p:grpSpPr>
        <p:pic>
          <p:nvPicPr>
            <p:cNvPr id="229" name="그림 228">
              <a:extLst>
                <a:ext uri="{FF2B5EF4-FFF2-40B4-BE49-F238E27FC236}">
                  <a16:creationId xmlns:a16="http://schemas.microsoft.com/office/drawing/2014/main" id="{47112E87-97D6-CC47-EADD-0F3781CE5BC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9481" t="36352" r="16646" b="36786"/>
            <a:stretch/>
          </p:blipFill>
          <p:spPr>
            <a:xfrm>
              <a:off x="7365683" y="3474510"/>
              <a:ext cx="108298" cy="414921"/>
            </a:xfrm>
            <a:prstGeom prst="rect">
              <a:avLst/>
            </a:prstGeom>
          </p:spPr>
        </p:pic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6E58DDDB-B90A-A89B-4E7B-F6C59E862B88}"/>
                </a:ext>
              </a:extLst>
            </p:cNvPr>
            <p:cNvSpPr txBox="1"/>
            <p:nvPr/>
          </p:nvSpPr>
          <p:spPr>
            <a:xfrm>
              <a:off x="7418175" y="3440960"/>
              <a:ext cx="79361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HF CON</a:t>
              </a:r>
              <a:endParaRPr lang="ko-KR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6" name="TextBox 235">
              <a:extLst>
                <a:ext uri="{FF2B5EF4-FFF2-40B4-BE49-F238E27FC236}">
                  <a16:creationId xmlns:a16="http://schemas.microsoft.com/office/drawing/2014/main" id="{914904BC-6DB6-CB3A-F4E6-6E3883BA0BB6}"/>
                </a:ext>
              </a:extLst>
            </p:cNvPr>
            <p:cNvSpPr txBox="1"/>
            <p:nvPr/>
          </p:nvSpPr>
          <p:spPr>
            <a:xfrm>
              <a:off x="7418175" y="3578786"/>
              <a:ext cx="79361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HF</a:t>
              </a:r>
              <a:r>
                <a: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+ K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7" name="TextBox 236">
              <a:extLst>
                <a:ext uri="{FF2B5EF4-FFF2-40B4-BE49-F238E27FC236}">
                  <a16:creationId xmlns:a16="http://schemas.microsoft.com/office/drawing/2014/main" id="{645F9645-8602-F9DE-41D0-139E032F86A8}"/>
                </a:ext>
              </a:extLst>
            </p:cNvPr>
            <p:cNvSpPr txBox="1"/>
            <p:nvPr/>
          </p:nvSpPr>
          <p:spPr>
            <a:xfrm>
              <a:off x="7418175" y="3717412"/>
              <a:ext cx="79361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HF</a:t>
              </a:r>
              <a:r>
                <a: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Ts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2" name="TextBox 31">
            <a:extLst>
              <a:ext uri="{FF2B5EF4-FFF2-40B4-BE49-F238E27FC236}">
                <a16:creationId xmlns:a16="http://schemas.microsoft.com/office/drawing/2014/main" id="{2DE1BE53-429A-FEFD-8FC6-502F70081E05}"/>
              </a:ext>
            </a:extLst>
          </p:cNvPr>
          <p:cNvSpPr txBox="1"/>
          <p:nvPr/>
        </p:nvSpPr>
        <p:spPr>
          <a:xfrm rot="16200000">
            <a:off x="3883008" y="3975721"/>
            <a:ext cx="16955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8W/10W weight gain (%)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8" name="그룹 57">
            <a:extLst>
              <a:ext uri="{FF2B5EF4-FFF2-40B4-BE49-F238E27FC236}">
                <a16:creationId xmlns:a16="http://schemas.microsoft.com/office/drawing/2014/main" id="{BDC3E383-11A3-0A8A-5EE7-A5899AE1771C}"/>
              </a:ext>
            </a:extLst>
          </p:cNvPr>
          <p:cNvGrpSpPr/>
          <p:nvPr/>
        </p:nvGrpSpPr>
        <p:grpSpPr>
          <a:xfrm>
            <a:off x="4690218" y="3392062"/>
            <a:ext cx="417718" cy="1473915"/>
            <a:chOff x="4756086" y="3361621"/>
            <a:chExt cx="417718" cy="1473915"/>
          </a:xfrm>
        </p:grpSpPr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3F19A19D-1BE8-DD22-3FE8-83C203ECD5A6}"/>
                </a:ext>
              </a:extLst>
            </p:cNvPr>
            <p:cNvSpPr txBox="1"/>
            <p:nvPr/>
          </p:nvSpPr>
          <p:spPr>
            <a:xfrm>
              <a:off x="4792295" y="4604704"/>
              <a:ext cx="38150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900" b="1">
                  <a:latin typeface="Arial" panose="020B0604020202020204" pitchFamily="34" charset="0"/>
                  <a:cs typeface="Arial" panose="020B0604020202020204" pitchFamily="34" charset="0"/>
                </a:rPr>
                <a:t>-5</a:t>
              </a:r>
              <a:endParaRPr lang="ko-KR" altLang="en-US" sz="9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A99B5117-F058-1F3C-D347-2C4B4DBB22E2}"/>
                </a:ext>
              </a:extLst>
            </p:cNvPr>
            <p:cNvSpPr txBox="1"/>
            <p:nvPr/>
          </p:nvSpPr>
          <p:spPr>
            <a:xfrm>
              <a:off x="4765718" y="3361621"/>
              <a:ext cx="37719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900" b="1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ko-KR" altLang="en-US" sz="9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22E87E85-0DD1-8D36-B33D-255692A0EF81}"/>
                </a:ext>
              </a:extLst>
            </p:cNvPr>
            <p:cNvSpPr txBox="1"/>
            <p:nvPr/>
          </p:nvSpPr>
          <p:spPr>
            <a:xfrm>
              <a:off x="4756086" y="3767470"/>
              <a:ext cx="37719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900" b="1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ko-KR" altLang="en-US" sz="9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E96852D8-ECD8-CA69-7AF5-751F321B7C53}"/>
                </a:ext>
              </a:extLst>
            </p:cNvPr>
            <p:cNvSpPr txBox="1"/>
            <p:nvPr/>
          </p:nvSpPr>
          <p:spPr>
            <a:xfrm>
              <a:off x="4759100" y="4187746"/>
              <a:ext cx="37719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900" b="1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9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0" name="그룹 99">
            <a:extLst>
              <a:ext uri="{FF2B5EF4-FFF2-40B4-BE49-F238E27FC236}">
                <a16:creationId xmlns:a16="http://schemas.microsoft.com/office/drawing/2014/main" id="{7A86F150-0EFF-DABC-3220-049213B189CE}"/>
              </a:ext>
            </a:extLst>
          </p:cNvPr>
          <p:cNvGrpSpPr/>
          <p:nvPr/>
        </p:nvGrpSpPr>
        <p:grpSpPr>
          <a:xfrm>
            <a:off x="5178614" y="4762715"/>
            <a:ext cx="1470253" cy="458332"/>
            <a:chOff x="5244482" y="4732274"/>
            <a:chExt cx="1470253" cy="458332"/>
          </a:xfrm>
        </p:grpSpPr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98A8B90F-57A7-300D-F4E7-E955162A1A26}"/>
                </a:ext>
              </a:extLst>
            </p:cNvPr>
            <p:cNvSpPr txBox="1"/>
            <p:nvPr/>
          </p:nvSpPr>
          <p:spPr>
            <a:xfrm>
              <a:off x="5244482" y="4732274"/>
              <a:ext cx="47509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900" b="1">
                  <a:latin typeface="Arial" panose="020B0604020202020204" pitchFamily="34" charset="0"/>
                  <a:cs typeface="Arial" panose="020B0604020202020204" pitchFamily="34" charset="0"/>
                </a:rPr>
                <a:t>CON</a:t>
              </a:r>
              <a:endParaRPr lang="ko-KR" altLang="en-US" sz="9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8AF3F12E-56DE-937E-08F0-ED1B984D95EC}"/>
                </a:ext>
              </a:extLst>
            </p:cNvPr>
            <p:cNvSpPr txBox="1"/>
            <p:nvPr/>
          </p:nvSpPr>
          <p:spPr>
            <a:xfrm>
              <a:off x="5817672" y="4732274"/>
              <a:ext cx="3675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Ka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B06CA1D3-609E-C183-0983-88AAE91E5620}"/>
                </a:ext>
              </a:extLst>
            </p:cNvPr>
            <p:cNvSpPr txBox="1"/>
            <p:nvPr/>
          </p:nvSpPr>
          <p:spPr>
            <a:xfrm>
              <a:off x="6347155" y="4732274"/>
              <a:ext cx="3675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Ts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8" name="직선 연결선 248">
              <a:extLst>
                <a:ext uri="{FF2B5EF4-FFF2-40B4-BE49-F238E27FC236}">
                  <a16:creationId xmlns:a16="http://schemas.microsoft.com/office/drawing/2014/main" id="{2365A094-0961-B249-7676-4FF6CEC5D017}"/>
                </a:ext>
              </a:extLst>
            </p:cNvPr>
            <p:cNvCxnSpPr>
              <a:cxnSpLocks/>
            </p:cNvCxnSpPr>
            <p:nvPr/>
          </p:nvCxnSpPr>
          <p:spPr>
            <a:xfrm>
              <a:off x="5308068" y="4960618"/>
              <a:ext cx="131753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727DACF5-F7D0-A782-E33D-695C2E36E5AB}"/>
                </a:ext>
              </a:extLst>
            </p:cNvPr>
            <p:cNvSpPr txBox="1"/>
            <p:nvPr/>
          </p:nvSpPr>
          <p:spPr>
            <a:xfrm>
              <a:off x="5701352" y="4944385"/>
              <a:ext cx="5188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>
                  <a:latin typeface="Arial" panose="020B0604020202020204" pitchFamily="34" charset="0"/>
                  <a:cs typeface="Arial" panose="020B0604020202020204" pitchFamily="34" charset="0"/>
                </a:rPr>
                <a:t>HF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120" name="그림 119" descr="차트이(가) 표시된 사진&#10;&#10;자동 생성된 설명">
            <a:extLst>
              <a:ext uri="{FF2B5EF4-FFF2-40B4-BE49-F238E27FC236}">
                <a16:creationId xmlns:a16="http://schemas.microsoft.com/office/drawing/2014/main" id="{98EA960F-770A-507B-464E-1FD14780B4A7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628" t="3428" r="43256" b="11204"/>
          <a:stretch/>
        </p:blipFill>
        <p:spPr>
          <a:xfrm>
            <a:off x="5008855" y="3237967"/>
            <a:ext cx="1772135" cy="1557496"/>
          </a:xfrm>
          <a:prstGeom prst="rect">
            <a:avLst/>
          </a:prstGeom>
        </p:spPr>
      </p:pic>
      <p:grpSp>
        <p:nvGrpSpPr>
          <p:cNvPr id="2" name="그룹 1">
            <a:extLst>
              <a:ext uri="{FF2B5EF4-FFF2-40B4-BE49-F238E27FC236}">
                <a16:creationId xmlns:a16="http://schemas.microsoft.com/office/drawing/2014/main" id="{80388C08-2F91-362F-8196-FE3E1F1C3368}"/>
              </a:ext>
            </a:extLst>
          </p:cNvPr>
          <p:cNvGrpSpPr/>
          <p:nvPr/>
        </p:nvGrpSpPr>
        <p:grpSpPr>
          <a:xfrm>
            <a:off x="86723" y="5871192"/>
            <a:ext cx="2967086" cy="1836965"/>
            <a:chOff x="138600" y="5340320"/>
            <a:chExt cx="2967086" cy="1836965"/>
          </a:xfrm>
        </p:grpSpPr>
        <p:pic>
          <p:nvPicPr>
            <p:cNvPr id="4" name="그림 3">
              <a:extLst>
                <a:ext uri="{FF2B5EF4-FFF2-40B4-BE49-F238E27FC236}">
                  <a16:creationId xmlns:a16="http://schemas.microsoft.com/office/drawing/2014/main" id="{30F5A3E8-68C8-0C9F-E88F-52CF3037D89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583" t="8418" r="25090" b="11084"/>
            <a:stretch/>
          </p:blipFill>
          <p:spPr>
            <a:xfrm>
              <a:off x="585686" y="5439962"/>
              <a:ext cx="2520000" cy="1551608"/>
            </a:xfrm>
            <a:prstGeom prst="rect">
              <a:avLst/>
            </a:prstGeom>
          </p:spPr>
        </p:pic>
        <p:grpSp>
          <p:nvGrpSpPr>
            <p:cNvPr id="13" name="그룹 12">
              <a:extLst>
                <a:ext uri="{FF2B5EF4-FFF2-40B4-BE49-F238E27FC236}">
                  <a16:creationId xmlns:a16="http://schemas.microsoft.com/office/drawing/2014/main" id="{B1790AE3-94DD-CF01-D7A8-C1266201E3D1}"/>
                </a:ext>
              </a:extLst>
            </p:cNvPr>
            <p:cNvGrpSpPr/>
            <p:nvPr/>
          </p:nvGrpSpPr>
          <p:grpSpPr>
            <a:xfrm>
              <a:off x="886507" y="6931064"/>
              <a:ext cx="1903991" cy="246221"/>
              <a:chOff x="671358" y="6931064"/>
              <a:chExt cx="1903991" cy="246221"/>
            </a:xfrm>
          </p:grpSpPr>
          <p:sp>
            <p:nvSpPr>
              <p:cNvPr id="234" name="TextBox 233">
                <a:extLst>
                  <a:ext uri="{FF2B5EF4-FFF2-40B4-BE49-F238E27FC236}">
                    <a16:creationId xmlns:a16="http://schemas.microsoft.com/office/drawing/2014/main" id="{A585C49E-49B0-AEFB-00E0-17014D1E6705}"/>
                  </a:ext>
                </a:extLst>
              </p:cNvPr>
              <p:cNvSpPr txBox="1"/>
              <p:nvPr/>
            </p:nvSpPr>
            <p:spPr>
              <a:xfrm>
                <a:off x="671358" y="6931064"/>
                <a:ext cx="67017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000" b="1">
                    <a:latin typeface="Arial" panose="020B0604020202020204" pitchFamily="34" charset="0"/>
                    <a:cs typeface="Arial" panose="020B0604020202020204" pitchFamily="34" charset="0"/>
                  </a:rPr>
                  <a:t>AST</a:t>
                </a:r>
                <a:endParaRPr lang="ko-KR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8" name="TextBox 237">
                <a:extLst>
                  <a:ext uri="{FF2B5EF4-FFF2-40B4-BE49-F238E27FC236}">
                    <a16:creationId xmlns:a16="http://schemas.microsoft.com/office/drawing/2014/main" id="{6E994E5C-DA6E-ADEF-3DA8-98D6740580A6}"/>
                  </a:ext>
                </a:extLst>
              </p:cNvPr>
              <p:cNvSpPr txBox="1"/>
              <p:nvPr/>
            </p:nvSpPr>
            <p:spPr>
              <a:xfrm>
                <a:off x="1905172" y="6931064"/>
                <a:ext cx="67017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000" b="1">
                    <a:latin typeface="Arial" panose="020B0604020202020204" pitchFamily="34" charset="0"/>
                    <a:cs typeface="Arial" panose="020B0604020202020204" pitchFamily="34" charset="0"/>
                  </a:rPr>
                  <a:t>ALT</a:t>
                </a:r>
                <a:endParaRPr lang="ko-KR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4" name="그룹 13">
              <a:extLst>
                <a:ext uri="{FF2B5EF4-FFF2-40B4-BE49-F238E27FC236}">
                  <a16:creationId xmlns:a16="http://schemas.microsoft.com/office/drawing/2014/main" id="{62B39BBE-6571-47D6-2906-FF911FE93E8E}"/>
                </a:ext>
              </a:extLst>
            </p:cNvPr>
            <p:cNvGrpSpPr/>
            <p:nvPr/>
          </p:nvGrpSpPr>
          <p:grpSpPr>
            <a:xfrm>
              <a:off x="256651" y="5340320"/>
              <a:ext cx="416540" cy="1706160"/>
              <a:chOff x="41502" y="5340320"/>
              <a:chExt cx="416540" cy="1706160"/>
            </a:xfrm>
          </p:grpSpPr>
          <p:sp>
            <p:nvSpPr>
              <p:cNvPr id="225" name="TextBox 224">
                <a:extLst>
                  <a:ext uri="{FF2B5EF4-FFF2-40B4-BE49-F238E27FC236}">
                    <a16:creationId xmlns:a16="http://schemas.microsoft.com/office/drawing/2014/main" id="{F379D207-B1E0-AA0D-9B28-C7FE60E3E247}"/>
                  </a:ext>
                </a:extLst>
              </p:cNvPr>
              <p:cNvSpPr txBox="1"/>
              <p:nvPr/>
            </p:nvSpPr>
            <p:spPr>
              <a:xfrm>
                <a:off x="210056" y="6815648"/>
                <a:ext cx="24798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900" b="1">
                    <a:latin typeface="Arial" panose="020B0604020202020204" pitchFamily="34" charset="0"/>
                    <a:cs typeface="Arial" panose="020B0604020202020204" pitchFamily="34" charset="0"/>
                  </a:rPr>
                  <a:t>0 </a:t>
                </a:r>
                <a:endParaRPr lang="ko-KR" altLang="en-US" sz="9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6" name="TextBox 225">
                <a:extLst>
                  <a:ext uri="{FF2B5EF4-FFF2-40B4-BE49-F238E27FC236}">
                    <a16:creationId xmlns:a16="http://schemas.microsoft.com/office/drawing/2014/main" id="{85D0886C-7797-5CC1-5538-4A02C1BBF0A0}"/>
                  </a:ext>
                </a:extLst>
              </p:cNvPr>
              <p:cNvSpPr txBox="1"/>
              <p:nvPr/>
            </p:nvSpPr>
            <p:spPr>
              <a:xfrm>
                <a:off x="137428" y="6571829"/>
                <a:ext cx="32061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900" b="1">
                    <a:latin typeface="Arial" panose="020B0604020202020204" pitchFamily="34" charset="0"/>
                    <a:cs typeface="Arial" panose="020B0604020202020204" pitchFamily="34" charset="0"/>
                  </a:rPr>
                  <a:t>50 </a:t>
                </a:r>
                <a:endParaRPr lang="ko-KR" altLang="en-US" sz="9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7" name="TextBox 226">
                <a:extLst>
                  <a:ext uri="{FF2B5EF4-FFF2-40B4-BE49-F238E27FC236}">
                    <a16:creationId xmlns:a16="http://schemas.microsoft.com/office/drawing/2014/main" id="{1BF28BD5-203D-EFE1-B0B6-1BC8736E268F}"/>
                  </a:ext>
                </a:extLst>
              </p:cNvPr>
              <p:cNvSpPr txBox="1"/>
              <p:nvPr/>
            </p:nvSpPr>
            <p:spPr>
              <a:xfrm>
                <a:off x="41502" y="6328010"/>
                <a:ext cx="41654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900" b="1">
                    <a:latin typeface="Arial" panose="020B0604020202020204" pitchFamily="34" charset="0"/>
                    <a:cs typeface="Arial" panose="020B0604020202020204" pitchFamily="34" charset="0"/>
                  </a:rPr>
                  <a:t>100 </a:t>
                </a:r>
                <a:endParaRPr lang="ko-KR" altLang="en-US" sz="9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0" name="TextBox 229">
                <a:extLst>
                  <a:ext uri="{FF2B5EF4-FFF2-40B4-BE49-F238E27FC236}">
                    <a16:creationId xmlns:a16="http://schemas.microsoft.com/office/drawing/2014/main" id="{EEA8A893-346F-3F72-FDB2-4CB0C44DB535}"/>
                  </a:ext>
                </a:extLst>
              </p:cNvPr>
              <p:cNvSpPr txBox="1"/>
              <p:nvPr/>
            </p:nvSpPr>
            <p:spPr>
              <a:xfrm>
                <a:off x="41502" y="6066781"/>
                <a:ext cx="41654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900" b="1">
                    <a:latin typeface="Arial" panose="020B0604020202020204" pitchFamily="34" charset="0"/>
                    <a:cs typeface="Arial" panose="020B0604020202020204" pitchFamily="34" charset="0"/>
                  </a:rPr>
                  <a:t>150 </a:t>
                </a:r>
                <a:endParaRPr lang="ko-KR" altLang="en-US" sz="9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1" name="TextBox 230">
                <a:extLst>
                  <a:ext uri="{FF2B5EF4-FFF2-40B4-BE49-F238E27FC236}">
                    <a16:creationId xmlns:a16="http://schemas.microsoft.com/office/drawing/2014/main" id="{CE400905-16D7-5F7D-806E-C64482ECB231}"/>
                  </a:ext>
                </a:extLst>
              </p:cNvPr>
              <p:cNvSpPr txBox="1"/>
              <p:nvPr/>
            </p:nvSpPr>
            <p:spPr>
              <a:xfrm>
                <a:off x="41502" y="5830715"/>
                <a:ext cx="41654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900" b="1">
                    <a:latin typeface="Arial" panose="020B0604020202020204" pitchFamily="34" charset="0"/>
                    <a:cs typeface="Arial" panose="020B0604020202020204" pitchFamily="34" charset="0"/>
                  </a:rPr>
                  <a:t>200 </a:t>
                </a:r>
                <a:endParaRPr lang="ko-KR" altLang="en-US" sz="9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2" name="TextBox 231">
                <a:extLst>
                  <a:ext uri="{FF2B5EF4-FFF2-40B4-BE49-F238E27FC236}">
                    <a16:creationId xmlns:a16="http://schemas.microsoft.com/office/drawing/2014/main" id="{24D44C71-0731-6653-0B33-9301F8E8DB98}"/>
                  </a:ext>
                </a:extLst>
              </p:cNvPr>
              <p:cNvSpPr txBox="1"/>
              <p:nvPr/>
            </p:nvSpPr>
            <p:spPr>
              <a:xfrm>
                <a:off x="41502" y="5586117"/>
                <a:ext cx="41654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900" b="1">
                    <a:latin typeface="Arial" panose="020B0604020202020204" pitchFamily="34" charset="0"/>
                    <a:cs typeface="Arial" panose="020B0604020202020204" pitchFamily="34" charset="0"/>
                  </a:rPr>
                  <a:t>250 </a:t>
                </a:r>
                <a:endParaRPr lang="ko-KR" altLang="en-US" sz="9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3" name="TextBox 232">
                <a:extLst>
                  <a:ext uri="{FF2B5EF4-FFF2-40B4-BE49-F238E27FC236}">
                    <a16:creationId xmlns:a16="http://schemas.microsoft.com/office/drawing/2014/main" id="{58B450B1-C9BE-9ABF-71D3-70A88BDD16B9}"/>
                  </a:ext>
                </a:extLst>
              </p:cNvPr>
              <p:cNvSpPr txBox="1"/>
              <p:nvPr/>
            </p:nvSpPr>
            <p:spPr>
              <a:xfrm>
                <a:off x="41502" y="5340320"/>
                <a:ext cx="41654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900" b="1">
                    <a:latin typeface="Arial" panose="020B0604020202020204" pitchFamily="34" charset="0"/>
                    <a:cs typeface="Arial" panose="020B0604020202020204" pitchFamily="34" charset="0"/>
                  </a:rPr>
                  <a:t>300 </a:t>
                </a:r>
                <a:endParaRPr lang="ko-KR" altLang="en-US" sz="9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07E9213F-FC64-4038-955B-8C3BAD719F0F}"/>
                </a:ext>
              </a:extLst>
            </p:cNvPr>
            <p:cNvSpPr txBox="1"/>
            <p:nvPr/>
          </p:nvSpPr>
          <p:spPr>
            <a:xfrm rot="16200000">
              <a:off x="-73953" y="6059086"/>
              <a:ext cx="67132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>
                  <a:solidFill>
                    <a:srgbClr val="0D0E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/L</a:t>
              </a:r>
              <a:endParaRPr lang="ko-KR" altLang="en-US" sz="1000" b="1">
                <a:solidFill>
                  <a:srgbClr val="0D0E1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39" name="그룹 238">
            <a:extLst>
              <a:ext uri="{FF2B5EF4-FFF2-40B4-BE49-F238E27FC236}">
                <a16:creationId xmlns:a16="http://schemas.microsoft.com/office/drawing/2014/main" id="{FF3DB1C9-EB30-CD7F-A668-A3DA74462303}"/>
              </a:ext>
            </a:extLst>
          </p:cNvPr>
          <p:cNvGrpSpPr/>
          <p:nvPr/>
        </p:nvGrpSpPr>
        <p:grpSpPr>
          <a:xfrm>
            <a:off x="3132626" y="5767904"/>
            <a:ext cx="2967601" cy="1938012"/>
            <a:chOff x="3196868" y="7894541"/>
            <a:chExt cx="2967601" cy="1938012"/>
          </a:xfrm>
        </p:grpSpPr>
        <p:grpSp>
          <p:nvGrpSpPr>
            <p:cNvPr id="240" name="그룹 239">
              <a:extLst>
                <a:ext uri="{FF2B5EF4-FFF2-40B4-BE49-F238E27FC236}">
                  <a16:creationId xmlns:a16="http://schemas.microsoft.com/office/drawing/2014/main" id="{B8130156-16F5-8F2F-3610-DF4883AA8B73}"/>
                </a:ext>
              </a:extLst>
            </p:cNvPr>
            <p:cNvGrpSpPr/>
            <p:nvPr/>
          </p:nvGrpSpPr>
          <p:grpSpPr>
            <a:xfrm>
              <a:off x="3318281" y="7982601"/>
              <a:ext cx="416540" cy="1706160"/>
              <a:chOff x="3168078" y="5230293"/>
              <a:chExt cx="416540" cy="1706160"/>
            </a:xfrm>
          </p:grpSpPr>
          <p:sp>
            <p:nvSpPr>
              <p:cNvPr id="246" name="TextBox 245">
                <a:extLst>
                  <a:ext uri="{FF2B5EF4-FFF2-40B4-BE49-F238E27FC236}">
                    <a16:creationId xmlns:a16="http://schemas.microsoft.com/office/drawing/2014/main" id="{AB0FC2C8-D5DF-3FF3-1348-E0A036AFC57E}"/>
                  </a:ext>
                </a:extLst>
              </p:cNvPr>
              <p:cNvSpPr txBox="1"/>
              <p:nvPr/>
            </p:nvSpPr>
            <p:spPr>
              <a:xfrm>
                <a:off x="3336632" y="6705621"/>
                <a:ext cx="24798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900" b="1">
                    <a:latin typeface="Arial" panose="020B0604020202020204" pitchFamily="34" charset="0"/>
                    <a:cs typeface="Arial" panose="020B0604020202020204" pitchFamily="34" charset="0"/>
                  </a:rPr>
                  <a:t>0 </a:t>
                </a:r>
                <a:endParaRPr lang="ko-KR" altLang="en-US" sz="9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7" name="TextBox 246">
                <a:extLst>
                  <a:ext uri="{FF2B5EF4-FFF2-40B4-BE49-F238E27FC236}">
                    <a16:creationId xmlns:a16="http://schemas.microsoft.com/office/drawing/2014/main" id="{0D719EA4-357B-AE40-5AE1-0C15222853B2}"/>
                  </a:ext>
                </a:extLst>
              </p:cNvPr>
              <p:cNvSpPr txBox="1"/>
              <p:nvPr/>
            </p:nvSpPr>
            <p:spPr>
              <a:xfrm>
                <a:off x="3264004" y="6461802"/>
                <a:ext cx="32061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900" b="1">
                    <a:latin typeface="Arial" panose="020B0604020202020204" pitchFamily="34" charset="0"/>
                    <a:cs typeface="Arial" panose="020B0604020202020204" pitchFamily="34" charset="0"/>
                  </a:rPr>
                  <a:t>50 </a:t>
                </a:r>
                <a:endParaRPr lang="ko-KR" altLang="en-US" sz="9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8" name="TextBox 247">
                <a:extLst>
                  <a:ext uri="{FF2B5EF4-FFF2-40B4-BE49-F238E27FC236}">
                    <a16:creationId xmlns:a16="http://schemas.microsoft.com/office/drawing/2014/main" id="{7997F467-27E7-D5BB-CBBB-EB495BB74282}"/>
                  </a:ext>
                </a:extLst>
              </p:cNvPr>
              <p:cNvSpPr txBox="1"/>
              <p:nvPr/>
            </p:nvSpPr>
            <p:spPr>
              <a:xfrm>
                <a:off x="3168078" y="6217983"/>
                <a:ext cx="41654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900" b="1">
                    <a:latin typeface="Arial" panose="020B0604020202020204" pitchFamily="34" charset="0"/>
                    <a:cs typeface="Arial" panose="020B0604020202020204" pitchFamily="34" charset="0"/>
                  </a:rPr>
                  <a:t>100 </a:t>
                </a:r>
                <a:endParaRPr lang="ko-KR" altLang="en-US" sz="9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9" name="TextBox 248">
                <a:extLst>
                  <a:ext uri="{FF2B5EF4-FFF2-40B4-BE49-F238E27FC236}">
                    <a16:creationId xmlns:a16="http://schemas.microsoft.com/office/drawing/2014/main" id="{8953CCF8-3BC6-1A92-3CED-BCE2103502D6}"/>
                  </a:ext>
                </a:extLst>
              </p:cNvPr>
              <p:cNvSpPr txBox="1"/>
              <p:nvPr/>
            </p:nvSpPr>
            <p:spPr>
              <a:xfrm>
                <a:off x="3168078" y="5956754"/>
                <a:ext cx="41654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900" b="1">
                    <a:latin typeface="Arial" panose="020B0604020202020204" pitchFamily="34" charset="0"/>
                    <a:cs typeface="Arial" panose="020B0604020202020204" pitchFamily="34" charset="0"/>
                  </a:rPr>
                  <a:t>150 </a:t>
                </a:r>
                <a:endParaRPr lang="ko-KR" altLang="en-US" sz="9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0" name="TextBox 249">
                <a:extLst>
                  <a:ext uri="{FF2B5EF4-FFF2-40B4-BE49-F238E27FC236}">
                    <a16:creationId xmlns:a16="http://schemas.microsoft.com/office/drawing/2014/main" id="{EB6A7C07-387B-751A-AE17-845E67497D10}"/>
                  </a:ext>
                </a:extLst>
              </p:cNvPr>
              <p:cNvSpPr txBox="1"/>
              <p:nvPr/>
            </p:nvSpPr>
            <p:spPr>
              <a:xfrm>
                <a:off x="3168078" y="5720688"/>
                <a:ext cx="41654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900" b="1">
                    <a:latin typeface="Arial" panose="020B0604020202020204" pitchFamily="34" charset="0"/>
                    <a:cs typeface="Arial" panose="020B0604020202020204" pitchFamily="34" charset="0"/>
                  </a:rPr>
                  <a:t>200 </a:t>
                </a:r>
                <a:endParaRPr lang="ko-KR" altLang="en-US" sz="9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1" name="TextBox 250">
                <a:extLst>
                  <a:ext uri="{FF2B5EF4-FFF2-40B4-BE49-F238E27FC236}">
                    <a16:creationId xmlns:a16="http://schemas.microsoft.com/office/drawing/2014/main" id="{3ADF31B8-D832-2D53-1E06-CF45DC3D40FB}"/>
                  </a:ext>
                </a:extLst>
              </p:cNvPr>
              <p:cNvSpPr txBox="1"/>
              <p:nvPr/>
            </p:nvSpPr>
            <p:spPr>
              <a:xfrm>
                <a:off x="3168078" y="5476090"/>
                <a:ext cx="41654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900" b="1">
                    <a:latin typeface="Arial" panose="020B0604020202020204" pitchFamily="34" charset="0"/>
                    <a:cs typeface="Arial" panose="020B0604020202020204" pitchFamily="34" charset="0"/>
                  </a:rPr>
                  <a:t>250 </a:t>
                </a:r>
                <a:endParaRPr lang="ko-KR" altLang="en-US" sz="9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2" name="TextBox 251">
                <a:extLst>
                  <a:ext uri="{FF2B5EF4-FFF2-40B4-BE49-F238E27FC236}">
                    <a16:creationId xmlns:a16="http://schemas.microsoft.com/office/drawing/2014/main" id="{82BEDB32-A080-0545-A783-6FF1651D6061}"/>
                  </a:ext>
                </a:extLst>
              </p:cNvPr>
              <p:cNvSpPr txBox="1"/>
              <p:nvPr/>
            </p:nvSpPr>
            <p:spPr>
              <a:xfrm>
                <a:off x="3168078" y="5230293"/>
                <a:ext cx="41654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900" b="1">
                    <a:latin typeface="Arial" panose="020B0604020202020204" pitchFamily="34" charset="0"/>
                    <a:cs typeface="Arial" panose="020B0604020202020204" pitchFamily="34" charset="0"/>
                  </a:rPr>
                  <a:t>300 </a:t>
                </a:r>
                <a:endParaRPr lang="ko-KR" altLang="en-US" sz="9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41" name="그룹 240">
              <a:extLst>
                <a:ext uri="{FF2B5EF4-FFF2-40B4-BE49-F238E27FC236}">
                  <a16:creationId xmlns:a16="http://schemas.microsoft.com/office/drawing/2014/main" id="{525186B2-41EE-6A03-AB39-70148FA0F03A}"/>
                </a:ext>
              </a:extLst>
            </p:cNvPr>
            <p:cNvGrpSpPr/>
            <p:nvPr/>
          </p:nvGrpSpPr>
          <p:grpSpPr>
            <a:xfrm>
              <a:off x="3972876" y="9586332"/>
              <a:ext cx="1952799" cy="246221"/>
              <a:chOff x="3822673" y="6834024"/>
              <a:chExt cx="1952799" cy="246221"/>
            </a:xfrm>
          </p:grpSpPr>
          <p:sp>
            <p:nvSpPr>
              <p:cNvPr id="244" name="TextBox 243">
                <a:extLst>
                  <a:ext uri="{FF2B5EF4-FFF2-40B4-BE49-F238E27FC236}">
                    <a16:creationId xmlns:a16="http://schemas.microsoft.com/office/drawing/2014/main" id="{A5CA45FC-65C7-17A9-B620-074FF3EFDC26}"/>
                  </a:ext>
                </a:extLst>
              </p:cNvPr>
              <p:cNvSpPr txBox="1"/>
              <p:nvPr/>
            </p:nvSpPr>
            <p:spPr>
              <a:xfrm>
                <a:off x="3822673" y="6834024"/>
                <a:ext cx="67017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000" b="1">
                    <a:latin typeface="Arial" panose="020B0604020202020204" pitchFamily="34" charset="0"/>
                    <a:cs typeface="Arial" panose="020B0604020202020204" pitchFamily="34" charset="0"/>
                  </a:rPr>
                  <a:t>TC</a:t>
                </a:r>
                <a:endParaRPr lang="ko-KR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5" name="TextBox 244">
                <a:extLst>
                  <a:ext uri="{FF2B5EF4-FFF2-40B4-BE49-F238E27FC236}">
                    <a16:creationId xmlns:a16="http://schemas.microsoft.com/office/drawing/2014/main" id="{F77D5C49-2D30-CAA9-6E87-83E67C7D9B66}"/>
                  </a:ext>
                </a:extLst>
              </p:cNvPr>
              <p:cNvSpPr txBox="1"/>
              <p:nvPr/>
            </p:nvSpPr>
            <p:spPr>
              <a:xfrm>
                <a:off x="5105295" y="6834024"/>
                <a:ext cx="67017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000" b="1">
                    <a:latin typeface="Arial" panose="020B0604020202020204" pitchFamily="34" charset="0"/>
                    <a:cs typeface="Arial" panose="020B0604020202020204" pitchFamily="34" charset="0"/>
                  </a:rPr>
                  <a:t>LDL-C</a:t>
                </a:r>
                <a:endParaRPr lang="ko-KR" altLang="en-US" sz="10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242" name="그림 241">
              <a:extLst>
                <a:ext uri="{FF2B5EF4-FFF2-40B4-BE49-F238E27FC236}">
                  <a16:creationId xmlns:a16="http://schemas.microsoft.com/office/drawing/2014/main" id="{80684D96-5F24-C77C-D048-7CFB7115F74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269" t="5919" r="26175" b="9762"/>
            <a:stretch/>
          </p:blipFill>
          <p:spPr>
            <a:xfrm>
              <a:off x="3644469" y="7894541"/>
              <a:ext cx="2520000" cy="1764936"/>
            </a:xfrm>
            <a:prstGeom prst="rect">
              <a:avLst/>
            </a:prstGeom>
          </p:spPr>
        </p:pic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E00A165C-FC28-B51D-4556-4740117B5AC1}"/>
                </a:ext>
              </a:extLst>
            </p:cNvPr>
            <p:cNvSpPr txBox="1"/>
            <p:nvPr/>
          </p:nvSpPr>
          <p:spPr>
            <a:xfrm rot="16200000">
              <a:off x="3019813" y="8704911"/>
              <a:ext cx="61572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00" b="1">
                  <a:solidFill>
                    <a:srgbClr val="0D0E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g/dL</a:t>
              </a:r>
              <a:endParaRPr lang="ko-KR" altLang="en-US" sz="1100" b="1">
                <a:solidFill>
                  <a:srgbClr val="0D0E1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53" name="TextBox 252">
            <a:extLst>
              <a:ext uri="{FF2B5EF4-FFF2-40B4-BE49-F238E27FC236}">
                <a16:creationId xmlns:a16="http://schemas.microsoft.com/office/drawing/2014/main" id="{73B76F91-CDA7-54C2-D2D3-346E895A6CD3}"/>
              </a:ext>
            </a:extLst>
          </p:cNvPr>
          <p:cNvSpPr txBox="1"/>
          <p:nvPr/>
        </p:nvSpPr>
        <p:spPr>
          <a:xfrm>
            <a:off x="-10460" y="546012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>
                <a:solidFill>
                  <a:srgbClr val="0D0E1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1400" b="1">
              <a:solidFill>
                <a:srgbClr val="0D0E1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54" name="그룹 253">
            <a:extLst>
              <a:ext uri="{FF2B5EF4-FFF2-40B4-BE49-F238E27FC236}">
                <a16:creationId xmlns:a16="http://schemas.microsoft.com/office/drawing/2014/main" id="{2B76BAC4-17C6-F51C-539A-80383A22D720}"/>
              </a:ext>
            </a:extLst>
          </p:cNvPr>
          <p:cNvGrpSpPr/>
          <p:nvPr/>
        </p:nvGrpSpPr>
        <p:grpSpPr>
          <a:xfrm>
            <a:off x="6082758" y="5835136"/>
            <a:ext cx="838344" cy="1164362"/>
            <a:chOff x="5652313" y="7805929"/>
            <a:chExt cx="838344" cy="1164362"/>
          </a:xfrm>
        </p:grpSpPr>
        <p:sp>
          <p:nvSpPr>
            <p:cNvPr id="255" name="TextBox 254">
              <a:extLst>
                <a:ext uri="{FF2B5EF4-FFF2-40B4-BE49-F238E27FC236}">
                  <a16:creationId xmlns:a16="http://schemas.microsoft.com/office/drawing/2014/main" id="{76FF704B-675E-6785-02F3-663DC4789FD6}"/>
                </a:ext>
              </a:extLst>
            </p:cNvPr>
            <p:cNvSpPr txBox="1"/>
            <p:nvPr/>
          </p:nvSpPr>
          <p:spPr>
            <a:xfrm>
              <a:off x="5697046" y="7805929"/>
              <a:ext cx="79361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NC CON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7E9D8C11-69FF-F94F-2C26-43E228159AE6}"/>
                </a:ext>
              </a:extLst>
            </p:cNvPr>
            <p:cNvSpPr txBox="1"/>
            <p:nvPr/>
          </p:nvSpPr>
          <p:spPr>
            <a:xfrm>
              <a:off x="5697046" y="8005227"/>
              <a:ext cx="79361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  <a:r>
                <a: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K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3D023E8C-4A55-73F8-7517-F3A406EA18A7}"/>
                </a:ext>
              </a:extLst>
            </p:cNvPr>
            <p:cNvSpPr txBox="1"/>
            <p:nvPr/>
          </p:nvSpPr>
          <p:spPr>
            <a:xfrm>
              <a:off x="5697046" y="8180532"/>
              <a:ext cx="79361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  <a:r>
                <a: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+ Ts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F99442EA-9997-9781-840F-65A25FB82F35}"/>
                </a:ext>
              </a:extLst>
            </p:cNvPr>
            <p:cNvSpPr txBox="1"/>
            <p:nvPr/>
          </p:nvSpPr>
          <p:spPr>
            <a:xfrm>
              <a:off x="5697046" y="8361407"/>
              <a:ext cx="79361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>
                  <a:latin typeface="Arial" panose="020B0604020202020204" pitchFamily="34" charset="0"/>
                  <a:cs typeface="Arial" panose="020B0604020202020204" pitchFamily="34" charset="0"/>
                </a:rPr>
                <a:t>HF CON</a:t>
              </a:r>
              <a:endParaRPr lang="ko-KR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CAD5F8A2-E34D-3DC3-9465-780B6E8C330F}"/>
                </a:ext>
              </a:extLst>
            </p:cNvPr>
            <p:cNvSpPr txBox="1"/>
            <p:nvPr/>
          </p:nvSpPr>
          <p:spPr>
            <a:xfrm>
              <a:off x="5697046" y="8556383"/>
              <a:ext cx="79361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HF</a:t>
              </a:r>
              <a:r>
                <a: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K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B673897D-67CD-92FC-3DA1-5F0395B29733}"/>
                </a:ext>
              </a:extLst>
            </p:cNvPr>
            <p:cNvSpPr txBox="1"/>
            <p:nvPr/>
          </p:nvSpPr>
          <p:spPr>
            <a:xfrm>
              <a:off x="5697046" y="8739459"/>
              <a:ext cx="79361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HF</a:t>
              </a:r>
              <a:r>
                <a: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+ Ts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30" name="그림 129">
              <a:extLst>
                <a:ext uri="{FF2B5EF4-FFF2-40B4-BE49-F238E27FC236}">
                  <a16:creationId xmlns:a16="http://schemas.microsoft.com/office/drawing/2014/main" id="{00E7D2C8-F05F-9AE3-0CB0-0EB041AB07D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1782" t="18365" r="15680" b="32674"/>
            <a:stretch/>
          </p:blipFill>
          <p:spPr>
            <a:xfrm>
              <a:off x="5652313" y="7881053"/>
              <a:ext cx="104378" cy="1046263"/>
            </a:xfrm>
            <a:prstGeom prst="rect">
              <a:avLst/>
            </a:prstGeom>
          </p:spPr>
        </p:pic>
      </p:grpSp>
      <p:sp>
        <p:nvSpPr>
          <p:cNvPr id="131" name="TextBox 130">
            <a:extLst>
              <a:ext uri="{FF2B5EF4-FFF2-40B4-BE49-F238E27FC236}">
                <a16:creationId xmlns:a16="http://schemas.microsoft.com/office/drawing/2014/main" id="{CBE2C4E5-946C-0B14-6BDE-C6571FE0DA15}"/>
              </a:ext>
            </a:extLst>
          </p:cNvPr>
          <p:cNvSpPr txBox="1"/>
          <p:nvPr/>
        </p:nvSpPr>
        <p:spPr>
          <a:xfrm>
            <a:off x="3091308" y="5461264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>
                <a:solidFill>
                  <a:srgbClr val="0D0E1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ko-KR" altLang="en-US" sz="1400" b="1">
              <a:solidFill>
                <a:srgbClr val="0D0E1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318035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1EFB7A8D-949B-EF3F-CC14-2D24D508E002}"/>
              </a:ext>
            </a:extLst>
          </p:cNvPr>
          <p:cNvSpPr txBox="1"/>
          <p:nvPr/>
        </p:nvSpPr>
        <p:spPr>
          <a:xfrm>
            <a:off x="83563" y="44297"/>
            <a:ext cx="1149674" cy="4925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ore-KR" sz="2601">
                <a:latin typeface="Arial" panose="020B0604020202020204" pitchFamily="34" charset="0"/>
                <a:cs typeface="Arial" panose="020B0604020202020204" pitchFamily="34" charset="0"/>
              </a:rPr>
              <a:t>Fig S</a:t>
            </a:r>
            <a:r>
              <a:rPr kumimoji="1" lang="en-US" altLang="ko-Kore-KR" sz="260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ko-Kore-KR" altLang="en-US" sz="260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그림 15" descr="차트이(가) 표시된 사진&#10;&#10;자동 생성된 설명">
            <a:extLst>
              <a:ext uri="{FF2B5EF4-FFF2-40B4-BE49-F238E27FC236}">
                <a16:creationId xmlns:a16="http://schemas.microsoft.com/office/drawing/2014/main" id="{B93347D6-6671-E5A5-B8A2-22DC122FB3F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246" t="4029" r="30908" b="9653"/>
          <a:stretch/>
        </p:blipFill>
        <p:spPr>
          <a:xfrm>
            <a:off x="1055024" y="934580"/>
            <a:ext cx="2160000" cy="2065478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0ED2F62C-59E3-79C1-A13A-C14D3C63DB14}"/>
              </a:ext>
            </a:extLst>
          </p:cNvPr>
          <p:cNvSpPr txBox="1"/>
          <p:nvPr/>
        </p:nvSpPr>
        <p:spPr>
          <a:xfrm>
            <a:off x="3362585" y="78069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7849BAE-99FF-9F59-5706-A4138B676B7F}"/>
              </a:ext>
            </a:extLst>
          </p:cNvPr>
          <p:cNvSpPr txBox="1"/>
          <p:nvPr/>
        </p:nvSpPr>
        <p:spPr>
          <a:xfrm>
            <a:off x="293129" y="780693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5FFAA63-9156-07B6-8F4B-C9F75D36B6FB}"/>
              </a:ext>
            </a:extLst>
          </p:cNvPr>
          <p:cNvSpPr txBox="1"/>
          <p:nvPr/>
        </p:nvSpPr>
        <p:spPr>
          <a:xfrm>
            <a:off x="293129" y="329668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C2049AE-14DF-0341-725B-1F6D9F407BEA}"/>
              </a:ext>
            </a:extLst>
          </p:cNvPr>
          <p:cNvSpPr txBox="1"/>
          <p:nvPr/>
        </p:nvSpPr>
        <p:spPr>
          <a:xfrm>
            <a:off x="3362585" y="329668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22CDC16-F74A-650D-748E-D38274E84712}"/>
              </a:ext>
            </a:extLst>
          </p:cNvPr>
          <p:cNvSpPr txBox="1"/>
          <p:nvPr/>
        </p:nvSpPr>
        <p:spPr>
          <a:xfrm>
            <a:off x="293129" y="5875530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그림 17" descr="차트이(가) 표시된 사진&#10;&#10;자동 생성된 설명">
            <a:extLst>
              <a:ext uri="{FF2B5EF4-FFF2-40B4-BE49-F238E27FC236}">
                <a16:creationId xmlns:a16="http://schemas.microsoft.com/office/drawing/2014/main" id="{42FB8764-81A1-E59C-A997-D3A4E76C80C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975" t="4671" r="31730" b="8560"/>
          <a:stretch/>
        </p:blipFill>
        <p:spPr>
          <a:xfrm>
            <a:off x="4204369" y="900975"/>
            <a:ext cx="2160000" cy="2099083"/>
          </a:xfrm>
          <a:prstGeom prst="rect">
            <a:avLst/>
          </a:prstGeom>
        </p:spPr>
      </p:pic>
      <p:pic>
        <p:nvPicPr>
          <p:cNvPr id="20" name="그림 19" descr="차트이(가) 표시된 사진&#10;&#10;자동 생성된 설명">
            <a:extLst>
              <a:ext uri="{FF2B5EF4-FFF2-40B4-BE49-F238E27FC236}">
                <a16:creationId xmlns:a16="http://schemas.microsoft.com/office/drawing/2014/main" id="{C2C3DA9F-8357-0783-B376-209F095EFE2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639" t="6070" r="31002" b="10404"/>
          <a:stretch/>
        </p:blipFill>
        <p:spPr>
          <a:xfrm>
            <a:off x="1055024" y="3669000"/>
            <a:ext cx="2160000" cy="1814831"/>
          </a:xfrm>
          <a:prstGeom prst="rect">
            <a:avLst/>
          </a:prstGeom>
        </p:spPr>
      </p:pic>
      <p:pic>
        <p:nvPicPr>
          <p:cNvPr id="22" name="그림 21" descr="차트이(가) 표시된 사진&#10;&#10;자동 생성된 설명">
            <a:extLst>
              <a:ext uri="{FF2B5EF4-FFF2-40B4-BE49-F238E27FC236}">
                <a16:creationId xmlns:a16="http://schemas.microsoft.com/office/drawing/2014/main" id="{01873BD5-716B-19FF-FD3B-79470E42159C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460" t="2909" r="31862" b="9519"/>
          <a:stretch/>
        </p:blipFill>
        <p:spPr>
          <a:xfrm>
            <a:off x="1055024" y="5992147"/>
            <a:ext cx="2160000" cy="1959739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8AE1B549-EA48-AA05-C249-866B47B7CCB9}"/>
              </a:ext>
            </a:extLst>
          </p:cNvPr>
          <p:cNvSpPr txBox="1"/>
          <p:nvPr/>
        </p:nvSpPr>
        <p:spPr>
          <a:xfrm>
            <a:off x="3383425" y="5884787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" name="그림 27" descr="차트이(가) 표시된 사진&#10;&#10;자동 생성된 설명">
            <a:extLst>
              <a:ext uri="{FF2B5EF4-FFF2-40B4-BE49-F238E27FC236}">
                <a16:creationId xmlns:a16="http://schemas.microsoft.com/office/drawing/2014/main" id="{E26C3096-AA79-A33F-D6F7-BF623CB4F43F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357" t="3958" r="31890" b="9349"/>
          <a:stretch/>
        </p:blipFill>
        <p:spPr>
          <a:xfrm>
            <a:off x="4204369" y="3394670"/>
            <a:ext cx="2160000" cy="2114209"/>
          </a:xfrm>
          <a:prstGeom prst="rect">
            <a:avLst/>
          </a:prstGeom>
        </p:spPr>
      </p:pic>
      <p:pic>
        <p:nvPicPr>
          <p:cNvPr id="30" name="그림 29" descr="차트이(가) 표시된 사진&#10;&#10;자동 생성된 설명">
            <a:extLst>
              <a:ext uri="{FF2B5EF4-FFF2-40B4-BE49-F238E27FC236}">
                <a16:creationId xmlns:a16="http://schemas.microsoft.com/office/drawing/2014/main" id="{633AC0A8-D1E4-6D3B-E33F-63585D542843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883" t="7287" r="32200" b="10242"/>
          <a:stretch/>
        </p:blipFill>
        <p:spPr>
          <a:xfrm>
            <a:off x="4204369" y="6294490"/>
            <a:ext cx="2160000" cy="1657396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00040AC2-D207-E6F7-95D2-E9221D9A5911}"/>
              </a:ext>
            </a:extLst>
          </p:cNvPr>
          <p:cNvSpPr txBox="1"/>
          <p:nvPr/>
        </p:nvSpPr>
        <p:spPr>
          <a:xfrm rot="16200000">
            <a:off x="-168566" y="1979516"/>
            <a:ext cx="151932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>
                <a:latin typeface="Arial" panose="020B0604020202020204" pitchFamily="34" charset="0"/>
                <a:cs typeface="Arial" panose="020B0604020202020204" pitchFamily="34" charset="0"/>
              </a:rPr>
              <a:t>Acetic acid (mg/L)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F4D0CA63-F470-AA9E-22BF-958FCF402EEA}"/>
              </a:ext>
            </a:extLst>
          </p:cNvPr>
          <p:cNvSpPr txBox="1"/>
          <p:nvPr/>
        </p:nvSpPr>
        <p:spPr>
          <a:xfrm>
            <a:off x="766241" y="2804273"/>
            <a:ext cx="3747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0 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8235A976-13AE-796F-60EE-3F34AA27C0B7}"/>
              </a:ext>
            </a:extLst>
          </p:cNvPr>
          <p:cNvSpPr txBox="1"/>
          <p:nvPr/>
        </p:nvSpPr>
        <p:spPr>
          <a:xfrm>
            <a:off x="693613" y="2505969"/>
            <a:ext cx="4473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3BF0619C-EADE-1661-B1AE-8347544AFE42}"/>
              </a:ext>
            </a:extLst>
          </p:cNvPr>
          <p:cNvSpPr txBox="1"/>
          <p:nvPr/>
        </p:nvSpPr>
        <p:spPr>
          <a:xfrm>
            <a:off x="693613" y="2227974"/>
            <a:ext cx="4473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E4CE049F-91BC-A700-9D0F-C32337F9619D}"/>
              </a:ext>
            </a:extLst>
          </p:cNvPr>
          <p:cNvSpPr txBox="1"/>
          <p:nvPr/>
        </p:nvSpPr>
        <p:spPr>
          <a:xfrm>
            <a:off x="693613" y="1929670"/>
            <a:ext cx="4473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0EFA830B-D1B8-BD5F-A88B-21D58C78E79C}"/>
              </a:ext>
            </a:extLst>
          </p:cNvPr>
          <p:cNvSpPr txBox="1"/>
          <p:nvPr/>
        </p:nvSpPr>
        <p:spPr>
          <a:xfrm>
            <a:off x="693613" y="1630047"/>
            <a:ext cx="4473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800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2AE6015E-382B-4B83-A17C-0AD5CF4EE3F5}"/>
              </a:ext>
            </a:extLst>
          </p:cNvPr>
          <p:cNvSpPr txBox="1"/>
          <p:nvPr/>
        </p:nvSpPr>
        <p:spPr>
          <a:xfrm>
            <a:off x="674832" y="1321621"/>
            <a:ext cx="4661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DB392717-60E6-8D9E-3D60-115951617242}"/>
              </a:ext>
            </a:extLst>
          </p:cNvPr>
          <p:cNvSpPr txBox="1"/>
          <p:nvPr/>
        </p:nvSpPr>
        <p:spPr>
          <a:xfrm>
            <a:off x="1268047" y="2949202"/>
            <a:ext cx="3747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NC 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FC82CA1D-1353-8345-2A77-FFC1CF22065C}"/>
              </a:ext>
            </a:extLst>
          </p:cNvPr>
          <p:cNvSpPr txBox="1"/>
          <p:nvPr/>
        </p:nvSpPr>
        <p:spPr>
          <a:xfrm>
            <a:off x="1573631" y="2949202"/>
            <a:ext cx="6688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NC+Ka 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7E6342B0-E361-CC77-1A0B-6F7F543FAD9E}"/>
              </a:ext>
            </a:extLst>
          </p:cNvPr>
          <p:cNvSpPr txBox="1"/>
          <p:nvPr/>
        </p:nvSpPr>
        <p:spPr>
          <a:xfrm>
            <a:off x="2045973" y="2949202"/>
            <a:ext cx="6688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HFHF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3AC6435F-3E2E-AFFA-A81B-B44E5939C382}"/>
              </a:ext>
            </a:extLst>
          </p:cNvPr>
          <p:cNvSpPr txBox="1"/>
          <p:nvPr/>
        </p:nvSpPr>
        <p:spPr>
          <a:xfrm>
            <a:off x="2517431" y="2949202"/>
            <a:ext cx="8451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HFHF+Ka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CC96F706-841C-4AC5-5CC4-BDA62816B7E2}"/>
              </a:ext>
            </a:extLst>
          </p:cNvPr>
          <p:cNvSpPr txBox="1"/>
          <p:nvPr/>
        </p:nvSpPr>
        <p:spPr>
          <a:xfrm rot="16200000">
            <a:off x="3050264" y="2045085"/>
            <a:ext cx="151932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>
                <a:latin typeface="Arial" panose="020B0604020202020204" pitchFamily="34" charset="0"/>
                <a:cs typeface="Arial" panose="020B0604020202020204" pitchFamily="34" charset="0"/>
              </a:rPr>
              <a:t>Butyric acid (mg/L)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28B30DE4-26A9-3A1A-443E-62A0331B3CE9}"/>
              </a:ext>
            </a:extLst>
          </p:cNvPr>
          <p:cNvSpPr txBox="1"/>
          <p:nvPr/>
        </p:nvSpPr>
        <p:spPr>
          <a:xfrm>
            <a:off x="3909738" y="2752190"/>
            <a:ext cx="3747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0 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7A8D5F62-85B8-EA97-BBDB-E29BDB169E0E}"/>
              </a:ext>
            </a:extLst>
          </p:cNvPr>
          <p:cNvSpPr txBox="1"/>
          <p:nvPr/>
        </p:nvSpPr>
        <p:spPr>
          <a:xfrm>
            <a:off x="3782607" y="2391567"/>
            <a:ext cx="5018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296D1EB3-67BB-60C4-D9A3-8F37E69B7055}"/>
              </a:ext>
            </a:extLst>
          </p:cNvPr>
          <p:cNvSpPr txBox="1"/>
          <p:nvPr/>
        </p:nvSpPr>
        <p:spPr>
          <a:xfrm>
            <a:off x="3782607" y="2035644"/>
            <a:ext cx="5018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200 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DEF6911B-9C81-384F-C6A3-15015B1EB6EC}"/>
              </a:ext>
            </a:extLst>
          </p:cNvPr>
          <p:cNvSpPr txBox="1"/>
          <p:nvPr/>
        </p:nvSpPr>
        <p:spPr>
          <a:xfrm>
            <a:off x="3782607" y="1664665"/>
            <a:ext cx="5018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300 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0F309AE4-0C01-A81C-E72B-7FBF52FCFDB0}"/>
              </a:ext>
            </a:extLst>
          </p:cNvPr>
          <p:cNvSpPr txBox="1"/>
          <p:nvPr/>
        </p:nvSpPr>
        <p:spPr>
          <a:xfrm>
            <a:off x="3782607" y="1284977"/>
            <a:ext cx="5018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400 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B0EC8AB6-F440-8CD0-ECBC-0994F91F2FF3}"/>
              </a:ext>
            </a:extLst>
          </p:cNvPr>
          <p:cNvSpPr txBox="1"/>
          <p:nvPr/>
        </p:nvSpPr>
        <p:spPr>
          <a:xfrm rot="16200000">
            <a:off x="-123701" y="4651492"/>
            <a:ext cx="160289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>
                <a:latin typeface="Arial" panose="020B0604020202020204" pitchFamily="34" charset="0"/>
                <a:cs typeface="Arial" panose="020B0604020202020204" pitchFamily="34" charset="0"/>
              </a:rPr>
              <a:t>Propionic acid (mg/L)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82174074-2BD7-CE90-933E-8DC714912762}"/>
              </a:ext>
            </a:extLst>
          </p:cNvPr>
          <p:cNvSpPr txBox="1"/>
          <p:nvPr/>
        </p:nvSpPr>
        <p:spPr>
          <a:xfrm>
            <a:off x="699056" y="5285619"/>
            <a:ext cx="4473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07A25248-FFBF-C886-DE4D-C777AE500AC1}"/>
              </a:ext>
            </a:extLst>
          </p:cNvPr>
          <p:cNvSpPr txBox="1"/>
          <p:nvPr/>
        </p:nvSpPr>
        <p:spPr>
          <a:xfrm>
            <a:off x="699056" y="4809554"/>
            <a:ext cx="4473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49FE7233-F6B4-0744-FE61-1CBC503401CC}"/>
              </a:ext>
            </a:extLst>
          </p:cNvPr>
          <p:cNvSpPr txBox="1"/>
          <p:nvPr/>
        </p:nvSpPr>
        <p:spPr>
          <a:xfrm>
            <a:off x="699056" y="4314325"/>
            <a:ext cx="4473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C2DDDBA1-3B5E-E943-A61A-627A975F8E40}"/>
              </a:ext>
            </a:extLst>
          </p:cNvPr>
          <p:cNvSpPr txBox="1"/>
          <p:nvPr/>
        </p:nvSpPr>
        <p:spPr>
          <a:xfrm>
            <a:off x="699056" y="3819436"/>
            <a:ext cx="4473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3A9A25ED-D4A7-6AA0-3BCC-C63586FC06E8}"/>
              </a:ext>
            </a:extLst>
          </p:cNvPr>
          <p:cNvSpPr txBox="1"/>
          <p:nvPr/>
        </p:nvSpPr>
        <p:spPr>
          <a:xfrm>
            <a:off x="3844119" y="5298608"/>
            <a:ext cx="4473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4669FCE8-5292-00B5-B931-EEAADF49FE93}"/>
              </a:ext>
            </a:extLst>
          </p:cNvPr>
          <p:cNvSpPr txBox="1"/>
          <p:nvPr/>
        </p:nvSpPr>
        <p:spPr>
          <a:xfrm>
            <a:off x="3844119" y="4925191"/>
            <a:ext cx="4473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43702294-5438-42D9-E0C3-63491A90F67F}"/>
              </a:ext>
            </a:extLst>
          </p:cNvPr>
          <p:cNvSpPr txBox="1"/>
          <p:nvPr/>
        </p:nvSpPr>
        <p:spPr>
          <a:xfrm>
            <a:off x="3844119" y="4581155"/>
            <a:ext cx="4473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4C0A4F34-8033-3B84-B228-B7AC0B7B231F}"/>
              </a:ext>
            </a:extLst>
          </p:cNvPr>
          <p:cNvSpPr txBox="1"/>
          <p:nvPr/>
        </p:nvSpPr>
        <p:spPr>
          <a:xfrm>
            <a:off x="3844119" y="3850352"/>
            <a:ext cx="4473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C32CCE52-D7E7-02F7-3ADB-F383DD2A1206}"/>
              </a:ext>
            </a:extLst>
          </p:cNvPr>
          <p:cNvSpPr txBox="1"/>
          <p:nvPr/>
        </p:nvSpPr>
        <p:spPr>
          <a:xfrm>
            <a:off x="3844119" y="4194388"/>
            <a:ext cx="4473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C357667B-F48E-9DF9-222F-D4878A48EBE1}"/>
              </a:ext>
            </a:extLst>
          </p:cNvPr>
          <p:cNvSpPr txBox="1"/>
          <p:nvPr/>
        </p:nvSpPr>
        <p:spPr>
          <a:xfrm rot="16200000">
            <a:off x="3080281" y="4522466"/>
            <a:ext cx="160289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>
                <a:latin typeface="Arial" panose="020B0604020202020204" pitchFamily="34" charset="0"/>
                <a:cs typeface="Arial" panose="020B0604020202020204" pitchFamily="34" charset="0"/>
              </a:rPr>
              <a:t>Valeric acid (mg/L)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1C3B41D9-58F3-AA72-6235-C7FE1036A2CC}"/>
              </a:ext>
            </a:extLst>
          </p:cNvPr>
          <p:cNvSpPr txBox="1"/>
          <p:nvPr/>
        </p:nvSpPr>
        <p:spPr>
          <a:xfrm>
            <a:off x="684222" y="7724674"/>
            <a:ext cx="4473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BCE2CF5A-4B5E-D07C-7C61-B7513E5D9F09}"/>
              </a:ext>
            </a:extLst>
          </p:cNvPr>
          <p:cNvSpPr txBox="1"/>
          <p:nvPr/>
        </p:nvSpPr>
        <p:spPr>
          <a:xfrm>
            <a:off x="684222" y="7239557"/>
            <a:ext cx="4473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9E9C6063-FAE6-E3CE-C160-5638C909621A}"/>
              </a:ext>
            </a:extLst>
          </p:cNvPr>
          <p:cNvSpPr txBox="1"/>
          <p:nvPr/>
        </p:nvSpPr>
        <p:spPr>
          <a:xfrm>
            <a:off x="684222" y="6742069"/>
            <a:ext cx="4473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A6B99C26-151D-905D-50AC-E9C53CDF9AA8}"/>
              </a:ext>
            </a:extLst>
          </p:cNvPr>
          <p:cNvSpPr txBox="1"/>
          <p:nvPr/>
        </p:nvSpPr>
        <p:spPr>
          <a:xfrm>
            <a:off x="684222" y="6259640"/>
            <a:ext cx="4473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DF212AA2-9C21-8990-A8D2-532392CC6EF6}"/>
              </a:ext>
            </a:extLst>
          </p:cNvPr>
          <p:cNvSpPr txBox="1"/>
          <p:nvPr/>
        </p:nvSpPr>
        <p:spPr>
          <a:xfrm rot="16200000">
            <a:off x="-117225" y="7007365"/>
            <a:ext cx="160289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>
                <a:latin typeface="Arial" panose="020B0604020202020204" pitchFamily="34" charset="0"/>
                <a:cs typeface="Arial" panose="020B0604020202020204" pitchFamily="34" charset="0"/>
              </a:rPr>
              <a:t>Lactic acid (mg/L)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1590B683-C185-E6F8-F85D-D1A42F1FA794}"/>
              </a:ext>
            </a:extLst>
          </p:cNvPr>
          <p:cNvSpPr txBox="1"/>
          <p:nvPr/>
        </p:nvSpPr>
        <p:spPr>
          <a:xfrm>
            <a:off x="3833473" y="7724674"/>
            <a:ext cx="4473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4A54E0F4-A035-7DE8-D2B8-614F20F4D0D4}"/>
              </a:ext>
            </a:extLst>
          </p:cNvPr>
          <p:cNvSpPr txBox="1"/>
          <p:nvPr/>
        </p:nvSpPr>
        <p:spPr>
          <a:xfrm>
            <a:off x="3824764" y="7219437"/>
            <a:ext cx="4473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588EDF9B-09FE-AC4E-BB30-82028B737954}"/>
              </a:ext>
            </a:extLst>
          </p:cNvPr>
          <p:cNvSpPr txBox="1"/>
          <p:nvPr/>
        </p:nvSpPr>
        <p:spPr>
          <a:xfrm>
            <a:off x="3824764" y="6732904"/>
            <a:ext cx="4473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667D8C3E-40F5-A91E-3DD3-F747519BD5B6}"/>
              </a:ext>
            </a:extLst>
          </p:cNvPr>
          <p:cNvSpPr txBox="1"/>
          <p:nvPr/>
        </p:nvSpPr>
        <p:spPr>
          <a:xfrm>
            <a:off x="3824764" y="6225356"/>
            <a:ext cx="4473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D052E3E7-38E7-060A-9EA3-0784A0B0193F}"/>
              </a:ext>
            </a:extLst>
          </p:cNvPr>
          <p:cNvSpPr txBox="1"/>
          <p:nvPr/>
        </p:nvSpPr>
        <p:spPr>
          <a:xfrm rot="16200000">
            <a:off x="3116204" y="6992383"/>
            <a:ext cx="160289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>
                <a:latin typeface="Arial" panose="020B0604020202020204" pitchFamily="34" charset="0"/>
                <a:cs typeface="Arial" panose="020B0604020202020204" pitchFamily="34" charset="0"/>
              </a:rPr>
              <a:t>Isovaleric acid (mg/L)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834C2E7C-46ED-89EB-2A48-28CF45B656DD}"/>
              </a:ext>
            </a:extLst>
          </p:cNvPr>
          <p:cNvSpPr txBox="1"/>
          <p:nvPr/>
        </p:nvSpPr>
        <p:spPr>
          <a:xfrm>
            <a:off x="4419798" y="2935554"/>
            <a:ext cx="3747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NC 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BF737BC5-8F68-1F4A-761A-DC671338F537}"/>
              </a:ext>
            </a:extLst>
          </p:cNvPr>
          <p:cNvSpPr txBox="1"/>
          <p:nvPr/>
        </p:nvSpPr>
        <p:spPr>
          <a:xfrm>
            <a:off x="4725382" y="2935554"/>
            <a:ext cx="6688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NC+Ka 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7DA86558-6AE0-744D-A468-E9D888B5419A}"/>
              </a:ext>
            </a:extLst>
          </p:cNvPr>
          <p:cNvSpPr txBox="1"/>
          <p:nvPr/>
        </p:nvSpPr>
        <p:spPr>
          <a:xfrm>
            <a:off x="5197724" y="2935554"/>
            <a:ext cx="6688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HFHF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15EF5E52-2A1F-B6ED-6409-40A8AA7C7397}"/>
              </a:ext>
            </a:extLst>
          </p:cNvPr>
          <p:cNvSpPr txBox="1"/>
          <p:nvPr/>
        </p:nvSpPr>
        <p:spPr>
          <a:xfrm>
            <a:off x="5669182" y="2935554"/>
            <a:ext cx="8451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HFHF+Ka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461F589D-490C-61C5-6AF4-59FBFFD46E4B}"/>
              </a:ext>
            </a:extLst>
          </p:cNvPr>
          <p:cNvSpPr txBox="1"/>
          <p:nvPr/>
        </p:nvSpPr>
        <p:spPr>
          <a:xfrm>
            <a:off x="1232209" y="5454718"/>
            <a:ext cx="3747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NC 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54F9CD1F-3C17-A30E-41B8-5734A5BD84A8}"/>
              </a:ext>
            </a:extLst>
          </p:cNvPr>
          <p:cNvSpPr txBox="1"/>
          <p:nvPr/>
        </p:nvSpPr>
        <p:spPr>
          <a:xfrm>
            <a:off x="1537793" y="5454718"/>
            <a:ext cx="6688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NC+Ka 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744423AA-DACE-3E0C-01D8-4F6308D780ED}"/>
              </a:ext>
            </a:extLst>
          </p:cNvPr>
          <p:cNvSpPr txBox="1"/>
          <p:nvPr/>
        </p:nvSpPr>
        <p:spPr>
          <a:xfrm>
            <a:off x="2010135" y="5454718"/>
            <a:ext cx="6688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HFHF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D116C584-431B-B34C-7B4D-446B8E5CBE3B}"/>
              </a:ext>
            </a:extLst>
          </p:cNvPr>
          <p:cNvSpPr txBox="1"/>
          <p:nvPr/>
        </p:nvSpPr>
        <p:spPr>
          <a:xfrm>
            <a:off x="2481593" y="5454718"/>
            <a:ext cx="8451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HFHF+Ka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F2FCD026-3F12-BD11-0D60-260F3A63E17F}"/>
              </a:ext>
            </a:extLst>
          </p:cNvPr>
          <p:cNvSpPr txBox="1"/>
          <p:nvPr/>
        </p:nvSpPr>
        <p:spPr>
          <a:xfrm>
            <a:off x="4429583" y="5454718"/>
            <a:ext cx="3747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NC 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EBFAB174-A8EA-AD51-9E31-66A17C5690B7}"/>
              </a:ext>
            </a:extLst>
          </p:cNvPr>
          <p:cNvSpPr txBox="1"/>
          <p:nvPr/>
        </p:nvSpPr>
        <p:spPr>
          <a:xfrm>
            <a:off x="4735167" y="5454718"/>
            <a:ext cx="6688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NC+Ka 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F1F9011F-7E52-FE8E-8A67-34646C058082}"/>
              </a:ext>
            </a:extLst>
          </p:cNvPr>
          <p:cNvSpPr txBox="1"/>
          <p:nvPr/>
        </p:nvSpPr>
        <p:spPr>
          <a:xfrm>
            <a:off x="5207509" y="5454718"/>
            <a:ext cx="6688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HFHF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0FB152D3-1F42-AB34-6EFB-BC85F32CF624}"/>
              </a:ext>
            </a:extLst>
          </p:cNvPr>
          <p:cNvSpPr txBox="1"/>
          <p:nvPr/>
        </p:nvSpPr>
        <p:spPr>
          <a:xfrm>
            <a:off x="5678967" y="5454718"/>
            <a:ext cx="8451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HFHF+Ka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8AC9E5D2-CA63-64C4-3CAD-9E24973E05BC}"/>
              </a:ext>
            </a:extLst>
          </p:cNvPr>
          <p:cNvSpPr txBox="1"/>
          <p:nvPr/>
        </p:nvSpPr>
        <p:spPr>
          <a:xfrm>
            <a:off x="1277919" y="7881810"/>
            <a:ext cx="3747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NC 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D9817B7D-0745-C845-EC53-FD6920EDAA63}"/>
              </a:ext>
            </a:extLst>
          </p:cNvPr>
          <p:cNvSpPr txBox="1"/>
          <p:nvPr/>
        </p:nvSpPr>
        <p:spPr>
          <a:xfrm>
            <a:off x="1583503" y="7881810"/>
            <a:ext cx="6688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NC+Ka 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72839FCF-CC9F-34B2-4314-419FD3C2A1E3}"/>
              </a:ext>
            </a:extLst>
          </p:cNvPr>
          <p:cNvSpPr txBox="1"/>
          <p:nvPr/>
        </p:nvSpPr>
        <p:spPr>
          <a:xfrm>
            <a:off x="2055845" y="7881810"/>
            <a:ext cx="6688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HFHF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E303F318-269D-DD97-4690-B5C2CBFCBBB6}"/>
              </a:ext>
            </a:extLst>
          </p:cNvPr>
          <p:cNvSpPr txBox="1"/>
          <p:nvPr/>
        </p:nvSpPr>
        <p:spPr>
          <a:xfrm>
            <a:off x="2527303" y="7881810"/>
            <a:ext cx="8451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HFHF+Ka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6E0FFF53-B6F9-2D76-8D0E-756A89677459}"/>
              </a:ext>
            </a:extLst>
          </p:cNvPr>
          <p:cNvSpPr txBox="1"/>
          <p:nvPr/>
        </p:nvSpPr>
        <p:spPr>
          <a:xfrm>
            <a:off x="4416665" y="7868854"/>
            <a:ext cx="3747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NC 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54504314-6B36-F51A-160D-C23DB95024E6}"/>
              </a:ext>
            </a:extLst>
          </p:cNvPr>
          <p:cNvSpPr txBox="1"/>
          <p:nvPr/>
        </p:nvSpPr>
        <p:spPr>
          <a:xfrm>
            <a:off x="4722249" y="7868854"/>
            <a:ext cx="6688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NC+Ka 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3C1C50A8-93E0-6815-188A-1E54C8CCDA47}"/>
              </a:ext>
            </a:extLst>
          </p:cNvPr>
          <p:cNvSpPr txBox="1"/>
          <p:nvPr/>
        </p:nvSpPr>
        <p:spPr>
          <a:xfrm>
            <a:off x="5194591" y="7868854"/>
            <a:ext cx="6688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HFHF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E30892B2-9D0C-5001-087A-107FE743FAFF}"/>
              </a:ext>
            </a:extLst>
          </p:cNvPr>
          <p:cNvSpPr txBox="1"/>
          <p:nvPr/>
        </p:nvSpPr>
        <p:spPr>
          <a:xfrm>
            <a:off x="5666049" y="7868854"/>
            <a:ext cx="8451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HFHF+Ka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796115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516</TotalTime>
  <Words>321</Words>
  <Application>Microsoft Office PowerPoint</Application>
  <PresentationFormat>A4 용지(210x297mm)</PresentationFormat>
  <Paragraphs>195</Paragraphs>
  <Slides>2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Office 테마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권채영</dc:creator>
  <cp:lastModifiedBy>Kyoung Jin Choi</cp:lastModifiedBy>
  <cp:revision>79</cp:revision>
  <cp:lastPrinted>2023-03-29T04:51:39Z</cp:lastPrinted>
  <dcterms:created xsi:type="dcterms:W3CDTF">2022-04-27T06:24:12Z</dcterms:created>
  <dcterms:modified xsi:type="dcterms:W3CDTF">2023-05-10T02:17:35Z</dcterms:modified>
</cp:coreProperties>
</file>